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1"/>
  </p:notesMasterIdLst>
  <p:sldIdLst>
    <p:sldId id="286" r:id="rId2"/>
    <p:sldId id="259" r:id="rId3"/>
    <p:sldId id="280" r:id="rId4"/>
    <p:sldId id="270" r:id="rId5"/>
    <p:sldId id="265" r:id="rId6"/>
    <p:sldId id="277" r:id="rId7"/>
    <p:sldId id="279" r:id="rId8"/>
    <p:sldId id="284" r:id="rId9"/>
    <p:sldId id="283" r:id="rId10"/>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2CFFB"/>
    <a:srgbClr val="D883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15F3B771-8970-9B47-B771-2875ECA937DA}" v="54" dt="2023-07-26T21:20:49.220"/>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9272"/>
    <p:restoredTop sz="84354"/>
  </p:normalViewPr>
  <p:slideViewPr>
    <p:cSldViewPr snapToGrid="0">
      <p:cViewPr>
        <p:scale>
          <a:sx n="100" d="100"/>
          <a:sy n="100" d="100"/>
        </p:scale>
        <p:origin x="408" y="32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17" Type="http://schemas.microsoft.com/office/2015/10/relationships/revisionInfo" Target="revisionInfo.xml"/><Relationship Id="rId2" Type="http://schemas.openxmlformats.org/officeDocument/2006/relationships/slide" Target="slides/slide1.xml"/><Relationship Id="rId16" Type="http://schemas.microsoft.com/office/2016/11/relationships/changesInfo" Target="changesInfos/changesInfo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iciarfb@student.ubc.ca" userId="f6ce2832-c5ed-410e-8d5b-5828867bd127" providerId="ADAL" clId="{15F3B771-8970-9B47-B771-2875ECA937DA}"/>
    <pc:docChg chg="undo custSel addSld delSld modSld sldOrd">
      <pc:chgData name="iciarfb@student.ubc.ca" userId="f6ce2832-c5ed-410e-8d5b-5828867bd127" providerId="ADAL" clId="{15F3B771-8970-9B47-B771-2875ECA937DA}" dt="2023-07-26T21:22:39.977" v="2879" actId="1076"/>
      <pc:docMkLst>
        <pc:docMk/>
      </pc:docMkLst>
      <pc:sldChg chg="delSp modSp mod modNotesTx">
        <pc:chgData name="iciarfb@student.ubc.ca" userId="f6ce2832-c5ed-410e-8d5b-5828867bd127" providerId="ADAL" clId="{15F3B771-8970-9B47-B771-2875ECA937DA}" dt="2023-07-26T21:17:14.899" v="2581" actId="478"/>
        <pc:sldMkLst>
          <pc:docMk/>
          <pc:sldMk cId="1223773097" sldId="259"/>
        </pc:sldMkLst>
        <pc:spChg chg="mod">
          <ac:chgData name="iciarfb@student.ubc.ca" userId="f6ce2832-c5ed-410e-8d5b-5828867bd127" providerId="ADAL" clId="{15F3B771-8970-9B47-B771-2875ECA937DA}" dt="2023-07-26T21:16:33.471" v="2550" actId="20577"/>
          <ac:spMkLst>
            <pc:docMk/>
            <pc:sldMk cId="1223773097" sldId="259"/>
            <ac:spMk id="2" creationId="{E5EF32E4-345C-5FD2-A5A0-30A769882D49}"/>
          </ac:spMkLst>
        </pc:spChg>
        <pc:spChg chg="del mod">
          <ac:chgData name="iciarfb@student.ubc.ca" userId="f6ce2832-c5ed-410e-8d5b-5828867bd127" providerId="ADAL" clId="{15F3B771-8970-9B47-B771-2875ECA937DA}" dt="2023-07-26T21:17:14.899" v="2581" actId="478"/>
          <ac:spMkLst>
            <pc:docMk/>
            <pc:sldMk cId="1223773097" sldId="259"/>
            <ac:spMk id="10" creationId="{42824886-5BF9-4057-81A4-4B48DAAC4BC1}"/>
          </ac:spMkLst>
        </pc:spChg>
      </pc:sldChg>
      <pc:sldChg chg="delSp modSp mod modNotesTx">
        <pc:chgData name="iciarfb@student.ubc.ca" userId="f6ce2832-c5ed-410e-8d5b-5828867bd127" providerId="ADAL" clId="{15F3B771-8970-9B47-B771-2875ECA937DA}" dt="2023-07-26T21:17:05.948" v="2577" actId="478"/>
        <pc:sldMkLst>
          <pc:docMk/>
          <pc:sldMk cId="4195761390" sldId="265"/>
        </pc:sldMkLst>
        <pc:spChg chg="mod">
          <ac:chgData name="iciarfb@student.ubc.ca" userId="f6ce2832-c5ed-410e-8d5b-5828867bd127" providerId="ADAL" clId="{15F3B771-8970-9B47-B771-2875ECA937DA}" dt="2023-07-26T21:17:02.962" v="2574" actId="20577"/>
          <ac:spMkLst>
            <pc:docMk/>
            <pc:sldMk cId="4195761390" sldId="265"/>
            <ac:spMk id="2" creationId="{E16C1D69-7CA6-2243-553D-87D89C8FE2C6}"/>
          </ac:spMkLst>
        </pc:spChg>
        <pc:spChg chg="del mod">
          <ac:chgData name="iciarfb@student.ubc.ca" userId="f6ce2832-c5ed-410e-8d5b-5828867bd127" providerId="ADAL" clId="{15F3B771-8970-9B47-B771-2875ECA937DA}" dt="2023-07-26T21:17:05.948" v="2577" actId="478"/>
          <ac:spMkLst>
            <pc:docMk/>
            <pc:sldMk cId="4195761390" sldId="265"/>
            <ac:spMk id="9" creationId="{D24F3D53-57DE-48D7-9449-17DF71846616}"/>
          </ac:spMkLst>
        </pc:spChg>
      </pc:sldChg>
      <pc:sldChg chg="delSp modSp mod modNotesTx">
        <pc:chgData name="iciarfb@student.ubc.ca" userId="f6ce2832-c5ed-410e-8d5b-5828867bd127" providerId="ADAL" clId="{15F3B771-8970-9B47-B771-2875ECA937DA}" dt="2023-07-26T21:17:08.523" v="2579" actId="478"/>
        <pc:sldMkLst>
          <pc:docMk/>
          <pc:sldMk cId="547679064" sldId="270"/>
        </pc:sldMkLst>
        <pc:spChg chg="mod">
          <ac:chgData name="iciarfb@student.ubc.ca" userId="f6ce2832-c5ed-410e-8d5b-5828867bd127" providerId="ADAL" clId="{15F3B771-8970-9B47-B771-2875ECA937DA}" dt="2023-07-26T21:16:44.531" v="2560" actId="20577"/>
          <ac:spMkLst>
            <pc:docMk/>
            <pc:sldMk cId="547679064" sldId="270"/>
            <ac:spMk id="2" creationId="{C307E780-A8AE-A490-E3B9-F6F954823E4C}"/>
          </ac:spMkLst>
        </pc:spChg>
        <pc:spChg chg="del mod">
          <ac:chgData name="iciarfb@student.ubc.ca" userId="f6ce2832-c5ed-410e-8d5b-5828867bd127" providerId="ADAL" clId="{15F3B771-8970-9B47-B771-2875ECA937DA}" dt="2023-07-26T21:17:08.523" v="2579" actId="478"/>
          <ac:spMkLst>
            <pc:docMk/>
            <pc:sldMk cId="547679064" sldId="270"/>
            <ac:spMk id="5" creationId="{2D91360F-B496-4096-9B5A-82B27F805557}"/>
          </ac:spMkLst>
        </pc:spChg>
      </pc:sldChg>
      <pc:sldChg chg="delSp modSp mod modNotesTx">
        <pc:chgData name="iciarfb@student.ubc.ca" userId="f6ce2832-c5ed-410e-8d5b-5828867bd127" providerId="ADAL" clId="{15F3B771-8970-9B47-B771-2875ECA937DA}" dt="2023-07-26T21:17:24.701" v="2583" actId="478"/>
        <pc:sldMkLst>
          <pc:docMk/>
          <pc:sldMk cId="3508169395" sldId="277"/>
        </pc:sldMkLst>
        <pc:spChg chg="mod">
          <ac:chgData name="iciarfb@student.ubc.ca" userId="f6ce2832-c5ed-410e-8d5b-5828867bd127" providerId="ADAL" clId="{15F3B771-8970-9B47-B771-2875ECA937DA}" dt="2023-07-26T21:16:57.315" v="2570" actId="20577"/>
          <ac:spMkLst>
            <pc:docMk/>
            <pc:sldMk cId="3508169395" sldId="277"/>
            <ac:spMk id="3" creationId="{36BF64BE-A0A6-D5A0-5B21-F043B8E005A4}"/>
          </ac:spMkLst>
        </pc:spChg>
        <pc:spChg chg="del mod">
          <ac:chgData name="iciarfb@student.ubc.ca" userId="f6ce2832-c5ed-410e-8d5b-5828867bd127" providerId="ADAL" clId="{15F3B771-8970-9B47-B771-2875ECA937DA}" dt="2023-07-26T21:17:24.701" v="2583" actId="478"/>
          <ac:spMkLst>
            <pc:docMk/>
            <pc:sldMk cId="3508169395" sldId="277"/>
            <ac:spMk id="5" creationId="{2D91360F-B496-4096-9B5A-82B27F805557}"/>
          </ac:spMkLst>
        </pc:spChg>
      </pc:sldChg>
      <pc:sldChg chg="delSp modSp mod modNotesTx">
        <pc:chgData name="iciarfb@student.ubc.ca" userId="f6ce2832-c5ed-410e-8d5b-5828867bd127" providerId="ADAL" clId="{15F3B771-8970-9B47-B771-2875ECA937DA}" dt="2023-07-26T21:17:30.727" v="2589" actId="478"/>
        <pc:sldMkLst>
          <pc:docMk/>
          <pc:sldMk cId="2299653574" sldId="279"/>
        </pc:sldMkLst>
        <pc:spChg chg="mod">
          <ac:chgData name="iciarfb@student.ubc.ca" userId="f6ce2832-c5ed-410e-8d5b-5828867bd127" providerId="ADAL" clId="{15F3B771-8970-9B47-B771-2875ECA937DA}" dt="2023-07-26T21:17:28.152" v="2585" actId="20577"/>
          <ac:spMkLst>
            <pc:docMk/>
            <pc:sldMk cId="2299653574" sldId="279"/>
            <ac:spMk id="2" creationId="{6C6F2E60-E45F-7C98-3063-59B7653BF965}"/>
          </ac:spMkLst>
        </pc:spChg>
        <pc:spChg chg="del mod">
          <ac:chgData name="iciarfb@student.ubc.ca" userId="f6ce2832-c5ed-410e-8d5b-5828867bd127" providerId="ADAL" clId="{15F3B771-8970-9B47-B771-2875ECA937DA}" dt="2023-07-26T21:17:30.727" v="2589" actId="478"/>
          <ac:spMkLst>
            <pc:docMk/>
            <pc:sldMk cId="2299653574" sldId="279"/>
            <ac:spMk id="5" creationId="{2D91360F-B496-4096-9B5A-82B27F805557}"/>
          </ac:spMkLst>
        </pc:spChg>
      </pc:sldChg>
      <pc:sldChg chg="delSp modSp mod modNotesTx">
        <pc:chgData name="iciarfb@student.ubc.ca" userId="f6ce2832-c5ed-410e-8d5b-5828867bd127" providerId="ADAL" clId="{15F3B771-8970-9B47-B771-2875ECA937DA}" dt="2023-07-26T21:17:12.695" v="2580" actId="478"/>
        <pc:sldMkLst>
          <pc:docMk/>
          <pc:sldMk cId="3144242104" sldId="280"/>
        </pc:sldMkLst>
        <pc:spChg chg="mod">
          <ac:chgData name="iciarfb@student.ubc.ca" userId="f6ce2832-c5ed-410e-8d5b-5828867bd127" providerId="ADAL" clId="{15F3B771-8970-9B47-B771-2875ECA937DA}" dt="2023-07-26T21:16:37.692" v="2554" actId="20577"/>
          <ac:spMkLst>
            <pc:docMk/>
            <pc:sldMk cId="3144242104" sldId="280"/>
            <ac:spMk id="4" creationId="{25F12E37-6DBC-9C5B-5033-1204219213E2}"/>
          </ac:spMkLst>
        </pc:spChg>
        <pc:spChg chg="del mod">
          <ac:chgData name="iciarfb@student.ubc.ca" userId="f6ce2832-c5ed-410e-8d5b-5828867bd127" providerId="ADAL" clId="{15F3B771-8970-9B47-B771-2875ECA937DA}" dt="2023-07-26T21:17:12.695" v="2580" actId="478"/>
          <ac:spMkLst>
            <pc:docMk/>
            <pc:sldMk cId="3144242104" sldId="280"/>
            <ac:spMk id="5" creationId="{215A1628-C2D4-4227-A0F2-EB18D924EB8B}"/>
          </ac:spMkLst>
        </pc:spChg>
      </pc:sldChg>
      <pc:sldChg chg="delSp modSp mod modNotesTx">
        <pc:chgData name="iciarfb@student.ubc.ca" userId="f6ce2832-c5ed-410e-8d5b-5828867bd127" providerId="ADAL" clId="{15F3B771-8970-9B47-B771-2875ECA937DA}" dt="2023-07-26T21:17:46.034" v="2599" actId="478"/>
        <pc:sldMkLst>
          <pc:docMk/>
          <pc:sldMk cId="2174551628" sldId="283"/>
        </pc:sldMkLst>
        <pc:spChg chg="mod">
          <ac:chgData name="iciarfb@student.ubc.ca" userId="f6ce2832-c5ed-410e-8d5b-5828867bd127" providerId="ADAL" clId="{15F3B771-8970-9B47-B771-2875ECA937DA}" dt="2023-07-26T21:17:41.867" v="2596" actId="20577"/>
          <ac:spMkLst>
            <pc:docMk/>
            <pc:sldMk cId="2174551628" sldId="283"/>
            <ac:spMk id="3" creationId="{E01F77EA-EE28-A6C9-246D-D38C7DE0D230}"/>
          </ac:spMkLst>
        </pc:spChg>
        <pc:spChg chg="del">
          <ac:chgData name="iciarfb@student.ubc.ca" userId="f6ce2832-c5ed-410e-8d5b-5828867bd127" providerId="ADAL" clId="{15F3B771-8970-9B47-B771-2875ECA937DA}" dt="2023-07-26T21:17:46.034" v="2599" actId="478"/>
          <ac:spMkLst>
            <pc:docMk/>
            <pc:sldMk cId="2174551628" sldId="283"/>
            <ac:spMk id="5" creationId="{2D91360F-B496-4096-9B5A-82B27F805557}"/>
          </ac:spMkLst>
        </pc:spChg>
      </pc:sldChg>
      <pc:sldChg chg="delSp modSp mod modNotesTx">
        <pc:chgData name="iciarfb@student.ubc.ca" userId="f6ce2832-c5ed-410e-8d5b-5828867bd127" providerId="ADAL" clId="{15F3B771-8970-9B47-B771-2875ECA937DA}" dt="2023-07-26T21:17:38.602" v="2594" actId="478"/>
        <pc:sldMkLst>
          <pc:docMk/>
          <pc:sldMk cId="885623364" sldId="284"/>
        </pc:sldMkLst>
        <pc:spChg chg="mod">
          <ac:chgData name="iciarfb@student.ubc.ca" userId="f6ce2832-c5ed-410e-8d5b-5828867bd127" providerId="ADAL" clId="{15F3B771-8970-9B47-B771-2875ECA937DA}" dt="2023-07-26T21:17:34.940" v="2591" actId="20577"/>
          <ac:spMkLst>
            <pc:docMk/>
            <pc:sldMk cId="885623364" sldId="284"/>
            <ac:spMk id="2" creationId="{9EB6C5AB-9E23-55F7-1C7A-087D88711514}"/>
          </ac:spMkLst>
        </pc:spChg>
        <pc:spChg chg="del">
          <ac:chgData name="iciarfb@student.ubc.ca" userId="f6ce2832-c5ed-410e-8d5b-5828867bd127" providerId="ADAL" clId="{15F3B771-8970-9B47-B771-2875ECA937DA}" dt="2023-07-26T21:17:38.602" v="2594" actId="478"/>
          <ac:spMkLst>
            <pc:docMk/>
            <pc:sldMk cId="885623364" sldId="284"/>
            <ac:spMk id="5" creationId="{2D91360F-B496-4096-9B5A-82B27F805557}"/>
          </ac:spMkLst>
        </pc:spChg>
      </pc:sldChg>
      <pc:sldChg chg="addSp delSp modSp add del mod ord">
        <pc:chgData name="iciarfb@student.ubc.ca" userId="f6ce2832-c5ed-410e-8d5b-5828867bd127" providerId="ADAL" clId="{15F3B771-8970-9B47-B771-2875ECA937DA}" dt="2023-07-26T21:16:25.741" v="2546" actId="2696"/>
        <pc:sldMkLst>
          <pc:docMk/>
          <pc:sldMk cId="2051545750" sldId="285"/>
        </pc:sldMkLst>
        <pc:spChg chg="mod">
          <ac:chgData name="iciarfb@student.ubc.ca" userId="f6ce2832-c5ed-410e-8d5b-5828867bd127" providerId="ADAL" clId="{15F3B771-8970-9B47-B771-2875ECA937DA}" dt="2023-07-26T19:35:16.360" v="780" actId="1076"/>
          <ac:spMkLst>
            <pc:docMk/>
            <pc:sldMk cId="2051545750" sldId="285"/>
            <ac:spMk id="2" creationId="{E5EF32E4-345C-5FD2-A5A0-30A769882D49}"/>
          </ac:spMkLst>
        </pc:spChg>
        <pc:spChg chg="add mod">
          <ac:chgData name="iciarfb@student.ubc.ca" userId="f6ce2832-c5ed-410e-8d5b-5828867bd127" providerId="ADAL" clId="{15F3B771-8970-9B47-B771-2875ECA937DA}" dt="2023-07-26T19:43:10.784" v="874" actId="208"/>
          <ac:spMkLst>
            <pc:docMk/>
            <pc:sldMk cId="2051545750" sldId="285"/>
            <ac:spMk id="4" creationId="{174EA6FF-BF67-B860-FA34-E043EC319BB4}"/>
          </ac:spMkLst>
        </pc:spChg>
        <pc:spChg chg="add mod">
          <ac:chgData name="iciarfb@student.ubc.ca" userId="f6ce2832-c5ed-410e-8d5b-5828867bd127" providerId="ADAL" clId="{15F3B771-8970-9B47-B771-2875ECA937DA}" dt="2023-07-26T19:43:10.784" v="874" actId="208"/>
          <ac:spMkLst>
            <pc:docMk/>
            <pc:sldMk cId="2051545750" sldId="285"/>
            <ac:spMk id="5" creationId="{374E29C6-C8F3-BD5C-E873-54CE3D5A196F}"/>
          </ac:spMkLst>
        </pc:spChg>
        <pc:spChg chg="add mod">
          <ac:chgData name="iciarfb@student.ubc.ca" userId="f6ce2832-c5ed-410e-8d5b-5828867bd127" providerId="ADAL" clId="{15F3B771-8970-9B47-B771-2875ECA937DA}" dt="2023-07-26T19:43:10.784" v="874" actId="208"/>
          <ac:spMkLst>
            <pc:docMk/>
            <pc:sldMk cId="2051545750" sldId="285"/>
            <ac:spMk id="6" creationId="{ECEC8F6B-752D-B7CF-DB2F-CA3046B9A6D2}"/>
          </ac:spMkLst>
        </pc:spChg>
        <pc:spChg chg="add mod">
          <ac:chgData name="iciarfb@student.ubc.ca" userId="f6ce2832-c5ed-410e-8d5b-5828867bd127" providerId="ADAL" clId="{15F3B771-8970-9B47-B771-2875ECA937DA}" dt="2023-07-26T19:43:10.784" v="874" actId="208"/>
          <ac:spMkLst>
            <pc:docMk/>
            <pc:sldMk cId="2051545750" sldId="285"/>
            <ac:spMk id="8" creationId="{1927AA64-BAD0-6DAF-D3C3-4ECEB4F26831}"/>
          </ac:spMkLst>
        </pc:spChg>
        <pc:spChg chg="del">
          <ac:chgData name="iciarfb@student.ubc.ca" userId="f6ce2832-c5ed-410e-8d5b-5828867bd127" providerId="ADAL" clId="{15F3B771-8970-9B47-B771-2875ECA937DA}" dt="2023-07-26T19:14:37.226" v="5" actId="478"/>
          <ac:spMkLst>
            <pc:docMk/>
            <pc:sldMk cId="2051545750" sldId="285"/>
            <ac:spMk id="9" creationId="{50651FFA-D6F7-4083-9DEC-E3797BB2C286}"/>
          </ac:spMkLst>
        </pc:spChg>
        <pc:spChg chg="add mod">
          <ac:chgData name="iciarfb@student.ubc.ca" userId="f6ce2832-c5ed-410e-8d5b-5828867bd127" providerId="ADAL" clId="{15F3B771-8970-9B47-B771-2875ECA937DA}" dt="2023-07-26T19:43:10.784" v="874" actId="208"/>
          <ac:spMkLst>
            <pc:docMk/>
            <pc:sldMk cId="2051545750" sldId="285"/>
            <ac:spMk id="11" creationId="{3A98F658-3852-5502-BA92-0D8D5D123ADC}"/>
          </ac:spMkLst>
        </pc:spChg>
        <pc:spChg chg="add mod">
          <ac:chgData name="iciarfb@student.ubc.ca" userId="f6ce2832-c5ed-410e-8d5b-5828867bd127" providerId="ADAL" clId="{15F3B771-8970-9B47-B771-2875ECA937DA}" dt="2023-07-26T19:43:10.784" v="874" actId="208"/>
          <ac:spMkLst>
            <pc:docMk/>
            <pc:sldMk cId="2051545750" sldId="285"/>
            <ac:spMk id="12" creationId="{887CC30F-1FEC-F0C8-B429-73BD9B87B39B}"/>
          </ac:spMkLst>
        </pc:spChg>
        <pc:spChg chg="add mod">
          <ac:chgData name="iciarfb@student.ubc.ca" userId="f6ce2832-c5ed-410e-8d5b-5828867bd127" providerId="ADAL" clId="{15F3B771-8970-9B47-B771-2875ECA937DA}" dt="2023-07-26T19:43:10.784" v="874" actId="208"/>
          <ac:spMkLst>
            <pc:docMk/>
            <pc:sldMk cId="2051545750" sldId="285"/>
            <ac:spMk id="13" creationId="{526D7270-34ED-4B54-764A-CC283A44090B}"/>
          </ac:spMkLst>
        </pc:spChg>
        <pc:spChg chg="add mod">
          <ac:chgData name="iciarfb@student.ubc.ca" userId="f6ce2832-c5ed-410e-8d5b-5828867bd127" providerId="ADAL" clId="{15F3B771-8970-9B47-B771-2875ECA937DA}" dt="2023-07-26T19:43:10.784" v="874" actId="208"/>
          <ac:spMkLst>
            <pc:docMk/>
            <pc:sldMk cId="2051545750" sldId="285"/>
            <ac:spMk id="14" creationId="{C80A265C-2E62-8FE6-3B15-A09ECDAB8A9C}"/>
          </ac:spMkLst>
        </pc:spChg>
        <pc:spChg chg="mod">
          <ac:chgData name="iciarfb@student.ubc.ca" userId="f6ce2832-c5ed-410e-8d5b-5828867bd127" providerId="ADAL" clId="{15F3B771-8970-9B47-B771-2875ECA937DA}" dt="2023-07-26T19:22:21.448" v="188" actId="207"/>
          <ac:spMkLst>
            <pc:docMk/>
            <pc:sldMk cId="2051545750" sldId="285"/>
            <ac:spMk id="27" creationId="{EF2EFC0A-07F9-B69B-5A2E-D52D68859B17}"/>
          </ac:spMkLst>
        </pc:spChg>
        <pc:spChg chg="mod">
          <ac:chgData name="iciarfb@student.ubc.ca" userId="f6ce2832-c5ed-410e-8d5b-5828867bd127" providerId="ADAL" clId="{15F3B771-8970-9B47-B771-2875ECA937DA}" dt="2023-07-26T19:22:23.459" v="189" actId="207"/>
          <ac:spMkLst>
            <pc:docMk/>
            <pc:sldMk cId="2051545750" sldId="285"/>
            <ac:spMk id="28" creationId="{05B59014-6C64-3412-E28D-95098F4D2938}"/>
          </ac:spMkLst>
        </pc:spChg>
        <pc:spChg chg="mod">
          <ac:chgData name="iciarfb@student.ubc.ca" userId="f6ce2832-c5ed-410e-8d5b-5828867bd127" providerId="ADAL" clId="{15F3B771-8970-9B47-B771-2875ECA937DA}" dt="2023-07-26T19:21:13.331" v="159"/>
          <ac:spMkLst>
            <pc:docMk/>
            <pc:sldMk cId="2051545750" sldId="285"/>
            <ac:spMk id="32" creationId="{9836D1D5-877B-3915-59C5-EA4C933342C3}"/>
          </ac:spMkLst>
        </pc:spChg>
        <pc:spChg chg="mod">
          <ac:chgData name="iciarfb@student.ubc.ca" userId="f6ce2832-c5ed-410e-8d5b-5828867bd127" providerId="ADAL" clId="{15F3B771-8970-9B47-B771-2875ECA937DA}" dt="2023-07-26T19:21:13.331" v="159"/>
          <ac:spMkLst>
            <pc:docMk/>
            <pc:sldMk cId="2051545750" sldId="285"/>
            <ac:spMk id="33" creationId="{B4E9329D-F973-1EB1-3C3A-1835576DCE26}"/>
          </ac:spMkLst>
        </pc:spChg>
        <pc:spChg chg="mod">
          <ac:chgData name="iciarfb@student.ubc.ca" userId="f6ce2832-c5ed-410e-8d5b-5828867bd127" providerId="ADAL" clId="{15F3B771-8970-9B47-B771-2875ECA937DA}" dt="2023-07-26T19:21:13.331" v="159"/>
          <ac:spMkLst>
            <pc:docMk/>
            <pc:sldMk cId="2051545750" sldId="285"/>
            <ac:spMk id="37" creationId="{AAF86C6F-E232-A9E2-C901-A3D590EE4D32}"/>
          </ac:spMkLst>
        </pc:spChg>
        <pc:spChg chg="mod">
          <ac:chgData name="iciarfb@student.ubc.ca" userId="f6ce2832-c5ed-410e-8d5b-5828867bd127" providerId="ADAL" clId="{15F3B771-8970-9B47-B771-2875ECA937DA}" dt="2023-07-26T19:21:13.331" v="159"/>
          <ac:spMkLst>
            <pc:docMk/>
            <pc:sldMk cId="2051545750" sldId="285"/>
            <ac:spMk id="38" creationId="{65F17D46-5D14-1BED-A64A-C94A5AD2BA3E}"/>
          </ac:spMkLst>
        </pc:spChg>
        <pc:spChg chg="mod">
          <ac:chgData name="iciarfb@student.ubc.ca" userId="f6ce2832-c5ed-410e-8d5b-5828867bd127" providerId="ADAL" clId="{15F3B771-8970-9B47-B771-2875ECA937DA}" dt="2023-07-26T19:21:13.331" v="159"/>
          <ac:spMkLst>
            <pc:docMk/>
            <pc:sldMk cId="2051545750" sldId="285"/>
            <ac:spMk id="42" creationId="{67D0FEE5-75CD-75D5-FE28-31382D8FE53D}"/>
          </ac:spMkLst>
        </pc:spChg>
        <pc:spChg chg="mod">
          <ac:chgData name="iciarfb@student.ubc.ca" userId="f6ce2832-c5ed-410e-8d5b-5828867bd127" providerId="ADAL" clId="{15F3B771-8970-9B47-B771-2875ECA937DA}" dt="2023-07-26T19:21:13.331" v="159"/>
          <ac:spMkLst>
            <pc:docMk/>
            <pc:sldMk cId="2051545750" sldId="285"/>
            <ac:spMk id="43" creationId="{796E0CAA-BCFF-2900-7002-15DB2C72E005}"/>
          </ac:spMkLst>
        </pc:spChg>
        <pc:spChg chg="mod">
          <ac:chgData name="iciarfb@student.ubc.ca" userId="f6ce2832-c5ed-410e-8d5b-5828867bd127" providerId="ADAL" clId="{15F3B771-8970-9B47-B771-2875ECA937DA}" dt="2023-07-26T19:21:13.331" v="159"/>
          <ac:spMkLst>
            <pc:docMk/>
            <pc:sldMk cId="2051545750" sldId="285"/>
            <ac:spMk id="47" creationId="{1BEC47A3-B3D6-CB8D-47B4-D5AF499F6094}"/>
          </ac:spMkLst>
        </pc:spChg>
        <pc:spChg chg="mod">
          <ac:chgData name="iciarfb@student.ubc.ca" userId="f6ce2832-c5ed-410e-8d5b-5828867bd127" providerId="ADAL" clId="{15F3B771-8970-9B47-B771-2875ECA937DA}" dt="2023-07-26T19:21:13.331" v="159"/>
          <ac:spMkLst>
            <pc:docMk/>
            <pc:sldMk cId="2051545750" sldId="285"/>
            <ac:spMk id="48" creationId="{0A221ABD-F3AD-6DEE-1035-4C0CC964D623}"/>
          </ac:spMkLst>
        </pc:spChg>
        <pc:spChg chg="del mod topLvl">
          <ac:chgData name="iciarfb@student.ubc.ca" userId="f6ce2832-c5ed-410e-8d5b-5828867bd127" providerId="ADAL" clId="{15F3B771-8970-9B47-B771-2875ECA937DA}" dt="2023-07-26T19:21:33.838" v="162" actId="478"/>
          <ac:spMkLst>
            <pc:docMk/>
            <pc:sldMk cId="2051545750" sldId="285"/>
            <ac:spMk id="50" creationId="{4C6A19E2-355D-11B0-D5D1-A172B7CDD094}"/>
          </ac:spMkLst>
        </pc:spChg>
        <pc:spChg chg="del mod topLvl">
          <ac:chgData name="iciarfb@student.ubc.ca" userId="f6ce2832-c5ed-410e-8d5b-5828867bd127" providerId="ADAL" clId="{15F3B771-8970-9B47-B771-2875ECA937DA}" dt="2023-07-26T19:22:32.261" v="192" actId="478"/>
          <ac:spMkLst>
            <pc:docMk/>
            <pc:sldMk cId="2051545750" sldId="285"/>
            <ac:spMk id="51" creationId="{A115EF00-BF23-5A2F-1F23-CAD554CC6B66}"/>
          </ac:spMkLst>
        </pc:spChg>
        <pc:spChg chg="del mod topLvl">
          <ac:chgData name="iciarfb@student.ubc.ca" userId="f6ce2832-c5ed-410e-8d5b-5828867bd127" providerId="ADAL" clId="{15F3B771-8970-9B47-B771-2875ECA937DA}" dt="2023-07-26T19:21:37.446" v="164" actId="478"/>
          <ac:spMkLst>
            <pc:docMk/>
            <pc:sldMk cId="2051545750" sldId="285"/>
            <ac:spMk id="53" creationId="{E8A0A80B-E47E-21C8-FBF1-BB60E791CA74}"/>
          </ac:spMkLst>
        </pc:spChg>
        <pc:spChg chg="del mod topLvl">
          <ac:chgData name="iciarfb@student.ubc.ca" userId="f6ce2832-c5ed-410e-8d5b-5828867bd127" providerId="ADAL" clId="{15F3B771-8970-9B47-B771-2875ECA937DA}" dt="2023-07-26T19:22:38.302" v="194" actId="478"/>
          <ac:spMkLst>
            <pc:docMk/>
            <pc:sldMk cId="2051545750" sldId="285"/>
            <ac:spMk id="54" creationId="{9A3954CF-75F0-225B-8096-024FC42ADA71}"/>
          </ac:spMkLst>
        </pc:spChg>
        <pc:spChg chg="del mod topLvl">
          <ac:chgData name="iciarfb@student.ubc.ca" userId="f6ce2832-c5ed-410e-8d5b-5828867bd127" providerId="ADAL" clId="{15F3B771-8970-9B47-B771-2875ECA937DA}" dt="2023-07-26T19:21:32.027" v="161" actId="478"/>
          <ac:spMkLst>
            <pc:docMk/>
            <pc:sldMk cId="2051545750" sldId="285"/>
            <ac:spMk id="56" creationId="{9A5C12AA-5A2F-9550-67E4-A070823F7D89}"/>
          </ac:spMkLst>
        </pc:spChg>
        <pc:spChg chg="mod topLvl">
          <ac:chgData name="iciarfb@student.ubc.ca" userId="f6ce2832-c5ed-410e-8d5b-5828867bd127" providerId="ADAL" clId="{15F3B771-8970-9B47-B771-2875ECA937DA}" dt="2023-07-26T19:35:34.885" v="784" actId="404"/>
          <ac:spMkLst>
            <pc:docMk/>
            <pc:sldMk cId="2051545750" sldId="285"/>
            <ac:spMk id="57" creationId="{820FB7C0-329A-2D6E-70A1-64F8AFE307C5}"/>
          </ac:spMkLst>
        </pc:spChg>
        <pc:spChg chg="del mod topLvl">
          <ac:chgData name="iciarfb@student.ubc.ca" userId="f6ce2832-c5ed-410e-8d5b-5828867bd127" providerId="ADAL" clId="{15F3B771-8970-9B47-B771-2875ECA937DA}" dt="2023-07-26T19:21:35.722" v="163" actId="478"/>
          <ac:spMkLst>
            <pc:docMk/>
            <pc:sldMk cId="2051545750" sldId="285"/>
            <ac:spMk id="59" creationId="{4A172306-E799-6579-359E-003E4B3427E6}"/>
          </ac:spMkLst>
        </pc:spChg>
        <pc:spChg chg="del mod topLvl">
          <ac:chgData name="iciarfb@student.ubc.ca" userId="f6ce2832-c5ed-410e-8d5b-5828867bd127" providerId="ADAL" clId="{15F3B771-8970-9B47-B771-2875ECA937DA}" dt="2023-07-26T19:22:38.302" v="194" actId="478"/>
          <ac:spMkLst>
            <pc:docMk/>
            <pc:sldMk cId="2051545750" sldId="285"/>
            <ac:spMk id="60" creationId="{8A87D8C6-7184-FB66-98D0-5E7813893FCD}"/>
          </ac:spMkLst>
        </pc:spChg>
        <pc:spChg chg="del mod topLvl">
          <ac:chgData name="iciarfb@student.ubc.ca" userId="f6ce2832-c5ed-410e-8d5b-5828867bd127" providerId="ADAL" clId="{15F3B771-8970-9B47-B771-2875ECA937DA}" dt="2023-07-26T19:21:39.156" v="165" actId="478"/>
          <ac:spMkLst>
            <pc:docMk/>
            <pc:sldMk cId="2051545750" sldId="285"/>
            <ac:spMk id="62" creationId="{0E5D5D67-33BC-36B3-C2AB-3BF94715ABA1}"/>
          </ac:spMkLst>
        </pc:spChg>
        <pc:spChg chg="del mod topLvl">
          <ac:chgData name="iciarfb@student.ubc.ca" userId="f6ce2832-c5ed-410e-8d5b-5828867bd127" providerId="ADAL" clId="{15F3B771-8970-9B47-B771-2875ECA937DA}" dt="2023-07-26T19:22:38.302" v="194" actId="478"/>
          <ac:spMkLst>
            <pc:docMk/>
            <pc:sldMk cId="2051545750" sldId="285"/>
            <ac:spMk id="63" creationId="{3FF55AC1-0DC3-B68F-9496-3B1F912A9F10}"/>
          </ac:spMkLst>
        </pc:spChg>
        <pc:spChg chg="add mod">
          <ac:chgData name="iciarfb@student.ubc.ca" userId="f6ce2832-c5ed-410e-8d5b-5828867bd127" providerId="ADAL" clId="{15F3B771-8970-9B47-B771-2875ECA937DA}" dt="2023-07-26T19:35:50.892" v="788" actId="1076"/>
          <ac:spMkLst>
            <pc:docMk/>
            <pc:sldMk cId="2051545750" sldId="285"/>
            <ac:spMk id="64" creationId="{4426E213-D202-20F5-0381-F3B8C491BDC2}"/>
          </ac:spMkLst>
        </pc:spChg>
        <pc:spChg chg="add del mod">
          <ac:chgData name="iciarfb@student.ubc.ca" userId="f6ce2832-c5ed-410e-8d5b-5828867bd127" providerId="ADAL" clId="{15F3B771-8970-9B47-B771-2875ECA937DA}" dt="2023-07-26T19:22:41.321" v="196" actId="478"/>
          <ac:spMkLst>
            <pc:docMk/>
            <pc:sldMk cId="2051545750" sldId="285"/>
            <ac:spMk id="65" creationId="{0FA5871F-B6D6-8D5F-63E1-04D2D4F9073E}"/>
          </ac:spMkLst>
        </pc:spChg>
        <pc:spChg chg="add del mod">
          <ac:chgData name="iciarfb@student.ubc.ca" userId="f6ce2832-c5ed-410e-8d5b-5828867bd127" providerId="ADAL" clId="{15F3B771-8970-9B47-B771-2875ECA937DA}" dt="2023-07-26T19:22:41.321" v="196" actId="478"/>
          <ac:spMkLst>
            <pc:docMk/>
            <pc:sldMk cId="2051545750" sldId="285"/>
            <ac:spMk id="66" creationId="{3723EAB7-90C6-3B54-F867-9FECD92F1854}"/>
          </ac:spMkLst>
        </pc:spChg>
        <pc:spChg chg="add del mod">
          <ac:chgData name="iciarfb@student.ubc.ca" userId="f6ce2832-c5ed-410e-8d5b-5828867bd127" providerId="ADAL" clId="{15F3B771-8970-9B47-B771-2875ECA937DA}" dt="2023-07-26T19:22:41.321" v="196" actId="478"/>
          <ac:spMkLst>
            <pc:docMk/>
            <pc:sldMk cId="2051545750" sldId="285"/>
            <ac:spMk id="67" creationId="{A2D6C161-78E7-4535-E5D1-6F14D9A16E8B}"/>
          </ac:spMkLst>
        </pc:spChg>
        <pc:spChg chg="add del mod">
          <ac:chgData name="iciarfb@student.ubc.ca" userId="f6ce2832-c5ed-410e-8d5b-5828867bd127" providerId="ADAL" clId="{15F3B771-8970-9B47-B771-2875ECA937DA}" dt="2023-07-26T19:22:38.302" v="194" actId="478"/>
          <ac:spMkLst>
            <pc:docMk/>
            <pc:sldMk cId="2051545750" sldId="285"/>
            <ac:spMk id="68" creationId="{7846825C-57A4-840C-CD2D-4C193E55DF73}"/>
          </ac:spMkLst>
        </pc:spChg>
        <pc:spChg chg="mod">
          <ac:chgData name="iciarfb@student.ubc.ca" userId="f6ce2832-c5ed-410e-8d5b-5828867bd127" providerId="ADAL" clId="{15F3B771-8970-9B47-B771-2875ECA937DA}" dt="2023-07-26T19:25:28.965" v="370"/>
          <ac:spMkLst>
            <pc:docMk/>
            <pc:sldMk cId="2051545750" sldId="285"/>
            <ac:spMk id="74" creationId="{103C7B65-C65B-4960-5E9B-7718E7BB1BEB}"/>
          </ac:spMkLst>
        </pc:spChg>
        <pc:spChg chg="mod">
          <ac:chgData name="iciarfb@student.ubc.ca" userId="f6ce2832-c5ed-410e-8d5b-5828867bd127" providerId="ADAL" clId="{15F3B771-8970-9B47-B771-2875ECA937DA}" dt="2023-07-26T19:25:28.965" v="370"/>
          <ac:spMkLst>
            <pc:docMk/>
            <pc:sldMk cId="2051545750" sldId="285"/>
            <ac:spMk id="75" creationId="{BB0604DD-BAC2-A966-268E-9B0C34F94E31}"/>
          </ac:spMkLst>
        </pc:spChg>
        <pc:spChg chg="add mod">
          <ac:chgData name="iciarfb@student.ubc.ca" userId="f6ce2832-c5ed-410e-8d5b-5828867bd127" providerId="ADAL" clId="{15F3B771-8970-9B47-B771-2875ECA937DA}" dt="2023-07-26T19:36:46.087" v="802" actId="1076"/>
          <ac:spMkLst>
            <pc:docMk/>
            <pc:sldMk cId="2051545750" sldId="285"/>
            <ac:spMk id="76" creationId="{7C1322E2-D589-6CEB-8048-09007E57FD94}"/>
          </ac:spMkLst>
        </pc:spChg>
        <pc:spChg chg="add mod">
          <ac:chgData name="iciarfb@student.ubc.ca" userId="f6ce2832-c5ed-410e-8d5b-5828867bd127" providerId="ADAL" clId="{15F3B771-8970-9B47-B771-2875ECA937DA}" dt="2023-07-26T19:36:52.595" v="804" actId="1076"/>
          <ac:spMkLst>
            <pc:docMk/>
            <pc:sldMk cId="2051545750" sldId="285"/>
            <ac:spMk id="77" creationId="{7032C59C-8A37-4517-0AB6-B12922178F1A}"/>
          </ac:spMkLst>
        </pc:spChg>
        <pc:spChg chg="add mod">
          <ac:chgData name="iciarfb@student.ubc.ca" userId="f6ce2832-c5ed-410e-8d5b-5828867bd127" providerId="ADAL" clId="{15F3B771-8970-9B47-B771-2875ECA937DA}" dt="2023-07-26T19:43:10.784" v="874" actId="208"/>
          <ac:spMkLst>
            <pc:docMk/>
            <pc:sldMk cId="2051545750" sldId="285"/>
            <ac:spMk id="78" creationId="{6435770D-FD6E-35DE-FE76-ADBEE73F6016}"/>
          </ac:spMkLst>
        </pc:spChg>
        <pc:spChg chg="add mod">
          <ac:chgData name="iciarfb@student.ubc.ca" userId="f6ce2832-c5ed-410e-8d5b-5828867bd127" providerId="ADAL" clId="{15F3B771-8970-9B47-B771-2875ECA937DA}" dt="2023-07-26T19:43:10.784" v="874" actId="208"/>
          <ac:spMkLst>
            <pc:docMk/>
            <pc:sldMk cId="2051545750" sldId="285"/>
            <ac:spMk id="79" creationId="{D7A273E8-19AC-80FE-09D3-FE0229A0A8B0}"/>
          </ac:spMkLst>
        </pc:spChg>
        <pc:spChg chg="mod">
          <ac:chgData name="iciarfb@student.ubc.ca" userId="f6ce2832-c5ed-410e-8d5b-5828867bd127" providerId="ADAL" clId="{15F3B771-8970-9B47-B771-2875ECA937DA}" dt="2023-07-26T19:32:45.816" v="688"/>
          <ac:spMkLst>
            <pc:docMk/>
            <pc:sldMk cId="2051545750" sldId="285"/>
            <ac:spMk id="84" creationId="{06502059-0E0E-D1F5-427D-45E4A7C31D19}"/>
          </ac:spMkLst>
        </pc:spChg>
        <pc:spChg chg="mod">
          <ac:chgData name="iciarfb@student.ubc.ca" userId="f6ce2832-c5ed-410e-8d5b-5828867bd127" providerId="ADAL" clId="{15F3B771-8970-9B47-B771-2875ECA937DA}" dt="2023-07-26T19:32:45.816" v="688"/>
          <ac:spMkLst>
            <pc:docMk/>
            <pc:sldMk cId="2051545750" sldId="285"/>
            <ac:spMk id="85" creationId="{B4926D7F-EB26-C66F-0361-818842ED8DA9}"/>
          </ac:spMkLst>
        </pc:spChg>
        <pc:spChg chg="add mod">
          <ac:chgData name="iciarfb@student.ubc.ca" userId="f6ce2832-c5ed-410e-8d5b-5828867bd127" providerId="ADAL" clId="{15F3B771-8970-9B47-B771-2875ECA937DA}" dt="2023-07-26T19:37:04.758" v="805" actId="1076"/>
          <ac:spMkLst>
            <pc:docMk/>
            <pc:sldMk cId="2051545750" sldId="285"/>
            <ac:spMk id="86" creationId="{4718A319-927C-E3DA-53B3-A7E95103B98D}"/>
          </ac:spMkLst>
        </pc:spChg>
        <pc:spChg chg="add mod">
          <ac:chgData name="iciarfb@student.ubc.ca" userId="f6ce2832-c5ed-410e-8d5b-5828867bd127" providerId="ADAL" clId="{15F3B771-8970-9B47-B771-2875ECA937DA}" dt="2023-07-26T19:37:11.044" v="807" actId="404"/>
          <ac:spMkLst>
            <pc:docMk/>
            <pc:sldMk cId="2051545750" sldId="285"/>
            <ac:spMk id="87" creationId="{A4F98E15-61AF-526D-AB05-15230A091CF9}"/>
          </ac:spMkLst>
        </pc:spChg>
        <pc:spChg chg="mod">
          <ac:chgData name="iciarfb@student.ubc.ca" userId="f6ce2832-c5ed-410e-8d5b-5828867bd127" providerId="ADAL" clId="{15F3B771-8970-9B47-B771-2875ECA937DA}" dt="2023-07-26T19:33:25.917" v="741"/>
          <ac:spMkLst>
            <pc:docMk/>
            <pc:sldMk cId="2051545750" sldId="285"/>
            <ac:spMk id="91" creationId="{EFE08643-7F73-F050-0EF1-7423DA8D31D4}"/>
          </ac:spMkLst>
        </pc:spChg>
        <pc:spChg chg="mod">
          <ac:chgData name="iciarfb@student.ubc.ca" userId="f6ce2832-c5ed-410e-8d5b-5828867bd127" providerId="ADAL" clId="{15F3B771-8970-9B47-B771-2875ECA937DA}" dt="2023-07-26T19:33:25.917" v="741"/>
          <ac:spMkLst>
            <pc:docMk/>
            <pc:sldMk cId="2051545750" sldId="285"/>
            <ac:spMk id="92" creationId="{8933795D-02F1-3B00-8B2F-61A0FDDBA22F}"/>
          </ac:spMkLst>
        </pc:spChg>
        <pc:spChg chg="add mod">
          <ac:chgData name="iciarfb@student.ubc.ca" userId="f6ce2832-c5ed-410e-8d5b-5828867bd127" providerId="ADAL" clId="{15F3B771-8970-9B47-B771-2875ECA937DA}" dt="2023-07-26T19:37:21.738" v="808" actId="1076"/>
          <ac:spMkLst>
            <pc:docMk/>
            <pc:sldMk cId="2051545750" sldId="285"/>
            <ac:spMk id="93" creationId="{FBEA9902-FECB-AC77-65A8-202D9572B7F7}"/>
          </ac:spMkLst>
        </pc:spChg>
        <pc:spChg chg="add mod">
          <ac:chgData name="iciarfb@student.ubc.ca" userId="f6ce2832-c5ed-410e-8d5b-5828867bd127" providerId="ADAL" clId="{15F3B771-8970-9B47-B771-2875ECA937DA}" dt="2023-07-26T19:37:33.512" v="813" actId="20577"/>
          <ac:spMkLst>
            <pc:docMk/>
            <pc:sldMk cId="2051545750" sldId="285"/>
            <ac:spMk id="94" creationId="{F5CBF33E-0432-CE1F-31AD-02333AC5BA0F}"/>
          </ac:spMkLst>
        </pc:spChg>
        <pc:spChg chg="mod">
          <ac:chgData name="iciarfb@student.ubc.ca" userId="f6ce2832-c5ed-410e-8d5b-5828867bd127" providerId="ADAL" clId="{15F3B771-8970-9B47-B771-2875ECA937DA}" dt="2023-07-26T19:37:38.417" v="814"/>
          <ac:spMkLst>
            <pc:docMk/>
            <pc:sldMk cId="2051545750" sldId="285"/>
            <ac:spMk id="101" creationId="{7EF6EF8E-D568-C8F7-FC6D-A62F5EB1DDFD}"/>
          </ac:spMkLst>
        </pc:spChg>
        <pc:spChg chg="mod">
          <ac:chgData name="iciarfb@student.ubc.ca" userId="f6ce2832-c5ed-410e-8d5b-5828867bd127" providerId="ADAL" clId="{15F3B771-8970-9B47-B771-2875ECA937DA}" dt="2023-07-26T19:37:38.417" v="814"/>
          <ac:spMkLst>
            <pc:docMk/>
            <pc:sldMk cId="2051545750" sldId="285"/>
            <ac:spMk id="102" creationId="{AE1D8CA4-D657-00EA-7C89-BE270A8ACC33}"/>
          </ac:spMkLst>
        </pc:spChg>
        <pc:spChg chg="add mod">
          <ac:chgData name="iciarfb@student.ubc.ca" userId="f6ce2832-c5ed-410e-8d5b-5828867bd127" providerId="ADAL" clId="{15F3B771-8970-9B47-B771-2875ECA937DA}" dt="2023-07-26T19:37:56.961" v="842" actId="1038"/>
          <ac:spMkLst>
            <pc:docMk/>
            <pc:sldMk cId="2051545750" sldId="285"/>
            <ac:spMk id="103" creationId="{450AAB55-CF7C-078E-1CD2-23B9DD2E74A6}"/>
          </ac:spMkLst>
        </pc:spChg>
        <pc:spChg chg="add mod">
          <ac:chgData name="iciarfb@student.ubc.ca" userId="f6ce2832-c5ed-410e-8d5b-5828867bd127" providerId="ADAL" clId="{15F3B771-8970-9B47-B771-2875ECA937DA}" dt="2023-07-26T19:37:46.404" v="817" actId="20577"/>
          <ac:spMkLst>
            <pc:docMk/>
            <pc:sldMk cId="2051545750" sldId="285"/>
            <ac:spMk id="104" creationId="{780298FB-0303-29C1-01EA-42A2CF0335B7}"/>
          </ac:spMkLst>
        </pc:spChg>
        <pc:spChg chg="add del mod">
          <ac:chgData name="iciarfb@student.ubc.ca" userId="f6ce2832-c5ed-410e-8d5b-5828867bd127" providerId="ADAL" clId="{15F3B771-8970-9B47-B771-2875ECA937DA}" dt="2023-07-26T19:41:15.087" v="853" actId="478"/>
          <ac:spMkLst>
            <pc:docMk/>
            <pc:sldMk cId="2051545750" sldId="285"/>
            <ac:spMk id="107" creationId="{F4771298-5D36-6359-DC44-4C843D82126E}"/>
          </ac:spMkLst>
        </pc:spChg>
        <pc:spChg chg="add del mod">
          <ac:chgData name="iciarfb@student.ubc.ca" userId="f6ce2832-c5ed-410e-8d5b-5828867bd127" providerId="ADAL" clId="{15F3B771-8970-9B47-B771-2875ECA937DA}" dt="2023-07-26T19:41:22.160" v="855"/>
          <ac:spMkLst>
            <pc:docMk/>
            <pc:sldMk cId="2051545750" sldId="285"/>
            <ac:spMk id="108" creationId="{664DDCA7-6525-C0A5-4153-0657168F9D1D}"/>
          </ac:spMkLst>
        </pc:spChg>
        <pc:spChg chg="add del mod">
          <ac:chgData name="iciarfb@student.ubc.ca" userId="f6ce2832-c5ed-410e-8d5b-5828867bd127" providerId="ADAL" clId="{15F3B771-8970-9B47-B771-2875ECA937DA}" dt="2023-07-26T19:41:22.160" v="855"/>
          <ac:spMkLst>
            <pc:docMk/>
            <pc:sldMk cId="2051545750" sldId="285"/>
            <ac:spMk id="109" creationId="{8C238297-B785-FEB4-5C3E-473A61FE2382}"/>
          </ac:spMkLst>
        </pc:spChg>
        <pc:spChg chg="add del mod">
          <ac:chgData name="iciarfb@student.ubc.ca" userId="f6ce2832-c5ed-410e-8d5b-5828867bd127" providerId="ADAL" clId="{15F3B771-8970-9B47-B771-2875ECA937DA}" dt="2023-07-26T19:41:22.160" v="855"/>
          <ac:spMkLst>
            <pc:docMk/>
            <pc:sldMk cId="2051545750" sldId="285"/>
            <ac:spMk id="110" creationId="{F9D0615E-2B1E-20AB-9F20-6CADD8BA76BF}"/>
          </ac:spMkLst>
        </pc:spChg>
        <pc:spChg chg="mod">
          <ac:chgData name="iciarfb@student.ubc.ca" userId="f6ce2832-c5ed-410e-8d5b-5828867bd127" providerId="ADAL" clId="{15F3B771-8970-9B47-B771-2875ECA937DA}" dt="2023-07-26T19:41:15.605" v="854"/>
          <ac:spMkLst>
            <pc:docMk/>
            <pc:sldMk cId="2051545750" sldId="285"/>
            <ac:spMk id="112" creationId="{C57581EB-AC1A-1917-91DE-88AC1AA548D1}"/>
          </ac:spMkLst>
        </pc:spChg>
        <pc:spChg chg="mod">
          <ac:chgData name="iciarfb@student.ubc.ca" userId="f6ce2832-c5ed-410e-8d5b-5828867bd127" providerId="ADAL" clId="{15F3B771-8970-9B47-B771-2875ECA937DA}" dt="2023-07-26T19:41:15.605" v="854"/>
          <ac:spMkLst>
            <pc:docMk/>
            <pc:sldMk cId="2051545750" sldId="285"/>
            <ac:spMk id="113" creationId="{4CD84E64-42BE-CEB6-A1CD-4521428C9540}"/>
          </ac:spMkLst>
        </pc:spChg>
        <pc:spChg chg="mod">
          <ac:chgData name="iciarfb@student.ubc.ca" userId="f6ce2832-c5ed-410e-8d5b-5828867bd127" providerId="ADAL" clId="{15F3B771-8970-9B47-B771-2875ECA937DA}" dt="2023-07-26T19:41:15.605" v="854"/>
          <ac:spMkLst>
            <pc:docMk/>
            <pc:sldMk cId="2051545750" sldId="285"/>
            <ac:spMk id="114" creationId="{BFD9A79A-3940-F2B7-10DF-9B909CD58092}"/>
          </ac:spMkLst>
        </pc:spChg>
        <pc:spChg chg="mod">
          <ac:chgData name="iciarfb@student.ubc.ca" userId="f6ce2832-c5ed-410e-8d5b-5828867bd127" providerId="ADAL" clId="{15F3B771-8970-9B47-B771-2875ECA937DA}" dt="2023-07-26T19:41:15.605" v="854"/>
          <ac:spMkLst>
            <pc:docMk/>
            <pc:sldMk cId="2051545750" sldId="285"/>
            <ac:spMk id="115" creationId="{816DC07E-F906-180D-E6BE-D52B9C9AD17C}"/>
          </ac:spMkLst>
        </pc:spChg>
        <pc:spChg chg="mod">
          <ac:chgData name="iciarfb@student.ubc.ca" userId="f6ce2832-c5ed-410e-8d5b-5828867bd127" providerId="ADAL" clId="{15F3B771-8970-9B47-B771-2875ECA937DA}" dt="2023-07-26T19:41:15.605" v="854"/>
          <ac:spMkLst>
            <pc:docMk/>
            <pc:sldMk cId="2051545750" sldId="285"/>
            <ac:spMk id="117" creationId="{DF09B84E-60A8-4790-8E7E-7EF95039AC83}"/>
          </ac:spMkLst>
        </pc:spChg>
        <pc:spChg chg="mod">
          <ac:chgData name="iciarfb@student.ubc.ca" userId="f6ce2832-c5ed-410e-8d5b-5828867bd127" providerId="ADAL" clId="{15F3B771-8970-9B47-B771-2875ECA937DA}" dt="2023-07-26T19:41:15.605" v="854"/>
          <ac:spMkLst>
            <pc:docMk/>
            <pc:sldMk cId="2051545750" sldId="285"/>
            <ac:spMk id="118" creationId="{182BAFCE-10BB-134A-8349-7E1B4441C5C3}"/>
          </ac:spMkLst>
        </pc:spChg>
        <pc:spChg chg="mod">
          <ac:chgData name="iciarfb@student.ubc.ca" userId="f6ce2832-c5ed-410e-8d5b-5828867bd127" providerId="ADAL" clId="{15F3B771-8970-9B47-B771-2875ECA937DA}" dt="2023-07-26T19:41:15.605" v="854"/>
          <ac:spMkLst>
            <pc:docMk/>
            <pc:sldMk cId="2051545750" sldId="285"/>
            <ac:spMk id="119" creationId="{79648B23-34B3-3CFD-A26C-C1D2DB1BEC67}"/>
          </ac:spMkLst>
        </pc:spChg>
        <pc:spChg chg="mod">
          <ac:chgData name="iciarfb@student.ubc.ca" userId="f6ce2832-c5ed-410e-8d5b-5828867bd127" providerId="ADAL" clId="{15F3B771-8970-9B47-B771-2875ECA937DA}" dt="2023-07-26T19:41:15.605" v="854"/>
          <ac:spMkLst>
            <pc:docMk/>
            <pc:sldMk cId="2051545750" sldId="285"/>
            <ac:spMk id="120" creationId="{DA70A1C3-7570-34DC-401C-9EEE2B6371CD}"/>
          </ac:spMkLst>
        </pc:spChg>
        <pc:spChg chg="mod">
          <ac:chgData name="iciarfb@student.ubc.ca" userId="f6ce2832-c5ed-410e-8d5b-5828867bd127" providerId="ADAL" clId="{15F3B771-8970-9B47-B771-2875ECA937DA}" dt="2023-07-26T19:41:15.605" v="854"/>
          <ac:spMkLst>
            <pc:docMk/>
            <pc:sldMk cId="2051545750" sldId="285"/>
            <ac:spMk id="122" creationId="{32D8A753-A11D-E8C2-E886-9C34802711B6}"/>
          </ac:spMkLst>
        </pc:spChg>
        <pc:spChg chg="mod">
          <ac:chgData name="iciarfb@student.ubc.ca" userId="f6ce2832-c5ed-410e-8d5b-5828867bd127" providerId="ADAL" clId="{15F3B771-8970-9B47-B771-2875ECA937DA}" dt="2023-07-26T19:41:15.605" v="854"/>
          <ac:spMkLst>
            <pc:docMk/>
            <pc:sldMk cId="2051545750" sldId="285"/>
            <ac:spMk id="123" creationId="{3CF5DA87-D7BB-3C84-7C4D-337D5473F708}"/>
          </ac:spMkLst>
        </pc:spChg>
        <pc:spChg chg="mod">
          <ac:chgData name="iciarfb@student.ubc.ca" userId="f6ce2832-c5ed-410e-8d5b-5828867bd127" providerId="ADAL" clId="{15F3B771-8970-9B47-B771-2875ECA937DA}" dt="2023-07-26T19:41:15.605" v="854"/>
          <ac:spMkLst>
            <pc:docMk/>
            <pc:sldMk cId="2051545750" sldId="285"/>
            <ac:spMk id="124" creationId="{A2AAAD43-1481-4BED-B7E7-72B85D9A888D}"/>
          </ac:spMkLst>
        </pc:spChg>
        <pc:spChg chg="mod">
          <ac:chgData name="iciarfb@student.ubc.ca" userId="f6ce2832-c5ed-410e-8d5b-5828867bd127" providerId="ADAL" clId="{15F3B771-8970-9B47-B771-2875ECA937DA}" dt="2023-07-26T19:41:15.605" v="854"/>
          <ac:spMkLst>
            <pc:docMk/>
            <pc:sldMk cId="2051545750" sldId="285"/>
            <ac:spMk id="125" creationId="{F02C2453-FC97-88B3-DBE0-2469447A1F85}"/>
          </ac:spMkLst>
        </pc:spChg>
        <pc:spChg chg="mod">
          <ac:chgData name="iciarfb@student.ubc.ca" userId="f6ce2832-c5ed-410e-8d5b-5828867bd127" providerId="ADAL" clId="{15F3B771-8970-9B47-B771-2875ECA937DA}" dt="2023-07-26T19:41:15.605" v="854"/>
          <ac:spMkLst>
            <pc:docMk/>
            <pc:sldMk cId="2051545750" sldId="285"/>
            <ac:spMk id="127" creationId="{889C28AD-7795-5AF3-2AD9-9005A80507C0}"/>
          </ac:spMkLst>
        </pc:spChg>
        <pc:spChg chg="mod">
          <ac:chgData name="iciarfb@student.ubc.ca" userId="f6ce2832-c5ed-410e-8d5b-5828867bd127" providerId="ADAL" clId="{15F3B771-8970-9B47-B771-2875ECA937DA}" dt="2023-07-26T19:41:15.605" v="854"/>
          <ac:spMkLst>
            <pc:docMk/>
            <pc:sldMk cId="2051545750" sldId="285"/>
            <ac:spMk id="128" creationId="{2583294C-9F6B-4ACA-5073-E79D2E1BFDF9}"/>
          </ac:spMkLst>
        </pc:spChg>
        <pc:spChg chg="mod">
          <ac:chgData name="iciarfb@student.ubc.ca" userId="f6ce2832-c5ed-410e-8d5b-5828867bd127" providerId="ADAL" clId="{15F3B771-8970-9B47-B771-2875ECA937DA}" dt="2023-07-26T19:41:15.605" v="854"/>
          <ac:spMkLst>
            <pc:docMk/>
            <pc:sldMk cId="2051545750" sldId="285"/>
            <ac:spMk id="129" creationId="{300AB1C7-FB18-769F-082A-5801886A1D6F}"/>
          </ac:spMkLst>
        </pc:spChg>
        <pc:spChg chg="mod">
          <ac:chgData name="iciarfb@student.ubc.ca" userId="f6ce2832-c5ed-410e-8d5b-5828867bd127" providerId="ADAL" clId="{15F3B771-8970-9B47-B771-2875ECA937DA}" dt="2023-07-26T19:41:15.605" v="854"/>
          <ac:spMkLst>
            <pc:docMk/>
            <pc:sldMk cId="2051545750" sldId="285"/>
            <ac:spMk id="130" creationId="{C27874A8-5F01-8D86-C894-713941DB478F}"/>
          </ac:spMkLst>
        </pc:spChg>
        <pc:spChg chg="mod">
          <ac:chgData name="iciarfb@student.ubc.ca" userId="f6ce2832-c5ed-410e-8d5b-5828867bd127" providerId="ADAL" clId="{15F3B771-8970-9B47-B771-2875ECA937DA}" dt="2023-07-26T19:41:15.605" v="854"/>
          <ac:spMkLst>
            <pc:docMk/>
            <pc:sldMk cId="2051545750" sldId="285"/>
            <ac:spMk id="132" creationId="{6D935F61-69C2-9EBE-03E8-2B4B27953ED3}"/>
          </ac:spMkLst>
        </pc:spChg>
        <pc:spChg chg="mod">
          <ac:chgData name="iciarfb@student.ubc.ca" userId="f6ce2832-c5ed-410e-8d5b-5828867bd127" providerId="ADAL" clId="{15F3B771-8970-9B47-B771-2875ECA937DA}" dt="2023-07-26T19:41:15.605" v="854"/>
          <ac:spMkLst>
            <pc:docMk/>
            <pc:sldMk cId="2051545750" sldId="285"/>
            <ac:spMk id="133" creationId="{A148A6AF-1711-E9A6-6F04-D5B4D709908B}"/>
          </ac:spMkLst>
        </pc:spChg>
        <pc:spChg chg="mod">
          <ac:chgData name="iciarfb@student.ubc.ca" userId="f6ce2832-c5ed-410e-8d5b-5828867bd127" providerId="ADAL" clId="{15F3B771-8970-9B47-B771-2875ECA937DA}" dt="2023-07-26T19:41:15.605" v="854"/>
          <ac:spMkLst>
            <pc:docMk/>
            <pc:sldMk cId="2051545750" sldId="285"/>
            <ac:spMk id="134" creationId="{EA1A39D7-3731-F815-A329-98B758EADFEA}"/>
          </ac:spMkLst>
        </pc:spChg>
        <pc:spChg chg="mod">
          <ac:chgData name="iciarfb@student.ubc.ca" userId="f6ce2832-c5ed-410e-8d5b-5828867bd127" providerId="ADAL" clId="{15F3B771-8970-9B47-B771-2875ECA937DA}" dt="2023-07-26T19:41:15.605" v="854"/>
          <ac:spMkLst>
            <pc:docMk/>
            <pc:sldMk cId="2051545750" sldId="285"/>
            <ac:spMk id="135" creationId="{292A3295-98BD-6566-24DF-6A8E91B44766}"/>
          </ac:spMkLst>
        </pc:spChg>
        <pc:spChg chg="add del mod">
          <ac:chgData name="iciarfb@student.ubc.ca" userId="f6ce2832-c5ed-410e-8d5b-5828867bd127" providerId="ADAL" clId="{15F3B771-8970-9B47-B771-2875ECA937DA}" dt="2023-07-26T19:41:22.160" v="855"/>
          <ac:spMkLst>
            <pc:docMk/>
            <pc:sldMk cId="2051545750" sldId="285"/>
            <ac:spMk id="136" creationId="{54CEE193-199B-B2B6-028B-ABF1EBCD7AE1}"/>
          </ac:spMkLst>
        </pc:spChg>
        <pc:spChg chg="add del mod">
          <ac:chgData name="iciarfb@student.ubc.ca" userId="f6ce2832-c5ed-410e-8d5b-5828867bd127" providerId="ADAL" clId="{15F3B771-8970-9B47-B771-2875ECA937DA}" dt="2023-07-26T19:41:22.160" v="855"/>
          <ac:spMkLst>
            <pc:docMk/>
            <pc:sldMk cId="2051545750" sldId="285"/>
            <ac:spMk id="137" creationId="{6DAE7801-D189-80BF-044B-24A57134A81E}"/>
          </ac:spMkLst>
        </pc:spChg>
        <pc:spChg chg="add del mod">
          <ac:chgData name="iciarfb@student.ubc.ca" userId="f6ce2832-c5ed-410e-8d5b-5828867bd127" providerId="ADAL" clId="{15F3B771-8970-9B47-B771-2875ECA937DA}" dt="2023-07-26T19:41:22.160" v="855"/>
          <ac:spMkLst>
            <pc:docMk/>
            <pc:sldMk cId="2051545750" sldId="285"/>
            <ac:spMk id="138" creationId="{1EE16725-B85F-9346-983A-CE15DA624F6A}"/>
          </ac:spMkLst>
        </pc:spChg>
        <pc:spChg chg="add del mod">
          <ac:chgData name="iciarfb@student.ubc.ca" userId="f6ce2832-c5ed-410e-8d5b-5828867bd127" providerId="ADAL" clId="{15F3B771-8970-9B47-B771-2875ECA937DA}" dt="2023-07-26T19:41:22.160" v="855"/>
          <ac:spMkLst>
            <pc:docMk/>
            <pc:sldMk cId="2051545750" sldId="285"/>
            <ac:spMk id="139" creationId="{F97CCD8E-BE6E-A9AF-B4C2-8D0087371497}"/>
          </ac:spMkLst>
        </pc:spChg>
        <pc:spChg chg="add del mod">
          <ac:chgData name="iciarfb@student.ubc.ca" userId="f6ce2832-c5ed-410e-8d5b-5828867bd127" providerId="ADAL" clId="{15F3B771-8970-9B47-B771-2875ECA937DA}" dt="2023-07-26T19:41:22.160" v="855"/>
          <ac:spMkLst>
            <pc:docMk/>
            <pc:sldMk cId="2051545750" sldId="285"/>
            <ac:spMk id="140" creationId="{ABE8C91F-00FA-A3F1-548D-92BDBD6D1C24}"/>
          </ac:spMkLst>
        </pc:spChg>
        <pc:spChg chg="add del mod">
          <ac:chgData name="iciarfb@student.ubc.ca" userId="f6ce2832-c5ed-410e-8d5b-5828867bd127" providerId="ADAL" clId="{15F3B771-8970-9B47-B771-2875ECA937DA}" dt="2023-07-26T19:41:22.160" v="855"/>
          <ac:spMkLst>
            <pc:docMk/>
            <pc:sldMk cId="2051545750" sldId="285"/>
            <ac:spMk id="143" creationId="{DF10E584-3ACC-74A1-083A-65FBEBE79691}"/>
          </ac:spMkLst>
        </pc:spChg>
        <pc:spChg chg="add mod">
          <ac:chgData name="iciarfb@student.ubc.ca" userId="f6ce2832-c5ed-410e-8d5b-5828867bd127" providerId="ADAL" clId="{15F3B771-8970-9B47-B771-2875ECA937DA}" dt="2023-07-26T20:09:59.251" v="1029" actId="14100"/>
          <ac:spMkLst>
            <pc:docMk/>
            <pc:sldMk cId="2051545750" sldId="285"/>
            <ac:spMk id="144" creationId="{43B519F9-3B6B-F768-67A0-4E7E8A495335}"/>
          </ac:spMkLst>
        </pc:spChg>
        <pc:spChg chg="add mod">
          <ac:chgData name="iciarfb@student.ubc.ca" userId="f6ce2832-c5ed-410e-8d5b-5828867bd127" providerId="ADAL" clId="{15F3B771-8970-9B47-B771-2875ECA937DA}" dt="2023-07-26T20:10:08.431" v="1031" actId="1076"/>
          <ac:spMkLst>
            <pc:docMk/>
            <pc:sldMk cId="2051545750" sldId="285"/>
            <ac:spMk id="145" creationId="{82DAABC1-6D79-118D-F65A-D224C7CD2F27}"/>
          </ac:spMkLst>
        </pc:spChg>
        <pc:spChg chg="add del mod">
          <ac:chgData name="iciarfb@student.ubc.ca" userId="f6ce2832-c5ed-410e-8d5b-5828867bd127" providerId="ADAL" clId="{15F3B771-8970-9B47-B771-2875ECA937DA}" dt="2023-07-26T19:43:22.859" v="875" actId="478"/>
          <ac:spMkLst>
            <pc:docMk/>
            <pc:sldMk cId="2051545750" sldId="285"/>
            <ac:spMk id="146" creationId="{1D685FDD-B987-318D-FDAA-082651582C5E}"/>
          </ac:spMkLst>
        </pc:spChg>
        <pc:spChg chg="del mod topLvl">
          <ac:chgData name="iciarfb@student.ubc.ca" userId="f6ce2832-c5ed-410e-8d5b-5828867bd127" providerId="ADAL" clId="{15F3B771-8970-9B47-B771-2875ECA937DA}" dt="2023-07-26T20:07:30.502" v="977" actId="478"/>
          <ac:spMkLst>
            <pc:docMk/>
            <pc:sldMk cId="2051545750" sldId="285"/>
            <ac:spMk id="148" creationId="{5FA2CF00-DA06-F71C-B16A-19A6110E796F}"/>
          </ac:spMkLst>
        </pc:spChg>
        <pc:spChg chg="del mod">
          <ac:chgData name="iciarfb@student.ubc.ca" userId="f6ce2832-c5ed-410e-8d5b-5828867bd127" providerId="ADAL" clId="{15F3B771-8970-9B47-B771-2875ECA937DA}" dt="2023-07-26T19:44:09.876" v="881" actId="478"/>
          <ac:spMkLst>
            <pc:docMk/>
            <pc:sldMk cId="2051545750" sldId="285"/>
            <ac:spMk id="149" creationId="{5C1D6C28-6576-CD62-9923-DEFA580E3A51}"/>
          </ac:spMkLst>
        </pc:spChg>
        <pc:spChg chg="del mod topLvl">
          <ac:chgData name="iciarfb@student.ubc.ca" userId="f6ce2832-c5ed-410e-8d5b-5828867bd127" providerId="ADAL" clId="{15F3B771-8970-9B47-B771-2875ECA937DA}" dt="2023-07-26T19:44:09.876" v="881" actId="478"/>
          <ac:spMkLst>
            <pc:docMk/>
            <pc:sldMk cId="2051545750" sldId="285"/>
            <ac:spMk id="150" creationId="{92C2C89E-34D3-EEBC-AE20-F5CF67A38434}"/>
          </ac:spMkLst>
        </pc:spChg>
        <pc:spChg chg="del mod">
          <ac:chgData name="iciarfb@student.ubc.ca" userId="f6ce2832-c5ed-410e-8d5b-5828867bd127" providerId="ADAL" clId="{15F3B771-8970-9B47-B771-2875ECA937DA}" dt="2023-07-26T19:43:48.804" v="876" actId="478"/>
          <ac:spMkLst>
            <pc:docMk/>
            <pc:sldMk cId="2051545750" sldId="285"/>
            <ac:spMk id="151" creationId="{683F8E17-7181-9475-4797-8BB16CA7C668}"/>
          </ac:spMkLst>
        </pc:spChg>
        <pc:spChg chg="del mod">
          <ac:chgData name="iciarfb@student.ubc.ca" userId="f6ce2832-c5ed-410e-8d5b-5828867bd127" providerId="ADAL" clId="{15F3B771-8970-9B47-B771-2875ECA937DA}" dt="2023-07-26T19:44:51.431" v="897" actId="478"/>
          <ac:spMkLst>
            <pc:docMk/>
            <pc:sldMk cId="2051545750" sldId="285"/>
            <ac:spMk id="153" creationId="{F3A7EBF1-75AB-9EBB-F31B-365E7E4B60FE}"/>
          </ac:spMkLst>
        </pc:spChg>
        <pc:spChg chg="mod">
          <ac:chgData name="iciarfb@student.ubc.ca" userId="f6ce2832-c5ed-410e-8d5b-5828867bd127" providerId="ADAL" clId="{15F3B771-8970-9B47-B771-2875ECA937DA}" dt="2023-07-26T19:41:42.410" v="859" actId="404"/>
          <ac:spMkLst>
            <pc:docMk/>
            <pc:sldMk cId="2051545750" sldId="285"/>
            <ac:spMk id="154" creationId="{730437D8-8D04-ABB0-6C8F-F264D490892F}"/>
          </ac:spMkLst>
        </pc:spChg>
        <pc:spChg chg="mod">
          <ac:chgData name="iciarfb@student.ubc.ca" userId="f6ce2832-c5ed-410e-8d5b-5828867bd127" providerId="ADAL" clId="{15F3B771-8970-9B47-B771-2875ECA937DA}" dt="2023-07-26T19:41:42.410" v="859" actId="404"/>
          <ac:spMkLst>
            <pc:docMk/>
            <pc:sldMk cId="2051545750" sldId="285"/>
            <ac:spMk id="155" creationId="{D5D33A6F-B1FD-7E75-3E0B-5374697D3605}"/>
          </ac:spMkLst>
        </pc:spChg>
        <pc:spChg chg="mod">
          <ac:chgData name="iciarfb@student.ubc.ca" userId="f6ce2832-c5ed-410e-8d5b-5828867bd127" providerId="ADAL" clId="{15F3B771-8970-9B47-B771-2875ECA937DA}" dt="2023-07-26T19:41:42.410" v="859" actId="404"/>
          <ac:spMkLst>
            <pc:docMk/>
            <pc:sldMk cId="2051545750" sldId="285"/>
            <ac:spMk id="156" creationId="{D0DCF491-DC27-588B-E099-D4E4CB1AC20F}"/>
          </ac:spMkLst>
        </pc:spChg>
        <pc:spChg chg="mod">
          <ac:chgData name="iciarfb@student.ubc.ca" userId="f6ce2832-c5ed-410e-8d5b-5828867bd127" providerId="ADAL" clId="{15F3B771-8970-9B47-B771-2875ECA937DA}" dt="2023-07-26T19:41:42.410" v="859" actId="404"/>
          <ac:spMkLst>
            <pc:docMk/>
            <pc:sldMk cId="2051545750" sldId="285"/>
            <ac:spMk id="158" creationId="{09054201-643B-9808-6049-5970D616AD7E}"/>
          </ac:spMkLst>
        </pc:spChg>
        <pc:spChg chg="mod">
          <ac:chgData name="iciarfb@student.ubc.ca" userId="f6ce2832-c5ed-410e-8d5b-5828867bd127" providerId="ADAL" clId="{15F3B771-8970-9B47-B771-2875ECA937DA}" dt="2023-07-26T19:41:42.410" v="859" actId="404"/>
          <ac:spMkLst>
            <pc:docMk/>
            <pc:sldMk cId="2051545750" sldId="285"/>
            <ac:spMk id="159" creationId="{A1B82747-86B6-941F-E910-189EF66BA1FE}"/>
          </ac:spMkLst>
        </pc:spChg>
        <pc:spChg chg="mod">
          <ac:chgData name="iciarfb@student.ubc.ca" userId="f6ce2832-c5ed-410e-8d5b-5828867bd127" providerId="ADAL" clId="{15F3B771-8970-9B47-B771-2875ECA937DA}" dt="2023-07-26T19:41:42.410" v="859" actId="404"/>
          <ac:spMkLst>
            <pc:docMk/>
            <pc:sldMk cId="2051545750" sldId="285"/>
            <ac:spMk id="160" creationId="{031FECA3-872F-9935-9681-1792107DEF13}"/>
          </ac:spMkLst>
        </pc:spChg>
        <pc:spChg chg="mod">
          <ac:chgData name="iciarfb@student.ubc.ca" userId="f6ce2832-c5ed-410e-8d5b-5828867bd127" providerId="ADAL" clId="{15F3B771-8970-9B47-B771-2875ECA937DA}" dt="2023-07-26T19:41:42.410" v="859" actId="404"/>
          <ac:spMkLst>
            <pc:docMk/>
            <pc:sldMk cId="2051545750" sldId="285"/>
            <ac:spMk id="161" creationId="{200937B4-681A-2BA5-38BF-E7D99F265F7F}"/>
          </ac:spMkLst>
        </pc:spChg>
        <pc:spChg chg="mod">
          <ac:chgData name="iciarfb@student.ubc.ca" userId="f6ce2832-c5ed-410e-8d5b-5828867bd127" providerId="ADAL" clId="{15F3B771-8970-9B47-B771-2875ECA937DA}" dt="2023-07-26T19:41:42.410" v="859" actId="404"/>
          <ac:spMkLst>
            <pc:docMk/>
            <pc:sldMk cId="2051545750" sldId="285"/>
            <ac:spMk id="163" creationId="{DE2D74EF-E035-D8A1-ED92-A4FEC80C8BBA}"/>
          </ac:spMkLst>
        </pc:spChg>
        <pc:spChg chg="mod">
          <ac:chgData name="iciarfb@student.ubc.ca" userId="f6ce2832-c5ed-410e-8d5b-5828867bd127" providerId="ADAL" clId="{15F3B771-8970-9B47-B771-2875ECA937DA}" dt="2023-07-26T19:45:35.004" v="921" actId="20577"/>
          <ac:spMkLst>
            <pc:docMk/>
            <pc:sldMk cId="2051545750" sldId="285"/>
            <ac:spMk id="164" creationId="{D5422FFF-F911-2DC5-E87B-F155E9031308}"/>
          </ac:spMkLst>
        </pc:spChg>
        <pc:spChg chg="mod">
          <ac:chgData name="iciarfb@student.ubc.ca" userId="f6ce2832-c5ed-410e-8d5b-5828867bd127" providerId="ADAL" clId="{15F3B771-8970-9B47-B771-2875ECA937DA}" dt="2023-07-26T19:41:42.410" v="859" actId="404"/>
          <ac:spMkLst>
            <pc:docMk/>
            <pc:sldMk cId="2051545750" sldId="285"/>
            <ac:spMk id="165" creationId="{492CB4E5-3ACD-48F9-807E-AAB3B5A17132}"/>
          </ac:spMkLst>
        </pc:spChg>
        <pc:spChg chg="mod">
          <ac:chgData name="iciarfb@student.ubc.ca" userId="f6ce2832-c5ed-410e-8d5b-5828867bd127" providerId="ADAL" clId="{15F3B771-8970-9B47-B771-2875ECA937DA}" dt="2023-07-26T19:41:42.410" v="859" actId="404"/>
          <ac:spMkLst>
            <pc:docMk/>
            <pc:sldMk cId="2051545750" sldId="285"/>
            <ac:spMk id="166" creationId="{FE786FF3-12AF-C8C0-E50F-B3EF6D298E7B}"/>
          </ac:spMkLst>
        </pc:spChg>
        <pc:spChg chg="mod">
          <ac:chgData name="iciarfb@student.ubc.ca" userId="f6ce2832-c5ed-410e-8d5b-5828867bd127" providerId="ADAL" clId="{15F3B771-8970-9B47-B771-2875ECA937DA}" dt="2023-07-26T19:41:42.410" v="859" actId="404"/>
          <ac:spMkLst>
            <pc:docMk/>
            <pc:sldMk cId="2051545750" sldId="285"/>
            <ac:spMk id="168" creationId="{420F28BD-111A-CAD9-5EDD-720655332C47}"/>
          </ac:spMkLst>
        </pc:spChg>
        <pc:spChg chg="mod">
          <ac:chgData name="iciarfb@student.ubc.ca" userId="f6ce2832-c5ed-410e-8d5b-5828867bd127" providerId="ADAL" clId="{15F3B771-8970-9B47-B771-2875ECA937DA}" dt="2023-07-26T19:41:42.410" v="859" actId="404"/>
          <ac:spMkLst>
            <pc:docMk/>
            <pc:sldMk cId="2051545750" sldId="285"/>
            <ac:spMk id="169" creationId="{15452BA0-940C-11C1-8686-16407AD0849E}"/>
          </ac:spMkLst>
        </pc:spChg>
        <pc:spChg chg="mod">
          <ac:chgData name="iciarfb@student.ubc.ca" userId="f6ce2832-c5ed-410e-8d5b-5828867bd127" providerId="ADAL" clId="{15F3B771-8970-9B47-B771-2875ECA937DA}" dt="2023-07-26T19:41:42.410" v="859" actId="404"/>
          <ac:spMkLst>
            <pc:docMk/>
            <pc:sldMk cId="2051545750" sldId="285"/>
            <ac:spMk id="170" creationId="{8AB7C3A3-9894-3B01-2925-236419316608}"/>
          </ac:spMkLst>
        </pc:spChg>
        <pc:spChg chg="mod">
          <ac:chgData name="iciarfb@student.ubc.ca" userId="f6ce2832-c5ed-410e-8d5b-5828867bd127" providerId="ADAL" clId="{15F3B771-8970-9B47-B771-2875ECA937DA}" dt="2023-07-26T19:41:42.410" v="859" actId="404"/>
          <ac:spMkLst>
            <pc:docMk/>
            <pc:sldMk cId="2051545750" sldId="285"/>
            <ac:spMk id="171" creationId="{12269808-DEAC-C4F2-2E45-A8F8D400B39F}"/>
          </ac:spMkLst>
        </pc:spChg>
        <pc:spChg chg="add del mod">
          <ac:chgData name="iciarfb@student.ubc.ca" userId="f6ce2832-c5ed-410e-8d5b-5828867bd127" providerId="ADAL" clId="{15F3B771-8970-9B47-B771-2875ECA937DA}" dt="2023-07-26T19:42:49.337" v="871" actId="478"/>
          <ac:spMkLst>
            <pc:docMk/>
            <pc:sldMk cId="2051545750" sldId="285"/>
            <ac:spMk id="172" creationId="{A4B119A0-F664-72B8-CF4C-B59EA3B114F6}"/>
          </ac:spMkLst>
        </pc:spChg>
        <pc:spChg chg="add del mod">
          <ac:chgData name="iciarfb@student.ubc.ca" userId="f6ce2832-c5ed-410e-8d5b-5828867bd127" providerId="ADAL" clId="{15F3B771-8970-9B47-B771-2875ECA937DA}" dt="2023-07-26T19:42:49.337" v="871" actId="478"/>
          <ac:spMkLst>
            <pc:docMk/>
            <pc:sldMk cId="2051545750" sldId="285"/>
            <ac:spMk id="173" creationId="{D2E19C81-BC83-6A63-FE26-A87E3E6B050E}"/>
          </ac:spMkLst>
        </pc:spChg>
        <pc:spChg chg="add del mod">
          <ac:chgData name="iciarfb@student.ubc.ca" userId="f6ce2832-c5ed-410e-8d5b-5828867bd127" providerId="ADAL" clId="{15F3B771-8970-9B47-B771-2875ECA937DA}" dt="2023-07-26T19:42:49.337" v="871" actId="478"/>
          <ac:spMkLst>
            <pc:docMk/>
            <pc:sldMk cId="2051545750" sldId="285"/>
            <ac:spMk id="174" creationId="{FC34B2BF-2208-E60A-6C58-65BD8C1C2AB6}"/>
          </ac:spMkLst>
        </pc:spChg>
        <pc:spChg chg="add del mod">
          <ac:chgData name="iciarfb@student.ubc.ca" userId="f6ce2832-c5ed-410e-8d5b-5828867bd127" providerId="ADAL" clId="{15F3B771-8970-9B47-B771-2875ECA937DA}" dt="2023-07-26T19:42:49.337" v="871" actId="478"/>
          <ac:spMkLst>
            <pc:docMk/>
            <pc:sldMk cId="2051545750" sldId="285"/>
            <ac:spMk id="175" creationId="{08B18AB5-01DB-6401-7311-247471309960}"/>
          </ac:spMkLst>
        </pc:spChg>
        <pc:spChg chg="add mod">
          <ac:chgData name="iciarfb@student.ubc.ca" userId="f6ce2832-c5ed-410e-8d5b-5828867bd127" providerId="ADAL" clId="{15F3B771-8970-9B47-B771-2875ECA937DA}" dt="2023-07-26T19:41:42.410" v="859" actId="404"/>
          <ac:spMkLst>
            <pc:docMk/>
            <pc:sldMk cId="2051545750" sldId="285"/>
            <ac:spMk id="176" creationId="{325FB3B2-8A77-D3CB-131E-8A57007734C1}"/>
          </ac:spMkLst>
        </pc:spChg>
        <pc:spChg chg="add mod">
          <ac:chgData name="iciarfb@student.ubc.ca" userId="f6ce2832-c5ed-410e-8d5b-5828867bd127" providerId="ADAL" clId="{15F3B771-8970-9B47-B771-2875ECA937DA}" dt="2023-07-26T19:41:42.410" v="859" actId="404"/>
          <ac:spMkLst>
            <pc:docMk/>
            <pc:sldMk cId="2051545750" sldId="285"/>
            <ac:spMk id="179" creationId="{C214F53F-1413-C7FE-10E8-93650997B5CA}"/>
          </ac:spMkLst>
        </pc:spChg>
        <pc:spChg chg="add del mod">
          <ac:chgData name="iciarfb@student.ubc.ca" userId="f6ce2832-c5ed-410e-8d5b-5828867bd127" providerId="ADAL" clId="{15F3B771-8970-9B47-B771-2875ECA937DA}" dt="2023-07-26T20:07:30.502" v="977" actId="478"/>
          <ac:spMkLst>
            <pc:docMk/>
            <pc:sldMk cId="2051545750" sldId="285"/>
            <ac:spMk id="180" creationId="{6DFEE28F-E1CA-BDEC-B92C-A77312CD8C45}"/>
          </ac:spMkLst>
        </pc:spChg>
        <pc:spChg chg="add del mod">
          <ac:chgData name="iciarfb@student.ubc.ca" userId="f6ce2832-c5ed-410e-8d5b-5828867bd127" providerId="ADAL" clId="{15F3B771-8970-9B47-B771-2875ECA937DA}" dt="2023-07-26T20:07:30.502" v="977" actId="478"/>
          <ac:spMkLst>
            <pc:docMk/>
            <pc:sldMk cId="2051545750" sldId="285"/>
            <ac:spMk id="181" creationId="{82AC4FC1-666A-3D2A-20DA-0286F595300F}"/>
          </ac:spMkLst>
        </pc:spChg>
        <pc:spChg chg="add mod">
          <ac:chgData name="iciarfb@student.ubc.ca" userId="f6ce2832-c5ed-410e-8d5b-5828867bd127" providerId="ADAL" clId="{15F3B771-8970-9B47-B771-2875ECA937DA}" dt="2023-07-26T20:08:55.174" v="1016" actId="1076"/>
          <ac:spMkLst>
            <pc:docMk/>
            <pc:sldMk cId="2051545750" sldId="285"/>
            <ac:spMk id="182" creationId="{D5EECE43-EBF8-B1A1-1639-0BA8B5AF85C9}"/>
          </ac:spMkLst>
        </pc:spChg>
        <pc:spChg chg="add mod">
          <ac:chgData name="iciarfb@student.ubc.ca" userId="f6ce2832-c5ed-410e-8d5b-5828867bd127" providerId="ADAL" clId="{15F3B771-8970-9B47-B771-2875ECA937DA}" dt="2023-07-26T20:08:55.174" v="1016" actId="1076"/>
          <ac:spMkLst>
            <pc:docMk/>
            <pc:sldMk cId="2051545750" sldId="285"/>
            <ac:spMk id="183" creationId="{4DA74BC7-BF85-A356-E581-AA4CA0ADFFEC}"/>
          </ac:spMkLst>
        </pc:spChg>
        <pc:spChg chg="add mod">
          <ac:chgData name="iciarfb@student.ubc.ca" userId="f6ce2832-c5ed-410e-8d5b-5828867bd127" providerId="ADAL" clId="{15F3B771-8970-9B47-B771-2875ECA937DA}" dt="2023-07-26T20:08:55.174" v="1016" actId="1076"/>
          <ac:spMkLst>
            <pc:docMk/>
            <pc:sldMk cId="2051545750" sldId="285"/>
            <ac:spMk id="184" creationId="{2F0C0B7E-32B3-27C2-6C33-064B76A3AB0F}"/>
          </ac:spMkLst>
        </pc:spChg>
        <pc:spChg chg="add mod">
          <ac:chgData name="iciarfb@student.ubc.ca" userId="f6ce2832-c5ed-410e-8d5b-5828867bd127" providerId="ADAL" clId="{15F3B771-8970-9B47-B771-2875ECA937DA}" dt="2023-07-26T20:08:55.174" v="1016" actId="1076"/>
          <ac:spMkLst>
            <pc:docMk/>
            <pc:sldMk cId="2051545750" sldId="285"/>
            <ac:spMk id="185" creationId="{AAADDD5C-CBDF-F857-9C99-2D065A031FEA}"/>
          </ac:spMkLst>
        </pc:spChg>
        <pc:spChg chg="add mod">
          <ac:chgData name="iciarfb@student.ubc.ca" userId="f6ce2832-c5ed-410e-8d5b-5828867bd127" providerId="ADAL" clId="{15F3B771-8970-9B47-B771-2875ECA937DA}" dt="2023-07-26T20:08:55.174" v="1016" actId="1076"/>
          <ac:spMkLst>
            <pc:docMk/>
            <pc:sldMk cId="2051545750" sldId="285"/>
            <ac:spMk id="186" creationId="{E80E703A-3B2D-9317-8440-757BA9D844E7}"/>
          </ac:spMkLst>
        </pc:spChg>
        <pc:spChg chg="add mod">
          <ac:chgData name="iciarfb@student.ubc.ca" userId="f6ce2832-c5ed-410e-8d5b-5828867bd127" providerId="ADAL" clId="{15F3B771-8970-9B47-B771-2875ECA937DA}" dt="2023-07-26T20:08:55.174" v="1016" actId="1076"/>
          <ac:spMkLst>
            <pc:docMk/>
            <pc:sldMk cId="2051545750" sldId="285"/>
            <ac:spMk id="187" creationId="{D26D5C6E-0306-1149-E131-45172D9E3D07}"/>
          </ac:spMkLst>
        </pc:spChg>
        <pc:spChg chg="add mod">
          <ac:chgData name="iciarfb@student.ubc.ca" userId="f6ce2832-c5ed-410e-8d5b-5828867bd127" providerId="ADAL" clId="{15F3B771-8970-9B47-B771-2875ECA937DA}" dt="2023-07-26T20:08:55.174" v="1016" actId="1076"/>
          <ac:spMkLst>
            <pc:docMk/>
            <pc:sldMk cId="2051545750" sldId="285"/>
            <ac:spMk id="188" creationId="{471A6882-4D4D-DB23-884D-9DEBB05AFF1E}"/>
          </ac:spMkLst>
        </pc:spChg>
        <pc:spChg chg="add mod">
          <ac:chgData name="iciarfb@student.ubc.ca" userId="f6ce2832-c5ed-410e-8d5b-5828867bd127" providerId="ADAL" clId="{15F3B771-8970-9B47-B771-2875ECA937DA}" dt="2023-07-26T20:08:55.174" v="1016" actId="1076"/>
          <ac:spMkLst>
            <pc:docMk/>
            <pc:sldMk cId="2051545750" sldId="285"/>
            <ac:spMk id="189" creationId="{73ED305A-AFAD-5135-918D-B6C6CE129ACA}"/>
          </ac:spMkLst>
        </pc:spChg>
        <pc:spChg chg="add mod">
          <ac:chgData name="iciarfb@student.ubc.ca" userId="f6ce2832-c5ed-410e-8d5b-5828867bd127" providerId="ADAL" clId="{15F3B771-8970-9B47-B771-2875ECA937DA}" dt="2023-07-26T20:08:55.174" v="1016" actId="1076"/>
          <ac:spMkLst>
            <pc:docMk/>
            <pc:sldMk cId="2051545750" sldId="285"/>
            <ac:spMk id="190" creationId="{8938AB5D-71C1-2454-6A89-7377607AABD5}"/>
          </ac:spMkLst>
        </pc:spChg>
        <pc:spChg chg="add mod">
          <ac:chgData name="iciarfb@student.ubc.ca" userId="f6ce2832-c5ed-410e-8d5b-5828867bd127" providerId="ADAL" clId="{15F3B771-8970-9B47-B771-2875ECA937DA}" dt="2023-07-26T20:08:55.174" v="1016" actId="1076"/>
          <ac:spMkLst>
            <pc:docMk/>
            <pc:sldMk cId="2051545750" sldId="285"/>
            <ac:spMk id="191" creationId="{D36E1AE0-E26E-009A-4D2E-9F3C84479E28}"/>
          </ac:spMkLst>
        </pc:spChg>
        <pc:spChg chg="add mod">
          <ac:chgData name="iciarfb@student.ubc.ca" userId="f6ce2832-c5ed-410e-8d5b-5828867bd127" providerId="ADAL" clId="{15F3B771-8970-9B47-B771-2875ECA937DA}" dt="2023-07-26T20:08:55.174" v="1016" actId="1076"/>
          <ac:spMkLst>
            <pc:docMk/>
            <pc:sldMk cId="2051545750" sldId="285"/>
            <ac:spMk id="192" creationId="{1B950292-F9F6-C65E-544D-A857ECB45FC8}"/>
          </ac:spMkLst>
        </pc:spChg>
        <pc:spChg chg="add mod">
          <ac:chgData name="iciarfb@student.ubc.ca" userId="f6ce2832-c5ed-410e-8d5b-5828867bd127" providerId="ADAL" clId="{15F3B771-8970-9B47-B771-2875ECA937DA}" dt="2023-07-26T20:08:55.174" v="1016" actId="1076"/>
          <ac:spMkLst>
            <pc:docMk/>
            <pc:sldMk cId="2051545750" sldId="285"/>
            <ac:spMk id="193" creationId="{2CD159B9-B26A-3195-2959-0F165A76C37C}"/>
          </ac:spMkLst>
        </pc:spChg>
        <pc:spChg chg="add mod">
          <ac:chgData name="iciarfb@student.ubc.ca" userId="f6ce2832-c5ed-410e-8d5b-5828867bd127" providerId="ADAL" clId="{15F3B771-8970-9B47-B771-2875ECA937DA}" dt="2023-07-26T20:09:02.901" v="1020" actId="20577"/>
          <ac:spMkLst>
            <pc:docMk/>
            <pc:sldMk cId="2051545750" sldId="285"/>
            <ac:spMk id="194" creationId="{981A4930-B7BD-04A8-4C50-E211E4291667}"/>
          </ac:spMkLst>
        </pc:spChg>
        <pc:spChg chg="add mod">
          <ac:chgData name="iciarfb@student.ubc.ca" userId="f6ce2832-c5ed-410e-8d5b-5828867bd127" providerId="ADAL" clId="{15F3B771-8970-9B47-B771-2875ECA937DA}" dt="2023-07-26T20:09:16.334" v="1026" actId="1076"/>
          <ac:spMkLst>
            <pc:docMk/>
            <pc:sldMk cId="2051545750" sldId="285"/>
            <ac:spMk id="195" creationId="{A64DD6A9-8BB3-3230-44FF-61F7A51DA965}"/>
          </ac:spMkLst>
        </pc:spChg>
        <pc:grpChg chg="add mod">
          <ac:chgData name="iciarfb@student.ubc.ca" userId="f6ce2832-c5ed-410e-8d5b-5828867bd127" providerId="ADAL" clId="{15F3B771-8970-9B47-B771-2875ECA937DA}" dt="2023-07-26T19:34:36.373" v="772" actId="1076"/>
          <ac:grpSpMkLst>
            <pc:docMk/>
            <pc:sldMk cId="2051545750" sldId="285"/>
            <ac:grpSpMk id="24" creationId="{0578AC0A-17E0-477B-CB11-8FB1AB55A553}"/>
          </ac:grpSpMkLst>
        </pc:grpChg>
        <pc:grpChg chg="mod">
          <ac:chgData name="iciarfb@student.ubc.ca" userId="f6ce2832-c5ed-410e-8d5b-5828867bd127" providerId="ADAL" clId="{15F3B771-8970-9B47-B771-2875ECA937DA}" dt="2023-07-26T19:21:13.331" v="159"/>
          <ac:grpSpMkLst>
            <pc:docMk/>
            <pc:sldMk cId="2051545750" sldId="285"/>
            <ac:grpSpMk id="26" creationId="{9D253A3A-4E2D-B188-1798-C45F24F5455A}"/>
          </ac:grpSpMkLst>
        </pc:grpChg>
        <pc:grpChg chg="add del mod">
          <ac:chgData name="iciarfb@student.ubc.ca" userId="f6ce2832-c5ed-410e-8d5b-5828867bd127" providerId="ADAL" clId="{15F3B771-8970-9B47-B771-2875ECA937DA}" dt="2023-07-26T19:22:31.252" v="191" actId="478"/>
          <ac:grpSpMkLst>
            <pc:docMk/>
            <pc:sldMk cId="2051545750" sldId="285"/>
            <ac:grpSpMk id="29" creationId="{938C8BE9-83CF-033D-9C23-1A225E293D2A}"/>
          </ac:grpSpMkLst>
        </pc:grpChg>
        <pc:grpChg chg="mod">
          <ac:chgData name="iciarfb@student.ubc.ca" userId="f6ce2832-c5ed-410e-8d5b-5828867bd127" providerId="ADAL" clId="{15F3B771-8970-9B47-B771-2875ECA937DA}" dt="2023-07-26T19:21:13.331" v="159"/>
          <ac:grpSpMkLst>
            <pc:docMk/>
            <pc:sldMk cId="2051545750" sldId="285"/>
            <ac:grpSpMk id="31" creationId="{4D1B8594-ACA4-B5C5-B84B-356C4EC56359}"/>
          </ac:grpSpMkLst>
        </pc:grpChg>
        <pc:grpChg chg="add del mod">
          <ac:chgData name="iciarfb@student.ubc.ca" userId="f6ce2832-c5ed-410e-8d5b-5828867bd127" providerId="ADAL" clId="{15F3B771-8970-9B47-B771-2875ECA937DA}" dt="2023-07-26T19:22:33.639" v="193" actId="478"/>
          <ac:grpSpMkLst>
            <pc:docMk/>
            <pc:sldMk cId="2051545750" sldId="285"/>
            <ac:grpSpMk id="34" creationId="{F5FC7BAC-2723-596B-5BCF-83F81F243AF3}"/>
          </ac:grpSpMkLst>
        </pc:grpChg>
        <pc:grpChg chg="mod">
          <ac:chgData name="iciarfb@student.ubc.ca" userId="f6ce2832-c5ed-410e-8d5b-5828867bd127" providerId="ADAL" clId="{15F3B771-8970-9B47-B771-2875ECA937DA}" dt="2023-07-26T19:21:13.331" v="159"/>
          <ac:grpSpMkLst>
            <pc:docMk/>
            <pc:sldMk cId="2051545750" sldId="285"/>
            <ac:grpSpMk id="36" creationId="{E61A43AF-03C4-6870-3DC5-9884DCCD192D}"/>
          </ac:grpSpMkLst>
        </pc:grpChg>
        <pc:grpChg chg="add del mod">
          <ac:chgData name="iciarfb@student.ubc.ca" userId="f6ce2832-c5ed-410e-8d5b-5828867bd127" providerId="ADAL" clId="{15F3B771-8970-9B47-B771-2875ECA937DA}" dt="2023-07-26T19:22:38.302" v="194" actId="478"/>
          <ac:grpSpMkLst>
            <pc:docMk/>
            <pc:sldMk cId="2051545750" sldId="285"/>
            <ac:grpSpMk id="39" creationId="{A2AA755E-2505-49A6-FB35-F169A7E04F6C}"/>
          </ac:grpSpMkLst>
        </pc:grpChg>
        <pc:grpChg chg="mod">
          <ac:chgData name="iciarfb@student.ubc.ca" userId="f6ce2832-c5ed-410e-8d5b-5828867bd127" providerId="ADAL" clId="{15F3B771-8970-9B47-B771-2875ECA937DA}" dt="2023-07-26T19:21:13.331" v="159"/>
          <ac:grpSpMkLst>
            <pc:docMk/>
            <pc:sldMk cId="2051545750" sldId="285"/>
            <ac:grpSpMk id="41" creationId="{111A65C6-FA86-D208-575B-A3E696971B79}"/>
          </ac:grpSpMkLst>
        </pc:grpChg>
        <pc:grpChg chg="add del mod">
          <ac:chgData name="iciarfb@student.ubc.ca" userId="f6ce2832-c5ed-410e-8d5b-5828867bd127" providerId="ADAL" clId="{15F3B771-8970-9B47-B771-2875ECA937DA}" dt="2023-07-26T19:22:39.232" v="195" actId="478"/>
          <ac:grpSpMkLst>
            <pc:docMk/>
            <pc:sldMk cId="2051545750" sldId="285"/>
            <ac:grpSpMk id="44" creationId="{E83DED61-00D9-D124-9BA9-0843667AA59C}"/>
          </ac:grpSpMkLst>
        </pc:grpChg>
        <pc:grpChg chg="mod">
          <ac:chgData name="iciarfb@student.ubc.ca" userId="f6ce2832-c5ed-410e-8d5b-5828867bd127" providerId="ADAL" clId="{15F3B771-8970-9B47-B771-2875ECA937DA}" dt="2023-07-26T19:21:13.331" v="159"/>
          <ac:grpSpMkLst>
            <pc:docMk/>
            <pc:sldMk cId="2051545750" sldId="285"/>
            <ac:grpSpMk id="46" creationId="{20A65CB2-7A4F-9147-72D2-66504466C8AF}"/>
          </ac:grpSpMkLst>
        </pc:grpChg>
        <pc:grpChg chg="add del mod">
          <ac:chgData name="iciarfb@student.ubc.ca" userId="f6ce2832-c5ed-410e-8d5b-5828867bd127" providerId="ADAL" clId="{15F3B771-8970-9B47-B771-2875ECA937DA}" dt="2023-07-26T19:21:33.838" v="162" actId="478"/>
          <ac:grpSpMkLst>
            <pc:docMk/>
            <pc:sldMk cId="2051545750" sldId="285"/>
            <ac:grpSpMk id="49" creationId="{9C11509C-1E6B-37C2-7733-3A87A5F7755D}"/>
          </ac:grpSpMkLst>
        </pc:grpChg>
        <pc:grpChg chg="add del mod">
          <ac:chgData name="iciarfb@student.ubc.ca" userId="f6ce2832-c5ed-410e-8d5b-5828867bd127" providerId="ADAL" clId="{15F3B771-8970-9B47-B771-2875ECA937DA}" dt="2023-07-26T19:21:37.446" v="164" actId="478"/>
          <ac:grpSpMkLst>
            <pc:docMk/>
            <pc:sldMk cId="2051545750" sldId="285"/>
            <ac:grpSpMk id="52" creationId="{F0B1A255-15B9-604B-415C-C3F4D3E868E8}"/>
          </ac:grpSpMkLst>
        </pc:grpChg>
        <pc:grpChg chg="add del mod">
          <ac:chgData name="iciarfb@student.ubc.ca" userId="f6ce2832-c5ed-410e-8d5b-5828867bd127" providerId="ADAL" clId="{15F3B771-8970-9B47-B771-2875ECA937DA}" dt="2023-07-26T19:21:32.027" v="161" actId="478"/>
          <ac:grpSpMkLst>
            <pc:docMk/>
            <pc:sldMk cId="2051545750" sldId="285"/>
            <ac:grpSpMk id="55" creationId="{703F0DD4-A393-2BE9-DAE2-7512D6E4A965}"/>
          </ac:grpSpMkLst>
        </pc:grpChg>
        <pc:grpChg chg="add del mod">
          <ac:chgData name="iciarfb@student.ubc.ca" userId="f6ce2832-c5ed-410e-8d5b-5828867bd127" providerId="ADAL" clId="{15F3B771-8970-9B47-B771-2875ECA937DA}" dt="2023-07-26T19:21:35.722" v="163" actId="478"/>
          <ac:grpSpMkLst>
            <pc:docMk/>
            <pc:sldMk cId="2051545750" sldId="285"/>
            <ac:grpSpMk id="58" creationId="{1BEA4155-C135-C42B-F3B7-74FC96995072}"/>
          </ac:grpSpMkLst>
        </pc:grpChg>
        <pc:grpChg chg="add del mod">
          <ac:chgData name="iciarfb@student.ubc.ca" userId="f6ce2832-c5ed-410e-8d5b-5828867bd127" providerId="ADAL" clId="{15F3B771-8970-9B47-B771-2875ECA937DA}" dt="2023-07-26T19:21:39.156" v="165" actId="478"/>
          <ac:grpSpMkLst>
            <pc:docMk/>
            <pc:sldMk cId="2051545750" sldId="285"/>
            <ac:grpSpMk id="61" creationId="{9E8F2A56-3227-AA11-FC90-147DA3237342}"/>
          </ac:grpSpMkLst>
        </pc:grpChg>
        <pc:grpChg chg="add mod">
          <ac:chgData name="iciarfb@student.ubc.ca" userId="f6ce2832-c5ed-410e-8d5b-5828867bd127" providerId="ADAL" clId="{15F3B771-8970-9B47-B771-2875ECA937DA}" dt="2023-07-26T19:36:46.087" v="802" actId="1076"/>
          <ac:grpSpMkLst>
            <pc:docMk/>
            <pc:sldMk cId="2051545750" sldId="285"/>
            <ac:grpSpMk id="71" creationId="{A9DDB3E6-3009-0769-DE73-A75B9C06265E}"/>
          </ac:grpSpMkLst>
        </pc:grpChg>
        <pc:grpChg chg="mod">
          <ac:chgData name="iciarfb@student.ubc.ca" userId="f6ce2832-c5ed-410e-8d5b-5828867bd127" providerId="ADAL" clId="{15F3B771-8970-9B47-B771-2875ECA937DA}" dt="2023-07-26T19:25:28.965" v="370"/>
          <ac:grpSpMkLst>
            <pc:docMk/>
            <pc:sldMk cId="2051545750" sldId="285"/>
            <ac:grpSpMk id="73" creationId="{6AE1CC2F-C169-2D9E-46F3-41C344353B48}"/>
          </ac:grpSpMkLst>
        </pc:grpChg>
        <pc:grpChg chg="add mod">
          <ac:chgData name="iciarfb@student.ubc.ca" userId="f6ce2832-c5ed-410e-8d5b-5828867bd127" providerId="ADAL" clId="{15F3B771-8970-9B47-B771-2875ECA937DA}" dt="2023-07-26T19:37:04.758" v="805" actId="1076"/>
          <ac:grpSpMkLst>
            <pc:docMk/>
            <pc:sldMk cId="2051545750" sldId="285"/>
            <ac:grpSpMk id="81" creationId="{AEBEA258-FAE4-0206-C0AE-9E9D25CB53BC}"/>
          </ac:grpSpMkLst>
        </pc:grpChg>
        <pc:grpChg chg="mod">
          <ac:chgData name="iciarfb@student.ubc.ca" userId="f6ce2832-c5ed-410e-8d5b-5828867bd127" providerId="ADAL" clId="{15F3B771-8970-9B47-B771-2875ECA937DA}" dt="2023-07-26T19:32:45.816" v="688"/>
          <ac:grpSpMkLst>
            <pc:docMk/>
            <pc:sldMk cId="2051545750" sldId="285"/>
            <ac:grpSpMk id="83" creationId="{6462F5C7-3C9F-B0FA-87F5-D3F5A0C18DA7}"/>
          </ac:grpSpMkLst>
        </pc:grpChg>
        <pc:grpChg chg="add mod">
          <ac:chgData name="iciarfb@student.ubc.ca" userId="f6ce2832-c5ed-410e-8d5b-5828867bd127" providerId="ADAL" clId="{15F3B771-8970-9B47-B771-2875ECA937DA}" dt="2023-07-26T19:37:21.738" v="808" actId="1076"/>
          <ac:grpSpMkLst>
            <pc:docMk/>
            <pc:sldMk cId="2051545750" sldId="285"/>
            <ac:grpSpMk id="88" creationId="{B4725383-46C4-3374-B650-F69CA903B4BF}"/>
          </ac:grpSpMkLst>
        </pc:grpChg>
        <pc:grpChg chg="mod">
          <ac:chgData name="iciarfb@student.ubc.ca" userId="f6ce2832-c5ed-410e-8d5b-5828867bd127" providerId="ADAL" clId="{15F3B771-8970-9B47-B771-2875ECA937DA}" dt="2023-07-26T19:33:25.917" v="741"/>
          <ac:grpSpMkLst>
            <pc:docMk/>
            <pc:sldMk cId="2051545750" sldId="285"/>
            <ac:grpSpMk id="90" creationId="{9990FDCF-CC3A-0317-D4AD-FD8B096DCD65}"/>
          </ac:grpSpMkLst>
        </pc:grpChg>
        <pc:grpChg chg="add mod">
          <ac:chgData name="iciarfb@student.ubc.ca" userId="f6ce2832-c5ed-410e-8d5b-5828867bd127" providerId="ADAL" clId="{15F3B771-8970-9B47-B771-2875ECA937DA}" dt="2023-07-26T19:37:42.647" v="815" actId="1076"/>
          <ac:grpSpMkLst>
            <pc:docMk/>
            <pc:sldMk cId="2051545750" sldId="285"/>
            <ac:grpSpMk id="98" creationId="{1381E044-B9DE-09C5-342F-A133D8229DF9}"/>
          </ac:grpSpMkLst>
        </pc:grpChg>
        <pc:grpChg chg="mod">
          <ac:chgData name="iciarfb@student.ubc.ca" userId="f6ce2832-c5ed-410e-8d5b-5828867bd127" providerId="ADAL" clId="{15F3B771-8970-9B47-B771-2875ECA937DA}" dt="2023-07-26T19:37:38.417" v="814"/>
          <ac:grpSpMkLst>
            <pc:docMk/>
            <pc:sldMk cId="2051545750" sldId="285"/>
            <ac:grpSpMk id="100" creationId="{7C8162D5-A59F-2808-9DFA-8398FA484165}"/>
          </ac:grpSpMkLst>
        </pc:grpChg>
        <pc:grpChg chg="add del mod">
          <ac:chgData name="iciarfb@student.ubc.ca" userId="f6ce2832-c5ed-410e-8d5b-5828867bd127" providerId="ADAL" clId="{15F3B771-8970-9B47-B771-2875ECA937DA}" dt="2023-07-26T19:41:22.160" v="855"/>
          <ac:grpSpMkLst>
            <pc:docMk/>
            <pc:sldMk cId="2051545750" sldId="285"/>
            <ac:grpSpMk id="111" creationId="{C4022088-6936-312D-8653-2A21FA5118B2}"/>
          </ac:grpSpMkLst>
        </pc:grpChg>
        <pc:grpChg chg="add del mod">
          <ac:chgData name="iciarfb@student.ubc.ca" userId="f6ce2832-c5ed-410e-8d5b-5828867bd127" providerId="ADAL" clId="{15F3B771-8970-9B47-B771-2875ECA937DA}" dt="2023-07-26T19:41:22.160" v="855"/>
          <ac:grpSpMkLst>
            <pc:docMk/>
            <pc:sldMk cId="2051545750" sldId="285"/>
            <ac:grpSpMk id="116" creationId="{C9FDA921-DBF2-4078-F1A7-22D909DCEB5F}"/>
          </ac:grpSpMkLst>
        </pc:grpChg>
        <pc:grpChg chg="add del mod">
          <ac:chgData name="iciarfb@student.ubc.ca" userId="f6ce2832-c5ed-410e-8d5b-5828867bd127" providerId="ADAL" clId="{15F3B771-8970-9B47-B771-2875ECA937DA}" dt="2023-07-26T19:41:22.160" v="855"/>
          <ac:grpSpMkLst>
            <pc:docMk/>
            <pc:sldMk cId="2051545750" sldId="285"/>
            <ac:grpSpMk id="121" creationId="{5EA6C834-42D4-1BE2-046C-FF2B5080B87C}"/>
          </ac:grpSpMkLst>
        </pc:grpChg>
        <pc:grpChg chg="add del mod">
          <ac:chgData name="iciarfb@student.ubc.ca" userId="f6ce2832-c5ed-410e-8d5b-5828867bd127" providerId="ADAL" clId="{15F3B771-8970-9B47-B771-2875ECA937DA}" dt="2023-07-26T19:41:22.160" v="855"/>
          <ac:grpSpMkLst>
            <pc:docMk/>
            <pc:sldMk cId="2051545750" sldId="285"/>
            <ac:grpSpMk id="126" creationId="{8CF05CC9-5D17-C534-C06D-B60D9D304C7C}"/>
          </ac:grpSpMkLst>
        </pc:grpChg>
        <pc:grpChg chg="add del mod">
          <ac:chgData name="iciarfb@student.ubc.ca" userId="f6ce2832-c5ed-410e-8d5b-5828867bd127" providerId="ADAL" clId="{15F3B771-8970-9B47-B771-2875ECA937DA}" dt="2023-07-26T19:41:22.160" v="855"/>
          <ac:grpSpMkLst>
            <pc:docMk/>
            <pc:sldMk cId="2051545750" sldId="285"/>
            <ac:grpSpMk id="131" creationId="{24091D44-008E-0405-070F-61D74E29A472}"/>
          </ac:grpSpMkLst>
        </pc:grpChg>
        <pc:grpChg chg="add del mod">
          <ac:chgData name="iciarfb@student.ubc.ca" userId="f6ce2832-c5ed-410e-8d5b-5828867bd127" providerId="ADAL" clId="{15F3B771-8970-9B47-B771-2875ECA937DA}" dt="2023-07-26T19:44:09.876" v="881" actId="478"/>
          <ac:grpSpMkLst>
            <pc:docMk/>
            <pc:sldMk cId="2051545750" sldId="285"/>
            <ac:grpSpMk id="147" creationId="{685A34B9-418B-4EDF-6A3F-CC7200A4406C}"/>
          </ac:grpSpMkLst>
        </pc:grpChg>
        <pc:grpChg chg="add del mod">
          <ac:chgData name="iciarfb@student.ubc.ca" userId="f6ce2832-c5ed-410e-8d5b-5828867bd127" providerId="ADAL" clId="{15F3B771-8970-9B47-B771-2875ECA937DA}" dt="2023-07-26T19:45:40.833" v="924" actId="478"/>
          <ac:grpSpMkLst>
            <pc:docMk/>
            <pc:sldMk cId="2051545750" sldId="285"/>
            <ac:grpSpMk id="152" creationId="{8ABBF4D2-2CF9-95C6-1F50-0CD60DFDF9B7}"/>
          </ac:grpSpMkLst>
        </pc:grpChg>
        <pc:grpChg chg="add del mod">
          <ac:chgData name="iciarfb@student.ubc.ca" userId="f6ce2832-c5ed-410e-8d5b-5828867bd127" providerId="ADAL" clId="{15F3B771-8970-9B47-B771-2875ECA937DA}" dt="2023-07-26T19:45:34.108" v="920" actId="478"/>
          <ac:grpSpMkLst>
            <pc:docMk/>
            <pc:sldMk cId="2051545750" sldId="285"/>
            <ac:grpSpMk id="157" creationId="{B8EFA557-8CAF-0EBD-CF12-39255B9A3B17}"/>
          </ac:grpSpMkLst>
        </pc:grpChg>
        <pc:grpChg chg="add del mod">
          <ac:chgData name="iciarfb@student.ubc.ca" userId="f6ce2832-c5ed-410e-8d5b-5828867bd127" providerId="ADAL" clId="{15F3B771-8970-9B47-B771-2875ECA937DA}" dt="2023-07-26T19:45:37.458" v="922" actId="478"/>
          <ac:grpSpMkLst>
            <pc:docMk/>
            <pc:sldMk cId="2051545750" sldId="285"/>
            <ac:grpSpMk id="162" creationId="{B6D54EE0-9DD5-399F-3EE6-5227D599B583}"/>
          </ac:grpSpMkLst>
        </pc:grpChg>
        <pc:grpChg chg="add del mod">
          <ac:chgData name="iciarfb@student.ubc.ca" userId="f6ce2832-c5ed-410e-8d5b-5828867bd127" providerId="ADAL" clId="{15F3B771-8970-9B47-B771-2875ECA937DA}" dt="2023-07-26T19:45:38.844" v="923" actId="478"/>
          <ac:grpSpMkLst>
            <pc:docMk/>
            <pc:sldMk cId="2051545750" sldId="285"/>
            <ac:grpSpMk id="167" creationId="{820E651E-B7A7-CB1A-671F-4042C29C1A87}"/>
          </ac:grpSpMkLst>
        </pc:grpChg>
        <pc:picChg chg="del">
          <ac:chgData name="iciarfb@student.ubc.ca" userId="f6ce2832-c5ed-410e-8d5b-5828867bd127" providerId="ADAL" clId="{15F3B771-8970-9B47-B771-2875ECA937DA}" dt="2023-07-26T19:14:21.110" v="2" actId="478"/>
          <ac:picMkLst>
            <pc:docMk/>
            <pc:sldMk cId="2051545750" sldId="285"/>
            <ac:picMk id="3" creationId="{94F69B65-1F2E-4BD1-BBED-74760398BB83}"/>
          </ac:picMkLst>
        </pc:picChg>
        <pc:picChg chg="del">
          <ac:chgData name="iciarfb@student.ubc.ca" userId="f6ce2832-c5ed-410e-8d5b-5828867bd127" providerId="ADAL" clId="{15F3B771-8970-9B47-B771-2875ECA937DA}" dt="2023-07-26T19:14:22.434" v="3" actId="478"/>
          <ac:picMkLst>
            <pc:docMk/>
            <pc:sldMk cId="2051545750" sldId="285"/>
            <ac:picMk id="7" creationId="{C2CE4858-0DCD-44DB-A935-12EBC6829327}"/>
          </ac:picMkLst>
        </pc:picChg>
        <pc:picChg chg="add mod">
          <ac:chgData name="iciarfb@student.ubc.ca" userId="f6ce2832-c5ed-410e-8d5b-5828867bd127" providerId="ADAL" clId="{15F3B771-8970-9B47-B771-2875ECA937DA}" dt="2023-07-26T19:39:02.125" v="850" actId="1076"/>
          <ac:picMkLst>
            <pc:docMk/>
            <pc:sldMk cId="2051545750" sldId="285"/>
            <ac:picMk id="16" creationId="{F03D1F9B-3202-5401-3417-07911044155F}"/>
          </ac:picMkLst>
        </pc:picChg>
        <pc:picChg chg="add mod">
          <ac:chgData name="iciarfb@student.ubc.ca" userId="f6ce2832-c5ed-410e-8d5b-5828867bd127" providerId="ADAL" clId="{15F3B771-8970-9B47-B771-2875ECA937DA}" dt="2023-07-26T19:39:02.125" v="850" actId="1076"/>
          <ac:picMkLst>
            <pc:docMk/>
            <pc:sldMk cId="2051545750" sldId="285"/>
            <ac:picMk id="18" creationId="{2B95BE51-38BA-6B3D-FE26-34A249A60D90}"/>
          </ac:picMkLst>
        </pc:picChg>
        <pc:cxnChg chg="add del mod">
          <ac:chgData name="iciarfb@student.ubc.ca" userId="f6ce2832-c5ed-410e-8d5b-5828867bd127" providerId="ADAL" clId="{15F3B771-8970-9B47-B771-2875ECA937DA}" dt="2023-07-26T19:38:49.060" v="848" actId="478"/>
          <ac:cxnSpMkLst>
            <pc:docMk/>
            <pc:sldMk cId="2051545750" sldId="285"/>
            <ac:cxnSpMk id="20" creationId="{5298C40B-00E8-C9B4-8416-0E03859AAB16}"/>
          </ac:cxnSpMkLst>
        </pc:cxnChg>
        <pc:cxnChg chg="add mod">
          <ac:chgData name="iciarfb@student.ubc.ca" userId="f6ce2832-c5ed-410e-8d5b-5828867bd127" providerId="ADAL" clId="{15F3B771-8970-9B47-B771-2875ECA937DA}" dt="2023-07-26T19:38:19.855" v="847" actId="208"/>
          <ac:cxnSpMkLst>
            <pc:docMk/>
            <pc:sldMk cId="2051545750" sldId="285"/>
            <ac:cxnSpMk id="23" creationId="{BF861192-1350-48A8-B67B-90C372E7579F}"/>
          </ac:cxnSpMkLst>
        </pc:cxnChg>
        <pc:cxnChg chg="mod">
          <ac:chgData name="iciarfb@student.ubc.ca" userId="f6ce2832-c5ed-410e-8d5b-5828867bd127" providerId="ADAL" clId="{15F3B771-8970-9B47-B771-2875ECA937DA}" dt="2023-07-26T19:22:58.453" v="199" actId="14100"/>
          <ac:cxnSpMkLst>
            <pc:docMk/>
            <pc:sldMk cId="2051545750" sldId="285"/>
            <ac:cxnSpMk id="25" creationId="{C012E4E4-5D93-A313-2D21-F4C7F36726CD}"/>
          </ac:cxnSpMkLst>
        </pc:cxnChg>
        <pc:cxnChg chg="mod">
          <ac:chgData name="iciarfb@student.ubc.ca" userId="f6ce2832-c5ed-410e-8d5b-5828867bd127" providerId="ADAL" clId="{15F3B771-8970-9B47-B771-2875ECA937DA}" dt="2023-07-26T19:21:13.331" v="159"/>
          <ac:cxnSpMkLst>
            <pc:docMk/>
            <pc:sldMk cId="2051545750" sldId="285"/>
            <ac:cxnSpMk id="30" creationId="{B95E5D1B-B4B2-0535-A6BD-5994620461B3}"/>
          </ac:cxnSpMkLst>
        </pc:cxnChg>
        <pc:cxnChg chg="mod">
          <ac:chgData name="iciarfb@student.ubc.ca" userId="f6ce2832-c5ed-410e-8d5b-5828867bd127" providerId="ADAL" clId="{15F3B771-8970-9B47-B771-2875ECA937DA}" dt="2023-07-26T19:21:13.331" v="159"/>
          <ac:cxnSpMkLst>
            <pc:docMk/>
            <pc:sldMk cId="2051545750" sldId="285"/>
            <ac:cxnSpMk id="35" creationId="{2551CDDB-88E3-99DC-9513-BE49D2C6B1A5}"/>
          </ac:cxnSpMkLst>
        </pc:cxnChg>
        <pc:cxnChg chg="mod">
          <ac:chgData name="iciarfb@student.ubc.ca" userId="f6ce2832-c5ed-410e-8d5b-5828867bd127" providerId="ADAL" clId="{15F3B771-8970-9B47-B771-2875ECA937DA}" dt="2023-07-26T19:21:13.331" v="159"/>
          <ac:cxnSpMkLst>
            <pc:docMk/>
            <pc:sldMk cId="2051545750" sldId="285"/>
            <ac:cxnSpMk id="40" creationId="{E6BF3B52-0394-43E1-8DCA-CD5D085BF896}"/>
          </ac:cxnSpMkLst>
        </pc:cxnChg>
        <pc:cxnChg chg="mod">
          <ac:chgData name="iciarfb@student.ubc.ca" userId="f6ce2832-c5ed-410e-8d5b-5828867bd127" providerId="ADAL" clId="{15F3B771-8970-9B47-B771-2875ECA937DA}" dt="2023-07-26T19:21:13.331" v="159"/>
          <ac:cxnSpMkLst>
            <pc:docMk/>
            <pc:sldMk cId="2051545750" sldId="285"/>
            <ac:cxnSpMk id="45" creationId="{B2AA6696-51DA-7F75-6A33-DD25E465C05B}"/>
          </ac:cxnSpMkLst>
        </pc:cxnChg>
        <pc:cxnChg chg="mod">
          <ac:chgData name="iciarfb@student.ubc.ca" userId="f6ce2832-c5ed-410e-8d5b-5828867bd127" providerId="ADAL" clId="{15F3B771-8970-9B47-B771-2875ECA937DA}" dt="2023-07-26T19:25:28.965" v="370"/>
          <ac:cxnSpMkLst>
            <pc:docMk/>
            <pc:sldMk cId="2051545750" sldId="285"/>
            <ac:cxnSpMk id="72" creationId="{6D3D01E4-3D28-A098-B8EB-819457B536CD}"/>
          </ac:cxnSpMkLst>
        </pc:cxnChg>
        <pc:cxnChg chg="add del mod">
          <ac:chgData name="iciarfb@student.ubc.ca" userId="f6ce2832-c5ed-410e-8d5b-5828867bd127" providerId="ADAL" clId="{15F3B771-8970-9B47-B771-2875ECA937DA}" dt="2023-07-26T19:34:41.725" v="773" actId="478"/>
          <ac:cxnSpMkLst>
            <pc:docMk/>
            <pc:sldMk cId="2051545750" sldId="285"/>
            <ac:cxnSpMk id="80" creationId="{E0125BA0-C37B-C028-BF84-8B3F5DA2B51B}"/>
          </ac:cxnSpMkLst>
        </pc:cxnChg>
        <pc:cxnChg chg="mod">
          <ac:chgData name="iciarfb@student.ubc.ca" userId="f6ce2832-c5ed-410e-8d5b-5828867bd127" providerId="ADAL" clId="{15F3B771-8970-9B47-B771-2875ECA937DA}" dt="2023-07-26T19:32:45.816" v="688"/>
          <ac:cxnSpMkLst>
            <pc:docMk/>
            <pc:sldMk cId="2051545750" sldId="285"/>
            <ac:cxnSpMk id="82" creationId="{60326890-85F4-C4DE-3CBD-1B1FFECDA1AC}"/>
          </ac:cxnSpMkLst>
        </pc:cxnChg>
        <pc:cxnChg chg="mod">
          <ac:chgData name="iciarfb@student.ubc.ca" userId="f6ce2832-c5ed-410e-8d5b-5828867bd127" providerId="ADAL" clId="{15F3B771-8970-9B47-B771-2875ECA937DA}" dt="2023-07-26T19:33:25.917" v="741"/>
          <ac:cxnSpMkLst>
            <pc:docMk/>
            <pc:sldMk cId="2051545750" sldId="285"/>
            <ac:cxnSpMk id="89" creationId="{B680A7F9-4C71-C907-DD48-246394289949}"/>
          </ac:cxnSpMkLst>
        </pc:cxnChg>
        <pc:cxnChg chg="mod">
          <ac:chgData name="iciarfb@student.ubc.ca" userId="f6ce2832-c5ed-410e-8d5b-5828867bd127" providerId="ADAL" clId="{15F3B771-8970-9B47-B771-2875ECA937DA}" dt="2023-07-26T19:37:38.417" v="814"/>
          <ac:cxnSpMkLst>
            <pc:docMk/>
            <pc:sldMk cId="2051545750" sldId="285"/>
            <ac:cxnSpMk id="99" creationId="{43A1A59B-F063-A984-A9FF-2DA3EF19E41F}"/>
          </ac:cxnSpMkLst>
        </pc:cxnChg>
        <pc:cxnChg chg="add del mod">
          <ac:chgData name="iciarfb@student.ubc.ca" userId="f6ce2832-c5ed-410e-8d5b-5828867bd127" providerId="ADAL" clId="{15F3B771-8970-9B47-B771-2875ECA937DA}" dt="2023-07-26T19:41:22.160" v="855"/>
          <ac:cxnSpMkLst>
            <pc:docMk/>
            <pc:sldMk cId="2051545750" sldId="285"/>
            <ac:cxnSpMk id="141" creationId="{97BA58D0-5391-807A-1B11-47E1B77492EB}"/>
          </ac:cxnSpMkLst>
        </pc:cxnChg>
        <pc:cxnChg chg="add del mod">
          <ac:chgData name="iciarfb@student.ubc.ca" userId="f6ce2832-c5ed-410e-8d5b-5828867bd127" providerId="ADAL" clId="{15F3B771-8970-9B47-B771-2875ECA937DA}" dt="2023-07-26T19:41:22.160" v="855"/>
          <ac:cxnSpMkLst>
            <pc:docMk/>
            <pc:sldMk cId="2051545750" sldId="285"/>
            <ac:cxnSpMk id="142" creationId="{4A34BE48-0C90-78D3-6899-2BAF29BB18A0}"/>
          </ac:cxnSpMkLst>
        </pc:cxnChg>
        <pc:cxnChg chg="add mod">
          <ac:chgData name="iciarfb@student.ubc.ca" userId="f6ce2832-c5ed-410e-8d5b-5828867bd127" providerId="ADAL" clId="{15F3B771-8970-9B47-B771-2875ECA937DA}" dt="2023-07-26T19:41:27.148" v="857" actId="1076"/>
          <ac:cxnSpMkLst>
            <pc:docMk/>
            <pc:sldMk cId="2051545750" sldId="285"/>
            <ac:cxnSpMk id="177" creationId="{30E6B7AE-ED99-0288-5644-CF8159F3A3CB}"/>
          </ac:cxnSpMkLst>
        </pc:cxnChg>
        <pc:cxnChg chg="add mod">
          <ac:chgData name="iciarfb@student.ubc.ca" userId="f6ce2832-c5ed-410e-8d5b-5828867bd127" providerId="ADAL" clId="{15F3B771-8970-9B47-B771-2875ECA937DA}" dt="2023-07-26T19:41:27.148" v="857" actId="1076"/>
          <ac:cxnSpMkLst>
            <pc:docMk/>
            <pc:sldMk cId="2051545750" sldId="285"/>
            <ac:cxnSpMk id="178" creationId="{22303952-4B38-3971-6048-D52B84482FC2}"/>
          </ac:cxnSpMkLst>
        </pc:cxnChg>
      </pc:sldChg>
      <pc:sldChg chg="addSp delSp modSp add mod modNotesTx">
        <pc:chgData name="iciarfb@student.ubc.ca" userId="f6ce2832-c5ed-410e-8d5b-5828867bd127" providerId="ADAL" clId="{15F3B771-8970-9B47-B771-2875ECA937DA}" dt="2023-07-26T21:22:39.977" v="2879" actId="1076"/>
        <pc:sldMkLst>
          <pc:docMk/>
          <pc:sldMk cId="1737476794" sldId="286"/>
        </pc:sldMkLst>
        <pc:spChg chg="del">
          <ac:chgData name="iciarfb@student.ubc.ca" userId="f6ce2832-c5ed-410e-8d5b-5828867bd127" providerId="ADAL" clId="{15F3B771-8970-9B47-B771-2875ECA937DA}" dt="2023-07-26T20:33:49.532" v="1577" actId="478"/>
          <ac:spMkLst>
            <pc:docMk/>
            <pc:sldMk cId="1737476794" sldId="286"/>
            <ac:spMk id="2" creationId="{E5EF32E4-345C-5FD2-A5A0-30A769882D49}"/>
          </ac:spMkLst>
        </pc:spChg>
        <pc:spChg chg="del">
          <ac:chgData name="iciarfb@student.ubc.ca" userId="f6ce2832-c5ed-410e-8d5b-5828867bd127" providerId="ADAL" clId="{15F3B771-8970-9B47-B771-2875ECA937DA}" dt="2023-07-26T20:10:26.468" v="1033" actId="478"/>
          <ac:spMkLst>
            <pc:docMk/>
            <pc:sldMk cId="1737476794" sldId="286"/>
            <ac:spMk id="4" creationId="{174EA6FF-BF67-B860-FA34-E043EC319BB4}"/>
          </ac:spMkLst>
        </pc:spChg>
        <pc:spChg chg="del">
          <ac:chgData name="iciarfb@student.ubc.ca" userId="f6ce2832-c5ed-410e-8d5b-5828867bd127" providerId="ADAL" clId="{15F3B771-8970-9B47-B771-2875ECA937DA}" dt="2023-07-26T20:10:26.468" v="1033" actId="478"/>
          <ac:spMkLst>
            <pc:docMk/>
            <pc:sldMk cId="1737476794" sldId="286"/>
            <ac:spMk id="5" creationId="{374E29C6-C8F3-BD5C-E873-54CE3D5A196F}"/>
          </ac:spMkLst>
        </pc:spChg>
        <pc:spChg chg="del">
          <ac:chgData name="iciarfb@student.ubc.ca" userId="f6ce2832-c5ed-410e-8d5b-5828867bd127" providerId="ADAL" clId="{15F3B771-8970-9B47-B771-2875ECA937DA}" dt="2023-07-26T20:10:26.468" v="1033" actId="478"/>
          <ac:spMkLst>
            <pc:docMk/>
            <pc:sldMk cId="1737476794" sldId="286"/>
            <ac:spMk id="6" creationId="{ECEC8F6B-752D-B7CF-DB2F-CA3046B9A6D2}"/>
          </ac:spMkLst>
        </pc:spChg>
        <pc:spChg chg="del">
          <ac:chgData name="iciarfb@student.ubc.ca" userId="f6ce2832-c5ed-410e-8d5b-5828867bd127" providerId="ADAL" clId="{15F3B771-8970-9B47-B771-2875ECA937DA}" dt="2023-07-26T20:10:26.468" v="1033" actId="478"/>
          <ac:spMkLst>
            <pc:docMk/>
            <pc:sldMk cId="1737476794" sldId="286"/>
            <ac:spMk id="8" creationId="{1927AA64-BAD0-6DAF-D3C3-4ECEB4F26831}"/>
          </ac:spMkLst>
        </pc:spChg>
        <pc:spChg chg="del">
          <ac:chgData name="iciarfb@student.ubc.ca" userId="f6ce2832-c5ed-410e-8d5b-5828867bd127" providerId="ADAL" clId="{15F3B771-8970-9B47-B771-2875ECA937DA}" dt="2023-07-26T20:10:44.082" v="1041" actId="478"/>
          <ac:spMkLst>
            <pc:docMk/>
            <pc:sldMk cId="1737476794" sldId="286"/>
            <ac:spMk id="10" creationId="{42824886-5BF9-4057-81A4-4B48DAAC4BC1}"/>
          </ac:spMkLst>
        </pc:spChg>
        <pc:spChg chg="del">
          <ac:chgData name="iciarfb@student.ubc.ca" userId="f6ce2832-c5ed-410e-8d5b-5828867bd127" providerId="ADAL" clId="{15F3B771-8970-9B47-B771-2875ECA937DA}" dt="2023-07-26T20:10:26.468" v="1033" actId="478"/>
          <ac:spMkLst>
            <pc:docMk/>
            <pc:sldMk cId="1737476794" sldId="286"/>
            <ac:spMk id="11" creationId="{3A98F658-3852-5502-BA92-0D8D5D123ADC}"/>
          </ac:spMkLst>
        </pc:spChg>
        <pc:spChg chg="del">
          <ac:chgData name="iciarfb@student.ubc.ca" userId="f6ce2832-c5ed-410e-8d5b-5828867bd127" providerId="ADAL" clId="{15F3B771-8970-9B47-B771-2875ECA937DA}" dt="2023-07-26T20:10:26.468" v="1033" actId="478"/>
          <ac:spMkLst>
            <pc:docMk/>
            <pc:sldMk cId="1737476794" sldId="286"/>
            <ac:spMk id="12" creationId="{887CC30F-1FEC-F0C8-B429-73BD9B87B39B}"/>
          </ac:spMkLst>
        </pc:spChg>
        <pc:spChg chg="del">
          <ac:chgData name="iciarfb@student.ubc.ca" userId="f6ce2832-c5ed-410e-8d5b-5828867bd127" providerId="ADAL" clId="{15F3B771-8970-9B47-B771-2875ECA937DA}" dt="2023-07-26T20:10:26.468" v="1033" actId="478"/>
          <ac:spMkLst>
            <pc:docMk/>
            <pc:sldMk cId="1737476794" sldId="286"/>
            <ac:spMk id="13" creationId="{526D7270-34ED-4B54-764A-CC283A44090B}"/>
          </ac:spMkLst>
        </pc:spChg>
        <pc:spChg chg="del">
          <ac:chgData name="iciarfb@student.ubc.ca" userId="f6ce2832-c5ed-410e-8d5b-5828867bd127" providerId="ADAL" clId="{15F3B771-8970-9B47-B771-2875ECA937DA}" dt="2023-07-26T20:10:26.468" v="1033" actId="478"/>
          <ac:spMkLst>
            <pc:docMk/>
            <pc:sldMk cId="1737476794" sldId="286"/>
            <ac:spMk id="14" creationId="{C80A265C-2E62-8FE6-3B15-A09ECDAB8A9C}"/>
          </ac:spMkLst>
        </pc:spChg>
        <pc:spChg chg="add mod">
          <ac:chgData name="iciarfb@student.ubc.ca" userId="f6ce2832-c5ed-410e-8d5b-5828867bd127" providerId="ADAL" clId="{15F3B771-8970-9B47-B771-2875ECA937DA}" dt="2023-07-26T21:06:07.739" v="1917" actId="1076"/>
          <ac:spMkLst>
            <pc:docMk/>
            <pc:sldMk cId="1737476794" sldId="286"/>
            <ac:spMk id="17" creationId="{D234ED19-DDF2-6A31-DC83-F1DEEE792FC5}"/>
          </ac:spMkLst>
        </pc:spChg>
        <pc:spChg chg="add mod">
          <ac:chgData name="iciarfb@student.ubc.ca" userId="f6ce2832-c5ed-410e-8d5b-5828867bd127" providerId="ADAL" clId="{15F3B771-8970-9B47-B771-2875ECA937DA}" dt="2023-07-26T21:06:07.739" v="1917" actId="1076"/>
          <ac:spMkLst>
            <pc:docMk/>
            <pc:sldMk cId="1737476794" sldId="286"/>
            <ac:spMk id="19" creationId="{0EE65EB1-FF07-2B40-72B1-05FA47DCC941}"/>
          </ac:spMkLst>
        </pc:spChg>
        <pc:spChg chg="add mod">
          <ac:chgData name="iciarfb@student.ubc.ca" userId="f6ce2832-c5ed-410e-8d5b-5828867bd127" providerId="ADAL" clId="{15F3B771-8970-9B47-B771-2875ECA937DA}" dt="2023-07-26T21:06:07.739" v="1917" actId="1076"/>
          <ac:spMkLst>
            <pc:docMk/>
            <pc:sldMk cId="1737476794" sldId="286"/>
            <ac:spMk id="20" creationId="{758909E3-8FC0-E7C5-C318-EE555542D616}"/>
          </ac:spMkLst>
        </pc:spChg>
        <pc:spChg chg="add mod">
          <ac:chgData name="iciarfb@student.ubc.ca" userId="f6ce2832-c5ed-410e-8d5b-5828867bd127" providerId="ADAL" clId="{15F3B771-8970-9B47-B771-2875ECA937DA}" dt="2023-07-26T21:06:22.775" v="1923" actId="1035"/>
          <ac:spMkLst>
            <pc:docMk/>
            <pc:sldMk cId="1737476794" sldId="286"/>
            <ac:spMk id="21" creationId="{B6B119C4-C544-20A2-3E5E-BA8450A2EBA5}"/>
          </ac:spMkLst>
        </pc:spChg>
        <pc:spChg chg="add mod">
          <ac:chgData name="iciarfb@student.ubc.ca" userId="f6ce2832-c5ed-410e-8d5b-5828867bd127" providerId="ADAL" clId="{15F3B771-8970-9B47-B771-2875ECA937DA}" dt="2023-07-26T21:06:07.739" v="1917" actId="1076"/>
          <ac:spMkLst>
            <pc:docMk/>
            <pc:sldMk cId="1737476794" sldId="286"/>
            <ac:spMk id="22" creationId="{92D76D3D-D1D1-4837-AD42-2E1DC49F3366}"/>
          </ac:spMkLst>
        </pc:spChg>
        <pc:spChg chg="add mod">
          <ac:chgData name="iciarfb@student.ubc.ca" userId="f6ce2832-c5ed-410e-8d5b-5828867bd127" providerId="ADAL" clId="{15F3B771-8970-9B47-B771-2875ECA937DA}" dt="2023-07-26T21:06:07.739" v="1917" actId="1076"/>
          <ac:spMkLst>
            <pc:docMk/>
            <pc:sldMk cId="1737476794" sldId="286"/>
            <ac:spMk id="29" creationId="{CD47768E-A5A5-CEB1-5484-79D78D50735C}"/>
          </ac:spMkLst>
        </pc:spChg>
        <pc:spChg chg="add mod">
          <ac:chgData name="iciarfb@student.ubc.ca" userId="f6ce2832-c5ed-410e-8d5b-5828867bd127" providerId="ADAL" clId="{15F3B771-8970-9B47-B771-2875ECA937DA}" dt="2023-07-26T21:06:07.739" v="1917" actId="1076"/>
          <ac:spMkLst>
            <pc:docMk/>
            <pc:sldMk cId="1737476794" sldId="286"/>
            <ac:spMk id="30" creationId="{F4891494-C164-EA70-51C2-BEEB4D0EC0AE}"/>
          </ac:spMkLst>
        </pc:spChg>
        <pc:spChg chg="add mod">
          <ac:chgData name="iciarfb@student.ubc.ca" userId="f6ce2832-c5ed-410e-8d5b-5828867bd127" providerId="ADAL" clId="{15F3B771-8970-9B47-B771-2875ECA937DA}" dt="2023-07-26T21:06:07.739" v="1917" actId="1076"/>
          <ac:spMkLst>
            <pc:docMk/>
            <pc:sldMk cId="1737476794" sldId="286"/>
            <ac:spMk id="31" creationId="{FCB7EE02-61A4-2A2F-A6A5-15B24E73097C}"/>
          </ac:spMkLst>
        </pc:spChg>
        <pc:spChg chg="add mod">
          <ac:chgData name="iciarfb@student.ubc.ca" userId="f6ce2832-c5ed-410e-8d5b-5828867bd127" providerId="ADAL" clId="{15F3B771-8970-9B47-B771-2875ECA937DA}" dt="2023-07-26T21:06:07.739" v="1917" actId="1076"/>
          <ac:spMkLst>
            <pc:docMk/>
            <pc:sldMk cId="1737476794" sldId="286"/>
            <ac:spMk id="32" creationId="{FF2989DD-4979-1570-B3D5-9B4E8BCD9E26}"/>
          </ac:spMkLst>
        </pc:spChg>
        <pc:spChg chg="add mod">
          <ac:chgData name="iciarfb@student.ubc.ca" userId="f6ce2832-c5ed-410e-8d5b-5828867bd127" providerId="ADAL" clId="{15F3B771-8970-9B47-B771-2875ECA937DA}" dt="2023-07-26T21:06:14.721" v="1921" actId="1076"/>
          <ac:spMkLst>
            <pc:docMk/>
            <pc:sldMk cId="1737476794" sldId="286"/>
            <ac:spMk id="33" creationId="{CC725582-D771-DF9A-A63A-AD6B159BD480}"/>
          </ac:spMkLst>
        </pc:spChg>
        <pc:spChg chg="add mod">
          <ac:chgData name="iciarfb@student.ubc.ca" userId="f6ce2832-c5ed-410e-8d5b-5828867bd127" providerId="ADAL" clId="{15F3B771-8970-9B47-B771-2875ECA937DA}" dt="2023-07-26T21:21:42.119" v="2832" actId="20577"/>
          <ac:spMkLst>
            <pc:docMk/>
            <pc:sldMk cId="1737476794" sldId="286"/>
            <ac:spMk id="34" creationId="{850A5CA8-1E3B-AE8B-7DFC-3054318A0F2C}"/>
          </ac:spMkLst>
        </pc:spChg>
        <pc:spChg chg="add mod">
          <ac:chgData name="iciarfb@student.ubc.ca" userId="f6ce2832-c5ed-410e-8d5b-5828867bd127" providerId="ADAL" clId="{15F3B771-8970-9B47-B771-2875ECA937DA}" dt="2023-07-26T21:16:06.247" v="2545" actId="1036"/>
          <ac:spMkLst>
            <pc:docMk/>
            <pc:sldMk cId="1737476794" sldId="286"/>
            <ac:spMk id="35" creationId="{28AC0B3B-23A7-6FDA-0DA3-AACE422AF682}"/>
          </ac:spMkLst>
        </pc:spChg>
        <pc:spChg chg="add mod">
          <ac:chgData name="iciarfb@student.ubc.ca" userId="f6ce2832-c5ed-410e-8d5b-5828867bd127" providerId="ADAL" clId="{15F3B771-8970-9B47-B771-2875ECA937DA}" dt="2023-07-26T21:16:06.247" v="2545" actId="1036"/>
          <ac:spMkLst>
            <pc:docMk/>
            <pc:sldMk cId="1737476794" sldId="286"/>
            <ac:spMk id="36" creationId="{88FC984E-4B84-1144-B49C-20EA94F5109E}"/>
          </ac:spMkLst>
        </pc:spChg>
        <pc:spChg chg="add mod">
          <ac:chgData name="iciarfb@student.ubc.ca" userId="f6ce2832-c5ed-410e-8d5b-5828867bd127" providerId="ADAL" clId="{15F3B771-8970-9B47-B771-2875ECA937DA}" dt="2023-07-26T21:16:06.247" v="2545" actId="1036"/>
          <ac:spMkLst>
            <pc:docMk/>
            <pc:sldMk cId="1737476794" sldId="286"/>
            <ac:spMk id="37" creationId="{ACB50DCC-684B-F23F-1218-DDE15FD2081E}"/>
          </ac:spMkLst>
        </pc:spChg>
        <pc:spChg chg="add mod">
          <ac:chgData name="iciarfb@student.ubc.ca" userId="f6ce2832-c5ed-410e-8d5b-5828867bd127" providerId="ADAL" clId="{15F3B771-8970-9B47-B771-2875ECA937DA}" dt="2023-07-26T21:16:06.247" v="2545" actId="1036"/>
          <ac:spMkLst>
            <pc:docMk/>
            <pc:sldMk cId="1737476794" sldId="286"/>
            <ac:spMk id="38" creationId="{C410C335-302D-8528-3D56-A9CF5CF08CA8}"/>
          </ac:spMkLst>
        </pc:spChg>
        <pc:spChg chg="add mod">
          <ac:chgData name="iciarfb@student.ubc.ca" userId="f6ce2832-c5ed-410e-8d5b-5828867bd127" providerId="ADAL" clId="{15F3B771-8970-9B47-B771-2875ECA937DA}" dt="2023-07-26T21:16:06.247" v="2545" actId="1036"/>
          <ac:spMkLst>
            <pc:docMk/>
            <pc:sldMk cId="1737476794" sldId="286"/>
            <ac:spMk id="39" creationId="{365B8828-1235-3872-1745-7C83DE9E412E}"/>
          </ac:spMkLst>
        </pc:spChg>
        <pc:spChg chg="add mod">
          <ac:chgData name="iciarfb@student.ubc.ca" userId="f6ce2832-c5ed-410e-8d5b-5828867bd127" providerId="ADAL" clId="{15F3B771-8970-9B47-B771-2875ECA937DA}" dt="2023-07-26T21:16:06.247" v="2545" actId="1036"/>
          <ac:spMkLst>
            <pc:docMk/>
            <pc:sldMk cId="1737476794" sldId="286"/>
            <ac:spMk id="40" creationId="{FF1BC6EB-5D8B-90BA-7FF0-D9CB1BB7F5E9}"/>
          </ac:spMkLst>
        </pc:spChg>
        <pc:spChg chg="add mod">
          <ac:chgData name="iciarfb@student.ubc.ca" userId="f6ce2832-c5ed-410e-8d5b-5828867bd127" providerId="ADAL" clId="{15F3B771-8970-9B47-B771-2875ECA937DA}" dt="2023-07-26T21:16:06.247" v="2545" actId="1036"/>
          <ac:spMkLst>
            <pc:docMk/>
            <pc:sldMk cId="1737476794" sldId="286"/>
            <ac:spMk id="41" creationId="{142773F4-5361-DCD5-FDB8-248F7B47EE99}"/>
          </ac:spMkLst>
        </pc:spChg>
        <pc:spChg chg="add mod">
          <ac:chgData name="iciarfb@student.ubc.ca" userId="f6ce2832-c5ed-410e-8d5b-5828867bd127" providerId="ADAL" clId="{15F3B771-8970-9B47-B771-2875ECA937DA}" dt="2023-07-26T21:16:06.247" v="2545" actId="1036"/>
          <ac:spMkLst>
            <pc:docMk/>
            <pc:sldMk cId="1737476794" sldId="286"/>
            <ac:spMk id="42" creationId="{8B14481D-AA87-888F-5A48-A9BB2ECC0E1C}"/>
          </ac:spMkLst>
        </pc:spChg>
        <pc:spChg chg="add mod">
          <ac:chgData name="iciarfb@student.ubc.ca" userId="f6ce2832-c5ed-410e-8d5b-5828867bd127" providerId="ADAL" clId="{15F3B771-8970-9B47-B771-2875ECA937DA}" dt="2023-07-26T21:16:06.247" v="2545" actId="1036"/>
          <ac:spMkLst>
            <pc:docMk/>
            <pc:sldMk cId="1737476794" sldId="286"/>
            <ac:spMk id="43" creationId="{CCA1DB6D-7590-CCDC-C7D8-F6E99F856BD8}"/>
          </ac:spMkLst>
        </pc:spChg>
        <pc:spChg chg="add mod">
          <ac:chgData name="iciarfb@student.ubc.ca" userId="f6ce2832-c5ed-410e-8d5b-5828867bd127" providerId="ADAL" clId="{15F3B771-8970-9B47-B771-2875ECA937DA}" dt="2023-07-26T21:16:06.247" v="2545" actId="1036"/>
          <ac:spMkLst>
            <pc:docMk/>
            <pc:sldMk cId="1737476794" sldId="286"/>
            <ac:spMk id="44" creationId="{D86A5E25-6FC4-9D2D-95B3-CD1EE60AF41B}"/>
          </ac:spMkLst>
        </pc:spChg>
        <pc:spChg chg="add mod">
          <ac:chgData name="iciarfb@student.ubc.ca" userId="f6ce2832-c5ed-410e-8d5b-5828867bd127" providerId="ADAL" clId="{15F3B771-8970-9B47-B771-2875ECA937DA}" dt="2023-07-26T21:16:06.247" v="2545" actId="1036"/>
          <ac:spMkLst>
            <pc:docMk/>
            <pc:sldMk cId="1737476794" sldId="286"/>
            <ac:spMk id="45" creationId="{17E81C04-E669-0694-346E-E7A747B43636}"/>
          </ac:spMkLst>
        </pc:spChg>
        <pc:spChg chg="add mod">
          <ac:chgData name="iciarfb@student.ubc.ca" userId="f6ce2832-c5ed-410e-8d5b-5828867bd127" providerId="ADAL" clId="{15F3B771-8970-9B47-B771-2875ECA937DA}" dt="2023-07-26T21:16:06.247" v="2545" actId="1036"/>
          <ac:spMkLst>
            <pc:docMk/>
            <pc:sldMk cId="1737476794" sldId="286"/>
            <ac:spMk id="46" creationId="{31F42074-9C62-A5EB-C2D8-03C3EC037686}"/>
          </ac:spMkLst>
        </pc:spChg>
        <pc:spChg chg="add mod">
          <ac:chgData name="iciarfb@student.ubc.ca" userId="f6ce2832-c5ed-410e-8d5b-5828867bd127" providerId="ADAL" clId="{15F3B771-8970-9B47-B771-2875ECA937DA}" dt="2023-07-26T21:16:06.247" v="2545" actId="1036"/>
          <ac:spMkLst>
            <pc:docMk/>
            <pc:sldMk cId="1737476794" sldId="286"/>
            <ac:spMk id="47" creationId="{06F4DCDF-3910-6EF1-27FB-FDE598B45D74}"/>
          </ac:spMkLst>
        </pc:spChg>
        <pc:spChg chg="add mod">
          <ac:chgData name="iciarfb@student.ubc.ca" userId="f6ce2832-c5ed-410e-8d5b-5828867bd127" providerId="ADAL" clId="{15F3B771-8970-9B47-B771-2875ECA937DA}" dt="2023-07-26T21:16:06.247" v="2545" actId="1036"/>
          <ac:spMkLst>
            <pc:docMk/>
            <pc:sldMk cId="1737476794" sldId="286"/>
            <ac:spMk id="48" creationId="{1A497701-7041-7E8E-5318-5B9106C91CA7}"/>
          </ac:spMkLst>
        </pc:spChg>
        <pc:spChg chg="add mod">
          <ac:chgData name="iciarfb@student.ubc.ca" userId="f6ce2832-c5ed-410e-8d5b-5828867bd127" providerId="ADAL" clId="{15F3B771-8970-9B47-B771-2875ECA937DA}" dt="2023-07-26T21:16:06.247" v="2545" actId="1036"/>
          <ac:spMkLst>
            <pc:docMk/>
            <pc:sldMk cId="1737476794" sldId="286"/>
            <ac:spMk id="53" creationId="{0CB7CD61-5AB6-29F9-BFFA-12C96A6F8865}"/>
          </ac:spMkLst>
        </pc:spChg>
        <pc:spChg chg="add mod">
          <ac:chgData name="iciarfb@student.ubc.ca" userId="f6ce2832-c5ed-410e-8d5b-5828867bd127" providerId="ADAL" clId="{15F3B771-8970-9B47-B771-2875ECA937DA}" dt="2023-07-26T21:16:06.247" v="2545" actId="1036"/>
          <ac:spMkLst>
            <pc:docMk/>
            <pc:sldMk cId="1737476794" sldId="286"/>
            <ac:spMk id="54" creationId="{490C95DD-53B1-F2C0-872F-40FC20172954}"/>
          </ac:spMkLst>
        </pc:spChg>
        <pc:spChg chg="add mod">
          <ac:chgData name="iciarfb@student.ubc.ca" userId="f6ce2832-c5ed-410e-8d5b-5828867bd127" providerId="ADAL" clId="{15F3B771-8970-9B47-B771-2875ECA937DA}" dt="2023-07-26T21:16:06.247" v="2545" actId="1036"/>
          <ac:spMkLst>
            <pc:docMk/>
            <pc:sldMk cId="1737476794" sldId="286"/>
            <ac:spMk id="55" creationId="{BD3E952C-7D94-65E5-3D2B-3E3A158E4B00}"/>
          </ac:spMkLst>
        </pc:spChg>
        <pc:spChg chg="add del mod">
          <ac:chgData name="iciarfb@student.ubc.ca" userId="f6ce2832-c5ed-410e-8d5b-5828867bd127" providerId="ADAL" clId="{15F3B771-8970-9B47-B771-2875ECA937DA}" dt="2023-07-26T20:21:52.251" v="1214"/>
          <ac:spMkLst>
            <pc:docMk/>
            <pc:sldMk cId="1737476794" sldId="286"/>
            <ac:spMk id="56" creationId="{246E1167-5B17-DD70-4FA3-2E370E6033FD}"/>
          </ac:spMkLst>
        </pc:spChg>
        <pc:spChg chg="mod">
          <ac:chgData name="iciarfb@student.ubc.ca" userId="f6ce2832-c5ed-410e-8d5b-5828867bd127" providerId="ADAL" clId="{15F3B771-8970-9B47-B771-2875ECA937DA}" dt="2023-07-26T21:22:11.892" v="2867" actId="14100"/>
          <ac:spMkLst>
            <pc:docMk/>
            <pc:sldMk cId="1737476794" sldId="286"/>
            <ac:spMk id="57" creationId="{820FB7C0-329A-2D6E-70A1-64F8AFE307C5}"/>
          </ac:spMkLst>
        </pc:spChg>
        <pc:spChg chg="add mod">
          <ac:chgData name="iciarfb@student.ubc.ca" userId="f6ce2832-c5ed-410e-8d5b-5828867bd127" providerId="ADAL" clId="{15F3B771-8970-9B47-B771-2875ECA937DA}" dt="2023-07-26T21:16:06.247" v="2545" actId="1036"/>
          <ac:spMkLst>
            <pc:docMk/>
            <pc:sldMk cId="1737476794" sldId="286"/>
            <ac:spMk id="58" creationId="{16CC345C-DA7D-84BD-4B47-F94C0FD49895}"/>
          </ac:spMkLst>
        </pc:spChg>
        <pc:spChg chg="add mod">
          <ac:chgData name="iciarfb@student.ubc.ca" userId="f6ce2832-c5ed-410e-8d5b-5828867bd127" providerId="ADAL" clId="{15F3B771-8970-9B47-B771-2875ECA937DA}" dt="2023-07-26T21:16:06.247" v="2545" actId="1036"/>
          <ac:spMkLst>
            <pc:docMk/>
            <pc:sldMk cId="1737476794" sldId="286"/>
            <ac:spMk id="59" creationId="{3471BE8C-8C69-51D7-0158-58C7A5DF5490}"/>
          </ac:spMkLst>
        </pc:spChg>
        <pc:spChg chg="add mod">
          <ac:chgData name="iciarfb@student.ubc.ca" userId="f6ce2832-c5ed-410e-8d5b-5828867bd127" providerId="ADAL" clId="{15F3B771-8970-9B47-B771-2875ECA937DA}" dt="2023-07-26T21:21:32.132" v="2817" actId="20577"/>
          <ac:spMkLst>
            <pc:docMk/>
            <pc:sldMk cId="1737476794" sldId="286"/>
            <ac:spMk id="60" creationId="{0229327D-B7A9-9FAC-3DCB-F463C3F02A21}"/>
          </ac:spMkLst>
        </pc:spChg>
        <pc:spChg chg="add mod">
          <ac:chgData name="iciarfb@student.ubc.ca" userId="f6ce2832-c5ed-410e-8d5b-5828867bd127" providerId="ADAL" clId="{15F3B771-8970-9B47-B771-2875ECA937DA}" dt="2023-07-26T21:21:34.890" v="2822" actId="20577"/>
          <ac:spMkLst>
            <pc:docMk/>
            <pc:sldMk cId="1737476794" sldId="286"/>
            <ac:spMk id="61" creationId="{EE9C037D-961E-EB1F-840A-AEE47A2CEF90}"/>
          </ac:spMkLst>
        </pc:spChg>
        <pc:spChg chg="add mod">
          <ac:chgData name="iciarfb@student.ubc.ca" userId="f6ce2832-c5ed-410e-8d5b-5828867bd127" providerId="ADAL" clId="{15F3B771-8970-9B47-B771-2875ECA937DA}" dt="2023-07-26T21:21:38.376" v="2827" actId="20577"/>
          <ac:spMkLst>
            <pc:docMk/>
            <pc:sldMk cId="1737476794" sldId="286"/>
            <ac:spMk id="62" creationId="{5F345395-16F1-B77F-3A6D-BF4D2D39CCF4}"/>
          </ac:spMkLst>
        </pc:spChg>
        <pc:spChg chg="mod">
          <ac:chgData name="iciarfb@student.ubc.ca" userId="f6ce2832-c5ed-410e-8d5b-5828867bd127" providerId="ADAL" clId="{15F3B771-8970-9B47-B771-2875ECA937DA}" dt="2023-07-26T21:05:02.599" v="1902" actId="1076"/>
          <ac:spMkLst>
            <pc:docMk/>
            <pc:sldMk cId="1737476794" sldId="286"/>
            <ac:spMk id="64" creationId="{4426E213-D202-20F5-0381-F3B8C491BDC2}"/>
          </ac:spMkLst>
        </pc:spChg>
        <pc:spChg chg="add del">
          <ac:chgData name="iciarfb@student.ubc.ca" userId="f6ce2832-c5ed-410e-8d5b-5828867bd127" providerId="ADAL" clId="{15F3B771-8970-9B47-B771-2875ECA937DA}" dt="2023-07-26T21:06:54.847" v="1926" actId="478"/>
          <ac:spMkLst>
            <pc:docMk/>
            <pc:sldMk cId="1737476794" sldId="286"/>
            <ac:spMk id="66" creationId="{808F1296-AB1D-39E5-BE9E-395C77E23E14}"/>
          </ac:spMkLst>
        </pc:spChg>
        <pc:spChg chg="add mod">
          <ac:chgData name="iciarfb@student.ubc.ca" userId="f6ce2832-c5ed-410e-8d5b-5828867bd127" providerId="ADAL" clId="{15F3B771-8970-9B47-B771-2875ECA937DA}" dt="2023-07-26T21:09:11.856" v="1970" actId="1035"/>
          <ac:spMkLst>
            <pc:docMk/>
            <pc:sldMk cId="1737476794" sldId="286"/>
            <ac:spMk id="67" creationId="{A417FDAA-0280-BF6E-4CDB-319E6B600B90}"/>
          </ac:spMkLst>
        </pc:spChg>
        <pc:spChg chg="add del mod">
          <ac:chgData name="iciarfb@student.ubc.ca" userId="f6ce2832-c5ed-410e-8d5b-5828867bd127" providerId="ADAL" clId="{15F3B771-8970-9B47-B771-2875ECA937DA}" dt="2023-07-26T21:11:29.116" v="1988" actId="478"/>
          <ac:spMkLst>
            <pc:docMk/>
            <pc:sldMk cId="1737476794" sldId="286"/>
            <ac:spMk id="70" creationId="{2AC0DFBC-6D04-AB06-7C55-42EF58A4926A}"/>
          </ac:spMkLst>
        </pc:spChg>
        <pc:spChg chg="mod">
          <ac:chgData name="iciarfb@student.ubc.ca" userId="f6ce2832-c5ed-410e-8d5b-5828867bd127" providerId="ADAL" clId="{15F3B771-8970-9B47-B771-2875ECA937DA}" dt="2023-07-26T21:22:21.520" v="2872" actId="14100"/>
          <ac:spMkLst>
            <pc:docMk/>
            <pc:sldMk cId="1737476794" sldId="286"/>
            <ac:spMk id="76" creationId="{7C1322E2-D589-6CEB-8048-09007E57FD94}"/>
          </ac:spMkLst>
        </pc:spChg>
        <pc:spChg chg="mod">
          <ac:chgData name="iciarfb@student.ubc.ca" userId="f6ce2832-c5ed-410e-8d5b-5828867bd127" providerId="ADAL" clId="{15F3B771-8970-9B47-B771-2875ECA937DA}" dt="2023-07-26T21:05:27.669" v="1909" actId="1076"/>
          <ac:spMkLst>
            <pc:docMk/>
            <pc:sldMk cId="1737476794" sldId="286"/>
            <ac:spMk id="77" creationId="{7032C59C-8A37-4517-0AB6-B12922178F1A}"/>
          </ac:spMkLst>
        </pc:spChg>
        <pc:spChg chg="del">
          <ac:chgData name="iciarfb@student.ubc.ca" userId="f6ce2832-c5ed-410e-8d5b-5828867bd127" providerId="ADAL" clId="{15F3B771-8970-9B47-B771-2875ECA937DA}" dt="2023-07-26T20:10:26.468" v="1033" actId="478"/>
          <ac:spMkLst>
            <pc:docMk/>
            <pc:sldMk cId="1737476794" sldId="286"/>
            <ac:spMk id="78" creationId="{6435770D-FD6E-35DE-FE76-ADBEE73F6016}"/>
          </ac:spMkLst>
        </pc:spChg>
        <pc:spChg chg="del">
          <ac:chgData name="iciarfb@student.ubc.ca" userId="f6ce2832-c5ed-410e-8d5b-5828867bd127" providerId="ADAL" clId="{15F3B771-8970-9B47-B771-2875ECA937DA}" dt="2023-07-26T20:10:26.468" v="1033" actId="478"/>
          <ac:spMkLst>
            <pc:docMk/>
            <pc:sldMk cId="1737476794" sldId="286"/>
            <ac:spMk id="79" creationId="{D7A273E8-19AC-80FE-09D3-FE0229A0A8B0}"/>
          </ac:spMkLst>
        </pc:spChg>
        <pc:spChg chg="add mod">
          <ac:chgData name="iciarfb@student.ubc.ca" userId="f6ce2832-c5ed-410e-8d5b-5828867bd127" providerId="ADAL" clId="{15F3B771-8970-9B47-B771-2875ECA937DA}" dt="2023-07-26T21:18:30.762" v="2603" actId="1038"/>
          <ac:spMkLst>
            <pc:docMk/>
            <pc:sldMk cId="1737476794" sldId="286"/>
            <ac:spMk id="80" creationId="{24F8C930-8DF9-A2B1-B8B3-F8CD3F9623C5}"/>
          </ac:spMkLst>
        </pc:spChg>
        <pc:spChg chg="mod">
          <ac:chgData name="iciarfb@student.ubc.ca" userId="f6ce2832-c5ed-410e-8d5b-5828867bd127" providerId="ADAL" clId="{15F3B771-8970-9B47-B771-2875ECA937DA}" dt="2023-07-26T21:21:52.941" v="2854" actId="20577"/>
          <ac:spMkLst>
            <pc:docMk/>
            <pc:sldMk cId="1737476794" sldId="286"/>
            <ac:spMk id="86" creationId="{4718A319-927C-E3DA-53B3-A7E95103B98D}"/>
          </ac:spMkLst>
        </pc:spChg>
        <pc:spChg chg="mod">
          <ac:chgData name="iciarfb@student.ubc.ca" userId="f6ce2832-c5ed-410e-8d5b-5828867bd127" providerId="ADAL" clId="{15F3B771-8970-9B47-B771-2875ECA937DA}" dt="2023-07-26T21:11:04.523" v="1985" actId="1076"/>
          <ac:spMkLst>
            <pc:docMk/>
            <pc:sldMk cId="1737476794" sldId="286"/>
            <ac:spMk id="87" creationId="{A4F98E15-61AF-526D-AB05-15230A091CF9}"/>
          </ac:spMkLst>
        </pc:spChg>
        <pc:spChg chg="mod">
          <ac:chgData name="iciarfb@student.ubc.ca" userId="f6ce2832-c5ed-410e-8d5b-5828867bd127" providerId="ADAL" clId="{15F3B771-8970-9B47-B771-2875ECA937DA}" dt="2023-07-26T21:22:27.819" v="2876" actId="1035"/>
          <ac:spMkLst>
            <pc:docMk/>
            <pc:sldMk cId="1737476794" sldId="286"/>
            <ac:spMk id="93" creationId="{FBEA9902-FECB-AC77-65A8-202D9572B7F7}"/>
          </ac:spMkLst>
        </pc:spChg>
        <pc:spChg chg="mod">
          <ac:chgData name="iciarfb@student.ubc.ca" userId="f6ce2832-c5ed-410e-8d5b-5828867bd127" providerId="ADAL" clId="{15F3B771-8970-9B47-B771-2875ECA937DA}" dt="2023-07-26T21:22:39.977" v="2879" actId="1076"/>
          <ac:spMkLst>
            <pc:docMk/>
            <pc:sldMk cId="1737476794" sldId="286"/>
            <ac:spMk id="94" creationId="{F5CBF33E-0432-CE1F-31AD-02333AC5BA0F}"/>
          </ac:spMkLst>
        </pc:spChg>
        <pc:spChg chg="add mod">
          <ac:chgData name="iciarfb@student.ubc.ca" userId="f6ce2832-c5ed-410e-8d5b-5828867bd127" providerId="ADAL" clId="{15F3B771-8970-9B47-B771-2875ECA937DA}" dt="2023-07-26T21:21:05.826" v="2798" actId="208"/>
          <ac:spMkLst>
            <pc:docMk/>
            <pc:sldMk cId="1737476794" sldId="286"/>
            <ac:spMk id="95" creationId="{5AB51F67-0C87-80AA-6BF2-5A3C0B0AF40A}"/>
          </ac:spMkLst>
        </pc:spChg>
        <pc:spChg chg="add mod">
          <ac:chgData name="iciarfb@student.ubc.ca" userId="f6ce2832-c5ed-410e-8d5b-5828867bd127" providerId="ADAL" clId="{15F3B771-8970-9B47-B771-2875ECA937DA}" dt="2023-07-26T21:21:05.826" v="2798" actId="208"/>
          <ac:spMkLst>
            <pc:docMk/>
            <pc:sldMk cId="1737476794" sldId="286"/>
            <ac:spMk id="96" creationId="{57B90D2B-DE79-9057-9F68-2738FF1FCC43}"/>
          </ac:spMkLst>
        </pc:spChg>
        <pc:spChg chg="add mod">
          <ac:chgData name="iciarfb@student.ubc.ca" userId="f6ce2832-c5ed-410e-8d5b-5828867bd127" providerId="ADAL" clId="{15F3B771-8970-9B47-B771-2875ECA937DA}" dt="2023-07-26T21:21:05.826" v="2798" actId="208"/>
          <ac:spMkLst>
            <pc:docMk/>
            <pc:sldMk cId="1737476794" sldId="286"/>
            <ac:spMk id="97" creationId="{0BE9569E-3B63-C59F-2639-855A1B9122F7}"/>
          </ac:spMkLst>
        </pc:spChg>
        <pc:spChg chg="mod">
          <ac:chgData name="iciarfb@student.ubc.ca" userId="f6ce2832-c5ed-410e-8d5b-5828867bd127" providerId="ADAL" clId="{15F3B771-8970-9B47-B771-2875ECA937DA}" dt="2023-07-26T21:15:50.337" v="2540" actId="1076"/>
          <ac:spMkLst>
            <pc:docMk/>
            <pc:sldMk cId="1737476794" sldId="286"/>
            <ac:spMk id="103" creationId="{450AAB55-CF7C-078E-1CD2-23B9DD2E74A6}"/>
          </ac:spMkLst>
        </pc:spChg>
        <pc:spChg chg="mod">
          <ac:chgData name="iciarfb@student.ubc.ca" userId="f6ce2832-c5ed-410e-8d5b-5828867bd127" providerId="ADAL" clId="{15F3B771-8970-9B47-B771-2875ECA937DA}" dt="2023-07-26T21:15:56.160" v="2541" actId="1076"/>
          <ac:spMkLst>
            <pc:docMk/>
            <pc:sldMk cId="1737476794" sldId="286"/>
            <ac:spMk id="104" creationId="{780298FB-0303-29C1-01EA-42A2CF0335B7}"/>
          </ac:spMkLst>
        </pc:spChg>
        <pc:spChg chg="add mod">
          <ac:chgData name="iciarfb@student.ubc.ca" userId="f6ce2832-c5ed-410e-8d5b-5828867bd127" providerId="ADAL" clId="{15F3B771-8970-9B47-B771-2875ECA937DA}" dt="2023-07-26T21:21:11.719" v="2800" actId="1036"/>
          <ac:spMkLst>
            <pc:docMk/>
            <pc:sldMk cId="1737476794" sldId="286"/>
            <ac:spMk id="105" creationId="{91ADBE1F-0FBA-46A6-B175-3CD9E242D50D}"/>
          </ac:spMkLst>
        </pc:spChg>
        <pc:spChg chg="del">
          <ac:chgData name="iciarfb@student.ubc.ca" userId="f6ce2832-c5ed-410e-8d5b-5828867bd127" providerId="ADAL" clId="{15F3B771-8970-9B47-B771-2875ECA937DA}" dt="2023-07-26T20:10:35.795" v="1038" actId="478"/>
          <ac:spMkLst>
            <pc:docMk/>
            <pc:sldMk cId="1737476794" sldId="286"/>
            <ac:spMk id="144" creationId="{43B519F9-3B6B-F768-67A0-4E7E8A495335}"/>
          </ac:spMkLst>
        </pc:spChg>
        <pc:spChg chg="del">
          <ac:chgData name="iciarfb@student.ubc.ca" userId="f6ce2832-c5ed-410e-8d5b-5828867bd127" providerId="ADAL" clId="{15F3B771-8970-9B47-B771-2875ECA937DA}" dt="2023-07-26T20:10:30.173" v="1035" actId="478"/>
          <ac:spMkLst>
            <pc:docMk/>
            <pc:sldMk cId="1737476794" sldId="286"/>
            <ac:spMk id="145" creationId="{82DAABC1-6D79-118D-F65A-D224C7CD2F27}"/>
          </ac:spMkLst>
        </pc:spChg>
        <pc:spChg chg="del">
          <ac:chgData name="iciarfb@student.ubc.ca" userId="f6ce2832-c5ed-410e-8d5b-5828867bd127" providerId="ADAL" clId="{15F3B771-8970-9B47-B771-2875ECA937DA}" dt="2023-07-26T20:10:30.173" v="1035" actId="478"/>
          <ac:spMkLst>
            <pc:docMk/>
            <pc:sldMk cId="1737476794" sldId="286"/>
            <ac:spMk id="176" creationId="{325FB3B2-8A77-D3CB-131E-8A57007734C1}"/>
          </ac:spMkLst>
        </pc:spChg>
        <pc:spChg chg="del mod">
          <ac:chgData name="iciarfb@student.ubc.ca" userId="f6ce2832-c5ed-410e-8d5b-5828867bd127" providerId="ADAL" clId="{15F3B771-8970-9B47-B771-2875ECA937DA}" dt="2023-07-26T20:10:33.709" v="1037" actId="478"/>
          <ac:spMkLst>
            <pc:docMk/>
            <pc:sldMk cId="1737476794" sldId="286"/>
            <ac:spMk id="179" creationId="{C214F53F-1413-C7FE-10E8-93650997B5CA}"/>
          </ac:spMkLst>
        </pc:spChg>
        <pc:spChg chg="del">
          <ac:chgData name="iciarfb@student.ubc.ca" userId="f6ce2832-c5ed-410e-8d5b-5828867bd127" providerId="ADAL" clId="{15F3B771-8970-9B47-B771-2875ECA937DA}" dt="2023-07-26T20:10:30.173" v="1035" actId="478"/>
          <ac:spMkLst>
            <pc:docMk/>
            <pc:sldMk cId="1737476794" sldId="286"/>
            <ac:spMk id="182" creationId="{D5EECE43-EBF8-B1A1-1639-0BA8B5AF85C9}"/>
          </ac:spMkLst>
        </pc:spChg>
        <pc:spChg chg="del">
          <ac:chgData name="iciarfb@student.ubc.ca" userId="f6ce2832-c5ed-410e-8d5b-5828867bd127" providerId="ADAL" clId="{15F3B771-8970-9B47-B771-2875ECA937DA}" dt="2023-07-26T20:10:30.173" v="1035" actId="478"/>
          <ac:spMkLst>
            <pc:docMk/>
            <pc:sldMk cId="1737476794" sldId="286"/>
            <ac:spMk id="183" creationId="{4DA74BC7-BF85-A356-E581-AA4CA0ADFFEC}"/>
          </ac:spMkLst>
        </pc:spChg>
        <pc:spChg chg="del">
          <ac:chgData name="iciarfb@student.ubc.ca" userId="f6ce2832-c5ed-410e-8d5b-5828867bd127" providerId="ADAL" clId="{15F3B771-8970-9B47-B771-2875ECA937DA}" dt="2023-07-26T20:10:30.173" v="1035" actId="478"/>
          <ac:spMkLst>
            <pc:docMk/>
            <pc:sldMk cId="1737476794" sldId="286"/>
            <ac:spMk id="184" creationId="{2F0C0B7E-32B3-27C2-6C33-064B76A3AB0F}"/>
          </ac:spMkLst>
        </pc:spChg>
        <pc:spChg chg="del">
          <ac:chgData name="iciarfb@student.ubc.ca" userId="f6ce2832-c5ed-410e-8d5b-5828867bd127" providerId="ADAL" clId="{15F3B771-8970-9B47-B771-2875ECA937DA}" dt="2023-07-26T20:10:30.173" v="1035" actId="478"/>
          <ac:spMkLst>
            <pc:docMk/>
            <pc:sldMk cId="1737476794" sldId="286"/>
            <ac:spMk id="185" creationId="{AAADDD5C-CBDF-F857-9C99-2D065A031FEA}"/>
          </ac:spMkLst>
        </pc:spChg>
        <pc:spChg chg="del">
          <ac:chgData name="iciarfb@student.ubc.ca" userId="f6ce2832-c5ed-410e-8d5b-5828867bd127" providerId="ADAL" clId="{15F3B771-8970-9B47-B771-2875ECA937DA}" dt="2023-07-26T20:10:30.173" v="1035" actId="478"/>
          <ac:spMkLst>
            <pc:docMk/>
            <pc:sldMk cId="1737476794" sldId="286"/>
            <ac:spMk id="186" creationId="{E80E703A-3B2D-9317-8440-757BA9D844E7}"/>
          </ac:spMkLst>
        </pc:spChg>
        <pc:spChg chg="del">
          <ac:chgData name="iciarfb@student.ubc.ca" userId="f6ce2832-c5ed-410e-8d5b-5828867bd127" providerId="ADAL" clId="{15F3B771-8970-9B47-B771-2875ECA937DA}" dt="2023-07-26T20:10:30.173" v="1035" actId="478"/>
          <ac:spMkLst>
            <pc:docMk/>
            <pc:sldMk cId="1737476794" sldId="286"/>
            <ac:spMk id="187" creationId="{D26D5C6E-0306-1149-E131-45172D9E3D07}"/>
          </ac:spMkLst>
        </pc:spChg>
        <pc:spChg chg="del">
          <ac:chgData name="iciarfb@student.ubc.ca" userId="f6ce2832-c5ed-410e-8d5b-5828867bd127" providerId="ADAL" clId="{15F3B771-8970-9B47-B771-2875ECA937DA}" dt="2023-07-26T20:10:30.173" v="1035" actId="478"/>
          <ac:spMkLst>
            <pc:docMk/>
            <pc:sldMk cId="1737476794" sldId="286"/>
            <ac:spMk id="188" creationId="{471A6882-4D4D-DB23-884D-9DEBB05AFF1E}"/>
          </ac:spMkLst>
        </pc:spChg>
        <pc:spChg chg="del">
          <ac:chgData name="iciarfb@student.ubc.ca" userId="f6ce2832-c5ed-410e-8d5b-5828867bd127" providerId="ADAL" clId="{15F3B771-8970-9B47-B771-2875ECA937DA}" dt="2023-07-26T20:10:30.173" v="1035" actId="478"/>
          <ac:spMkLst>
            <pc:docMk/>
            <pc:sldMk cId="1737476794" sldId="286"/>
            <ac:spMk id="189" creationId="{73ED305A-AFAD-5135-918D-B6C6CE129ACA}"/>
          </ac:spMkLst>
        </pc:spChg>
        <pc:spChg chg="del">
          <ac:chgData name="iciarfb@student.ubc.ca" userId="f6ce2832-c5ed-410e-8d5b-5828867bd127" providerId="ADAL" clId="{15F3B771-8970-9B47-B771-2875ECA937DA}" dt="2023-07-26T20:10:30.173" v="1035" actId="478"/>
          <ac:spMkLst>
            <pc:docMk/>
            <pc:sldMk cId="1737476794" sldId="286"/>
            <ac:spMk id="190" creationId="{8938AB5D-71C1-2454-6A89-7377607AABD5}"/>
          </ac:spMkLst>
        </pc:spChg>
        <pc:spChg chg="del">
          <ac:chgData name="iciarfb@student.ubc.ca" userId="f6ce2832-c5ed-410e-8d5b-5828867bd127" providerId="ADAL" clId="{15F3B771-8970-9B47-B771-2875ECA937DA}" dt="2023-07-26T20:10:30.173" v="1035" actId="478"/>
          <ac:spMkLst>
            <pc:docMk/>
            <pc:sldMk cId="1737476794" sldId="286"/>
            <ac:spMk id="191" creationId="{D36E1AE0-E26E-009A-4D2E-9F3C84479E28}"/>
          </ac:spMkLst>
        </pc:spChg>
        <pc:spChg chg="del">
          <ac:chgData name="iciarfb@student.ubc.ca" userId="f6ce2832-c5ed-410e-8d5b-5828867bd127" providerId="ADAL" clId="{15F3B771-8970-9B47-B771-2875ECA937DA}" dt="2023-07-26T20:10:35.795" v="1038" actId="478"/>
          <ac:spMkLst>
            <pc:docMk/>
            <pc:sldMk cId="1737476794" sldId="286"/>
            <ac:spMk id="192" creationId="{1B950292-F9F6-C65E-544D-A857ECB45FC8}"/>
          </ac:spMkLst>
        </pc:spChg>
        <pc:spChg chg="del">
          <ac:chgData name="iciarfb@student.ubc.ca" userId="f6ce2832-c5ed-410e-8d5b-5828867bd127" providerId="ADAL" clId="{15F3B771-8970-9B47-B771-2875ECA937DA}" dt="2023-07-26T20:10:30.173" v="1035" actId="478"/>
          <ac:spMkLst>
            <pc:docMk/>
            <pc:sldMk cId="1737476794" sldId="286"/>
            <ac:spMk id="193" creationId="{2CD159B9-B26A-3195-2959-0F165A76C37C}"/>
          </ac:spMkLst>
        </pc:spChg>
        <pc:spChg chg="del">
          <ac:chgData name="iciarfb@student.ubc.ca" userId="f6ce2832-c5ed-410e-8d5b-5828867bd127" providerId="ADAL" clId="{15F3B771-8970-9B47-B771-2875ECA937DA}" dt="2023-07-26T20:10:30.173" v="1035" actId="478"/>
          <ac:spMkLst>
            <pc:docMk/>
            <pc:sldMk cId="1737476794" sldId="286"/>
            <ac:spMk id="194" creationId="{981A4930-B7BD-04A8-4C50-E211E4291667}"/>
          </ac:spMkLst>
        </pc:spChg>
        <pc:spChg chg="del">
          <ac:chgData name="iciarfb@student.ubc.ca" userId="f6ce2832-c5ed-410e-8d5b-5828867bd127" providerId="ADAL" clId="{15F3B771-8970-9B47-B771-2875ECA937DA}" dt="2023-07-26T20:10:30.173" v="1035" actId="478"/>
          <ac:spMkLst>
            <pc:docMk/>
            <pc:sldMk cId="1737476794" sldId="286"/>
            <ac:spMk id="195" creationId="{A64DD6A9-8BB3-3230-44FF-61F7A51DA965}"/>
          </ac:spMkLst>
        </pc:spChg>
        <pc:grpChg chg="mod">
          <ac:chgData name="iciarfb@student.ubc.ca" userId="f6ce2832-c5ed-410e-8d5b-5828867bd127" providerId="ADAL" clId="{15F3B771-8970-9B47-B771-2875ECA937DA}" dt="2023-07-26T21:04:43.670" v="1899" actId="1076"/>
          <ac:grpSpMkLst>
            <pc:docMk/>
            <pc:sldMk cId="1737476794" sldId="286"/>
            <ac:grpSpMk id="24" creationId="{0578AC0A-17E0-477B-CB11-8FB1AB55A553}"/>
          </ac:grpSpMkLst>
        </pc:grpChg>
        <pc:grpChg chg="mod">
          <ac:chgData name="iciarfb@student.ubc.ca" userId="f6ce2832-c5ed-410e-8d5b-5828867bd127" providerId="ADAL" clId="{15F3B771-8970-9B47-B771-2875ECA937DA}" dt="2023-07-26T21:05:23.558" v="1908" actId="1076"/>
          <ac:grpSpMkLst>
            <pc:docMk/>
            <pc:sldMk cId="1737476794" sldId="286"/>
            <ac:grpSpMk id="71" creationId="{A9DDB3E6-3009-0769-DE73-A75B9C06265E}"/>
          </ac:grpSpMkLst>
        </pc:grpChg>
        <pc:grpChg chg="mod">
          <ac:chgData name="iciarfb@student.ubc.ca" userId="f6ce2832-c5ed-410e-8d5b-5828867bd127" providerId="ADAL" clId="{15F3B771-8970-9B47-B771-2875ECA937DA}" dt="2023-07-26T21:10:50.895" v="1983" actId="1076"/>
          <ac:grpSpMkLst>
            <pc:docMk/>
            <pc:sldMk cId="1737476794" sldId="286"/>
            <ac:grpSpMk id="81" creationId="{AEBEA258-FAE4-0206-C0AE-9E9D25CB53BC}"/>
          </ac:grpSpMkLst>
        </pc:grpChg>
        <pc:grpChg chg="mod">
          <ac:chgData name="iciarfb@student.ubc.ca" userId="f6ce2832-c5ed-410e-8d5b-5828867bd127" providerId="ADAL" clId="{15F3B771-8970-9B47-B771-2875ECA937DA}" dt="2023-07-26T21:22:34.468" v="2878" actId="1076"/>
          <ac:grpSpMkLst>
            <pc:docMk/>
            <pc:sldMk cId="1737476794" sldId="286"/>
            <ac:grpSpMk id="88" creationId="{B4725383-46C4-3374-B650-F69CA903B4BF}"/>
          </ac:grpSpMkLst>
        </pc:grpChg>
        <pc:grpChg chg="mod">
          <ac:chgData name="iciarfb@student.ubc.ca" userId="f6ce2832-c5ed-410e-8d5b-5828867bd127" providerId="ADAL" clId="{15F3B771-8970-9B47-B771-2875ECA937DA}" dt="2023-07-26T21:15:46.743" v="2539" actId="1076"/>
          <ac:grpSpMkLst>
            <pc:docMk/>
            <pc:sldMk cId="1737476794" sldId="286"/>
            <ac:grpSpMk id="98" creationId="{1381E044-B9DE-09C5-342F-A133D8229DF9}"/>
          </ac:grpSpMkLst>
        </pc:grpChg>
        <pc:picChg chg="add mod">
          <ac:chgData name="iciarfb@student.ubc.ca" userId="f6ce2832-c5ed-410e-8d5b-5828867bd127" providerId="ADAL" clId="{15F3B771-8970-9B47-B771-2875ECA937DA}" dt="2023-07-26T21:10:39.108" v="1981" actId="1076"/>
          <ac:picMkLst>
            <pc:docMk/>
            <pc:sldMk cId="1737476794" sldId="286"/>
            <ac:picMk id="9" creationId="{6AE00838-B7E2-FA74-743A-2FF22630A232}"/>
          </ac:picMkLst>
        </pc:picChg>
        <pc:picChg chg="add mod">
          <ac:chgData name="iciarfb@student.ubc.ca" userId="f6ce2832-c5ed-410e-8d5b-5828867bd127" providerId="ADAL" clId="{15F3B771-8970-9B47-B771-2875ECA937DA}" dt="2023-07-26T21:10:33.984" v="1979" actId="1076"/>
          <ac:picMkLst>
            <pc:docMk/>
            <pc:sldMk cId="1737476794" sldId="286"/>
            <ac:picMk id="15" creationId="{5766E1BB-4FF5-6E25-0B41-F9F0F37A4B0B}"/>
          </ac:picMkLst>
        </pc:picChg>
        <pc:picChg chg="del">
          <ac:chgData name="iciarfb@student.ubc.ca" userId="f6ce2832-c5ed-410e-8d5b-5828867bd127" providerId="ADAL" clId="{15F3B771-8970-9B47-B771-2875ECA937DA}" dt="2023-07-26T20:10:27.441" v="1034" actId="478"/>
          <ac:picMkLst>
            <pc:docMk/>
            <pc:sldMk cId="1737476794" sldId="286"/>
            <ac:picMk id="16" creationId="{F03D1F9B-3202-5401-3417-07911044155F}"/>
          </ac:picMkLst>
        </pc:picChg>
        <pc:picChg chg="del">
          <ac:chgData name="iciarfb@student.ubc.ca" userId="f6ce2832-c5ed-410e-8d5b-5828867bd127" providerId="ADAL" clId="{15F3B771-8970-9B47-B771-2875ECA937DA}" dt="2023-07-26T20:10:26.468" v="1033" actId="478"/>
          <ac:picMkLst>
            <pc:docMk/>
            <pc:sldMk cId="1737476794" sldId="286"/>
            <ac:picMk id="18" creationId="{2B95BE51-38BA-6B3D-FE26-34A249A60D90}"/>
          </ac:picMkLst>
        </pc:picChg>
        <pc:picChg chg="add del mod">
          <ac:chgData name="iciarfb@student.ubc.ca" userId="f6ce2832-c5ed-410e-8d5b-5828867bd127" providerId="ADAL" clId="{15F3B771-8970-9B47-B771-2875ECA937DA}" dt="2023-07-26T21:11:31.886" v="1989" actId="478"/>
          <ac:picMkLst>
            <pc:docMk/>
            <pc:sldMk cId="1737476794" sldId="286"/>
            <ac:picMk id="69" creationId="{686FF8DB-5303-8BBB-10C5-680DA68796EE}"/>
          </ac:picMkLst>
        </pc:picChg>
        <pc:cxnChg chg="mod">
          <ac:chgData name="iciarfb@student.ubc.ca" userId="f6ce2832-c5ed-410e-8d5b-5828867bd127" providerId="ADAL" clId="{15F3B771-8970-9B47-B771-2875ECA937DA}" dt="2023-07-26T21:04:36.448" v="1898" actId="14100"/>
          <ac:cxnSpMkLst>
            <pc:docMk/>
            <pc:sldMk cId="1737476794" sldId="286"/>
            <ac:cxnSpMk id="23" creationId="{BF861192-1350-48A8-B67B-90C372E7579F}"/>
          </ac:cxnSpMkLst>
        </pc:cxnChg>
        <pc:cxnChg chg="add mod">
          <ac:chgData name="iciarfb@student.ubc.ca" userId="f6ce2832-c5ed-410e-8d5b-5828867bd127" providerId="ADAL" clId="{15F3B771-8970-9B47-B771-2875ECA937DA}" dt="2023-07-26T21:16:06.247" v="2545" actId="1036"/>
          <ac:cxnSpMkLst>
            <pc:docMk/>
            <pc:sldMk cId="1737476794" sldId="286"/>
            <ac:cxnSpMk id="50" creationId="{CBF167F7-5150-7B8F-5C50-5F4E5AE543AC}"/>
          </ac:cxnSpMkLst>
        </pc:cxnChg>
        <pc:cxnChg chg="add mod">
          <ac:chgData name="iciarfb@student.ubc.ca" userId="f6ce2832-c5ed-410e-8d5b-5828867bd127" providerId="ADAL" clId="{15F3B771-8970-9B47-B771-2875ECA937DA}" dt="2023-07-26T21:16:06.247" v="2545" actId="1036"/>
          <ac:cxnSpMkLst>
            <pc:docMk/>
            <pc:sldMk cId="1737476794" sldId="286"/>
            <ac:cxnSpMk id="51" creationId="{D3979507-6ED4-C867-C70E-F8A28E5CDB8B}"/>
          </ac:cxnSpMkLst>
        </pc:cxnChg>
        <pc:cxnChg chg="add mod">
          <ac:chgData name="iciarfb@student.ubc.ca" userId="f6ce2832-c5ed-410e-8d5b-5828867bd127" providerId="ADAL" clId="{15F3B771-8970-9B47-B771-2875ECA937DA}" dt="2023-07-26T21:16:06.247" v="2545" actId="1036"/>
          <ac:cxnSpMkLst>
            <pc:docMk/>
            <pc:sldMk cId="1737476794" sldId="286"/>
            <ac:cxnSpMk id="52" creationId="{81CC966B-8C04-8066-AE9E-10B7817A4036}"/>
          </ac:cxnSpMkLst>
        </pc:cxnChg>
        <pc:cxnChg chg="del mod">
          <ac:chgData name="iciarfb@student.ubc.ca" userId="f6ce2832-c5ed-410e-8d5b-5828867bd127" providerId="ADAL" clId="{15F3B771-8970-9B47-B771-2875ECA937DA}" dt="2023-07-26T20:10:30.173" v="1035" actId="478"/>
          <ac:cxnSpMkLst>
            <pc:docMk/>
            <pc:sldMk cId="1737476794" sldId="286"/>
            <ac:cxnSpMk id="177" creationId="{30E6B7AE-ED99-0288-5644-CF8159F3A3CB}"/>
          </ac:cxnSpMkLst>
        </pc:cxnChg>
        <pc:cxnChg chg="del">
          <ac:chgData name="iciarfb@student.ubc.ca" userId="f6ce2832-c5ed-410e-8d5b-5828867bd127" providerId="ADAL" clId="{15F3B771-8970-9B47-B771-2875ECA937DA}" dt="2023-07-26T20:10:30.173" v="1035" actId="478"/>
          <ac:cxnSpMkLst>
            <pc:docMk/>
            <pc:sldMk cId="1737476794" sldId="286"/>
            <ac:cxnSpMk id="178" creationId="{22303952-4B38-3971-6048-D52B84482FC2}"/>
          </ac:cxnSpMkLst>
        </pc:cxnChg>
      </pc:sldChg>
    </pc:docChg>
  </pc:docChgLst>
  <pc:docChgLst>
    <pc:chgData name="iciarfb@student.ubc.ca" userId="f6ce2832-c5ed-410e-8d5b-5828867bd127" providerId="ADAL" clId="{2DA6FF34-C9A3-304B-B571-F5209FC374A8}"/>
    <pc:docChg chg="modSld">
      <pc:chgData name="iciarfb@student.ubc.ca" userId="f6ce2832-c5ed-410e-8d5b-5828867bd127" providerId="ADAL" clId="{2DA6FF34-C9A3-304B-B571-F5209FC374A8}" dt="2023-05-17T19:36:50.907" v="187" actId="1076"/>
      <pc:docMkLst>
        <pc:docMk/>
      </pc:docMkLst>
      <pc:sldChg chg="addSp modSp mod">
        <pc:chgData name="iciarfb@student.ubc.ca" userId="f6ce2832-c5ed-410e-8d5b-5828867bd127" providerId="ADAL" clId="{2DA6FF34-C9A3-304B-B571-F5209FC374A8}" dt="2023-05-17T19:34:27.728" v="105" actId="1036"/>
        <pc:sldMkLst>
          <pc:docMk/>
          <pc:sldMk cId="1223773097" sldId="259"/>
        </pc:sldMkLst>
        <pc:spChg chg="add mod">
          <ac:chgData name="iciarfb@student.ubc.ca" userId="f6ce2832-c5ed-410e-8d5b-5828867bd127" providerId="ADAL" clId="{2DA6FF34-C9A3-304B-B571-F5209FC374A8}" dt="2023-05-17T19:34:27.728" v="105" actId="1036"/>
          <ac:spMkLst>
            <pc:docMk/>
            <pc:sldMk cId="1223773097" sldId="259"/>
            <ac:spMk id="2" creationId="{E5EF32E4-345C-5FD2-A5A0-30A769882D49}"/>
          </ac:spMkLst>
        </pc:spChg>
        <pc:picChg chg="mod">
          <ac:chgData name="iciarfb@student.ubc.ca" userId="f6ce2832-c5ed-410e-8d5b-5828867bd127" providerId="ADAL" clId="{2DA6FF34-C9A3-304B-B571-F5209FC374A8}" dt="2023-05-17T19:34:27.728" v="105" actId="1036"/>
          <ac:picMkLst>
            <pc:docMk/>
            <pc:sldMk cId="1223773097" sldId="259"/>
            <ac:picMk id="3" creationId="{94F69B65-1F2E-4BD1-BBED-74760398BB83}"/>
          </ac:picMkLst>
        </pc:picChg>
        <pc:picChg chg="mod">
          <ac:chgData name="iciarfb@student.ubc.ca" userId="f6ce2832-c5ed-410e-8d5b-5828867bd127" providerId="ADAL" clId="{2DA6FF34-C9A3-304B-B571-F5209FC374A8}" dt="2023-05-17T19:34:27.728" v="105" actId="1036"/>
          <ac:picMkLst>
            <pc:docMk/>
            <pc:sldMk cId="1223773097" sldId="259"/>
            <ac:picMk id="7" creationId="{C2CE4858-0DCD-44DB-A935-12EBC6829327}"/>
          </ac:picMkLst>
        </pc:picChg>
      </pc:sldChg>
      <pc:sldChg chg="addSp modSp mod">
        <pc:chgData name="iciarfb@student.ubc.ca" userId="f6ce2832-c5ed-410e-8d5b-5828867bd127" providerId="ADAL" clId="{2DA6FF34-C9A3-304B-B571-F5209FC374A8}" dt="2023-05-17T19:35:33.269" v="157" actId="1076"/>
        <pc:sldMkLst>
          <pc:docMk/>
          <pc:sldMk cId="4195761390" sldId="265"/>
        </pc:sldMkLst>
        <pc:spChg chg="add mod">
          <ac:chgData name="iciarfb@student.ubc.ca" userId="f6ce2832-c5ed-410e-8d5b-5828867bd127" providerId="ADAL" clId="{2DA6FF34-C9A3-304B-B571-F5209FC374A8}" dt="2023-05-17T19:35:33.269" v="157" actId="1076"/>
          <ac:spMkLst>
            <pc:docMk/>
            <pc:sldMk cId="4195761390" sldId="265"/>
            <ac:spMk id="2" creationId="{E16C1D69-7CA6-2243-553D-87D89C8FE2C6}"/>
          </ac:spMkLst>
        </pc:spChg>
      </pc:sldChg>
      <pc:sldChg chg="addSp modSp mod">
        <pc:chgData name="iciarfb@student.ubc.ca" userId="f6ce2832-c5ed-410e-8d5b-5828867bd127" providerId="ADAL" clId="{2DA6FF34-C9A3-304B-B571-F5209FC374A8}" dt="2023-05-17T19:35:14.054" v="151" actId="1076"/>
        <pc:sldMkLst>
          <pc:docMk/>
          <pc:sldMk cId="547679064" sldId="270"/>
        </pc:sldMkLst>
        <pc:spChg chg="add mod">
          <ac:chgData name="iciarfb@student.ubc.ca" userId="f6ce2832-c5ed-410e-8d5b-5828867bd127" providerId="ADAL" clId="{2DA6FF34-C9A3-304B-B571-F5209FC374A8}" dt="2023-05-17T19:35:14.054" v="151" actId="1076"/>
          <ac:spMkLst>
            <pc:docMk/>
            <pc:sldMk cId="547679064" sldId="270"/>
            <ac:spMk id="2" creationId="{C307E780-A8AE-A490-E3B9-F6F954823E4C}"/>
          </ac:spMkLst>
        </pc:spChg>
        <pc:spChg chg="mod">
          <ac:chgData name="iciarfb@student.ubc.ca" userId="f6ce2832-c5ed-410e-8d5b-5828867bd127" providerId="ADAL" clId="{2DA6FF34-C9A3-304B-B571-F5209FC374A8}" dt="2023-05-17T19:35:01.793" v="147" actId="1035"/>
          <ac:spMkLst>
            <pc:docMk/>
            <pc:sldMk cId="547679064" sldId="270"/>
            <ac:spMk id="6" creationId="{C8E51C1A-E593-48F2-B2CE-9778D9994EC6}"/>
          </ac:spMkLst>
        </pc:spChg>
        <pc:spChg chg="mod">
          <ac:chgData name="iciarfb@student.ubc.ca" userId="f6ce2832-c5ed-410e-8d5b-5828867bd127" providerId="ADAL" clId="{2DA6FF34-C9A3-304B-B571-F5209FC374A8}" dt="2023-05-17T19:35:01.793" v="147" actId="1035"/>
          <ac:spMkLst>
            <pc:docMk/>
            <pc:sldMk cId="547679064" sldId="270"/>
            <ac:spMk id="7" creationId="{3EDFE71B-E50C-4E20-BC82-8DC6D4BD042F}"/>
          </ac:spMkLst>
        </pc:spChg>
        <pc:picChg chg="mod">
          <ac:chgData name="iciarfb@student.ubc.ca" userId="f6ce2832-c5ed-410e-8d5b-5828867bd127" providerId="ADAL" clId="{2DA6FF34-C9A3-304B-B571-F5209FC374A8}" dt="2023-05-17T19:35:01.793" v="147" actId="1035"/>
          <ac:picMkLst>
            <pc:docMk/>
            <pc:sldMk cId="547679064" sldId="270"/>
            <ac:picMk id="4" creationId="{36D82AA1-14D9-4EA3-AD51-70195EF13A8E}"/>
          </ac:picMkLst>
        </pc:picChg>
        <pc:picChg chg="mod">
          <ac:chgData name="iciarfb@student.ubc.ca" userId="f6ce2832-c5ed-410e-8d5b-5828867bd127" providerId="ADAL" clId="{2DA6FF34-C9A3-304B-B571-F5209FC374A8}" dt="2023-05-17T19:35:01.793" v="147" actId="1035"/>
          <ac:picMkLst>
            <pc:docMk/>
            <pc:sldMk cId="547679064" sldId="270"/>
            <ac:picMk id="9" creationId="{84C53CEF-63BB-4BC4-8432-625515787844}"/>
          </ac:picMkLst>
        </pc:picChg>
      </pc:sldChg>
      <pc:sldChg chg="addSp modSp mod">
        <pc:chgData name="iciarfb@student.ubc.ca" userId="f6ce2832-c5ed-410e-8d5b-5828867bd127" providerId="ADAL" clId="{2DA6FF34-C9A3-304B-B571-F5209FC374A8}" dt="2023-05-17T19:35:54.832" v="166" actId="1076"/>
        <pc:sldMkLst>
          <pc:docMk/>
          <pc:sldMk cId="3508169395" sldId="277"/>
        </pc:sldMkLst>
        <pc:spChg chg="add mod">
          <ac:chgData name="iciarfb@student.ubc.ca" userId="f6ce2832-c5ed-410e-8d5b-5828867bd127" providerId="ADAL" clId="{2DA6FF34-C9A3-304B-B571-F5209FC374A8}" dt="2023-05-17T19:35:54.832" v="166" actId="1076"/>
          <ac:spMkLst>
            <pc:docMk/>
            <pc:sldMk cId="3508169395" sldId="277"/>
            <ac:spMk id="3" creationId="{36BF64BE-A0A6-D5A0-5B21-F043B8E005A4}"/>
          </ac:spMkLst>
        </pc:spChg>
      </pc:sldChg>
      <pc:sldChg chg="addSp modSp mod">
        <pc:chgData name="iciarfb@student.ubc.ca" userId="f6ce2832-c5ed-410e-8d5b-5828867bd127" providerId="ADAL" clId="{2DA6FF34-C9A3-304B-B571-F5209FC374A8}" dt="2023-05-17T19:36:09.677" v="171" actId="20577"/>
        <pc:sldMkLst>
          <pc:docMk/>
          <pc:sldMk cId="2299653574" sldId="279"/>
        </pc:sldMkLst>
        <pc:spChg chg="add mod">
          <ac:chgData name="iciarfb@student.ubc.ca" userId="f6ce2832-c5ed-410e-8d5b-5828867bd127" providerId="ADAL" clId="{2DA6FF34-C9A3-304B-B571-F5209FC374A8}" dt="2023-05-17T19:36:09.677" v="171" actId="20577"/>
          <ac:spMkLst>
            <pc:docMk/>
            <pc:sldMk cId="2299653574" sldId="279"/>
            <ac:spMk id="2" creationId="{6C6F2E60-E45F-7C98-3063-59B7653BF965}"/>
          </ac:spMkLst>
        </pc:spChg>
      </pc:sldChg>
      <pc:sldChg chg="addSp delSp modSp mod">
        <pc:chgData name="iciarfb@student.ubc.ca" userId="f6ce2832-c5ed-410e-8d5b-5828867bd127" providerId="ADAL" clId="{2DA6FF34-C9A3-304B-B571-F5209FC374A8}" dt="2023-05-17T19:34:52.833" v="132" actId="14100"/>
        <pc:sldMkLst>
          <pc:docMk/>
          <pc:sldMk cId="3144242104" sldId="280"/>
        </pc:sldMkLst>
        <pc:spChg chg="add del mod">
          <ac:chgData name="iciarfb@student.ubc.ca" userId="f6ce2832-c5ed-410e-8d5b-5828867bd127" providerId="ADAL" clId="{2DA6FF34-C9A3-304B-B571-F5209FC374A8}" dt="2023-05-17T19:34:08.848" v="59"/>
          <ac:spMkLst>
            <pc:docMk/>
            <pc:sldMk cId="3144242104" sldId="280"/>
            <ac:spMk id="2" creationId="{035CF8BF-7967-8FB7-A9DB-7D72D25F3D83}"/>
          </ac:spMkLst>
        </pc:spChg>
        <pc:spChg chg="add mod">
          <ac:chgData name="iciarfb@student.ubc.ca" userId="f6ce2832-c5ed-410e-8d5b-5828867bd127" providerId="ADAL" clId="{2DA6FF34-C9A3-304B-B571-F5209FC374A8}" dt="2023-05-17T19:34:52.833" v="132" actId="14100"/>
          <ac:spMkLst>
            <pc:docMk/>
            <pc:sldMk cId="3144242104" sldId="280"/>
            <ac:spMk id="4" creationId="{25F12E37-6DBC-9C5B-5033-1204219213E2}"/>
          </ac:spMkLst>
        </pc:spChg>
        <pc:picChg chg="mod">
          <ac:chgData name="iciarfb@student.ubc.ca" userId="f6ce2832-c5ed-410e-8d5b-5828867bd127" providerId="ADAL" clId="{2DA6FF34-C9A3-304B-B571-F5209FC374A8}" dt="2023-05-17T19:34:36.300" v="126" actId="1035"/>
          <ac:picMkLst>
            <pc:docMk/>
            <pc:sldMk cId="3144242104" sldId="280"/>
            <ac:picMk id="3" creationId="{3C551139-B7D7-4AE7-94EB-32712D29FFB0}"/>
          </ac:picMkLst>
        </pc:picChg>
        <pc:picChg chg="mod">
          <ac:chgData name="iciarfb@student.ubc.ca" userId="f6ce2832-c5ed-410e-8d5b-5828867bd127" providerId="ADAL" clId="{2DA6FF34-C9A3-304B-B571-F5209FC374A8}" dt="2023-05-17T19:34:36.300" v="126" actId="1035"/>
          <ac:picMkLst>
            <pc:docMk/>
            <pc:sldMk cId="3144242104" sldId="280"/>
            <ac:picMk id="7" creationId="{A446DD2E-18F2-471F-A797-9D9C550244B7}"/>
          </ac:picMkLst>
        </pc:picChg>
      </pc:sldChg>
      <pc:sldChg chg="addSp modSp mod">
        <pc:chgData name="iciarfb@student.ubc.ca" userId="f6ce2832-c5ed-410e-8d5b-5828867bd127" providerId="ADAL" clId="{2DA6FF34-C9A3-304B-B571-F5209FC374A8}" dt="2023-05-17T19:36:50.907" v="187" actId="1076"/>
        <pc:sldMkLst>
          <pc:docMk/>
          <pc:sldMk cId="2174551628" sldId="283"/>
        </pc:sldMkLst>
        <pc:spChg chg="add mod">
          <ac:chgData name="iciarfb@student.ubc.ca" userId="f6ce2832-c5ed-410e-8d5b-5828867bd127" providerId="ADAL" clId="{2DA6FF34-C9A3-304B-B571-F5209FC374A8}" dt="2023-05-17T19:36:50.907" v="187" actId="1076"/>
          <ac:spMkLst>
            <pc:docMk/>
            <pc:sldMk cId="2174551628" sldId="283"/>
            <ac:spMk id="3" creationId="{E01F77EA-EE28-A6C9-246D-D38C7DE0D230}"/>
          </ac:spMkLst>
        </pc:spChg>
      </pc:sldChg>
      <pc:sldChg chg="addSp modSp mod">
        <pc:chgData name="iciarfb@student.ubc.ca" userId="f6ce2832-c5ed-410e-8d5b-5828867bd127" providerId="ADAL" clId="{2DA6FF34-C9A3-304B-B571-F5209FC374A8}" dt="2023-05-17T19:36:18.563" v="173"/>
        <pc:sldMkLst>
          <pc:docMk/>
          <pc:sldMk cId="885623364" sldId="284"/>
        </pc:sldMkLst>
        <pc:spChg chg="add mod">
          <ac:chgData name="iciarfb@student.ubc.ca" userId="f6ce2832-c5ed-410e-8d5b-5828867bd127" providerId="ADAL" clId="{2DA6FF34-C9A3-304B-B571-F5209FC374A8}" dt="2023-05-17T19:36:18.563" v="173"/>
          <ac:spMkLst>
            <pc:docMk/>
            <pc:sldMk cId="885623364" sldId="284"/>
            <ac:spMk id="2" creationId="{9EB6C5AB-9E23-55F7-1C7A-087D88711514}"/>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CA"/>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B0563AA-57CA-0F42-8D2F-C9D62B885C46}" type="datetimeFigureOut">
              <a:rPr lang="en-CA" smtClean="0"/>
              <a:t>2023-07-26</a:t>
            </a:fld>
            <a:endParaRPr lang="en-CA"/>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CA"/>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CA"/>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EBB11EA-509A-D942-9B35-B98BF616736F}" type="slidenum">
              <a:rPr lang="en-CA" smtClean="0"/>
              <a:t>‹#›</a:t>
            </a:fld>
            <a:endParaRPr lang="en-CA"/>
          </a:p>
        </p:txBody>
      </p:sp>
    </p:spTree>
    <p:extLst>
      <p:ext uri="{BB962C8B-B14F-4D97-AF65-F5344CB8AC3E}">
        <p14:creationId xmlns:p14="http://schemas.microsoft.com/office/powerpoint/2010/main" val="65679730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CA" b="1" dirty="0"/>
              <a:t>Figure S1. Sequential flowchart of the methods followed in this study. </a:t>
            </a:r>
            <a:endParaRPr lang="en-CA" dirty="0"/>
          </a:p>
        </p:txBody>
      </p:sp>
      <p:sp>
        <p:nvSpPr>
          <p:cNvPr id="4" name="Slide Number Placeholder 3"/>
          <p:cNvSpPr>
            <a:spLocks noGrp="1"/>
          </p:cNvSpPr>
          <p:nvPr>
            <p:ph type="sldNum" sz="quarter" idx="5"/>
          </p:nvPr>
        </p:nvSpPr>
        <p:spPr/>
        <p:txBody>
          <a:bodyPr/>
          <a:lstStyle/>
          <a:p>
            <a:fld id="{0ECC49DA-DE5B-4D5E-82E1-9EAB42D53289}" type="slidenum">
              <a:rPr lang="en-CA" smtClean="0"/>
              <a:t>1</a:t>
            </a:fld>
            <a:endParaRPr lang="en-CA"/>
          </a:p>
        </p:txBody>
      </p:sp>
    </p:spTree>
    <p:extLst>
      <p:ext uri="{BB962C8B-B14F-4D97-AF65-F5344CB8AC3E}">
        <p14:creationId xmlns:p14="http://schemas.microsoft.com/office/powerpoint/2010/main" val="259740932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CA" b="1" dirty="0"/>
              <a:t>Figure S2. Relationship between reported and inferred gestational age (GA). </a:t>
            </a:r>
            <a:r>
              <a:rPr lang="en-CA" dirty="0"/>
              <a:t>Gestational age was inferred for all samples using the robust placental clock (Lee et al., 2019) as implemented in the R package planet. a. Association between reported and predicted GA in the training group, specifically in GSE100197 and GSE73375, which are the only 2 datasets out of 4 in the training group for which authors reported GA in weeks. b. Correlation between reported GA and inferred GA of all samples from GSE125605, GSE110829, GSE73375, and GSE75196, which are the only 4 datasets in this study that were not included as part of the training of the robust placental clock.</a:t>
            </a:r>
          </a:p>
        </p:txBody>
      </p:sp>
      <p:sp>
        <p:nvSpPr>
          <p:cNvPr id="4" name="Slide Number Placeholder 3"/>
          <p:cNvSpPr>
            <a:spLocks noGrp="1"/>
          </p:cNvSpPr>
          <p:nvPr>
            <p:ph type="sldNum" sz="quarter" idx="5"/>
          </p:nvPr>
        </p:nvSpPr>
        <p:spPr/>
        <p:txBody>
          <a:bodyPr/>
          <a:lstStyle/>
          <a:p>
            <a:fld id="{0ECC49DA-DE5B-4D5E-82E1-9EAB42D53289}" type="slidenum">
              <a:rPr lang="en-CA" smtClean="0"/>
              <a:t>2</a:t>
            </a:fld>
            <a:endParaRPr lang="en-CA"/>
          </a:p>
        </p:txBody>
      </p:sp>
    </p:spTree>
    <p:extLst>
      <p:ext uri="{BB962C8B-B14F-4D97-AF65-F5344CB8AC3E}">
        <p14:creationId xmlns:p14="http://schemas.microsoft.com/office/powerpoint/2010/main" val="86404727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CA" sz="1800" b="1" dirty="0">
                <a:solidFill>
                  <a:srgbClr val="000000"/>
                </a:solidFill>
                <a:effectLst/>
                <a:latin typeface="Source Sans Pro" panose="020B0503030403020204" pitchFamily="34" charset="0"/>
                <a:ea typeface="Times New Roman" panose="02020603050405020304" pitchFamily="18" charset="0"/>
              </a:rPr>
              <a:t>Figure S3. Probability of EOPE using a 5 CpG model in the validation group (n=48) and in the exploratory group (n=328). </a:t>
            </a:r>
            <a:r>
              <a:rPr lang="en-CA" sz="1800" dirty="0">
                <a:solidFill>
                  <a:srgbClr val="000000"/>
                </a:solidFill>
                <a:effectLst/>
                <a:latin typeface="Source Sans Pro" panose="020B0503030403020204" pitchFamily="34" charset="0"/>
                <a:ea typeface="Times New Roman" panose="02020603050405020304" pitchFamily="18" charset="0"/>
              </a:rPr>
              <a:t>A 5 CpG model was used to predict the outcome of BMIQ normalized samples in the validation and exploratory groups (the two groups were normalized separately). There are 11 nPTB samples, and 38 EOPE samples in the validation group. </a:t>
            </a:r>
            <a:r>
              <a:rPr lang="en-CA" sz="1800" b="1" dirty="0">
                <a:solidFill>
                  <a:srgbClr val="000000"/>
                </a:solidFill>
                <a:effectLst/>
                <a:latin typeface="Source Sans Pro" panose="020B0503030403020204" pitchFamily="34" charset="0"/>
                <a:ea typeface="Times New Roman" panose="02020603050405020304" pitchFamily="18" charset="0"/>
              </a:rPr>
              <a:t>a. </a:t>
            </a:r>
            <a:r>
              <a:rPr lang="en-CA" sz="1800" dirty="0">
                <a:solidFill>
                  <a:srgbClr val="000000"/>
                </a:solidFill>
                <a:effectLst/>
                <a:latin typeface="Source Sans Pro" panose="020B0503030403020204" pitchFamily="34" charset="0"/>
                <a:ea typeface="Times New Roman" panose="02020603050405020304" pitchFamily="18" charset="0"/>
              </a:rPr>
              <a:t>Receiver operating characteristic (ROC) curve in the validation group. A classification threshold of 56% was selected to maximize Youden’s J statistic (sensitivity + specificity – 1). The diagonal line indicates the curve for a classifier that predicts the majority class in all cases. </a:t>
            </a:r>
            <a:r>
              <a:rPr lang="en-CA" sz="1800" b="1" dirty="0">
                <a:solidFill>
                  <a:srgbClr val="000000"/>
                </a:solidFill>
                <a:effectLst/>
                <a:latin typeface="Source Sans Pro" panose="020B0503030403020204" pitchFamily="34" charset="0"/>
                <a:ea typeface="Times New Roman" panose="02020603050405020304" pitchFamily="18" charset="0"/>
              </a:rPr>
              <a:t>b.</a:t>
            </a:r>
            <a:r>
              <a:rPr lang="en-CA" sz="1800" dirty="0">
                <a:solidFill>
                  <a:srgbClr val="000000"/>
                </a:solidFill>
                <a:effectLst/>
                <a:latin typeface="Source Sans Pro" panose="020B0503030403020204" pitchFamily="34" charset="0"/>
                <a:ea typeface="Times New Roman" panose="02020603050405020304" pitchFamily="18" charset="0"/>
              </a:rPr>
              <a:t> Probability of EOPE of samples in the validation and exploratory groups. EOPE and nPTB samples in the plot belong to the validation group. </a:t>
            </a:r>
            <a:endParaRPr lang="en-CA" sz="1800" dirty="0">
              <a:effectLst/>
              <a:latin typeface="Times New Roman" panose="02020603050405020304" pitchFamily="18" charset="0"/>
              <a:ea typeface="Times New Roman" panose="02020603050405020304" pitchFamily="18" charset="0"/>
            </a:endParaRPr>
          </a:p>
          <a:p>
            <a:endParaRPr lang="en-CA" dirty="0"/>
          </a:p>
        </p:txBody>
      </p:sp>
      <p:sp>
        <p:nvSpPr>
          <p:cNvPr id="4" name="Slide Number Placeholder 3"/>
          <p:cNvSpPr>
            <a:spLocks noGrp="1"/>
          </p:cNvSpPr>
          <p:nvPr>
            <p:ph type="sldNum" sz="quarter" idx="5"/>
          </p:nvPr>
        </p:nvSpPr>
        <p:spPr/>
        <p:txBody>
          <a:bodyPr/>
          <a:lstStyle/>
          <a:p>
            <a:fld id="{0ECC49DA-DE5B-4D5E-82E1-9EAB42D53289}" type="slidenum">
              <a:rPr lang="en-CA" smtClean="0"/>
              <a:t>3</a:t>
            </a:fld>
            <a:endParaRPr lang="en-CA"/>
          </a:p>
        </p:txBody>
      </p:sp>
    </p:spTree>
    <p:extLst>
      <p:ext uri="{BB962C8B-B14F-4D97-AF65-F5344CB8AC3E}">
        <p14:creationId xmlns:p14="http://schemas.microsoft.com/office/powerpoint/2010/main" val="93309669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CA" sz="1200" b="1" dirty="0">
                <a:solidFill>
                  <a:srgbClr val="000000"/>
                </a:solidFill>
                <a:effectLst/>
                <a:latin typeface="Source Sans Pro" panose="020B0503030403020204" pitchFamily="34" charset="0"/>
                <a:ea typeface="Times New Roman" panose="02020603050405020304" pitchFamily="18" charset="0"/>
              </a:rPr>
              <a:t>Figure S4. Cell composition of samples in the training (n=83) and in the validation (n=48) groups. </a:t>
            </a:r>
            <a:r>
              <a:rPr lang="en-CA" sz="1200" b="0" dirty="0">
                <a:solidFill>
                  <a:srgbClr val="000000"/>
                </a:solidFill>
                <a:effectLst/>
                <a:latin typeface="Source Sans Pro" panose="020B0503030403020204" pitchFamily="34" charset="0"/>
                <a:ea typeface="Times New Roman" panose="02020603050405020304" pitchFamily="18" charset="0"/>
              </a:rPr>
              <a:t>Placental cell composition was estimated using the R package planet (Yuan et al., 2021). </a:t>
            </a:r>
          </a:p>
        </p:txBody>
      </p:sp>
      <p:sp>
        <p:nvSpPr>
          <p:cNvPr id="4" name="Slide Number Placeholder 3"/>
          <p:cNvSpPr>
            <a:spLocks noGrp="1"/>
          </p:cNvSpPr>
          <p:nvPr>
            <p:ph type="sldNum" sz="quarter" idx="5"/>
          </p:nvPr>
        </p:nvSpPr>
        <p:spPr/>
        <p:txBody>
          <a:bodyPr/>
          <a:lstStyle/>
          <a:p>
            <a:fld id="{0ECC49DA-DE5B-4D5E-82E1-9EAB42D53289}" type="slidenum">
              <a:rPr lang="en-CA" smtClean="0"/>
              <a:t>4</a:t>
            </a:fld>
            <a:endParaRPr lang="en-CA"/>
          </a:p>
        </p:txBody>
      </p:sp>
    </p:spTree>
    <p:extLst>
      <p:ext uri="{BB962C8B-B14F-4D97-AF65-F5344CB8AC3E}">
        <p14:creationId xmlns:p14="http://schemas.microsoft.com/office/powerpoint/2010/main" val="82111653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CA" sz="1200" b="1" dirty="0">
                <a:solidFill>
                  <a:srgbClr val="000000"/>
                </a:solidFill>
                <a:effectLst/>
                <a:latin typeface="Source Sans Pro" panose="020B0503030403020204" pitchFamily="34" charset="0"/>
                <a:ea typeface="Times New Roman" panose="02020603050405020304" pitchFamily="18" charset="0"/>
              </a:rPr>
              <a:t>Figure S5. Cell-specific placental DNAme at the top 5 predictive CpGs in eoPred. </a:t>
            </a:r>
            <a:r>
              <a:rPr lang="en-CA" sz="1200" b="0" dirty="0">
                <a:solidFill>
                  <a:srgbClr val="000000"/>
                </a:solidFill>
                <a:effectLst/>
                <a:latin typeface="Source Sans Pro" panose="020B0503030403020204" pitchFamily="34" charset="0"/>
                <a:ea typeface="Times New Roman" panose="02020603050405020304" pitchFamily="18" charset="0"/>
              </a:rPr>
              <a:t>Plots were generated using the placental methylome browser described by Yuan et al., 2021 and available at https://</a:t>
            </a:r>
            <a:r>
              <a:rPr lang="en-CA" sz="1200" b="0" dirty="0" err="1">
                <a:solidFill>
                  <a:srgbClr val="000000"/>
                </a:solidFill>
                <a:effectLst/>
                <a:latin typeface="Source Sans Pro" panose="020B0503030403020204" pitchFamily="34" charset="0"/>
                <a:ea typeface="Times New Roman" panose="02020603050405020304" pitchFamily="18" charset="0"/>
              </a:rPr>
              <a:t>robinsonlab.shinyapps.io</a:t>
            </a:r>
            <a:r>
              <a:rPr lang="en-CA" sz="1200" b="0" dirty="0">
                <a:solidFill>
                  <a:srgbClr val="000000"/>
                </a:solidFill>
                <a:effectLst/>
                <a:latin typeface="Source Sans Pro" panose="020B0503030403020204" pitchFamily="34" charset="0"/>
                <a:ea typeface="Times New Roman" panose="02020603050405020304" pitchFamily="18" charset="0"/>
              </a:rPr>
              <a:t>/</a:t>
            </a:r>
            <a:r>
              <a:rPr lang="en-CA" sz="1200" b="0" dirty="0" err="1">
                <a:solidFill>
                  <a:srgbClr val="000000"/>
                </a:solidFill>
                <a:effectLst/>
                <a:latin typeface="Source Sans Pro" panose="020B0503030403020204" pitchFamily="34" charset="0"/>
                <a:ea typeface="Times New Roman" panose="02020603050405020304" pitchFamily="18" charset="0"/>
              </a:rPr>
              <a:t>Placental_Methylome_Browser</a:t>
            </a:r>
            <a:r>
              <a:rPr lang="en-CA" sz="1200" b="0" dirty="0">
                <a:solidFill>
                  <a:srgbClr val="000000"/>
                </a:solidFill>
                <a:effectLst/>
                <a:latin typeface="Source Sans Pro" panose="020B0503030403020204" pitchFamily="34" charset="0"/>
                <a:ea typeface="Times New Roman" panose="02020603050405020304" pitchFamily="18" charset="0"/>
              </a:rPr>
              <a:t>/.</a:t>
            </a:r>
          </a:p>
          <a:p>
            <a:endParaRPr lang="en-CA" dirty="0"/>
          </a:p>
        </p:txBody>
      </p:sp>
      <p:sp>
        <p:nvSpPr>
          <p:cNvPr id="4" name="Slide Number Placeholder 3"/>
          <p:cNvSpPr>
            <a:spLocks noGrp="1"/>
          </p:cNvSpPr>
          <p:nvPr>
            <p:ph type="sldNum" sz="quarter" idx="5"/>
          </p:nvPr>
        </p:nvSpPr>
        <p:spPr/>
        <p:txBody>
          <a:bodyPr/>
          <a:lstStyle/>
          <a:p>
            <a:fld id="{0ECC49DA-DE5B-4D5E-82E1-9EAB42D53289}" type="slidenum">
              <a:rPr lang="en-CA" smtClean="0"/>
              <a:t>5</a:t>
            </a:fld>
            <a:endParaRPr lang="en-CA"/>
          </a:p>
        </p:txBody>
      </p:sp>
    </p:spTree>
    <p:extLst>
      <p:ext uri="{BB962C8B-B14F-4D97-AF65-F5344CB8AC3E}">
        <p14:creationId xmlns:p14="http://schemas.microsoft.com/office/powerpoint/2010/main" val="53439323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CA" sz="1200" b="1" dirty="0">
                <a:solidFill>
                  <a:srgbClr val="000000"/>
                </a:solidFill>
                <a:effectLst/>
                <a:latin typeface="Source Sans Pro" panose="020B0503030403020204" pitchFamily="34" charset="0"/>
                <a:ea typeface="Times New Roman" panose="02020603050405020304" pitchFamily="18" charset="0"/>
              </a:rPr>
              <a:t>Figure S6. Ancestry probabilities of samples in the training (n=83) and validation (n=49) and exploratory (n=328) groups. </a:t>
            </a:r>
            <a:r>
              <a:rPr lang="en-CA" sz="1200" b="0" dirty="0">
                <a:solidFill>
                  <a:srgbClr val="000000"/>
                </a:solidFill>
                <a:effectLst/>
                <a:latin typeface="Source Sans Pro" panose="020B0503030403020204" pitchFamily="34" charset="0"/>
                <a:ea typeface="Times New Roman" panose="02020603050405020304" pitchFamily="18" charset="0"/>
              </a:rPr>
              <a:t>Three ancestry probabilities (African/Asian/European) were assigned to each sample using the R package planet (Yuan et al., 2019). </a:t>
            </a:r>
          </a:p>
          <a:p>
            <a:endParaRPr lang="en-CA" dirty="0"/>
          </a:p>
        </p:txBody>
      </p:sp>
      <p:sp>
        <p:nvSpPr>
          <p:cNvPr id="4" name="Slide Number Placeholder 3"/>
          <p:cNvSpPr>
            <a:spLocks noGrp="1"/>
          </p:cNvSpPr>
          <p:nvPr>
            <p:ph type="sldNum" sz="quarter" idx="5"/>
          </p:nvPr>
        </p:nvSpPr>
        <p:spPr/>
        <p:txBody>
          <a:bodyPr/>
          <a:lstStyle/>
          <a:p>
            <a:fld id="{0ECC49DA-DE5B-4D5E-82E1-9EAB42D53289}" type="slidenum">
              <a:rPr lang="en-CA" smtClean="0"/>
              <a:t>6</a:t>
            </a:fld>
            <a:endParaRPr lang="en-CA"/>
          </a:p>
        </p:txBody>
      </p:sp>
    </p:spTree>
    <p:extLst>
      <p:ext uri="{BB962C8B-B14F-4D97-AF65-F5344CB8AC3E}">
        <p14:creationId xmlns:p14="http://schemas.microsoft.com/office/powerpoint/2010/main" val="322357982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CA" sz="1200" b="1" dirty="0">
                <a:solidFill>
                  <a:srgbClr val="000000"/>
                </a:solidFill>
                <a:effectLst/>
                <a:latin typeface="Source Sans Pro" panose="020B0503030403020204" pitchFamily="34" charset="0"/>
                <a:ea typeface="Times New Roman" panose="02020603050405020304" pitchFamily="18" charset="0"/>
              </a:rPr>
              <a:t>Figure S7. Average</a:t>
            </a:r>
            <a:r>
              <a:rPr lang="en-CA" sz="1200" b="0" dirty="0">
                <a:solidFill>
                  <a:srgbClr val="000000"/>
                </a:solidFill>
                <a:effectLst/>
                <a:latin typeface="Source Sans Pro" panose="020B0503030403020204" pitchFamily="34" charset="0"/>
                <a:ea typeface="Times New Roman" panose="02020603050405020304" pitchFamily="18" charset="0"/>
              </a:rPr>
              <a:t> </a:t>
            </a:r>
            <a:r>
              <a:rPr lang="en-CA" sz="1200" b="1" dirty="0">
                <a:effectLst/>
                <a:latin typeface="Source Sans Pro" panose="020B0503030403020204" pitchFamily="34" charset="0"/>
                <a:ea typeface="Source Sans Pro" panose="020B0503030403020204" pitchFamily="34" charset="0"/>
                <a:cs typeface="Times New Roman" panose="02020603050405020304" pitchFamily="18" charset="0"/>
              </a:rPr>
              <a:t>β values at the 45 predictive CpGs used by eoPred in EOPE (n=80) and nPTB (n=52) samples in the training and validation groups</a:t>
            </a:r>
            <a:r>
              <a:rPr lang="en-CA" sz="1200" b="1" dirty="0">
                <a:solidFill>
                  <a:srgbClr val="000000"/>
                </a:solidFill>
                <a:effectLst/>
                <a:latin typeface="Source Sans Pro" panose="020B0503030403020204" pitchFamily="34" charset="0"/>
                <a:ea typeface="Times New Roman" panose="02020603050405020304" pitchFamily="18" charset="0"/>
              </a:rPr>
              <a:t>. </a:t>
            </a:r>
            <a:r>
              <a:rPr lang="en-CA" sz="1200" b="0" dirty="0">
                <a:solidFill>
                  <a:srgbClr val="000000"/>
                </a:solidFill>
                <a:effectLst/>
                <a:latin typeface="Source Sans Pro" panose="020B0503030403020204" pitchFamily="34" charset="0"/>
                <a:ea typeface="Times New Roman" panose="02020603050405020304" pitchFamily="18" charset="0"/>
              </a:rPr>
              <a:t>There are 17 samples of African ancestry, 41 samples of Asian ancestry, and 74 samples of European ancestry depicted in the plot. Ancestry was inferred using three ancestry coordinates based on DNA methylation with the R package planet. EOPE and nPTB labels are based on the labelling by the original authors of each dataset and not on eoPred-assigned probabilities.</a:t>
            </a:r>
            <a:endParaRPr lang="en-CA" dirty="0"/>
          </a:p>
        </p:txBody>
      </p:sp>
      <p:sp>
        <p:nvSpPr>
          <p:cNvPr id="4" name="Slide Number Placeholder 3"/>
          <p:cNvSpPr>
            <a:spLocks noGrp="1"/>
          </p:cNvSpPr>
          <p:nvPr>
            <p:ph type="sldNum" sz="quarter" idx="5"/>
          </p:nvPr>
        </p:nvSpPr>
        <p:spPr/>
        <p:txBody>
          <a:bodyPr/>
          <a:lstStyle/>
          <a:p>
            <a:fld id="{0ECC49DA-DE5B-4D5E-82E1-9EAB42D53289}" type="slidenum">
              <a:rPr lang="en-CA" smtClean="0"/>
              <a:t>7</a:t>
            </a:fld>
            <a:endParaRPr lang="en-CA"/>
          </a:p>
        </p:txBody>
      </p:sp>
    </p:spTree>
    <p:extLst>
      <p:ext uri="{BB962C8B-B14F-4D97-AF65-F5344CB8AC3E}">
        <p14:creationId xmlns:p14="http://schemas.microsoft.com/office/powerpoint/2010/main" val="103682801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CA" sz="1200" b="1" dirty="0">
                <a:solidFill>
                  <a:srgbClr val="000000"/>
                </a:solidFill>
                <a:effectLst/>
                <a:latin typeface="Source Sans Pro" panose="020B0503030403020204" pitchFamily="34" charset="0"/>
                <a:ea typeface="Times New Roman" panose="02020603050405020304" pitchFamily="18" charset="0"/>
              </a:rPr>
              <a:t>Figure S8. Average</a:t>
            </a:r>
            <a:r>
              <a:rPr lang="en-CA" sz="1200" b="0" dirty="0">
                <a:solidFill>
                  <a:srgbClr val="000000"/>
                </a:solidFill>
                <a:effectLst/>
                <a:latin typeface="Source Sans Pro" panose="020B0503030403020204" pitchFamily="34" charset="0"/>
                <a:ea typeface="Times New Roman" panose="02020603050405020304" pitchFamily="18" charset="0"/>
              </a:rPr>
              <a:t> </a:t>
            </a:r>
            <a:r>
              <a:rPr lang="en-CA" sz="1200" b="1" dirty="0">
                <a:effectLst/>
                <a:latin typeface="Source Sans Pro" panose="020B0503030403020204" pitchFamily="34" charset="0"/>
                <a:ea typeface="Source Sans Pro" panose="020B0503030403020204" pitchFamily="34" charset="0"/>
                <a:cs typeface="Times New Roman" panose="02020603050405020304" pitchFamily="18" charset="0"/>
              </a:rPr>
              <a:t>β values at the 45 predictive CpGs used by eoPred in EOPE (n=93) and nPTB (n=283) samples in the validation and exploratory groups</a:t>
            </a:r>
            <a:r>
              <a:rPr lang="en-CA" sz="1200" b="1" dirty="0">
                <a:solidFill>
                  <a:srgbClr val="000000"/>
                </a:solidFill>
                <a:effectLst/>
                <a:latin typeface="Source Sans Pro" panose="020B0503030403020204" pitchFamily="34" charset="0"/>
                <a:ea typeface="Times New Roman" panose="02020603050405020304" pitchFamily="18" charset="0"/>
              </a:rPr>
              <a:t>. </a:t>
            </a:r>
            <a:r>
              <a:rPr lang="en-CA" sz="1200" b="0" dirty="0">
                <a:solidFill>
                  <a:srgbClr val="000000"/>
                </a:solidFill>
                <a:effectLst/>
                <a:latin typeface="Source Sans Pro" panose="020B0503030403020204" pitchFamily="34" charset="0"/>
                <a:ea typeface="Times New Roman" panose="02020603050405020304" pitchFamily="18" charset="0"/>
              </a:rPr>
              <a:t>Sample groups (EOPE/nPTB) are defined based on eoPred-assigned probabilities. Samples with &gt;55% probability of EOPE are classified as EOPE. There are 57 samples of African ancestry, 88 samples of Asian ancestry, and 231 samples of European ancestry depicted in the plot. Ancestry was inferred using three ancestry coordinates based on DNA methylation with the R package planet. </a:t>
            </a:r>
            <a:endParaRPr lang="en-CA" dirty="0"/>
          </a:p>
        </p:txBody>
      </p:sp>
      <p:sp>
        <p:nvSpPr>
          <p:cNvPr id="4" name="Slide Number Placeholder 3"/>
          <p:cNvSpPr>
            <a:spLocks noGrp="1"/>
          </p:cNvSpPr>
          <p:nvPr>
            <p:ph type="sldNum" sz="quarter" idx="5"/>
          </p:nvPr>
        </p:nvSpPr>
        <p:spPr/>
        <p:txBody>
          <a:bodyPr/>
          <a:lstStyle/>
          <a:p>
            <a:fld id="{0ECC49DA-DE5B-4D5E-82E1-9EAB42D53289}" type="slidenum">
              <a:rPr lang="en-CA" smtClean="0"/>
              <a:t>8</a:t>
            </a:fld>
            <a:endParaRPr lang="en-CA"/>
          </a:p>
        </p:txBody>
      </p:sp>
    </p:spTree>
    <p:extLst>
      <p:ext uri="{BB962C8B-B14F-4D97-AF65-F5344CB8AC3E}">
        <p14:creationId xmlns:p14="http://schemas.microsoft.com/office/powerpoint/2010/main" val="3928402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CA" sz="1200" b="1" dirty="0">
                <a:solidFill>
                  <a:srgbClr val="000000"/>
                </a:solidFill>
                <a:effectLst/>
                <a:latin typeface="Source Sans Pro" panose="020B0503030403020204" pitchFamily="34" charset="0"/>
                <a:ea typeface="Times New Roman" panose="02020603050405020304" pitchFamily="18" charset="0"/>
              </a:rPr>
              <a:t>Figure S9. Cell composition of EOPE and nPTB samples in the validation group. </a:t>
            </a:r>
            <a:r>
              <a:rPr lang="en-CA" sz="1200" b="0" dirty="0">
                <a:solidFill>
                  <a:srgbClr val="000000"/>
                </a:solidFill>
                <a:effectLst/>
                <a:latin typeface="Source Sans Pro" panose="020B0503030403020204" pitchFamily="34" charset="0"/>
                <a:ea typeface="Times New Roman" panose="02020603050405020304" pitchFamily="18" charset="0"/>
              </a:rPr>
              <a:t>Two datasets from the validation group are included in this plot (GSE125605 and GSE98224). Cell composition estimates were inferred using the R package planet. </a:t>
            </a:r>
            <a:endParaRPr lang="en-CA" dirty="0"/>
          </a:p>
          <a:p>
            <a:endParaRPr lang="en-CA" dirty="0"/>
          </a:p>
        </p:txBody>
      </p:sp>
      <p:sp>
        <p:nvSpPr>
          <p:cNvPr id="4" name="Slide Number Placeholder 3"/>
          <p:cNvSpPr>
            <a:spLocks noGrp="1"/>
          </p:cNvSpPr>
          <p:nvPr>
            <p:ph type="sldNum" sz="quarter" idx="5"/>
          </p:nvPr>
        </p:nvSpPr>
        <p:spPr/>
        <p:txBody>
          <a:bodyPr/>
          <a:lstStyle/>
          <a:p>
            <a:fld id="{0ECC49DA-DE5B-4D5E-82E1-9EAB42D53289}" type="slidenum">
              <a:rPr lang="en-CA" smtClean="0"/>
              <a:t>9</a:t>
            </a:fld>
            <a:endParaRPr lang="en-CA"/>
          </a:p>
        </p:txBody>
      </p:sp>
    </p:spTree>
    <p:extLst>
      <p:ext uri="{BB962C8B-B14F-4D97-AF65-F5344CB8AC3E}">
        <p14:creationId xmlns:p14="http://schemas.microsoft.com/office/powerpoint/2010/main" val="134368441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BD10891-03D1-B740-840C-23C18AA33E7D}" type="datetimeFigureOut">
              <a:rPr lang="en-CA" smtClean="0"/>
              <a:t>2023-07-26</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DCB0B7BD-A79F-2445-ADE6-115FDFF9C70C}" type="slidenum">
              <a:rPr lang="en-CA" smtClean="0"/>
              <a:t>‹#›</a:t>
            </a:fld>
            <a:endParaRPr lang="en-CA"/>
          </a:p>
        </p:txBody>
      </p:sp>
    </p:spTree>
    <p:extLst>
      <p:ext uri="{BB962C8B-B14F-4D97-AF65-F5344CB8AC3E}">
        <p14:creationId xmlns:p14="http://schemas.microsoft.com/office/powerpoint/2010/main" val="176164450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BD10891-03D1-B740-840C-23C18AA33E7D}" type="datetimeFigureOut">
              <a:rPr lang="en-CA" smtClean="0"/>
              <a:t>2023-07-26</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DCB0B7BD-A79F-2445-ADE6-115FDFF9C70C}" type="slidenum">
              <a:rPr lang="en-CA" smtClean="0"/>
              <a:t>‹#›</a:t>
            </a:fld>
            <a:endParaRPr lang="en-CA"/>
          </a:p>
        </p:txBody>
      </p:sp>
    </p:spTree>
    <p:extLst>
      <p:ext uri="{BB962C8B-B14F-4D97-AF65-F5344CB8AC3E}">
        <p14:creationId xmlns:p14="http://schemas.microsoft.com/office/powerpoint/2010/main" val="125823888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BD10891-03D1-B740-840C-23C18AA33E7D}" type="datetimeFigureOut">
              <a:rPr lang="en-CA" smtClean="0"/>
              <a:t>2023-07-26</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DCB0B7BD-A79F-2445-ADE6-115FDFF9C70C}" type="slidenum">
              <a:rPr lang="en-CA" smtClean="0"/>
              <a:t>‹#›</a:t>
            </a:fld>
            <a:endParaRPr lang="en-CA"/>
          </a:p>
        </p:txBody>
      </p:sp>
    </p:spTree>
    <p:extLst>
      <p:ext uri="{BB962C8B-B14F-4D97-AF65-F5344CB8AC3E}">
        <p14:creationId xmlns:p14="http://schemas.microsoft.com/office/powerpoint/2010/main" val="77284913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BD10891-03D1-B740-840C-23C18AA33E7D}" type="datetimeFigureOut">
              <a:rPr lang="en-CA" smtClean="0"/>
              <a:t>2023-07-26</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DCB0B7BD-A79F-2445-ADE6-115FDFF9C70C}" type="slidenum">
              <a:rPr lang="en-CA" smtClean="0"/>
              <a:t>‹#›</a:t>
            </a:fld>
            <a:endParaRPr lang="en-CA"/>
          </a:p>
        </p:txBody>
      </p:sp>
    </p:spTree>
    <p:extLst>
      <p:ext uri="{BB962C8B-B14F-4D97-AF65-F5344CB8AC3E}">
        <p14:creationId xmlns:p14="http://schemas.microsoft.com/office/powerpoint/2010/main" val="326121894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BD10891-03D1-B740-840C-23C18AA33E7D}" type="datetimeFigureOut">
              <a:rPr lang="en-CA" smtClean="0"/>
              <a:t>2023-07-26</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DCB0B7BD-A79F-2445-ADE6-115FDFF9C70C}" type="slidenum">
              <a:rPr lang="en-CA" smtClean="0"/>
              <a:t>‹#›</a:t>
            </a:fld>
            <a:endParaRPr lang="en-CA"/>
          </a:p>
        </p:txBody>
      </p:sp>
    </p:spTree>
    <p:extLst>
      <p:ext uri="{BB962C8B-B14F-4D97-AF65-F5344CB8AC3E}">
        <p14:creationId xmlns:p14="http://schemas.microsoft.com/office/powerpoint/2010/main" val="335417537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BD10891-03D1-B740-840C-23C18AA33E7D}" type="datetimeFigureOut">
              <a:rPr lang="en-CA" smtClean="0"/>
              <a:t>2023-07-26</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DCB0B7BD-A79F-2445-ADE6-115FDFF9C70C}" type="slidenum">
              <a:rPr lang="en-CA" smtClean="0"/>
              <a:t>‹#›</a:t>
            </a:fld>
            <a:endParaRPr lang="en-CA"/>
          </a:p>
        </p:txBody>
      </p:sp>
    </p:spTree>
    <p:extLst>
      <p:ext uri="{BB962C8B-B14F-4D97-AF65-F5344CB8AC3E}">
        <p14:creationId xmlns:p14="http://schemas.microsoft.com/office/powerpoint/2010/main" val="6654726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BD10891-03D1-B740-840C-23C18AA33E7D}" type="datetimeFigureOut">
              <a:rPr lang="en-CA" smtClean="0"/>
              <a:t>2023-07-26</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DCB0B7BD-A79F-2445-ADE6-115FDFF9C70C}" type="slidenum">
              <a:rPr lang="en-CA" smtClean="0"/>
              <a:t>‹#›</a:t>
            </a:fld>
            <a:endParaRPr lang="en-CA"/>
          </a:p>
        </p:txBody>
      </p:sp>
    </p:spTree>
    <p:extLst>
      <p:ext uri="{BB962C8B-B14F-4D97-AF65-F5344CB8AC3E}">
        <p14:creationId xmlns:p14="http://schemas.microsoft.com/office/powerpoint/2010/main" val="163053994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BD10891-03D1-B740-840C-23C18AA33E7D}" type="datetimeFigureOut">
              <a:rPr lang="en-CA" smtClean="0"/>
              <a:t>2023-07-26</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DCB0B7BD-A79F-2445-ADE6-115FDFF9C70C}" type="slidenum">
              <a:rPr lang="en-CA" smtClean="0"/>
              <a:t>‹#›</a:t>
            </a:fld>
            <a:endParaRPr lang="en-CA"/>
          </a:p>
        </p:txBody>
      </p:sp>
    </p:spTree>
    <p:extLst>
      <p:ext uri="{BB962C8B-B14F-4D97-AF65-F5344CB8AC3E}">
        <p14:creationId xmlns:p14="http://schemas.microsoft.com/office/powerpoint/2010/main" val="333223831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BD10891-03D1-B740-840C-23C18AA33E7D}" type="datetimeFigureOut">
              <a:rPr lang="en-CA" smtClean="0"/>
              <a:t>2023-07-26</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DCB0B7BD-A79F-2445-ADE6-115FDFF9C70C}" type="slidenum">
              <a:rPr lang="en-CA" smtClean="0"/>
              <a:t>‹#›</a:t>
            </a:fld>
            <a:endParaRPr lang="en-CA"/>
          </a:p>
        </p:txBody>
      </p:sp>
    </p:spTree>
    <p:extLst>
      <p:ext uri="{BB962C8B-B14F-4D97-AF65-F5344CB8AC3E}">
        <p14:creationId xmlns:p14="http://schemas.microsoft.com/office/powerpoint/2010/main" val="366676362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4BD10891-03D1-B740-840C-23C18AA33E7D}" type="datetimeFigureOut">
              <a:rPr lang="en-CA" smtClean="0"/>
              <a:t>2023-07-26</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DCB0B7BD-A79F-2445-ADE6-115FDFF9C70C}" type="slidenum">
              <a:rPr lang="en-CA" smtClean="0"/>
              <a:t>‹#›</a:t>
            </a:fld>
            <a:endParaRPr lang="en-CA"/>
          </a:p>
        </p:txBody>
      </p:sp>
    </p:spTree>
    <p:extLst>
      <p:ext uri="{BB962C8B-B14F-4D97-AF65-F5344CB8AC3E}">
        <p14:creationId xmlns:p14="http://schemas.microsoft.com/office/powerpoint/2010/main" val="6013976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4BD10891-03D1-B740-840C-23C18AA33E7D}" type="datetimeFigureOut">
              <a:rPr lang="en-CA" smtClean="0"/>
              <a:t>2023-07-26</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DCB0B7BD-A79F-2445-ADE6-115FDFF9C70C}" type="slidenum">
              <a:rPr lang="en-CA" smtClean="0"/>
              <a:t>‹#›</a:t>
            </a:fld>
            <a:endParaRPr lang="en-CA"/>
          </a:p>
        </p:txBody>
      </p:sp>
    </p:spTree>
    <p:extLst>
      <p:ext uri="{BB962C8B-B14F-4D97-AF65-F5344CB8AC3E}">
        <p14:creationId xmlns:p14="http://schemas.microsoft.com/office/powerpoint/2010/main" val="394462532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BD10891-03D1-B740-840C-23C18AA33E7D}" type="datetimeFigureOut">
              <a:rPr lang="en-CA" smtClean="0"/>
              <a:t>2023-07-26</a:t>
            </a:fld>
            <a:endParaRPr lang="en-CA"/>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CB0B7BD-A79F-2445-ADE6-115FDFF9C70C}" type="slidenum">
              <a:rPr lang="en-CA" smtClean="0"/>
              <a:t>‹#›</a:t>
            </a:fld>
            <a:endParaRPr lang="en-CA"/>
          </a:p>
        </p:txBody>
      </p:sp>
    </p:spTree>
    <p:extLst>
      <p:ext uri="{BB962C8B-B14F-4D97-AF65-F5344CB8AC3E}">
        <p14:creationId xmlns:p14="http://schemas.microsoft.com/office/powerpoint/2010/main" val="88940990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4.png"/></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6.png"/></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image" Target="../media/image8.png"/></Relationships>
</file>

<file path=ppt/slides/_rels/slide5.xml.rels><?xml version="1.0" encoding="UTF-8" standalone="yes"?>
<Relationships xmlns="http://schemas.openxmlformats.org/package/2006/relationships"><Relationship Id="rId3" Type="http://schemas.openxmlformats.org/officeDocument/2006/relationships/image" Target="../media/image9.PNG"/><Relationship Id="rId7" Type="http://schemas.openxmlformats.org/officeDocument/2006/relationships/image" Target="../media/image13.PNG"/><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image" Target="../media/image12.PNG"/><Relationship Id="rId5" Type="http://schemas.openxmlformats.org/officeDocument/2006/relationships/image" Target="../media/image11.PNG"/><Relationship Id="rId4" Type="http://schemas.openxmlformats.org/officeDocument/2006/relationships/image" Target="../media/image10.PNG"/></Relationships>
</file>

<file path=ppt/slides/_rels/slide6.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6.xml"/><Relationship Id="rId1" Type="http://schemas.openxmlformats.org/officeDocument/2006/relationships/slideLayout" Target="../slideLayouts/slideLayout2.xml"/><Relationship Id="rId4" Type="http://schemas.openxmlformats.org/officeDocument/2006/relationships/image" Target="../media/image15.png"/></Relationships>
</file>

<file path=ppt/slides/_rels/slide7.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23" name="Google Shape;1221;p37">
            <a:extLst>
              <a:ext uri="{FF2B5EF4-FFF2-40B4-BE49-F238E27FC236}">
                <a16:creationId xmlns:a16="http://schemas.microsoft.com/office/drawing/2014/main" id="{BF861192-1350-48A8-B67B-90C372E7579F}"/>
              </a:ext>
            </a:extLst>
          </p:cNvPr>
          <p:cNvCxnSpPr>
            <a:cxnSpLocks/>
          </p:cNvCxnSpPr>
          <p:nvPr/>
        </p:nvCxnSpPr>
        <p:spPr>
          <a:xfrm flipH="1">
            <a:off x="596482" y="170084"/>
            <a:ext cx="1206" cy="6586316"/>
          </a:xfrm>
          <a:prstGeom prst="straightConnector1">
            <a:avLst/>
          </a:prstGeom>
          <a:noFill/>
          <a:ln w="28575" cap="flat" cmpd="sng">
            <a:solidFill>
              <a:schemeClr val="tx1">
                <a:lumMod val="65000"/>
                <a:lumOff val="35000"/>
              </a:schemeClr>
            </a:solidFill>
            <a:prstDash val="solid"/>
            <a:round/>
            <a:headEnd type="none" w="med" len="med"/>
            <a:tailEnd type="none" w="med" len="med"/>
          </a:ln>
        </p:spPr>
      </p:cxnSp>
      <p:grpSp>
        <p:nvGrpSpPr>
          <p:cNvPr id="24" name="Google Shape;1222;p37">
            <a:extLst>
              <a:ext uri="{FF2B5EF4-FFF2-40B4-BE49-F238E27FC236}">
                <a16:creationId xmlns:a16="http://schemas.microsoft.com/office/drawing/2014/main" id="{0578AC0A-17E0-477B-CB11-8FB1AB55A553}"/>
              </a:ext>
            </a:extLst>
          </p:cNvPr>
          <p:cNvGrpSpPr/>
          <p:nvPr/>
        </p:nvGrpSpPr>
        <p:grpSpPr>
          <a:xfrm>
            <a:off x="501712" y="118091"/>
            <a:ext cx="212400" cy="409673"/>
            <a:chOff x="1532200" y="2458777"/>
            <a:chExt cx="212400" cy="409673"/>
          </a:xfrm>
        </p:grpSpPr>
        <p:cxnSp>
          <p:nvCxnSpPr>
            <p:cNvPr id="25" name="Google Shape;1223;p37">
              <a:extLst>
                <a:ext uri="{FF2B5EF4-FFF2-40B4-BE49-F238E27FC236}">
                  <a16:creationId xmlns:a16="http://schemas.microsoft.com/office/drawing/2014/main" id="{C012E4E4-5D93-A313-2D21-F4C7F36726CD}"/>
                </a:ext>
              </a:extLst>
            </p:cNvPr>
            <p:cNvCxnSpPr>
              <a:cxnSpLocks/>
              <a:endCxn id="28" idx="0"/>
            </p:cNvCxnSpPr>
            <p:nvPr/>
          </p:nvCxnSpPr>
          <p:spPr>
            <a:xfrm>
              <a:off x="1638483" y="2458777"/>
              <a:ext cx="0" cy="255106"/>
            </a:xfrm>
            <a:prstGeom prst="straightConnector1">
              <a:avLst/>
            </a:prstGeom>
            <a:noFill/>
            <a:ln w="9525" cap="flat" cmpd="sng">
              <a:solidFill>
                <a:schemeClr val="tx1"/>
              </a:solidFill>
              <a:prstDash val="dot"/>
              <a:round/>
              <a:headEnd type="none" w="med" len="med"/>
              <a:tailEnd type="none" w="med" len="med"/>
            </a:ln>
          </p:spPr>
        </p:cxnSp>
        <p:grpSp>
          <p:nvGrpSpPr>
            <p:cNvPr id="26" name="Google Shape;1225;p37">
              <a:extLst>
                <a:ext uri="{FF2B5EF4-FFF2-40B4-BE49-F238E27FC236}">
                  <a16:creationId xmlns:a16="http://schemas.microsoft.com/office/drawing/2014/main" id="{9D253A3A-4E2D-B188-1798-C45F24F5455A}"/>
                </a:ext>
              </a:extLst>
            </p:cNvPr>
            <p:cNvGrpSpPr/>
            <p:nvPr/>
          </p:nvGrpSpPr>
          <p:grpSpPr>
            <a:xfrm>
              <a:off x="1532200" y="2656050"/>
              <a:ext cx="212400" cy="212400"/>
              <a:chOff x="1502200" y="2740350"/>
              <a:chExt cx="212400" cy="212400"/>
            </a:xfrm>
          </p:grpSpPr>
          <p:sp>
            <p:nvSpPr>
              <p:cNvPr id="27" name="Google Shape;1226;p37">
                <a:extLst>
                  <a:ext uri="{FF2B5EF4-FFF2-40B4-BE49-F238E27FC236}">
                    <a16:creationId xmlns:a16="http://schemas.microsoft.com/office/drawing/2014/main" id="{EF2EFC0A-07F9-B69B-5A2E-D52D68859B17}"/>
                  </a:ext>
                </a:extLst>
              </p:cNvPr>
              <p:cNvSpPr/>
              <p:nvPr/>
            </p:nvSpPr>
            <p:spPr>
              <a:xfrm>
                <a:off x="1502200" y="2740350"/>
                <a:ext cx="212400" cy="212400"/>
              </a:xfrm>
              <a:prstGeom prst="ellipse">
                <a:avLst/>
              </a:prstGeom>
              <a:solidFill>
                <a:srgbClr val="FFFFFF"/>
              </a:solidFill>
              <a:ln w="19050" cap="flat" cmpd="sng">
                <a:solidFill>
                  <a:schemeClr val="tx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 name="Google Shape;1224;p37">
                <a:extLst>
                  <a:ext uri="{FF2B5EF4-FFF2-40B4-BE49-F238E27FC236}">
                    <a16:creationId xmlns:a16="http://schemas.microsoft.com/office/drawing/2014/main" id="{05B59014-6C64-3412-E28D-95098F4D2938}"/>
                  </a:ext>
                </a:extLst>
              </p:cNvPr>
              <p:cNvSpPr/>
              <p:nvPr/>
            </p:nvSpPr>
            <p:spPr>
              <a:xfrm>
                <a:off x="1560033" y="2798183"/>
                <a:ext cx="96900" cy="96900"/>
              </a:xfrm>
              <a:prstGeom prst="ellipse">
                <a:avLst/>
              </a:prstGeom>
              <a:solidFill>
                <a:schemeClr val="tx1"/>
              </a:solidFill>
              <a:ln w="19050" cap="flat" cmpd="sng">
                <a:no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dirty="0">
                  <a:solidFill>
                    <a:srgbClr val="A5C8B7"/>
                  </a:solidFill>
                </a:endParaRPr>
              </a:p>
            </p:txBody>
          </p:sp>
        </p:grpSp>
      </p:grpSp>
      <p:sp>
        <p:nvSpPr>
          <p:cNvPr id="57" name="Google Shape;1255;p37">
            <a:extLst>
              <a:ext uri="{FF2B5EF4-FFF2-40B4-BE49-F238E27FC236}">
                <a16:creationId xmlns:a16="http://schemas.microsoft.com/office/drawing/2014/main" id="{820FB7C0-329A-2D6E-70A1-64F8AFE307C5}"/>
              </a:ext>
            </a:extLst>
          </p:cNvPr>
          <p:cNvSpPr txBox="1"/>
          <p:nvPr/>
        </p:nvSpPr>
        <p:spPr>
          <a:xfrm>
            <a:off x="694367" y="226654"/>
            <a:ext cx="1961822" cy="932794"/>
          </a:xfrm>
          <a:prstGeom prst="rect">
            <a:avLst/>
          </a:prstGeom>
          <a:noFill/>
          <a:ln>
            <a:noFill/>
          </a:ln>
        </p:spPr>
        <p:txBody>
          <a:bodyPr spcFirstLastPara="1" wrap="square" lIns="91425" tIns="91425" rIns="91425" bIns="91425" anchor="t" anchorCtr="0">
            <a:noAutofit/>
          </a:bodyPr>
          <a:lstStyle/>
          <a:p>
            <a:pPr marL="0" lvl="0" indent="0" rtl="0">
              <a:spcBef>
                <a:spcPts val="0"/>
              </a:spcBef>
              <a:spcAft>
                <a:spcPts val="0"/>
              </a:spcAft>
              <a:buNone/>
            </a:pPr>
            <a:r>
              <a:rPr lang="en" sz="1400" b="1" dirty="0">
                <a:latin typeface="Source Sans Pro SemiBold" panose="020B0503030403020204" pitchFamily="34" charset="0"/>
                <a:ea typeface="Source Sans Pro SemiBold" panose="020B0503030403020204" pitchFamily="34" charset="0"/>
                <a:cs typeface="Fira Sans Extra Condensed"/>
                <a:sym typeface="Fira Sans Extra Condensed"/>
              </a:rPr>
              <a:t>Gather study data</a:t>
            </a:r>
          </a:p>
          <a:p>
            <a:pPr marL="0" lvl="0" indent="0" rtl="0">
              <a:spcBef>
                <a:spcPts val="0"/>
              </a:spcBef>
              <a:spcAft>
                <a:spcPts val="0"/>
              </a:spcAft>
              <a:buNone/>
            </a:pPr>
            <a:r>
              <a:rPr lang="en" sz="1100" dirty="0">
                <a:latin typeface="Source Sans Pro" panose="020B0503030403020204" pitchFamily="34" charset="0"/>
                <a:ea typeface="Source Sans Pro" panose="020B0503030403020204" pitchFamily="34" charset="0"/>
                <a:cs typeface="Fira Sans Extra Condensed"/>
                <a:sym typeface="Fira Sans Extra Condensed"/>
              </a:rPr>
              <a:t>Search for all public HM450K and HM850K datasets of placental chorionic villi with preeclampsia cases </a:t>
            </a:r>
            <a:endParaRPr sz="1100" dirty="0">
              <a:latin typeface="Source Sans Pro" panose="020B0503030403020204" pitchFamily="34" charset="0"/>
              <a:ea typeface="Source Sans Pro" panose="020B0503030403020204" pitchFamily="34" charset="0"/>
              <a:cs typeface="Fira Sans Extra Condensed"/>
              <a:sym typeface="Fira Sans Extra Condensed"/>
            </a:endParaRPr>
          </a:p>
        </p:txBody>
      </p:sp>
      <p:sp>
        <p:nvSpPr>
          <p:cNvPr id="64" name="Google Shape;1262;p37">
            <a:extLst>
              <a:ext uri="{FF2B5EF4-FFF2-40B4-BE49-F238E27FC236}">
                <a16:creationId xmlns:a16="http://schemas.microsoft.com/office/drawing/2014/main" id="{4426E213-D202-20F5-0381-F3B8C491BDC2}"/>
              </a:ext>
            </a:extLst>
          </p:cNvPr>
          <p:cNvSpPr txBox="1"/>
          <p:nvPr/>
        </p:nvSpPr>
        <p:spPr>
          <a:xfrm>
            <a:off x="-125510" y="157494"/>
            <a:ext cx="849600" cy="533400"/>
          </a:xfrm>
          <a:prstGeom prst="rect">
            <a:avLst/>
          </a:prstGeom>
          <a:noFill/>
          <a:ln>
            <a:noFill/>
          </a:ln>
        </p:spPr>
        <p:txBody>
          <a:bodyPr spcFirstLastPara="1" wrap="square" lIns="91425" tIns="91425" rIns="91425" bIns="91425" anchor="ctr" anchorCtr="0">
            <a:noAutofit/>
          </a:bodyPr>
          <a:lstStyle/>
          <a:p>
            <a:pPr marL="0" lvl="0" indent="0" algn="ctr" rtl="0">
              <a:spcBef>
                <a:spcPts val="0"/>
              </a:spcBef>
              <a:spcAft>
                <a:spcPts val="0"/>
              </a:spcAft>
              <a:buNone/>
            </a:pPr>
            <a:r>
              <a:rPr lang="en" sz="2400" b="1" dirty="0">
                <a:solidFill>
                  <a:schemeClr val="tx1">
                    <a:lumMod val="75000"/>
                    <a:lumOff val="25000"/>
                  </a:schemeClr>
                </a:solidFill>
                <a:latin typeface="Source Sans Pro SemiBold" panose="020B0503030403020204" pitchFamily="34" charset="0"/>
                <a:ea typeface="Source Sans Pro SemiBold" panose="020B0503030403020204" pitchFamily="34" charset="0"/>
                <a:cs typeface="Fira Sans Extra Condensed"/>
                <a:sym typeface="Fira Sans Extra Condensed"/>
              </a:rPr>
              <a:t>01</a:t>
            </a:r>
            <a:endParaRPr sz="2400" b="1" dirty="0">
              <a:solidFill>
                <a:schemeClr val="tx1">
                  <a:lumMod val="75000"/>
                  <a:lumOff val="25000"/>
                </a:schemeClr>
              </a:solidFill>
              <a:latin typeface="Source Sans Pro SemiBold" panose="020B0503030403020204" pitchFamily="34" charset="0"/>
              <a:ea typeface="Source Sans Pro SemiBold" panose="020B0503030403020204" pitchFamily="34" charset="0"/>
              <a:cs typeface="Fira Sans Extra Condensed"/>
              <a:sym typeface="Fira Sans Extra Condensed"/>
            </a:endParaRPr>
          </a:p>
        </p:txBody>
      </p:sp>
      <p:grpSp>
        <p:nvGrpSpPr>
          <p:cNvPr id="71" name="Google Shape;1222;p37">
            <a:extLst>
              <a:ext uri="{FF2B5EF4-FFF2-40B4-BE49-F238E27FC236}">
                <a16:creationId xmlns:a16="http://schemas.microsoft.com/office/drawing/2014/main" id="{A9DDB3E6-3009-0769-DE73-A75B9C06265E}"/>
              </a:ext>
            </a:extLst>
          </p:cNvPr>
          <p:cNvGrpSpPr/>
          <p:nvPr/>
        </p:nvGrpSpPr>
        <p:grpSpPr>
          <a:xfrm>
            <a:off x="491488" y="1177487"/>
            <a:ext cx="212400" cy="409673"/>
            <a:chOff x="1532200" y="2458777"/>
            <a:chExt cx="212400" cy="409673"/>
          </a:xfrm>
        </p:grpSpPr>
        <p:cxnSp>
          <p:nvCxnSpPr>
            <p:cNvPr id="72" name="Google Shape;1223;p37">
              <a:extLst>
                <a:ext uri="{FF2B5EF4-FFF2-40B4-BE49-F238E27FC236}">
                  <a16:creationId xmlns:a16="http://schemas.microsoft.com/office/drawing/2014/main" id="{6D3D01E4-3D28-A098-B8EB-819457B536CD}"/>
                </a:ext>
              </a:extLst>
            </p:cNvPr>
            <p:cNvCxnSpPr>
              <a:cxnSpLocks/>
              <a:endCxn id="75" idx="0"/>
            </p:cNvCxnSpPr>
            <p:nvPr/>
          </p:nvCxnSpPr>
          <p:spPr>
            <a:xfrm>
              <a:off x="1638483" y="2458777"/>
              <a:ext cx="0" cy="255106"/>
            </a:xfrm>
            <a:prstGeom prst="straightConnector1">
              <a:avLst/>
            </a:prstGeom>
            <a:noFill/>
            <a:ln w="9525" cap="flat" cmpd="sng">
              <a:solidFill>
                <a:schemeClr val="tx1"/>
              </a:solidFill>
              <a:prstDash val="dot"/>
              <a:round/>
              <a:headEnd type="none" w="med" len="med"/>
              <a:tailEnd type="none" w="med" len="med"/>
            </a:ln>
          </p:spPr>
        </p:cxnSp>
        <p:grpSp>
          <p:nvGrpSpPr>
            <p:cNvPr id="73" name="Google Shape;1225;p37">
              <a:extLst>
                <a:ext uri="{FF2B5EF4-FFF2-40B4-BE49-F238E27FC236}">
                  <a16:creationId xmlns:a16="http://schemas.microsoft.com/office/drawing/2014/main" id="{6AE1CC2F-C169-2D9E-46F3-41C344353B48}"/>
                </a:ext>
              </a:extLst>
            </p:cNvPr>
            <p:cNvGrpSpPr/>
            <p:nvPr/>
          </p:nvGrpSpPr>
          <p:grpSpPr>
            <a:xfrm>
              <a:off x="1532200" y="2656050"/>
              <a:ext cx="212400" cy="212400"/>
              <a:chOff x="1502200" y="2740350"/>
              <a:chExt cx="212400" cy="212400"/>
            </a:xfrm>
          </p:grpSpPr>
          <p:sp>
            <p:nvSpPr>
              <p:cNvPr id="74" name="Google Shape;1226;p37">
                <a:extLst>
                  <a:ext uri="{FF2B5EF4-FFF2-40B4-BE49-F238E27FC236}">
                    <a16:creationId xmlns:a16="http://schemas.microsoft.com/office/drawing/2014/main" id="{103C7B65-C65B-4960-5E9B-7718E7BB1BEB}"/>
                  </a:ext>
                </a:extLst>
              </p:cNvPr>
              <p:cNvSpPr/>
              <p:nvPr/>
            </p:nvSpPr>
            <p:spPr>
              <a:xfrm>
                <a:off x="1502200" y="2740350"/>
                <a:ext cx="212400" cy="212400"/>
              </a:xfrm>
              <a:prstGeom prst="ellipse">
                <a:avLst/>
              </a:prstGeom>
              <a:solidFill>
                <a:srgbClr val="FFFFFF"/>
              </a:solidFill>
              <a:ln w="19050" cap="flat" cmpd="sng">
                <a:solidFill>
                  <a:schemeClr val="tx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5" name="Google Shape;1224;p37">
                <a:extLst>
                  <a:ext uri="{FF2B5EF4-FFF2-40B4-BE49-F238E27FC236}">
                    <a16:creationId xmlns:a16="http://schemas.microsoft.com/office/drawing/2014/main" id="{BB0604DD-BAC2-A966-268E-9B0C34F94E31}"/>
                  </a:ext>
                </a:extLst>
              </p:cNvPr>
              <p:cNvSpPr/>
              <p:nvPr/>
            </p:nvSpPr>
            <p:spPr>
              <a:xfrm>
                <a:off x="1560033" y="2798183"/>
                <a:ext cx="96900" cy="96900"/>
              </a:xfrm>
              <a:prstGeom prst="ellipse">
                <a:avLst/>
              </a:prstGeom>
              <a:solidFill>
                <a:schemeClr val="tx1"/>
              </a:solidFill>
              <a:ln w="19050" cap="flat" cmpd="sng">
                <a:no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dirty="0">
                  <a:solidFill>
                    <a:srgbClr val="A5C8B7"/>
                  </a:solidFill>
                </a:endParaRPr>
              </a:p>
            </p:txBody>
          </p:sp>
        </p:grpSp>
      </p:grpSp>
      <p:sp>
        <p:nvSpPr>
          <p:cNvPr id="76" name="Google Shape;1255;p37">
            <a:extLst>
              <a:ext uri="{FF2B5EF4-FFF2-40B4-BE49-F238E27FC236}">
                <a16:creationId xmlns:a16="http://schemas.microsoft.com/office/drawing/2014/main" id="{7C1322E2-D589-6CEB-8048-09007E57FD94}"/>
              </a:ext>
            </a:extLst>
          </p:cNvPr>
          <p:cNvSpPr txBox="1"/>
          <p:nvPr/>
        </p:nvSpPr>
        <p:spPr>
          <a:xfrm>
            <a:off x="690841" y="1273971"/>
            <a:ext cx="2347390" cy="932794"/>
          </a:xfrm>
          <a:prstGeom prst="rect">
            <a:avLst/>
          </a:prstGeom>
          <a:noFill/>
          <a:ln>
            <a:noFill/>
          </a:ln>
        </p:spPr>
        <p:txBody>
          <a:bodyPr spcFirstLastPara="1" wrap="square" lIns="91425" tIns="91425" rIns="91425" bIns="91425" anchor="t" anchorCtr="0">
            <a:noAutofit/>
          </a:bodyPr>
          <a:lstStyle/>
          <a:p>
            <a:pPr marL="0" lvl="0" indent="0" rtl="0">
              <a:spcBef>
                <a:spcPts val="0"/>
              </a:spcBef>
              <a:spcAft>
                <a:spcPts val="0"/>
              </a:spcAft>
              <a:buNone/>
            </a:pPr>
            <a:r>
              <a:rPr lang="en" sz="1400" b="1" dirty="0">
                <a:latin typeface="Source Sans Pro SemiBold" panose="020B0503030403020204" pitchFamily="34" charset="0"/>
                <a:ea typeface="Source Sans Pro SemiBold" panose="020B0503030403020204" pitchFamily="34" charset="0"/>
                <a:cs typeface="Fira Sans Extra Condensed"/>
                <a:sym typeface="Fira Sans Extra Condensed"/>
              </a:rPr>
              <a:t>Rearrange data into groups</a:t>
            </a:r>
          </a:p>
          <a:p>
            <a:pPr marL="0" lvl="0" indent="0" rtl="0">
              <a:spcBef>
                <a:spcPts val="0"/>
              </a:spcBef>
              <a:spcAft>
                <a:spcPts val="0"/>
              </a:spcAft>
              <a:buNone/>
            </a:pPr>
            <a:r>
              <a:rPr lang="en" sz="1100" dirty="0">
                <a:latin typeface="Source Sans Pro" panose="020B0503030403020204" pitchFamily="34" charset="0"/>
                <a:ea typeface="Source Sans Pro" panose="020B0503030403020204" pitchFamily="34" charset="0"/>
                <a:cs typeface="Fira Sans Extra Condensed"/>
                <a:sym typeface="Fira Sans Extra Condensed"/>
              </a:rPr>
              <a:t>The training and testing groups are both comprised of EOPE and nPTB samples; the exploratory group contains all leftover samples of other etiologies.</a:t>
            </a:r>
          </a:p>
        </p:txBody>
      </p:sp>
      <p:sp>
        <p:nvSpPr>
          <p:cNvPr id="77" name="Google Shape;1262;p37">
            <a:extLst>
              <a:ext uri="{FF2B5EF4-FFF2-40B4-BE49-F238E27FC236}">
                <a16:creationId xmlns:a16="http://schemas.microsoft.com/office/drawing/2014/main" id="{7032C59C-8A37-4517-0AB6-B12922178F1A}"/>
              </a:ext>
            </a:extLst>
          </p:cNvPr>
          <p:cNvSpPr txBox="1"/>
          <p:nvPr/>
        </p:nvSpPr>
        <p:spPr>
          <a:xfrm>
            <a:off x="-128914" y="1199077"/>
            <a:ext cx="849600" cy="533400"/>
          </a:xfrm>
          <a:prstGeom prst="rect">
            <a:avLst/>
          </a:prstGeom>
          <a:noFill/>
          <a:ln>
            <a:noFill/>
          </a:ln>
        </p:spPr>
        <p:txBody>
          <a:bodyPr spcFirstLastPara="1" wrap="square" lIns="91425" tIns="91425" rIns="91425" bIns="91425" anchor="ctr" anchorCtr="0">
            <a:noAutofit/>
          </a:bodyPr>
          <a:lstStyle/>
          <a:p>
            <a:pPr marL="0" lvl="0" indent="0" algn="ctr" rtl="0">
              <a:spcBef>
                <a:spcPts val="0"/>
              </a:spcBef>
              <a:spcAft>
                <a:spcPts val="0"/>
              </a:spcAft>
              <a:buNone/>
            </a:pPr>
            <a:r>
              <a:rPr lang="en" sz="2400" b="1" dirty="0">
                <a:solidFill>
                  <a:schemeClr val="tx1">
                    <a:lumMod val="75000"/>
                    <a:lumOff val="25000"/>
                  </a:schemeClr>
                </a:solidFill>
                <a:latin typeface="Source Sans Pro SemiBold" panose="020B0503030403020204" pitchFamily="34" charset="0"/>
                <a:ea typeface="Source Sans Pro SemiBold" panose="020B0503030403020204" pitchFamily="34" charset="0"/>
                <a:cs typeface="Fira Sans Extra Condensed"/>
                <a:sym typeface="Fira Sans Extra Condensed"/>
              </a:rPr>
              <a:t>02</a:t>
            </a:r>
            <a:endParaRPr sz="2400" b="1" dirty="0">
              <a:solidFill>
                <a:schemeClr val="tx1">
                  <a:lumMod val="75000"/>
                  <a:lumOff val="25000"/>
                </a:schemeClr>
              </a:solidFill>
              <a:latin typeface="Source Sans Pro SemiBold" panose="020B0503030403020204" pitchFamily="34" charset="0"/>
              <a:ea typeface="Source Sans Pro SemiBold" panose="020B0503030403020204" pitchFamily="34" charset="0"/>
              <a:cs typeface="Fira Sans Extra Condensed"/>
              <a:sym typeface="Fira Sans Extra Condensed"/>
            </a:endParaRPr>
          </a:p>
        </p:txBody>
      </p:sp>
      <p:grpSp>
        <p:nvGrpSpPr>
          <p:cNvPr id="81" name="Google Shape;1222;p37">
            <a:extLst>
              <a:ext uri="{FF2B5EF4-FFF2-40B4-BE49-F238E27FC236}">
                <a16:creationId xmlns:a16="http://schemas.microsoft.com/office/drawing/2014/main" id="{AEBEA258-FAE4-0206-C0AE-9E9D25CB53BC}"/>
              </a:ext>
            </a:extLst>
          </p:cNvPr>
          <p:cNvGrpSpPr/>
          <p:nvPr/>
        </p:nvGrpSpPr>
        <p:grpSpPr>
          <a:xfrm>
            <a:off x="491488" y="2421283"/>
            <a:ext cx="212400" cy="409673"/>
            <a:chOff x="1532200" y="2458777"/>
            <a:chExt cx="212400" cy="409673"/>
          </a:xfrm>
        </p:grpSpPr>
        <p:cxnSp>
          <p:nvCxnSpPr>
            <p:cNvPr id="82" name="Google Shape;1223;p37">
              <a:extLst>
                <a:ext uri="{FF2B5EF4-FFF2-40B4-BE49-F238E27FC236}">
                  <a16:creationId xmlns:a16="http://schemas.microsoft.com/office/drawing/2014/main" id="{60326890-85F4-C4DE-3CBD-1B1FFECDA1AC}"/>
                </a:ext>
              </a:extLst>
            </p:cNvPr>
            <p:cNvCxnSpPr>
              <a:cxnSpLocks/>
              <a:endCxn id="85" idx="0"/>
            </p:cNvCxnSpPr>
            <p:nvPr/>
          </p:nvCxnSpPr>
          <p:spPr>
            <a:xfrm>
              <a:off x="1638483" y="2458777"/>
              <a:ext cx="0" cy="255106"/>
            </a:xfrm>
            <a:prstGeom prst="straightConnector1">
              <a:avLst/>
            </a:prstGeom>
            <a:noFill/>
            <a:ln w="9525" cap="flat" cmpd="sng">
              <a:solidFill>
                <a:schemeClr val="tx1"/>
              </a:solidFill>
              <a:prstDash val="dot"/>
              <a:round/>
              <a:headEnd type="none" w="med" len="med"/>
              <a:tailEnd type="none" w="med" len="med"/>
            </a:ln>
          </p:spPr>
        </p:cxnSp>
        <p:grpSp>
          <p:nvGrpSpPr>
            <p:cNvPr id="83" name="Google Shape;1225;p37">
              <a:extLst>
                <a:ext uri="{FF2B5EF4-FFF2-40B4-BE49-F238E27FC236}">
                  <a16:creationId xmlns:a16="http://schemas.microsoft.com/office/drawing/2014/main" id="{6462F5C7-3C9F-B0FA-87F5-D3F5A0C18DA7}"/>
                </a:ext>
              </a:extLst>
            </p:cNvPr>
            <p:cNvGrpSpPr/>
            <p:nvPr/>
          </p:nvGrpSpPr>
          <p:grpSpPr>
            <a:xfrm>
              <a:off x="1532200" y="2656050"/>
              <a:ext cx="212400" cy="212400"/>
              <a:chOff x="1502200" y="2740350"/>
              <a:chExt cx="212400" cy="212400"/>
            </a:xfrm>
          </p:grpSpPr>
          <p:sp>
            <p:nvSpPr>
              <p:cNvPr id="84" name="Google Shape;1226;p37">
                <a:extLst>
                  <a:ext uri="{FF2B5EF4-FFF2-40B4-BE49-F238E27FC236}">
                    <a16:creationId xmlns:a16="http://schemas.microsoft.com/office/drawing/2014/main" id="{06502059-0E0E-D1F5-427D-45E4A7C31D19}"/>
                  </a:ext>
                </a:extLst>
              </p:cNvPr>
              <p:cNvSpPr/>
              <p:nvPr/>
            </p:nvSpPr>
            <p:spPr>
              <a:xfrm>
                <a:off x="1502200" y="2740350"/>
                <a:ext cx="212400" cy="212400"/>
              </a:xfrm>
              <a:prstGeom prst="ellipse">
                <a:avLst/>
              </a:prstGeom>
              <a:solidFill>
                <a:srgbClr val="FFFFFF"/>
              </a:solidFill>
              <a:ln w="19050" cap="flat" cmpd="sng">
                <a:solidFill>
                  <a:schemeClr val="tx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5" name="Google Shape;1224;p37">
                <a:extLst>
                  <a:ext uri="{FF2B5EF4-FFF2-40B4-BE49-F238E27FC236}">
                    <a16:creationId xmlns:a16="http://schemas.microsoft.com/office/drawing/2014/main" id="{B4926D7F-EB26-C66F-0361-818842ED8DA9}"/>
                  </a:ext>
                </a:extLst>
              </p:cNvPr>
              <p:cNvSpPr/>
              <p:nvPr/>
            </p:nvSpPr>
            <p:spPr>
              <a:xfrm>
                <a:off x="1560033" y="2798183"/>
                <a:ext cx="96900" cy="96900"/>
              </a:xfrm>
              <a:prstGeom prst="ellipse">
                <a:avLst/>
              </a:prstGeom>
              <a:solidFill>
                <a:schemeClr val="tx1"/>
              </a:solidFill>
              <a:ln w="19050" cap="flat" cmpd="sng">
                <a:no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dirty="0">
                  <a:solidFill>
                    <a:srgbClr val="A5C8B7"/>
                  </a:solidFill>
                </a:endParaRPr>
              </a:p>
            </p:txBody>
          </p:sp>
        </p:grpSp>
      </p:grpSp>
      <p:sp>
        <p:nvSpPr>
          <p:cNvPr id="86" name="Google Shape;1255;p37">
            <a:extLst>
              <a:ext uri="{FF2B5EF4-FFF2-40B4-BE49-F238E27FC236}">
                <a16:creationId xmlns:a16="http://schemas.microsoft.com/office/drawing/2014/main" id="{4718A319-927C-E3DA-53B3-A7E95103B98D}"/>
              </a:ext>
            </a:extLst>
          </p:cNvPr>
          <p:cNvSpPr txBox="1"/>
          <p:nvPr/>
        </p:nvSpPr>
        <p:spPr>
          <a:xfrm>
            <a:off x="702282" y="2527670"/>
            <a:ext cx="2032336" cy="932794"/>
          </a:xfrm>
          <a:prstGeom prst="rect">
            <a:avLst/>
          </a:prstGeom>
          <a:noFill/>
          <a:ln>
            <a:noFill/>
          </a:ln>
        </p:spPr>
        <p:txBody>
          <a:bodyPr spcFirstLastPara="1" wrap="square" lIns="91425" tIns="91425" rIns="91425" bIns="91425" anchor="t" anchorCtr="0">
            <a:noAutofit/>
          </a:bodyPr>
          <a:lstStyle/>
          <a:p>
            <a:pPr marL="0" lvl="0" indent="0" rtl="0">
              <a:spcBef>
                <a:spcPts val="0"/>
              </a:spcBef>
              <a:spcAft>
                <a:spcPts val="0"/>
              </a:spcAft>
              <a:buNone/>
            </a:pPr>
            <a:r>
              <a:rPr lang="en" sz="1400" b="1" dirty="0">
                <a:latin typeface="Source Sans Pro SemiBold" panose="020B0503030403020204" pitchFamily="34" charset="0"/>
                <a:ea typeface="Source Sans Pro SemiBold" panose="020B0503030403020204" pitchFamily="34" charset="0"/>
                <a:cs typeface="Fira Sans Extra Condensed"/>
                <a:sym typeface="Fira Sans Extra Condensed"/>
              </a:rPr>
              <a:t>Quality control (QC)</a:t>
            </a:r>
          </a:p>
          <a:p>
            <a:pPr lvl="0" rtl="0">
              <a:spcBef>
                <a:spcPts val="0"/>
              </a:spcBef>
              <a:spcAft>
                <a:spcPts val="0"/>
              </a:spcAft>
            </a:pPr>
            <a:r>
              <a:rPr lang="en" sz="1100" dirty="0">
                <a:latin typeface="Source Sans Pro" panose="020B0503030403020204" pitchFamily="34" charset="0"/>
                <a:ea typeface="Source Sans Pro" panose="020B0503030403020204" pitchFamily="34" charset="0"/>
                <a:cs typeface="Fira Sans Extra Condensed"/>
                <a:sym typeface="Fira Sans Extra Condensed"/>
              </a:rPr>
              <a:t>Check the sample and probe quality and normalize each group </a:t>
            </a:r>
            <a:r>
              <a:rPr lang="en" sz="1100" u="sng" dirty="0">
                <a:latin typeface="Source Sans Pro" panose="020B0503030403020204" pitchFamily="34" charset="0"/>
                <a:ea typeface="Source Sans Pro" panose="020B0503030403020204" pitchFamily="34" charset="0"/>
                <a:cs typeface="Fira Sans Extra Condensed"/>
                <a:sym typeface="Fira Sans Extra Condensed"/>
              </a:rPr>
              <a:t>independently</a:t>
            </a:r>
          </a:p>
        </p:txBody>
      </p:sp>
      <p:sp>
        <p:nvSpPr>
          <p:cNvPr id="87" name="Google Shape;1262;p37">
            <a:extLst>
              <a:ext uri="{FF2B5EF4-FFF2-40B4-BE49-F238E27FC236}">
                <a16:creationId xmlns:a16="http://schemas.microsoft.com/office/drawing/2014/main" id="{A4F98E15-61AF-526D-AB05-15230A091CF9}"/>
              </a:ext>
            </a:extLst>
          </p:cNvPr>
          <p:cNvSpPr txBox="1"/>
          <p:nvPr/>
        </p:nvSpPr>
        <p:spPr>
          <a:xfrm>
            <a:off x="-128914" y="2450234"/>
            <a:ext cx="849600" cy="533400"/>
          </a:xfrm>
          <a:prstGeom prst="rect">
            <a:avLst/>
          </a:prstGeom>
          <a:noFill/>
          <a:ln>
            <a:noFill/>
          </a:ln>
        </p:spPr>
        <p:txBody>
          <a:bodyPr spcFirstLastPara="1" wrap="square" lIns="91425" tIns="91425" rIns="91425" bIns="91425" anchor="ctr" anchorCtr="0">
            <a:noAutofit/>
          </a:bodyPr>
          <a:lstStyle/>
          <a:p>
            <a:pPr marL="0" lvl="0" indent="0" algn="ctr" rtl="0">
              <a:spcBef>
                <a:spcPts val="0"/>
              </a:spcBef>
              <a:spcAft>
                <a:spcPts val="0"/>
              </a:spcAft>
              <a:buNone/>
            </a:pPr>
            <a:r>
              <a:rPr lang="en" sz="2400" b="1" dirty="0">
                <a:solidFill>
                  <a:schemeClr val="tx1">
                    <a:lumMod val="75000"/>
                    <a:lumOff val="25000"/>
                  </a:schemeClr>
                </a:solidFill>
                <a:latin typeface="Source Sans Pro SemiBold" panose="020B0503030403020204" pitchFamily="34" charset="0"/>
                <a:ea typeface="Source Sans Pro SemiBold" panose="020B0503030403020204" pitchFamily="34" charset="0"/>
                <a:cs typeface="Fira Sans Extra Condensed"/>
                <a:sym typeface="Fira Sans Extra Condensed"/>
              </a:rPr>
              <a:t>03</a:t>
            </a:r>
            <a:endParaRPr sz="2400" b="1" dirty="0">
              <a:solidFill>
                <a:schemeClr val="tx1">
                  <a:lumMod val="75000"/>
                  <a:lumOff val="25000"/>
                </a:schemeClr>
              </a:solidFill>
              <a:latin typeface="Source Sans Pro SemiBold" panose="020B0503030403020204" pitchFamily="34" charset="0"/>
              <a:ea typeface="Source Sans Pro SemiBold" panose="020B0503030403020204" pitchFamily="34" charset="0"/>
              <a:cs typeface="Fira Sans Extra Condensed"/>
              <a:sym typeface="Fira Sans Extra Condensed"/>
            </a:endParaRPr>
          </a:p>
        </p:txBody>
      </p:sp>
      <p:grpSp>
        <p:nvGrpSpPr>
          <p:cNvPr id="88" name="Google Shape;1222;p37">
            <a:extLst>
              <a:ext uri="{FF2B5EF4-FFF2-40B4-BE49-F238E27FC236}">
                <a16:creationId xmlns:a16="http://schemas.microsoft.com/office/drawing/2014/main" id="{B4725383-46C4-3374-B650-F69CA903B4BF}"/>
              </a:ext>
            </a:extLst>
          </p:cNvPr>
          <p:cNvGrpSpPr/>
          <p:nvPr/>
        </p:nvGrpSpPr>
        <p:grpSpPr>
          <a:xfrm>
            <a:off x="493413" y="3603520"/>
            <a:ext cx="212400" cy="409673"/>
            <a:chOff x="1532200" y="2458777"/>
            <a:chExt cx="212400" cy="409673"/>
          </a:xfrm>
        </p:grpSpPr>
        <p:cxnSp>
          <p:nvCxnSpPr>
            <p:cNvPr id="89" name="Google Shape;1223;p37">
              <a:extLst>
                <a:ext uri="{FF2B5EF4-FFF2-40B4-BE49-F238E27FC236}">
                  <a16:creationId xmlns:a16="http://schemas.microsoft.com/office/drawing/2014/main" id="{B680A7F9-4C71-C907-DD48-246394289949}"/>
                </a:ext>
              </a:extLst>
            </p:cNvPr>
            <p:cNvCxnSpPr>
              <a:cxnSpLocks/>
              <a:endCxn id="92" idx="0"/>
            </p:cNvCxnSpPr>
            <p:nvPr/>
          </p:nvCxnSpPr>
          <p:spPr>
            <a:xfrm>
              <a:off x="1638483" y="2458777"/>
              <a:ext cx="0" cy="255106"/>
            </a:xfrm>
            <a:prstGeom prst="straightConnector1">
              <a:avLst/>
            </a:prstGeom>
            <a:noFill/>
            <a:ln w="9525" cap="flat" cmpd="sng">
              <a:solidFill>
                <a:schemeClr val="tx1"/>
              </a:solidFill>
              <a:prstDash val="dot"/>
              <a:round/>
              <a:headEnd type="none" w="med" len="med"/>
              <a:tailEnd type="none" w="med" len="med"/>
            </a:ln>
          </p:spPr>
        </p:cxnSp>
        <p:grpSp>
          <p:nvGrpSpPr>
            <p:cNvPr id="90" name="Google Shape;1225;p37">
              <a:extLst>
                <a:ext uri="{FF2B5EF4-FFF2-40B4-BE49-F238E27FC236}">
                  <a16:creationId xmlns:a16="http://schemas.microsoft.com/office/drawing/2014/main" id="{9990FDCF-CC3A-0317-D4AD-FD8B096DCD65}"/>
                </a:ext>
              </a:extLst>
            </p:cNvPr>
            <p:cNvGrpSpPr/>
            <p:nvPr/>
          </p:nvGrpSpPr>
          <p:grpSpPr>
            <a:xfrm>
              <a:off x="1532200" y="2656050"/>
              <a:ext cx="212400" cy="212400"/>
              <a:chOff x="1502200" y="2740350"/>
              <a:chExt cx="212400" cy="212400"/>
            </a:xfrm>
          </p:grpSpPr>
          <p:sp>
            <p:nvSpPr>
              <p:cNvPr id="91" name="Google Shape;1226;p37">
                <a:extLst>
                  <a:ext uri="{FF2B5EF4-FFF2-40B4-BE49-F238E27FC236}">
                    <a16:creationId xmlns:a16="http://schemas.microsoft.com/office/drawing/2014/main" id="{EFE08643-7F73-F050-0EF1-7423DA8D31D4}"/>
                  </a:ext>
                </a:extLst>
              </p:cNvPr>
              <p:cNvSpPr/>
              <p:nvPr/>
            </p:nvSpPr>
            <p:spPr>
              <a:xfrm>
                <a:off x="1502200" y="2740350"/>
                <a:ext cx="212400" cy="212400"/>
              </a:xfrm>
              <a:prstGeom prst="ellipse">
                <a:avLst/>
              </a:prstGeom>
              <a:solidFill>
                <a:srgbClr val="FFFFFF"/>
              </a:solidFill>
              <a:ln w="19050" cap="flat" cmpd="sng">
                <a:solidFill>
                  <a:schemeClr val="tx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2" name="Google Shape;1224;p37">
                <a:extLst>
                  <a:ext uri="{FF2B5EF4-FFF2-40B4-BE49-F238E27FC236}">
                    <a16:creationId xmlns:a16="http://schemas.microsoft.com/office/drawing/2014/main" id="{8933795D-02F1-3B00-8B2F-61A0FDDBA22F}"/>
                  </a:ext>
                </a:extLst>
              </p:cNvPr>
              <p:cNvSpPr/>
              <p:nvPr/>
            </p:nvSpPr>
            <p:spPr>
              <a:xfrm>
                <a:off x="1560033" y="2798183"/>
                <a:ext cx="96900" cy="96900"/>
              </a:xfrm>
              <a:prstGeom prst="ellipse">
                <a:avLst/>
              </a:prstGeom>
              <a:solidFill>
                <a:schemeClr val="tx1"/>
              </a:solidFill>
              <a:ln w="19050" cap="flat" cmpd="sng">
                <a:no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dirty="0">
                  <a:solidFill>
                    <a:srgbClr val="A5C8B7"/>
                  </a:solidFill>
                </a:endParaRPr>
              </a:p>
            </p:txBody>
          </p:sp>
        </p:grpSp>
      </p:grpSp>
      <p:sp>
        <p:nvSpPr>
          <p:cNvPr id="93" name="Google Shape;1255;p37">
            <a:extLst>
              <a:ext uri="{FF2B5EF4-FFF2-40B4-BE49-F238E27FC236}">
                <a16:creationId xmlns:a16="http://schemas.microsoft.com/office/drawing/2014/main" id="{FBEA9902-FECB-AC77-65A8-202D9572B7F7}"/>
              </a:ext>
            </a:extLst>
          </p:cNvPr>
          <p:cNvSpPr txBox="1"/>
          <p:nvPr/>
        </p:nvSpPr>
        <p:spPr>
          <a:xfrm>
            <a:off x="690651" y="3701119"/>
            <a:ext cx="8148549" cy="932794"/>
          </a:xfrm>
          <a:prstGeom prst="rect">
            <a:avLst/>
          </a:prstGeom>
          <a:noFill/>
          <a:ln>
            <a:noFill/>
          </a:ln>
        </p:spPr>
        <p:txBody>
          <a:bodyPr spcFirstLastPara="1" wrap="square" lIns="91425" tIns="91425" rIns="91425" bIns="91425" anchor="t" anchorCtr="0">
            <a:noAutofit/>
          </a:bodyPr>
          <a:lstStyle/>
          <a:p>
            <a:pPr marL="0" lvl="0" indent="0" rtl="0">
              <a:spcBef>
                <a:spcPts val="0"/>
              </a:spcBef>
              <a:spcAft>
                <a:spcPts val="0"/>
              </a:spcAft>
              <a:buNone/>
            </a:pPr>
            <a:r>
              <a:rPr lang="en" sz="1400" b="1" dirty="0">
                <a:latin typeface="Source Sans Pro SemiBold" panose="020B0503030403020204" pitchFamily="34" charset="0"/>
                <a:ea typeface="Source Sans Pro SemiBold" panose="020B0503030403020204" pitchFamily="34" charset="0"/>
                <a:cs typeface="Fira Sans Extra Condensed"/>
                <a:sym typeface="Fira Sans Extra Condensed"/>
              </a:rPr>
              <a:t>Model development </a:t>
            </a:r>
            <a:r>
              <a:rPr lang="en" sz="1100" dirty="0">
                <a:latin typeface="Source Sans Pro" panose="020B0503030403020204" pitchFamily="34" charset="0"/>
                <a:ea typeface="Source Sans Pro" panose="020B0503030403020204" pitchFamily="34" charset="0"/>
                <a:cs typeface="Fira Sans Extra Condensed"/>
                <a:sym typeface="Fira Sans Extra Condensed"/>
              </a:rPr>
              <a:t>Using repeated (n=50) 3-fold cross-validation, find the best parameters to fit a sparse least squares discriminant analysis (sPLS-DA) model on the training group.  </a:t>
            </a:r>
            <a:endParaRPr lang="en" sz="1400" b="1" dirty="0">
              <a:latin typeface="Source Sans Pro SemiBold" panose="020B0503030403020204" pitchFamily="34" charset="0"/>
              <a:ea typeface="Source Sans Pro SemiBold" panose="020B0503030403020204" pitchFamily="34" charset="0"/>
              <a:cs typeface="Fira Sans Extra Condensed"/>
              <a:sym typeface="Fira Sans Extra Condensed"/>
            </a:endParaRPr>
          </a:p>
        </p:txBody>
      </p:sp>
      <p:sp>
        <p:nvSpPr>
          <p:cNvPr id="94" name="Google Shape;1262;p37">
            <a:extLst>
              <a:ext uri="{FF2B5EF4-FFF2-40B4-BE49-F238E27FC236}">
                <a16:creationId xmlns:a16="http://schemas.microsoft.com/office/drawing/2014/main" id="{F5CBF33E-0432-CE1F-31AD-02333AC5BA0F}"/>
              </a:ext>
            </a:extLst>
          </p:cNvPr>
          <p:cNvSpPr txBox="1"/>
          <p:nvPr/>
        </p:nvSpPr>
        <p:spPr>
          <a:xfrm>
            <a:off x="-114182" y="3647719"/>
            <a:ext cx="849600" cy="533400"/>
          </a:xfrm>
          <a:prstGeom prst="rect">
            <a:avLst/>
          </a:prstGeom>
          <a:noFill/>
          <a:ln>
            <a:noFill/>
          </a:ln>
        </p:spPr>
        <p:txBody>
          <a:bodyPr spcFirstLastPara="1" wrap="square" lIns="91425" tIns="91425" rIns="91425" bIns="91425" anchor="ctr" anchorCtr="0">
            <a:noAutofit/>
          </a:bodyPr>
          <a:lstStyle/>
          <a:p>
            <a:pPr marL="0" lvl="0" indent="0" algn="ctr" rtl="0">
              <a:spcBef>
                <a:spcPts val="0"/>
              </a:spcBef>
              <a:spcAft>
                <a:spcPts val="0"/>
              </a:spcAft>
              <a:buNone/>
            </a:pPr>
            <a:r>
              <a:rPr lang="en" sz="2400" b="1" dirty="0">
                <a:solidFill>
                  <a:schemeClr val="tx1">
                    <a:lumMod val="75000"/>
                    <a:lumOff val="25000"/>
                  </a:schemeClr>
                </a:solidFill>
                <a:latin typeface="Source Sans Pro SemiBold" panose="020B0503030403020204" pitchFamily="34" charset="0"/>
                <a:ea typeface="Source Sans Pro SemiBold" panose="020B0503030403020204" pitchFamily="34" charset="0"/>
                <a:cs typeface="Fira Sans Extra Condensed"/>
                <a:sym typeface="Fira Sans Extra Condensed"/>
              </a:rPr>
              <a:t>04</a:t>
            </a:r>
            <a:endParaRPr sz="2400" b="1" dirty="0">
              <a:solidFill>
                <a:schemeClr val="tx1">
                  <a:lumMod val="75000"/>
                  <a:lumOff val="25000"/>
                </a:schemeClr>
              </a:solidFill>
              <a:latin typeface="Source Sans Pro SemiBold" panose="020B0503030403020204" pitchFamily="34" charset="0"/>
              <a:ea typeface="Source Sans Pro SemiBold" panose="020B0503030403020204" pitchFamily="34" charset="0"/>
              <a:cs typeface="Fira Sans Extra Condensed"/>
              <a:sym typeface="Fira Sans Extra Condensed"/>
            </a:endParaRPr>
          </a:p>
        </p:txBody>
      </p:sp>
      <p:grpSp>
        <p:nvGrpSpPr>
          <p:cNvPr id="98" name="Google Shape;1222;p37">
            <a:extLst>
              <a:ext uri="{FF2B5EF4-FFF2-40B4-BE49-F238E27FC236}">
                <a16:creationId xmlns:a16="http://schemas.microsoft.com/office/drawing/2014/main" id="{1381E044-B9DE-09C5-342F-A133D8229DF9}"/>
              </a:ext>
            </a:extLst>
          </p:cNvPr>
          <p:cNvGrpSpPr/>
          <p:nvPr/>
        </p:nvGrpSpPr>
        <p:grpSpPr>
          <a:xfrm>
            <a:off x="491488" y="5972095"/>
            <a:ext cx="212400" cy="409673"/>
            <a:chOff x="1532200" y="2458777"/>
            <a:chExt cx="212400" cy="409673"/>
          </a:xfrm>
        </p:grpSpPr>
        <p:cxnSp>
          <p:nvCxnSpPr>
            <p:cNvPr id="99" name="Google Shape;1223;p37">
              <a:extLst>
                <a:ext uri="{FF2B5EF4-FFF2-40B4-BE49-F238E27FC236}">
                  <a16:creationId xmlns:a16="http://schemas.microsoft.com/office/drawing/2014/main" id="{43A1A59B-F063-A984-A9FF-2DA3EF19E41F}"/>
                </a:ext>
              </a:extLst>
            </p:cNvPr>
            <p:cNvCxnSpPr>
              <a:cxnSpLocks/>
              <a:endCxn id="102" idx="0"/>
            </p:cNvCxnSpPr>
            <p:nvPr/>
          </p:nvCxnSpPr>
          <p:spPr>
            <a:xfrm>
              <a:off x="1638483" y="2458777"/>
              <a:ext cx="0" cy="255106"/>
            </a:xfrm>
            <a:prstGeom prst="straightConnector1">
              <a:avLst/>
            </a:prstGeom>
            <a:noFill/>
            <a:ln w="9525" cap="flat" cmpd="sng">
              <a:solidFill>
                <a:schemeClr val="tx1"/>
              </a:solidFill>
              <a:prstDash val="dot"/>
              <a:round/>
              <a:headEnd type="none" w="med" len="med"/>
              <a:tailEnd type="none" w="med" len="med"/>
            </a:ln>
          </p:spPr>
        </p:cxnSp>
        <p:grpSp>
          <p:nvGrpSpPr>
            <p:cNvPr id="100" name="Google Shape;1225;p37">
              <a:extLst>
                <a:ext uri="{FF2B5EF4-FFF2-40B4-BE49-F238E27FC236}">
                  <a16:creationId xmlns:a16="http://schemas.microsoft.com/office/drawing/2014/main" id="{7C8162D5-A59F-2808-9DFA-8398FA484165}"/>
                </a:ext>
              </a:extLst>
            </p:cNvPr>
            <p:cNvGrpSpPr/>
            <p:nvPr/>
          </p:nvGrpSpPr>
          <p:grpSpPr>
            <a:xfrm>
              <a:off x="1532200" y="2656050"/>
              <a:ext cx="212400" cy="212400"/>
              <a:chOff x="1502200" y="2740350"/>
              <a:chExt cx="212400" cy="212400"/>
            </a:xfrm>
          </p:grpSpPr>
          <p:sp>
            <p:nvSpPr>
              <p:cNvPr id="101" name="Google Shape;1226;p37">
                <a:extLst>
                  <a:ext uri="{FF2B5EF4-FFF2-40B4-BE49-F238E27FC236}">
                    <a16:creationId xmlns:a16="http://schemas.microsoft.com/office/drawing/2014/main" id="{7EF6EF8E-D568-C8F7-FC6D-A62F5EB1DDFD}"/>
                  </a:ext>
                </a:extLst>
              </p:cNvPr>
              <p:cNvSpPr/>
              <p:nvPr/>
            </p:nvSpPr>
            <p:spPr>
              <a:xfrm>
                <a:off x="1502200" y="2740350"/>
                <a:ext cx="212400" cy="212400"/>
              </a:xfrm>
              <a:prstGeom prst="ellipse">
                <a:avLst/>
              </a:prstGeom>
              <a:solidFill>
                <a:srgbClr val="FFFFFF"/>
              </a:solidFill>
              <a:ln w="19050" cap="flat" cmpd="sng">
                <a:solidFill>
                  <a:schemeClr val="tx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2" name="Google Shape;1224;p37">
                <a:extLst>
                  <a:ext uri="{FF2B5EF4-FFF2-40B4-BE49-F238E27FC236}">
                    <a16:creationId xmlns:a16="http://schemas.microsoft.com/office/drawing/2014/main" id="{AE1D8CA4-D657-00EA-7C89-BE270A8ACC33}"/>
                  </a:ext>
                </a:extLst>
              </p:cNvPr>
              <p:cNvSpPr/>
              <p:nvPr/>
            </p:nvSpPr>
            <p:spPr>
              <a:xfrm>
                <a:off x="1560033" y="2798183"/>
                <a:ext cx="96900" cy="96900"/>
              </a:xfrm>
              <a:prstGeom prst="ellipse">
                <a:avLst/>
              </a:prstGeom>
              <a:solidFill>
                <a:schemeClr val="tx1"/>
              </a:solidFill>
              <a:ln w="19050" cap="flat" cmpd="sng">
                <a:no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dirty="0">
                  <a:solidFill>
                    <a:srgbClr val="A5C8B7"/>
                  </a:solidFill>
                </a:endParaRPr>
              </a:p>
            </p:txBody>
          </p:sp>
        </p:grpSp>
      </p:grpSp>
      <p:sp>
        <p:nvSpPr>
          <p:cNvPr id="103" name="Google Shape;1255;p37">
            <a:extLst>
              <a:ext uri="{FF2B5EF4-FFF2-40B4-BE49-F238E27FC236}">
                <a16:creationId xmlns:a16="http://schemas.microsoft.com/office/drawing/2014/main" id="{450AAB55-CF7C-078E-1CD2-23B9DD2E74A6}"/>
              </a:ext>
            </a:extLst>
          </p:cNvPr>
          <p:cNvSpPr txBox="1"/>
          <p:nvPr/>
        </p:nvSpPr>
        <p:spPr>
          <a:xfrm>
            <a:off x="714411" y="6088309"/>
            <a:ext cx="4843327" cy="932794"/>
          </a:xfrm>
          <a:prstGeom prst="rect">
            <a:avLst/>
          </a:prstGeom>
          <a:noFill/>
          <a:ln>
            <a:noFill/>
          </a:ln>
        </p:spPr>
        <p:txBody>
          <a:bodyPr spcFirstLastPara="1" wrap="square" lIns="91425" tIns="91425" rIns="91425" bIns="91425" anchor="t" anchorCtr="0">
            <a:noAutofit/>
          </a:bodyPr>
          <a:lstStyle/>
          <a:p>
            <a:pPr marL="0" lvl="0" indent="0" rtl="0">
              <a:spcBef>
                <a:spcPts val="0"/>
              </a:spcBef>
              <a:spcAft>
                <a:spcPts val="0"/>
              </a:spcAft>
              <a:buNone/>
            </a:pPr>
            <a:r>
              <a:rPr lang="en" sz="1400" b="1" dirty="0">
                <a:latin typeface="Source Sans Pro SemiBold" panose="020B0503030403020204" pitchFamily="34" charset="0"/>
                <a:ea typeface="Source Sans Pro SemiBold" panose="020B0503030403020204" pitchFamily="34" charset="0"/>
                <a:cs typeface="Fira Sans Extra Condensed"/>
                <a:sym typeface="Fira Sans Extra Condensed"/>
              </a:rPr>
              <a:t>Model validation</a:t>
            </a:r>
          </a:p>
          <a:p>
            <a:pPr marL="0" lvl="0" indent="0" rtl="0">
              <a:spcBef>
                <a:spcPts val="0"/>
              </a:spcBef>
              <a:spcAft>
                <a:spcPts val="0"/>
              </a:spcAft>
              <a:buNone/>
            </a:pPr>
            <a:r>
              <a:rPr lang="en" sz="1100" dirty="0">
                <a:latin typeface="Source Sans Pro" panose="020B0503030403020204" pitchFamily="34" charset="0"/>
                <a:ea typeface="Source Sans Pro" panose="020B0503030403020204" pitchFamily="34" charset="0"/>
                <a:cs typeface="Fira Sans Extra Condensed"/>
                <a:sym typeface="Fira Sans Extra Condensed"/>
              </a:rPr>
              <a:t>Evaluate final model performance on an independent validation cohort </a:t>
            </a:r>
          </a:p>
        </p:txBody>
      </p:sp>
      <p:sp>
        <p:nvSpPr>
          <p:cNvPr id="104" name="Google Shape;1262;p37">
            <a:extLst>
              <a:ext uri="{FF2B5EF4-FFF2-40B4-BE49-F238E27FC236}">
                <a16:creationId xmlns:a16="http://schemas.microsoft.com/office/drawing/2014/main" id="{780298FB-0303-29C1-01EA-42A2CF0335B7}"/>
              </a:ext>
            </a:extLst>
          </p:cNvPr>
          <p:cNvSpPr txBox="1"/>
          <p:nvPr/>
        </p:nvSpPr>
        <p:spPr>
          <a:xfrm>
            <a:off x="-151162" y="6005583"/>
            <a:ext cx="849600" cy="533400"/>
          </a:xfrm>
          <a:prstGeom prst="rect">
            <a:avLst/>
          </a:prstGeom>
          <a:noFill/>
          <a:ln>
            <a:noFill/>
          </a:ln>
        </p:spPr>
        <p:txBody>
          <a:bodyPr spcFirstLastPara="1" wrap="square" lIns="91425" tIns="91425" rIns="91425" bIns="91425" anchor="ctr" anchorCtr="0">
            <a:noAutofit/>
          </a:bodyPr>
          <a:lstStyle/>
          <a:p>
            <a:pPr marL="0" lvl="0" indent="0" algn="ctr" rtl="0">
              <a:spcBef>
                <a:spcPts val="0"/>
              </a:spcBef>
              <a:spcAft>
                <a:spcPts val="0"/>
              </a:spcAft>
              <a:buNone/>
            </a:pPr>
            <a:r>
              <a:rPr lang="en" sz="2400" b="1" dirty="0">
                <a:solidFill>
                  <a:schemeClr val="tx1">
                    <a:lumMod val="75000"/>
                    <a:lumOff val="25000"/>
                  </a:schemeClr>
                </a:solidFill>
                <a:latin typeface="Source Sans Pro SemiBold" panose="020B0503030403020204" pitchFamily="34" charset="0"/>
                <a:ea typeface="Source Sans Pro SemiBold" panose="020B0503030403020204" pitchFamily="34" charset="0"/>
                <a:cs typeface="Fira Sans Extra Condensed"/>
                <a:sym typeface="Fira Sans Extra Condensed"/>
              </a:rPr>
              <a:t>05</a:t>
            </a:r>
            <a:endParaRPr sz="2400" b="1" dirty="0">
              <a:solidFill>
                <a:schemeClr val="tx1">
                  <a:lumMod val="75000"/>
                  <a:lumOff val="25000"/>
                </a:schemeClr>
              </a:solidFill>
              <a:latin typeface="Source Sans Pro SemiBold" panose="020B0503030403020204" pitchFamily="34" charset="0"/>
              <a:ea typeface="Source Sans Pro SemiBold" panose="020B0503030403020204" pitchFamily="34" charset="0"/>
              <a:cs typeface="Fira Sans Extra Condensed"/>
              <a:sym typeface="Fira Sans Extra Condensed"/>
            </a:endParaRPr>
          </a:p>
        </p:txBody>
      </p:sp>
      <p:pic>
        <p:nvPicPr>
          <p:cNvPr id="9" name="Picture 8" descr="A black background with a black square&#10;&#10;Description automatically generated">
            <a:extLst>
              <a:ext uri="{FF2B5EF4-FFF2-40B4-BE49-F238E27FC236}">
                <a16:creationId xmlns:a16="http://schemas.microsoft.com/office/drawing/2014/main" id="{6AE00838-B7E2-FA74-743A-2FF22630A232}"/>
              </a:ext>
            </a:extLst>
          </p:cNvPr>
          <p:cNvPicPr>
            <a:picLocks noChangeAspect="1"/>
          </p:cNvPicPr>
          <p:nvPr/>
        </p:nvPicPr>
        <p:blipFill>
          <a:blip r:embed="rId3"/>
          <a:stretch>
            <a:fillRect/>
          </a:stretch>
        </p:blipFill>
        <p:spPr>
          <a:xfrm>
            <a:off x="2692813" y="136797"/>
            <a:ext cx="849145" cy="849145"/>
          </a:xfrm>
          <a:prstGeom prst="rect">
            <a:avLst/>
          </a:prstGeom>
        </p:spPr>
      </p:pic>
      <p:pic>
        <p:nvPicPr>
          <p:cNvPr id="15" name="Picture 14" descr="A blue and yellow logo&#10;&#10;Description automatically generated">
            <a:extLst>
              <a:ext uri="{FF2B5EF4-FFF2-40B4-BE49-F238E27FC236}">
                <a16:creationId xmlns:a16="http://schemas.microsoft.com/office/drawing/2014/main" id="{5766E1BB-4FF5-6E25-0B41-F9F0F37A4B0B}"/>
              </a:ext>
            </a:extLst>
          </p:cNvPr>
          <p:cNvPicPr>
            <a:picLocks noChangeAspect="1"/>
          </p:cNvPicPr>
          <p:nvPr/>
        </p:nvPicPr>
        <p:blipFill>
          <a:blip r:embed="rId4"/>
          <a:stretch>
            <a:fillRect/>
          </a:stretch>
        </p:blipFill>
        <p:spPr>
          <a:xfrm>
            <a:off x="2633292" y="749872"/>
            <a:ext cx="1035601" cy="411745"/>
          </a:xfrm>
          <a:prstGeom prst="rect">
            <a:avLst/>
          </a:prstGeom>
        </p:spPr>
      </p:pic>
      <p:sp>
        <p:nvSpPr>
          <p:cNvPr id="17" name="Rounded Rectangle 16">
            <a:extLst>
              <a:ext uri="{FF2B5EF4-FFF2-40B4-BE49-F238E27FC236}">
                <a16:creationId xmlns:a16="http://schemas.microsoft.com/office/drawing/2014/main" id="{D234ED19-DDF2-6A31-DC83-F1DEEE792FC5}"/>
              </a:ext>
            </a:extLst>
          </p:cNvPr>
          <p:cNvSpPr/>
          <p:nvPr/>
        </p:nvSpPr>
        <p:spPr>
          <a:xfrm>
            <a:off x="3696443" y="415092"/>
            <a:ext cx="1066680" cy="246796"/>
          </a:xfrm>
          <a:prstGeom prst="roundRect">
            <a:avLst/>
          </a:prstGeom>
          <a:noFill/>
          <a:ln>
            <a:solidFill>
              <a:schemeClr val="accent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400" dirty="0">
                <a:solidFill>
                  <a:schemeClr val="tx1"/>
                </a:solidFill>
                <a:latin typeface="Source Sans Pro Light" panose="020B0403030403020204" pitchFamily="34" charset="0"/>
                <a:ea typeface="Source Sans Pro Light" panose="020B0403030403020204" pitchFamily="34" charset="0"/>
              </a:rPr>
              <a:t>GSE100197</a:t>
            </a:r>
          </a:p>
        </p:txBody>
      </p:sp>
      <p:sp>
        <p:nvSpPr>
          <p:cNvPr id="19" name="Rounded Rectangle 18">
            <a:extLst>
              <a:ext uri="{FF2B5EF4-FFF2-40B4-BE49-F238E27FC236}">
                <a16:creationId xmlns:a16="http://schemas.microsoft.com/office/drawing/2014/main" id="{0EE65EB1-FF07-2B40-72B1-05FA47DCC941}"/>
              </a:ext>
            </a:extLst>
          </p:cNvPr>
          <p:cNvSpPr/>
          <p:nvPr/>
        </p:nvSpPr>
        <p:spPr>
          <a:xfrm>
            <a:off x="3696443" y="710367"/>
            <a:ext cx="1066680" cy="243680"/>
          </a:xfrm>
          <a:prstGeom prst="roundRect">
            <a:avLst/>
          </a:prstGeom>
          <a:noFill/>
          <a:ln>
            <a:solidFill>
              <a:schemeClr val="accent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400" dirty="0">
                <a:solidFill>
                  <a:schemeClr val="tx1"/>
                </a:solidFill>
                <a:latin typeface="Source Sans Pro Light" panose="020B0403030403020204" pitchFamily="34" charset="0"/>
                <a:ea typeface="Source Sans Pro Light" panose="020B0403030403020204" pitchFamily="34" charset="0"/>
              </a:rPr>
              <a:t>GSE103253</a:t>
            </a:r>
          </a:p>
        </p:txBody>
      </p:sp>
      <p:sp>
        <p:nvSpPr>
          <p:cNvPr id="20" name="Rounded Rectangle 19">
            <a:extLst>
              <a:ext uri="{FF2B5EF4-FFF2-40B4-BE49-F238E27FC236}">
                <a16:creationId xmlns:a16="http://schemas.microsoft.com/office/drawing/2014/main" id="{758909E3-8FC0-E7C5-C318-EE555542D616}"/>
              </a:ext>
            </a:extLst>
          </p:cNvPr>
          <p:cNvSpPr/>
          <p:nvPr/>
        </p:nvSpPr>
        <p:spPr>
          <a:xfrm>
            <a:off x="5880810" y="1004696"/>
            <a:ext cx="1064875" cy="240791"/>
          </a:xfrm>
          <a:prstGeom prst="roundRect">
            <a:avLst/>
          </a:prstGeom>
          <a:noFill/>
          <a:ln>
            <a:solidFill>
              <a:schemeClr val="accent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400" dirty="0">
                <a:solidFill>
                  <a:schemeClr val="tx1"/>
                </a:solidFill>
                <a:latin typeface="Source Sans Pro Light" panose="020B0403030403020204" pitchFamily="34" charset="0"/>
                <a:ea typeface="Source Sans Pro Light" panose="020B0403030403020204" pitchFamily="34" charset="0"/>
              </a:rPr>
              <a:t>GSE57767</a:t>
            </a:r>
          </a:p>
        </p:txBody>
      </p:sp>
      <p:sp>
        <p:nvSpPr>
          <p:cNvPr id="21" name="Rounded Rectangle 20">
            <a:extLst>
              <a:ext uri="{FF2B5EF4-FFF2-40B4-BE49-F238E27FC236}">
                <a16:creationId xmlns:a16="http://schemas.microsoft.com/office/drawing/2014/main" id="{B6B119C4-C544-20A2-3E5E-BA8450A2EBA5}"/>
              </a:ext>
            </a:extLst>
          </p:cNvPr>
          <p:cNvSpPr/>
          <p:nvPr/>
        </p:nvSpPr>
        <p:spPr>
          <a:xfrm>
            <a:off x="7004723" y="703559"/>
            <a:ext cx="1029454" cy="235892"/>
          </a:xfrm>
          <a:prstGeom prst="roundRect">
            <a:avLst/>
          </a:prstGeom>
          <a:noFill/>
          <a:ln>
            <a:solidFill>
              <a:schemeClr val="accent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400" dirty="0">
                <a:solidFill>
                  <a:schemeClr val="tx1"/>
                </a:solidFill>
                <a:latin typeface="Source Sans Pro Light" panose="020B0403030403020204" pitchFamily="34" charset="0"/>
                <a:ea typeface="Source Sans Pro Light" panose="020B0403030403020204" pitchFamily="34" charset="0"/>
              </a:rPr>
              <a:t>GSE73375</a:t>
            </a:r>
          </a:p>
        </p:txBody>
      </p:sp>
      <p:sp>
        <p:nvSpPr>
          <p:cNvPr id="22" name="Rounded Rectangle 21">
            <a:extLst>
              <a:ext uri="{FF2B5EF4-FFF2-40B4-BE49-F238E27FC236}">
                <a16:creationId xmlns:a16="http://schemas.microsoft.com/office/drawing/2014/main" id="{92D76D3D-D1D1-4837-AD42-2E1DC49F3366}"/>
              </a:ext>
            </a:extLst>
          </p:cNvPr>
          <p:cNvSpPr/>
          <p:nvPr/>
        </p:nvSpPr>
        <p:spPr>
          <a:xfrm>
            <a:off x="5880810" y="398628"/>
            <a:ext cx="1066680" cy="259603"/>
          </a:xfrm>
          <a:prstGeom prst="roundRect">
            <a:avLst/>
          </a:prstGeom>
          <a:noFill/>
          <a:ln>
            <a:solidFill>
              <a:schemeClr val="accent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400" dirty="0">
                <a:solidFill>
                  <a:schemeClr val="tx1"/>
                </a:solidFill>
                <a:latin typeface="Source Sans Pro Light" panose="020B0403030403020204" pitchFamily="34" charset="0"/>
                <a:ea typeface="Source Sans Pro Light" panose="020B0403030403020204" pitchFamily="34" charset="0"/>
              </a:rPr>
              <a:t>GSE125605</a:t>
            </a:r>
          </a:p>
        </p:txBody>
      </p:sp>
      <p:sp>
        <p:nvSpPr>
          <p:cNvPr id="29" name="Rounded Rectangle 28">
            <a:extLst>
              <a:ext uri="{FF2B5EF4-FFF2-40B4-BE49-F238E27FC236}">
                <a16:creationId xmlns:a16="http://schemas.microsoft.com/office/drawing/2014/main" id="{CD47768E-A5A5-CEB1-5484-79D78D50735C}"/>
              </a:ext>
            </a:extLst>
          </p:cNvPr>
          <p:cNvSpPr/>
          <p:nvPr/>
        </p:nvSpPr>
        <p:spPr>
          <a:xfrm>
            <a:off x="4815935" y="415092"/>
            <a:ext cx="1029457" cy="243681"/>
          </a:xfrm>
          <a:prstGeom prst="roundRect">
            <a:avLst/>
          </a:prstGeom>
          <a:noFill/>
          <a:ln>
            <a:solidFill>
              <a:schemeClr val="accent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400" dirty="0">
                <a:solidFill>
                  <a:schemeClr val="tx1"/>
                </a:solidFill>
                <a:latin typeface="Source Sans Pro Light" panose="020B0403030403020204" pitchFamily="34" charset="0"/>
                <a:ea typeface="Source Sans Pro Light" panose="020B0403030403020204" pitchFamily="34" charset="0"/>
              </a:rPr>
              <a:t>GSE98224</a:t>
            </a:r>
          </a:p>
        </p:txBody>
      </p:sp>
      <p:sp>
        <p:nvSpPr>
          <p:cNvPr id="30" name="Rounded Rectangle 29">
            <a:extLst>
              <a:ext uri="{FF2B5EF4-FFF2-40B4-BE49-F238E27FC236}">
                <a16:creationId xmlns:a16="http://schemas.microsoft.com/office/drawing/2014/main" id="{F4891494-C164-EA70-51C2-BEEB4D0EC0AE}"/>
              </a:ext>
            </a:extLst>
          </p:cNvPr>
          <p:cNvSpPr/>
          <p:nvPr/>
        </p:nvSpPr>
        <p:spPr>
          <a:xfrm>
            <a:off x="4822080" y="710367"/>
            <a:ext cx="1029456" cy="243680"/>
          </a:xfrm>
          <a:prstGeom prst="roundRect">
            <a:avLst/>
          </a:prstGeom>
          <a:noFill/>
          <a:ln>
            <a:solidFill>
              <a:schemeClr val="accent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400" dirty="0">
                <a:solidFill>
                  <a:schemeClr val="tx1"/>
                </a:solidFill>
                <a:latin typeface="Source Sans Pro Light" panose="020B0403030403020204" pitchFamily="34" charset="0"/>
                <a:ea typeface="Source Sans Pro Light" panose="020B0403030403020204" pitchFamily="34" charset="0"/>
              </a:rPr>
              <a:t>GSE203396</a:t>
            </a:r>
          </a:p>
        </p:txBody>
      </p:sp>
      <p:sp>
        <p:nvSpPr>
          <p:cNvPr id="31" name="Rounded Rectangle 30">
            <a:extLst>
              <a:ext uri="{FF2B5EF4-FFF2-40B4-BE49-F238E27FC236}">
                <a16:creationId xmlns:a16="http://schemas.microsoft.com/office/drawing/2014/main" id="{FCB7EE02-61A4-2A2F-A6A5-15B24E73097C}"/>
              </a:ext>
            </a:extLst>
          </p:cNvPr>
          <p:cNvSpPr/>
          <p:nvPr/>
        </p:nvSpPr>
        <p:spPr>
          <a:xfrm>
            <a:off x="5882616" y="714026"/>
            <a:ext cx="1064874" cy="238125"/>
          </a:xfrm>
          <a:prstGeom prst="roundRect">
            <a:avLst/>
          </a:prstGeom>
          <a:noFill/>
          <a:ln>
            <a:solidFill>
              <a:schemeClr val="accent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400" dirty="0">
                <a:solidFill>
                  <a:schemeClr val="tx1"/>
                </a:solidFill>
                <a:latin typeface="Source Sans Pro Light" panose="020B0403030403020204" pitchFamily="34" charset="0"/>
                <a:ea typeface="Source Sans Pro Light" panose="020B0403030403020204" pitchFamily="34" charset="0"/>
              </a:rPr>
              <a:t>GSE75196</a:t>
            </a:r>
          </a:p>
        </p:txBody>
      </p:sp>
      <p:sp>
        <p:nvSpPr>
          <p:cNvPr id="32" name="Rounded Rectangle 31">
            <a:extLst>
              <a:ext uri="{FF2B5EF4-FFF2-40B4-BE49-F238E27FC236}">
                <a16:creationId xmlns:a16="http://schemas.microsoft.com/office/drawing/2014/main" id="{FF2989DD-4979-1570-B3D5-9B4E8BCD9E26}"/>
              </a:ext>
            </a:extLst>
          </p:cNvPr>
          <p:cNvSpPr/>
          <p:nvPr/>
        </p:nvSpPr>
        <p:spPr>
          <a:xfrm>
            <a:off x="4815935" y="1001807"/>
            <a:ext cx="1029457" cy="243680"/>
          </a:xfrm>
          <a:prstGeom prst="roundRect">
            <a:avLst/>
          </a:prstGeom>
          <a:noFill/>
          <a:ln>
            <a:solidFill>
              <a:schemeClr val="accent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400" dirty="0">
                <a:solidFill>
                  <a:schemeClr val="tx1"/>
                </a:solidFill>
                <a:latin typeface="Source Sans Pro Light" panose="020B0403030403020204" pitchFamily="34" charset="0"/>
                <a:ea typeface="Source Sans Pro Light" panose="020B0403030403020204" pitchFamily="34" charset="0"/>
              </a:rPr>
              <a:t>GSE120981</a:t>
            </a:r>
          </a:p>
        </p:txBody>
      </p:sp>
      <p:sp>
        <p:nvSpPr>
          <p:cNvPr id="33" name="Rounded Rectangle 32">
            <a:extLst>
              <a:ext uri="{FF2B5EF4-FFF2-40B4-BE49-F238E27FC236}">
                <a16:creationId xmlns:a16="http://schemas.microsoft.com/office/drawing/2014/main" id="{CC725582-D771-DF9A-A63A-AD6B159BD480}"/>
              </a:ext>
            </a:extLst>
          </p:cNvPr>
          <p:cNvSpPr/>
          <p:nvPr/>
        </p:nvSpPr>
        <p:spPr>
          <a:xfrm>
            <a:off x="7001650" y="405923"/>
            <a:ext cx="1035601" cy="243680"/>
          </a:xfrm>
          <a:prstGeom prst="roundRect">
            <a:avLst/>
          </a:prstGeom>
          <a:noFill/>
          <a:ln>
            <a:solidFill>
              <a:schemeClr val="accent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400" dirty="0">
                <a:solidFill>
                  <a:schemeClr val="tx1"/>
                </a:solidFill>
                <a:latin typeface="Source Sans Pro Light" panose="020B0403030403020204" pitchFamily="34" charset="0"/>
                <a:ea typeface="Source Sans Pro Light" panose="020B0403030403020204" pitchFamily="34" charset="0"/>
              </a:rPr>
              <a:t>GSE49343</a:t>
            </a:r>
          </a:p>
        </p:txBody>
      </p:sp>
      <p:sp>
        <p:nvSpPr>
          <p:cNvPr id="34" name="Rectangle 33">
            <a:extLst>
              <a:ext uri="{FF2B5EF4-FFF2-40B4-BE49-F238E27FC236}">
                <a16:creationId xmlns:a16="http://schemas.microsoft.com/office/drawing/2014/main" id="{850A5CA8-1E3B-AE8B-7DFC-3054318A0F2C}"/>
              </a:ext>
            </a:extLst>
          </p:cNvPr>
          <p:cNvSpPr/>
          <p:nvPr/>
        </p:nvSpPr>
        <p:spPr>
          <a:xfrm>
            <a:off x="1503636" y="4418095"/>
            <a:ext cx="2248854" cy="435561"/>
          </a:xfrm>
          <a:prstGeom prst="rect">
            <a:avLst/>
          </a:prstGeom>
          <a:solidFill>
            <a:schemeClr val="accent6">
              <a:lumMod val="20000"/>
              <a:lumOff val="8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200" dirty="0">
                <a:solidFill>
                  <a:schemeClr val="tx1"/>
                </a:solidFill>
                <a:latin typeface="Manrope" pitchFamily="2" charset="0"/>
              </a:rPr>
              <a:t>TRAINING GROUP </a:t>
            </a:r>
          </a:p>
          <a:p>
            <a:pPr algn="ctr"/>
            <a:r>
              <a:rPr lang="en-CA" sz="1200" dirty="0">
                <a:solidFill>
                  <a:schemeClr val="tx1"/>
                </a:solidFill>
                <a:latin typeface="Manrope" pitchFamily="2" charset="0"/>
              </a:rPr>
              <a:t>(N=83, 42 EOPE, 41 nPTB)</a:t>
            </a:r>
          </a:p>
        </p:txBody>
      </p:sp>
      <p:sp>
        <p:nvSpPr>
          <p:cNvPr id="35" name="Rectangle 34">
            <a:extLst>
              <a:ext uri="{FF2B5EF4-FFF2-40B4-BE49-F238E27FC236}">
                <a16:creationId xmlns:a16="http://schemas.microsoft.com/office/drawing/2014/main" id="{28AC0B3B-23A7-6FDA-0DA3-AACE422AF682}"/>
              </a:ext>
            </a:extLst>
          </p:cNvPr>
          <p:cNvSpPr/>
          <p:nvPr/>
        </p:nvSpPr>
        <p:spPr>
          <a:xfrm>
            <a:off x="1506099" y="5085612"/>
            <a:ext cx="704601" cy="184795"/>
          </a:xfrm>
          <a:prstGeom prst="rect">
            <a:avLst/>
          </a:prstGeom>
          <a:solidFill>
            <a:schemeClr val="accent6">
              <a:lumMod val="20000"/>
              <a:lumOff val="8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200" dirty="0">
                <a:solidFill>
                  <a:schemeClr val="tx1"/>
                </a:solidFill>
                <a:latin typeface="Manrope" pitchFamily="2" charset="0"/>
              </a:rPr>
              <a:t>TRAIN</a:t>
            </a:r>
          </a:p>
        </p:txBody>
      </p:sp>
      <p:sp>
        <p:nvSpPr>
          <p:cNvPr id="36" name="Rectangle 35">
            <a:extLst>
              <a:ext uri="{FF2B5EF4-FFF2-40B4-BE49-F238E27FC236}">
                <a16:creationId xmlns:a16="http://schemas.microsoft.com/office/drawing/2014/main" id="{88FC984E-4B84-1144-B49C-20EA94F5109E}"/>
              </a:ext>
            </a:extLst>
          </p:cNvPr>
          <p:cNvSpPr/>
          <p:nvPr/>
        </p:nvSpPr>
        <p:spPr>
          <a:xfrm>
            <a:off x="2275952" y="5087230"/>
            <a:ext cx="704601" cy="184795"/>
          </a:xfrm>
          <a:prstGeom prst="rect">
            <a:avLst/>
          </a:prstGeom>
          <a:solidFill>
            <a:schemeClr val="accent4">
              <a:lumMod val="20000"/>
              <a:lumOff val="8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200" dirty="0">
                <a:solidFill>
                  <a:schemeClr val="tx1"/>
                </a:solidFill>
                <a:latin typeface="Manrope" pitchFamily="2" charset="0"/>
              </a:rPr>
              <a:t>test</a:t>
            </a:r>
          </a:p>
        </p:txBody>
      </p:sp>
      <p:sp>
        <p:nvSpPr>
          <p:cNvPr id="37" name="Rectangle 36">
            <a:extLst>
              <a:ext uri="{FF2B5EF4-FFF2-40B4-BE49-F238E27FC236}">
                <a16:creationId xmlns:a16="http://schemas.microsoft.com/office/drawing/2014/main" id="{ACB50DCC-684B-F23F-1218-DDE15FD2081E}"/>
              </a:ext>
            </a:extLst>
          </p:cNvPr>
          <p:cNvSpPr/>
          <p:nvPr/>
        </p:nvSpPr>
        <p:spPr>
          <a:xfrm>
            <a:off x="3040643" y="5090539"/>
            <a:ext cx="704601" cy="184795"/>
          </a:xfrm>
          <a:prstGeom prst="rect">
            <a:avLst/>
          </a:prstGeom>
          <a:solidFill>
            <a:schemeClr val="accent4">
              <a:lumMod val="20000"/>
              <a:lumOff val="8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200" dirty="0">
                <a:solidFill>
                  <a:schemeClr val="tx1"/>
                </a:solidFill>
                <a:latin typeface="Manrope" pitchFamily="2" charset="0"/>
              </a:rPr>
              <a:t>test</a:t>
            </a:r>
          </a:p>
        </p:txBody>
      </p:sp>
      <p:sp>
        <p:nvSpPr>
          <p:cNvPr id="38" name="Rectangle 37">
            <a:extLst>
              <a:ext uri="{FF2B5EF4-FFF2-40B4-BE49-F238E27FC236}">
                <a16:creationId xmlns:a16="http://schemas.microsoft.com/office/drawing/2014/main" id="{C410C335-302D-8528-3D56-A9CF5CF08CA8}"/>
              </a:ext>
            </a:extLst>
          </p:cNvPr>
          <p:cNvSpPr/>
          <p:nvPr/>
        </p:nvSpPr>
        <p:spPr>
          <a:xfrm>
            <a:off x="1506099" y="5316755"/>
            <a:ext cx="704601" cy="184795"/>
          </a:xfrm>
          <a:prstGeom prst="rect">
            <a:avLst/>
          </a:prstGeom>
          <a:solidFill>
            <a:schemeClr val="accent4">
              <a:lumMod val="20000"/>
              <a:lumOff val="8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200" dirty="0">
                <a:solidFill>
                  <a:schemeClr val="tx1"/>
                </a:solidFill>
                <a:latin typeface="Manrope" pitchFamily="2" charset="0"/>
              </a:rPr>
              <a:t>test</a:t>
            </a:r>
          </a:p>
        </p:txBody>
      </p:sp>
      <p:sp>
        <p:nvSpPr>
          <p:cNvPr id="39" name="Rectangle 38">
            <a:extLst>
              <a:ext uri="{FF2B5EF4-FFF2-40B4-BE49-F238E27FC236}">
                <a16:creationId xmlns:a16="http://schemas.microsoft.com/office/drawing/2014/main" id="{365B8828-1235-3872-1745-7C83DE9E412E}"/>
              </a:ext>
            </a:extLst>
          </p:cNvPr>
          <p:cNvSpPr/>
          <p:nvPr/>
        </p:nvSpPr>
        <p:spPr>
          <a:xfrm>
            <a:off x="2275952" y="5318373"/>
            <a:ext cx="704601" cy="184795"/>
          </a:xfrm>
          <a:prstGeom prst="rect">
            <a:avLst/>
          </a:prstGeom>
          <a:solidFill>
            <a:schemeClr val="accent6">
              <a:lumMod val="20000"/>
              <a:lumOff val="8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200" dirty="0">
                <a:solidFill>
                  <a:schemeClr val="tx1"/>
                </a:solidFill>
                <a:latin typeface="Manrope" pitchFamily="2" charset="0"/>
              </a:rPr>
              <a:t>TRAIN</a:t>
            </a:r>
          </a:p>
        </p:txBody>
      </p:sp>
      <p:sp>
        <p:nvSpPr>
          <p:cNvPr id="40" name="Rectangle 39">
            <a:extLst>
              <a:ext uri="{FF2B5EF4-FFF2-40B4-BE49-F238E27FC236}">
                <a16:creationId xmlns:a16="http://schemas.microsoft.com/office/drawing/2014/main" id="{FF1BC6EB-5D8B-90BA-7FF0-D9CB1BB7F5E9}"/>
              </a:ext>
            </a:extLst>
          </p:cNvPr>
          <p:cNvSpPr/>
          <p:nvPr/>
        </p:nvSpPr>
        <p:spPr>
          <a:xfrm>
            <a:off x="3040643" y="5321682"/>
            <a:ext cx="704601" cy="184795"/>
          </a:xfrm>
          <a:prstGeom prst="rect">
            <a:avLst/>
          </a:prstGeom>
          <a:solidFill>
            <a:schemeClr val="accent4">
              <a:lumMod val="20000"/>
              <a:lumOff val="8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200" dirty="0">
                <a:solidFill>
                  <a:schemeClr val="tx1"/>
                </a:solidFill>
                <a:latin typeface="Manrope" pitchFamily="2" charset="0"/>
              </a:rPr>
              <a:t>test</a:t>
            </a:r>
          </a:p>
        </p:txBody>
      </p:sp>
      <p:sp>
        <p:nvSpPr>
          <p:cNvPr id="41" name="Rectangle 40">
            <a:extLst>
              <a:ext uri="{FF2B5EF4-FFF2-40B4-BE49-F238E27FC236}">
                <a16:creationId xmlns:a16="http://schemas.microsoft.com/office/drawing/2014/main" id="{142773F4-5361-DCD5-FDB8-248F7B47EE99}"/>
              </a:ext>
            </a:extLst>
          </p:cNvPr>
          <p:cNvSpPr/>
          <p:nvPr/>
        </p:nvSpPr>
        <p:spPr>
          <a:xfrm>
            <a:off x="1506099" y="5752201"/>
            <a:ext cx="704601" cy="184795"/>
          </a:xfrm>
          <a:prstGeom prst="rect">
            <a:avLst/>
          </a:prstGeom>
          <a:solidFill>
            <a:schemeClr val="accent4">
              <a:lumMod val="20000"/>
              <a:lumOff val="8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200" dirty="0">
                <a:solidFill>
                  <a:schemeClr val="tx1"/>
                </a:solidFill>
                <a:latin typeface="Manrope" pitchFamily="2" charset="0"/>
              </a:rPr>
              <a:t>test</a:t>
            </a:r>
          </a:p>
        </p:txBody>
      </p:sp>
      <p:sp>
        <p:nvSpPr>
          <p:cNvPr id="42" name="Rectangle 41">
            <a:extLst>
              <a:ext uri="{FF2B5EF4-FFF2-40B4-BE49-F238E27FC236}">
                <a16:creationId xmlns:a16="http://schemas.microsoft.com/office/drawing/2014/main" id="{8B14481D-AA87-888F-5A48-A9BB2ECC0E1C}"/>
              </a:ext>
            </a:extLst>
          </p:cNvPr>
          <p:cNvSpPr/>
          <p:nvPr/>
        </p:nvSpPr>
        <p:spPr>
          <a:xfrm>
            <a:off x="2275952" y="5753819"/>
            <a:ext cx="704601" cy="184795"/>
          </a:xfrm>
          <a:prstGeom prst="rect">
            <a:avLst/>
          </a:prstGeom>
          <a:solidFill>
            <a:schemeClr val="accent4">
              <a:lumMod val="20000"/>
              <a:lumOff val="8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200" dirty="0">
                <a:solidFill>
                  <a:schemeClr val="tx1"/>
                </a:solidFill>
                <a:latin typeface="Manrope" pitchFamily="2" charset="0"/>
              </a:rPr>
              <a:t>test</a:t>
            </a:r>
          </a:p>
        </p:txBody>
      </p:sp>
      <p:sp>
        <p:nvSpPr>
          <p:cNvPr id="43" name="Rectangle 42">
            <a:extLst>
              <a:ext uri="{FF2B5EF4-FFF2-40B4-BE49-F238E27FC236}">
                <a16:creationId xmlns:a16="http://schemas.microsoft.com/office/drawing/2014/main" id="{CCA1DB6D-7590-CCDC-C7D8-F6E99F856BD8}"/>
              </a:ext>
            </a:extLst>
          </p:cNvPr>
          <p:cNvSpPr/>
          <p:nvPr/>
        </p:nvSpPr>
        <p:spPr>
          <a:xfrm>
            <a:off x="3040643" y="5757128"/>
            <a:ext cx="704601" cy="184795"/>
          </a:xfrm>
          <a:prstGeom prst="rect">
            <a:avLst/>
          </a:prstGeom>
          <a:solidFill>
            <a:schemeClr val="accent6">
              <a:lumMod val="20000"/>
              <a:lumOff val="8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200" dirty="0">
                <a:solidFill>
                  <a:schemeClr val="tx1"/>
                </a:solidFill>
                <a:latin typeface="Manrope" pitchFamily="2" charset="0"/>
              </a:rPr>
              <a:t>TRAIN</a:t>
            </a:r>
          </a:p>
        </p:txBody>
      </p:sp>
      <p:sp>
        <p:nvSpPr>
          <p:cNvPr id="44" name="Rectangle 43">
            <a:extLst>
              <a:ext uri="{FF2B5EF4-FFF2-40B4-BE49-F238E27FC236}">
                <a16:creationId xmlns:a16="http://schemas.microsoft.com/office/drawing/2014/main" id="{D86A5E25-6FC4-9D2D-95B3-CD1EE60AF41B}"/>
              </a:ext>
            </a:extLst>
          </p:cNvPr>
          <p:cNvSpPr/>
          <p:nvPr/>
        </p:nvSpPr>
        <p:spPr>
          <a:xfrm rot="5400000">
            <a:off x="2442392" y="5503167"/>
            <a:ext cx="371341" cy="272983"/>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lnSpc>
                <a:spcPts val="1620"/>
              </a:lnSpc>
            </a:pPr>
            <a:r>
              <a:rPr lang="en-CA" sz="2400" b="1" dirty="0">
                <a:solidFill>
                  <a:schemeClr val="tx1"/>
                </a:solidFill>
                <a:latin typeface="Manrope" pitchFamily="2" charset="0"/>
              </a:rPr>
              <a:t>…</a:t>
            </a:r>
          </a:p>
        </p:txBody>
      </p:sp>
      <p:sp>
        <p:nvSpPr>
          <p:cNvPr id="45" name="Rectangle 44">
            <a:extLst>
              <a:ext uri="{FF2B5EF4-FFF2-40B4-BE49-F238E27FC236}">
                <a16:creationId xmlns:a16="http://schemas.microsoft.com/office/drawing/2014/main" id="{17E81C04-E669-0694-346E-E7A747B43636}"/>
              </a:ext>
            </a:extLst>
          </p:cNvPr>
          <p:cNvSpPr/>
          <p:nvPr/>
        </p:nvSpPr>
        <p:spPr>
          <a:xfrm>
            <a:off x="1503636" y="4878419"/>
            <a:ext cx="2248854" cy="188146"/>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200" dirty="0">
                <a:solidFill>
                  <a:schemeClr val="tx1"/>
                </a:solidFill>
                <a:latin typeface="Manrope" pitchFamily="2" charset="0"/>
              </a:rPr>
              <a:t>split data into folds</a:t>
            </a:r>
          </a:p>
        </p:txBody>
      </p:sp>
      <p:sp>
        <p:nvSpPr>
          <p:cNvPr id="46" name="Rectangle 45">
            <a:extLst>
              <a:ext uri="{FF2B5EF4-FFF2-40B4-BE49-F238E27FC236}">
                <a16:creationId xmlns:a16="http://schemas.microsoft.com/office/drawing/2014/main" id="{31F42074-9C62-A5EB-C2D8-03C3EC037686}"/>
              </a:ext>
            </a:extLst>
          </p:cNvPr>
          <p:cNvSpPr/>
          <p:nvPr/>
        </p:nvSpPr>
        <p:spPr>
          <a:xfrm>
            <a:off x="735418" y="5109335"/>
            <a:ext cx="854180" cy="137348"/>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200" dirty="0">
                <a:solidFill>
                  <a:schemeClr val="tx1"/>
                </a:solidFill>
                <a:latin typeface="Manrope" pitchFamily="2" charset="0"/>
              </a:rPr>
              <a:t>Round 1</a:t>
            </a:r>
          </a:p>
        </p:txBody>
      </p:sp>
      <p:sp>
        <p:nvSpPr>
          <p:cNvPr id="47" name="Rectangle 46">
            <a:extLst>
              <a:ext uri="{FF2B5EF4-FFF2-40B4-BE49-F238E27FC236}">
                <a16:creationId xmlns:a16="http://schemas.microsoft.com/office/drawing/2014/main" id="{06F4DCDF-3910-6EF1-27FB-FDE598B45D74}"/>
              </a:ext>
            </a:extLst>
          </p:cNvPr>
          <p:cNvSpPr/>
          <p:nvPr/>
        </p:nvSpPr>
        <p:spPr>
          <a:xfrm>
            <a:off x="747427" y="5353774"/>
            <a:ext cx="854180" cy="137348"/>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200" dirty="0">
                <a:solidFill>
                  <a:schemeClr val="tx1"/>
                </a:solidFill>
                <a:latin typeface="Manrope" pitchFamily="2" charset="0"/>
              </a:rPr>
              <a:t>Round 2</a:t>
            </a:r>
          </a:p>
        </p:txBody>
      </p:sp>
      <p:sp>
        <p:nvSpPr>
          <p:cNvPr id="48" name="Rectangle 47">
            <a:extLst>
              <a:ext uri="{FF2B5EF4-FFF2-40B4-BE49-F238E27FC236}">
                <a16:creationId xmlns:a16="http://schemas.microsoft.com/office/drawing/2014/main" id="{1A497701-7041-7E8E-5318-5B9106C91CA7}"/>
              </a:ext>
            </a:extLst>
          </p:cNvPr>
          <p:cNvSpPr/>
          <p:nvPr/>
        </p:nvSpPr>
        <p:spPr>
          <a:xfrm>
            <a:off x="707501" y="5778793"/>
            <a:ext cx="854180" cy="137348"/>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200" dirty="0">
                <a:solidFill>
                  <a:schemeClr val="tx1"/>
                </a:solidFill>
                <a:latin typeface="Manrope" pitchFamily="2" charset="0"/>
              </a:rPr>
              <a:t>Round 50</a:t>
            </a:r>
          </a:p>
        </p:txBody>
      </p:sp>
      <p:cxnSp>
        <p:nvCxnSpPr>
          <p:cNvPr id="50" name="Straight Arrow Connector 49">
            <a:extLst>
              <a:ext uri="{FF2B5EF4-FFF2-40B4-BE49-F238E27FC236}">
                <a16:creationId xmlns:a16="http://schemas.microsoft.com/office/drawing/2014/main" id="{CBF167F7-5150-7B8F-5C50-5F4E5AE543AC}"/>
              </a:ext>
            </a:extLst>
          </p:cNvPr>
          <p:cNvCxnSpPr/>
          <p:nvPr/>
        </p:nvCxnSpPr>
        <p:spPr>
          <a:xfrm>
            <a:off x="3827010" y="5178009"/>
            <a:ext cx="181669"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1" name="Straight Arrow Connector 50">
            <a:extLst>
              <a:ext uri="{FF2B5EF4-FFF2-40B4-BE49-F238E27FC236}">
                <a16:creationId xmlns:a16="http://schemas.microsoft.com/office/drawing/2014/main" id="{D3979507-6ED4-C867-C70E-F8A28E5CDB8B}"/>
              </a:ext>
            </a:extLst>
          </p:cNvPr>
          <p:cNvCxnSpPr/>
          <p:nvPr/>
        </p:nvCxnSpPr>
        <p:spPr>
          <a:xfrm>
            <a:off x="3827010" y="5409152"/>
            <a:ext cx="181669"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2" name="Straight Arrow Connector 51">
            <a:extLst>
              <a:ext uri="{FF2B5EF4-FFF2-40B4-BE49-F238E27FC236}">
                <a16:creationId xmlns:a16="http://schemas.microsoft.com/office/drawing/2014/main" id="{81CC966B-8C04-8066-AE9E-10B7817A4036}"/>
              </a:ext>
            </a:extLst>
          </p:cNvPr>
          <p:cNvCxnSpPr/>
          <p:nvPr/>
        </p:nvCxnSpPr>
        <p:spPr>
          <a:xfrm>
            <a:off x="3827010" y="5844598"/>
            <a:ext cx="181669"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3" name="Rectangle 52">
            <a:extLst>
              <a:ext uri="{FF2B5EF4-FFF2-40B4-BE49-F238E27FC236}">
                <a16:creationId xmlns:a16="http://schemas.microsoft.com/office/drawing/2014/main" id="{0CB7CD61-5AB6-29F9-BFFA-12C96A6F8865}"/>
              </a:ext>
            </a:extLst>
          </p:cNvPr>
          <p:cNvSpPr/>
          <p:nvPr/>
        </p:nvSpPr>
        <p:spPr>
          <a:xfrm>
            <a:off x="3990592" y="5109342"/>
            <a:ext cx="1189849" cy="176195"/>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200" dirty="0">
                <a:solidFill>
                  <a:schemeClr val="tx1"/>
                </a:solidFill>
                <a:latin typeface="Manrope" pitchFamily="2" charset="0"/>
              </a:rPr>
              <a:t>Performance</a:t>
            </a:r>
            <a:r>
              <a:rPr lang="en-CA" sz="1200" baseline="-25000" dirty="0">
                <a:solidFill>
                  <a:schemeClr val="tx1"/>
                </a:solidFill>
                <a:latin typeface="Manrope" pitchFamily="2" charset="0"/>
              </a:rPr>
              <a:t>1</a:t>
            </a:r>
          </a:p>
        </p:txBody>
      </p:sp>
      <p:sp>
        <p:nvSpPr>
          <p:cNvPr id="54" name="Rectangle 53">
            <a:extLst>
              <a:ext uri="{FF2B5EF4-FFF2-40B4-BE49-F238E27FC236}">
                <a16:creationId xmlns:a16="http://schemas.microsoft.com/office/drawing/2014/main" id="{490C95DD-53B1-F2C0-872F-40FC20172954}"/>
              </a:ext>
            </a:extLst>
          </p:cNvPr>
          <p:cNvSpPr/>
          <p:nvPr/>
        </p:nvSpPr>
        <p:spPr>
          <a:xfrm>
            <a:off x="3933150" y="5325355"/>
            <a:ext cx="1320048" cy="176195"/>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200" dirty="0">
                <a:solidFill>
                  <a:schemeClr val="tx1"/>
                </a:solidFill>
                <a:latin typeface="Manrope" pitchFamily="2" charset="0"/>
              </a:rPr>
              <a:t>Performance</a:t>
            </a:r>
            <a:r>
              <a:rPr lang="en-CA" sz="1200" baseline="-25000" dirty="0">
                <a:solidFill>
                  <a:schemeClr val="tx1"/>
                </a:solidFill>
                <a:latin typeface="Manrope" pitchFamily="2" charset="0"/>
              </a:rPr>
              <a:t>2</a:t>
            </a:r>
          </a:p>
        </p:txBody>
      </p:sp>
      <p:sp>
        <p:nvSpPr>
          <p:cNvPr id="55" name="Rectangle 54">
            <a:extLst>
              <a:ext uri="{FF2B5EF4-FFF2-40B4-BE49-F238E27FC236}">
                <a16:creationId xmlns:a16="http://schemas.microsoft.com/office/drawing/2014/main" id="{BD3E952C-7D94-65E5-3D2B-3E3A158E4B00}"/>
              </a:ext>
            </a:extLst>
          </p:cNvPr>
          <p:cNvSpPr/>
          <p:nvPr/>
        </p:nvSpPr>
        <p:spPr>
          <a:xfrm>
            <a:off x="3969572" y="5756500"/>
            <a:ext cx="1320048" cy="176195"/>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200" dirty="0">
                <a:solidFill>
                  <a:schemeClr val="tx1"/>
                </a:solidFill>
                <a:latin typeface="Manrope" pitchFamily="2" charset="0"/>
              </a:rPr>
              <a:t>Performance</a:t>
            </a:r>
            <a:r>
              <a:rPr lang="en-CA" sz="1200" baseline="-25000" dirty="0">
                <a:solidFill>
                  <a:schemeClr val="tx1"/>
                </a:solidFill>
                <a:latin typeface="Manrope" pitchFamily="2" charset="0"/>
              </a:rPr>
              <a:t>50</a:t>
            </a:r>
          </a:p>
        </p:txBody>
      </p:sp>
      <p:sp>
        <p:nvSpPr>
          <p:cNvPr id="58" name="Right Brace 57">
            <a:extLst>
              <a:ext uri="{FF2B5EF4-FFF2-40B4-BE49-F238E27FC236}">
                <a16:creationId xmlns:a16="http://schemas.microsoft.com/office/drawing/2014/main" id="{16CC345C-DA7D-84BD-4B47-F94C0FD49895}"/>
              </a:ext>
            </a:extLst>
          </p:cNvPr>
          <p:cNvSpPr/>
          <p:nvPr/>
        </p:nvSpPr>
        <p:spPr>
          <a:xfrm>
            <a:off x="5180441" y="4933435"/>
            <a:ext cx="138641" cy="982226"/>
          </a:xfrm>
          <a:prstGeom prst="rightBrace">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CA"/>
          </a:p>
        </p:txBody>
      </p:sp>
      <p:sp>
        <p:nvSpPr>
          <p:cNvPr id="59" name="Rectangle 58">
            <a:extLst>
              <a:ext uri="{FF2B5EF4-FFF2-40B4-BE49-F238E27FC236}">
                <a16:creationId xmlns:a16="http://schemas.microsoft.com/office/drawing/2014/main" id="{3471BE8C-8C69-51D7-0158-58C7A5DF5490}"/>
              </a:ext>
            </a:extLst>
          </p:cNvPr>
          <p:cNvSpPr/>
          <p:nvPr/>
        </p:nvSpPr>
        <p:spPr>
          <a:xfrm>
            <a:off x="5319082" y="5362069"/>
            <a:ext cx="2184886" cy="328157"/>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CA" sz="1200" dirty="0">
                <a:solidFill>
                  <a:schemeClr val="tx1"/>
                </a:solidFill>
                <a:latin typeface="Manrope" pitchFamily="2" charset="0"/>
              </a:rPr>
              <a:t>Determine best parameters for the model + estimate average performance</a:t>
            </a:r>
            <a:endParaRPr lang="en-CA" sz="1200" baseline="-25000" dirty="0">
              <a:solidFill>
                <a:schemeClr val="tx1"/>
              </a:solidFill>
              <a:latin typeface="Manrope" pitchFamily="2" charset="0"/>
            </a:endParaRPr>
          </a:p>
        </p:txBody>
      </p:sp>
      <p:sp>
        <p:nvSpPr>
          <p:cNvPr id="60" name="Rectangle 59">
            <a:extLst>
              <a:ext uri="{FF2B5EF4-FFF2-40B4-BE49-F238E27FC236}">
                <a16:creationId xmlns:a16="http://schemas.microsoft.com/office/drawing/2014/main" id="{0229327D-B7A9-9FAC-3DCB-F463C3F02A21}"/>
              </a:ext>
            </a:extLst>
          </p:cNvPr>
          <p:cNvSpPr/>
          <p:nvPr/>
        </p:nvSpPr>
        <p:spPr>
          <a:xfrm>
            <a:off x="3633282" y="1587159"/>
            <a:ext cx="4495056" cy="229328"/>
          </a:xfrm>
          <a:prstGeom prst="rect">
            <a:avLst/>
          </a:prstGeom>
          <a:solidFill>
            <a:schemeClr val="accent6">
              <a:lumMod val="20000"/>
              <a:lumOff val="8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200" dirty="0">
                <a:solidFill>
                  <a:schemeClr val="tx1"/>
                </a:solidFill>
                <a:latin typeface="Manrope" pitchFamily="2" charset="0"/>
              </a:rPr>
              <a:t>TRAINING GROUP (N=83, 42 EOPE, 41 nPTB)</a:t>
            </a:r>
          </a:p>
        </p:txBody>
      </p:sp>
      <p:sp>
        <p:nvSpPr>
          <p:cNvPr id="61" name="Rectangle 60">
            <a:extLst>
              <a:ext uri="{FF2B5EF4-FFF2-40B4-BE49-F238E27FC236}">
                <a16:creationId xmlns:a16="http://schemas.microsoft.com/office/drawing/2014/main" id="{EE9C037D-961E-EB1F-840A-AEE47A2CEF90}"/>
              </a:ext>
            </a:extLst>
          </p:cNvPr>
          <p:cNvSpPr/>
          <p:nvPr/>
        </p:nvSpPr>
        <p:spPr>
          <a:xfrm>
            <a:off x="3633282" y="1878095"/>
            <a:ext cx="4495056" cy="213044"/>
          </a:xfrm>
          <a:prstGeom prst="rect">
            <a:avLst/>
          </a:prstGeom>
          <a:solidFill>
            <a:srgbClr val="F2CFFB"/>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200" dirty="0">
                <a:solidFill>
                  <a:schemeClr val="tx1"/>
                </a:solidFill>
                <a:latin typeface="Manrope" pitchFamily="2" charset="0"/>
              </a:rPr>
              <a:t>TESTING GROUP (N=49, 38 EOPE, 11 nPTB)</a:t>
            </a:r>
          </a:p>
        </p:txBody>
      </p:sp>
      <p:sp>
        <p:nvSpPr>
          <p:cNvPr id="62" name="Rectangle 61">
            <a:extLst>
              <a:ext uri="{FF2B5EF4-FFF2-40B4-BE49-F238E27FC236}">
                <a16:creationId xmlns:a16="http://schemas.microsoft.com/office/drawing/2014/main" id="{5F345395-16F1-B77F-3A6D-BF4D2D39CCF4}"/>
              </a:ext>
            </a:extLst>
          </p:cNvPr>
          <p:cNvSpPr/>
          <p:nvPr/>
        </p:nvSpPr>
        <p:spPr>
          <a:xfrm>
            <a:off x="3633282" y="2165873"/>
            <a:ext cx="4495056" cy="213044"/>
          </a:xfrm>
          <a:prstGeom prst="rect">
            <a:avLst/>
          </a:prstGeom>
          <a:solidFill>
            <a:schemeClr val="accent2">
              <a:lumMod val="20000"/>
              <a:lumOff val="8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200" dirty="0">
                <a:solidFill>
                  <a:schemeClr val="tx1"/>
                </a:solidFill>
                <a:latin typeface="Manrope" pitchFamily="2" charset="0"/>
              </a:rPr>
              <a:t>EXPLORATORY GROUP (N=329)</a:t>
            </a:r>
          </a:p>
        </p:txBody>
      </p:sp>
      <p:sp>
        <p:nvSpPr>
          <p:cNvPr id="67" name="Right Brace 66">
            <a:extLst>
              <a:ext uri="{FF2B5EF4-FFF2-40B4-BE49-F238E27FC236}">
                <a16:creationId xmlns:a16="http://schemas.microsoft.com/office/drawing/2014/main" id="{A417FDAA-0280-BF6E-4CDB-319E6B600B90}"/>
              </a:ext>
            </a:extLst>
          </p:cNvPr>
          <p:cNvSpPr/>
          <p:nvPr/>
        </p:nvSpPr>
        <p:spPr>
          <a:xfrm rot="5400000">
            <a:off x="5833686" y="-837409"/>
            <a:ext cx="94248" cy="4495056"/>
          </a:xfrm>
          <a:prstGeom prst="righ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CA"/>
          </a:p>
        </p:txBody>
      </p:sp>
      <p:sp>
        <p:nvSpPr>
          <p:cNvPr id="80" name="Right Brace 79">
            <a:extLst>
              <a:ext uri="{FF2B5EF4-FFF2-40B4-BE49-F238E27FC236}">
                <a16:creationId xmlns:a16="http://schemas.microsoft.com/office/drawing/2014/main" id="{24F8C930-8DF9-A2B1-B8B3-F8CD3F9623C5}"/>
              </a:ext>
            </a:extLst>
          </p:cNvPr>
          <p:cNvSpPr/>
          <p:nvPr/>
        </p:nvSpPr>
        <p:spPr>
          <a:xfrm rot="5400000">
            <a:off x="5823668" y="317685"/>
            <a:ext cx="94248" cy="4495056"/>
          </a:xfrm>
          <a:prstGeom prst="righ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CA"/>
          </a:p>
        </p:txBody>
      </p:sp>
      <p:sp>
        <p:nvSpPr>
          <p:cNvPr id="95" name="Rounded Rectangle 94">
            <a:extLst>
              <a:ext uri="{FF2B5EF4-FFF2-40B4-BE49-F238E27FC236}">
                <a16:creationId xmlns:a16="http://schemas.microsoft.com/office/drawing/2014/main" id="{5AB51F67-0C87-80AA-6BF2-5A3C0B0AF40A}"/>
              </a:ext>
            </a:extLst>
          </p:cNvPr>
          <p:cNvSpPr/>
          <p:nvPr/>
        </p:nvSpPr>
        <p:spPr>
          <a:xfrm>
            <a:off x="3619558" y="2726395"/>
            <a:ext cx="4495055" cy="217884"/>
          </a:xfrm>
          <a:prstGeom prst="roundRect">
            <a:avLst/>
          </a:prstGeom>
          <a:noFill/>
          <a:ln>
            <a:solidFill>
              <a:srgbClr val="00B05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400" dirty="0">
                <a:solidFill>
                  <a:schemeClr val="tx1"/>
                </a:solidFill>
                <a:latin typeface="Source Sans Pro Light" panose="020B0403030403020204" pitchFamily="34" charset="0"/>
                <a:ea typeface="Source Sans Pro Light" panose="020B0403030403020204" pitchFamily="34" charset="0"/>
              </a:rPr>
              <a:t>Remove samples that fail QC checks</a:t>
            </a:r>
          </a:p>
        </p:txBody>
      </p:sp>
      <p:sp>
        <p:nvSpPr>
          <p:cNvPr id="96" name="Rounded Rectangle 95">
            <a:extLst>
              <a:ext uri="{FF2B5EF4-FFF2-40B4-BE49-F238E27FC236}">
                <a16:creationId xmlns:a16="http://schemas.microsoft.com/office/drawing/2014/main" id="{57B90D2B-DE79-9057-9F68-2738FF1FCC43}"/>
              </a:ext>
            </a:extLst>
          </p:cNvPr>
          <p:cNvSpPr/>
          <p:nvPr/>
        </p:nvSpPr>
        <p:spPr>
          <a:xfrm>
            <a:off x="3619558" y="3003941"/>
            <a:ext cx="4495055" cy="217884"/>
          </a:xfrm>
          <a:prstGeom prst="roundRect">
            <a:avLst/>
          </a:prstGeom>
          <a:noFill/>
          <a:ln>
            <a:solidFill>
              <a:srgbClr val="00B05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400" dirty="0">
                <a:solidFill>
                  <a:schemeClr val="tx1"/>
                </a:solidFill>
                <a:latin typeface="Source Sans Pro Light" panose="020B0403030403020204" pitchFamily="34" charset="0"/>
                <a:ea typeface="Source Sans Pro Light" panose="020B0403030403020204" pitchFamily="34" charset="0"/>
              </a:rPr>
              <a:t>Remove probes that fail QC checks</a:t>
            </a:r>
          </a:p>
        </p:txBody>
      </p:sp>
      <p:sp>
        <p:nvSpPr>
          <p:cNvPr id="97" name="Rounded Rectangle 96">
            <a:extLst>
              <a:ext uri="{FF2B5EF4-FFF2-40B4-BE49-F238E27FC236}">
                <a16:creationId xmlns:a16="http://schemas.microsoft.com/office/drawing/2014/main" id="{0BE9569E-3B63-C59F-2639-855A1B9122F7}"/>
              </a:ext>
            </a:extLst>
          </p:cNvPr>
          <p:cNvSpPr/>
          <p:nvPr/>
        </p:nvSpPr>
        <p:spPr>
          <a:xfrm>
            <a:off x="3619558" y="3270884"/>
            <a:ext cx="4495055" cy="217884"/>
          </a:xfrm>
          <a:prstGeom prst="roundRect">
            <a:avLst/>
          </a:prstGeom>
          <a:noFill/>
          <a:ln>
            <a:solidFill>
              <a:srgbClr val="00B05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400" dirty="0">
                <a:solidFill>
                  <a:schemeClr val="tx1"/>
                </a:solidFill>
                <a:latin typeface="Source Sans Pro Light" panose="020B0403030403020204" pitchFamily="34" charset="0"/>
                <a:ea typeface="Source Sans Pro Light" panose="020B0403030403020204" pitchFamily="34" charset="0"/>
              </a:rPr>
              <a:t>BMIQ normalization</a:t>
            </a:r>
          </a:p>
        </p:txBody>
      </p:sp>
      <p:sp>
        <p:nvSpPr>
          <p:cNvPr id="105" name="Rounded Rectangle 104">
            <a:extLst>
              <a:ext uri="{FF2B5EF4-FFF2-40B4-BE49-F238E27FC236}">
                <a16:creationId xmlns:a16="http://schemas.microsoft.com/office/drawing/2014/main" id="{91ADBE1F-0FBA-46A6-B175-3CD9E242D50D}"/>
              </a:ext>
            </a:extLst>
          </p:cNvPr>
          <p:cNvSpPr/>
          <p:nvPr/>
        </p:nvSpPr>
        <p:spPr>
          <a:xfrm>
            <a:off x="4163997" y="3525768"/>
            <a:ext cx="4495055" cy="217884"/>
          </a:xfrm>
          <a:prstGeom prst="round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CA" sz="1100" dirty="0">
                <a:solidFill>
                  <a:schemeClr val="tx1"/>
                </a:solidFill>
                <a:latin typeface="Source Sans Pro Light" panose="020B0403030403020204" pitchFamily="34" charset="0"/>
                <a:ea typeface="Source Sans Pro Light" panose="020B0403030403020204" pitchFamily="34" charset="0"/>
              </a:rPr>
              <a:t>+ batch correction using ComBat only for the training cohort</a:t>
            </a:r>
          </a:p>
        </p:txBody>
      </p:sp>
    </p:spTree>
    <p:extLst>
      <p:ext uri="{BB962C8B-B14F-4D97-AF65-F5344CB8AC3E}">
        <p14:creationId xmlns:p14="http://schemas.microsoft.com/office/powerpoint/2010/main" val="173747679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94F69B65-1F2E-4BD1-BBED-74760398BB8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9591" y="1054408"/>
            <a:ext cx="5180199" cy="3697677"/>
          </a:xfrm>
          <a:prstGeom prst="rect">
            <a:avLst/>
          </a:prstGeom>
        </p:spPr>
      </p:pic>
      <p:sp>
        <p:nvSpPr>
          <p:cNvPr id="9" name="TextBox 8">
            <a:extLst>
              <a:ext uri="{FF2B5EF4-FFF2-40B4-BE49-F238E27FC236}">
                <a16:creationId xmlns:a16="http://schemas.microsoft.com/office/drawing/2014/main" id="{50651FFA-D6F7-4083-9DEC-E3797BB2C286}"/>
              </a:ext>
            </a:extLst>
          </p:cNvPr>
          <p:cNvSpPr txBox="1"/>
          <p:nvPr/>
        </p:nvSpPr>
        <p:spPr>
          <a:xfrm>
            <a:off x="4753532" y="2723551"/>
            <a:ext cx="237566" cy="209288"/>
          </a:xfrm>
          <a:prstGeom prst="rect">
            <a:avLst/>
          </a:prstGeom>
          <a:noFill/>
        </p:spPr>
        <p:txBody>
          <a:bodyPr wrap="none" rtlCol="0">
            <a:spAutoFit/>
          </a:bodyPr>
          <a:lstStyle/>
          <a:p>
            <a:r>
              <a:rPr lang="en-CA" sz="760" b="1" dirty="0"/>
              <a:t>b</a:t>
            </a:r>
          </a:p>
        </p:txBody>
      </p:sp>
      <p:pic>
        <p:nvPicPr>
          <p:cNvPr id="7" name="Picture 6">
            <a:extLst>
              <a:ext uri="{FF2B5EF4-FFF2-40B4-BE49-F238E27FC236}">
                <a16:creationId xmlns:a16="http://schemas.microsoft.com/office/drawing/2014/main" id="{C2CE4858-0DCD-44DB-A935-12EBC6829327}"/>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289788" y="897871"/>
            <a:ext cx="3854212" cy="3854212"/>
          </a:xfrm>
          <a:prstGeom prst="rect">
            <a:avLst/>
          </a:prstGeom>
        </p:spPr>
      </p:pic>
      <p:sp>
        <p:nvSpPr>
          <p:cNvPr id="2" name="TextBox 1">
            <a:extLst>
              <a:ext uri="{FF2B5EF4-FFF2-40B4-BE49-F238E27FC236}">
                <a16:creationId xmlns:a16="http://schemas.microsoft.com/office/drawing/2014/main" id="{E5EF32E4-345C-5FD2-A5A0-30A769882D49}"/>
              </a:ext>
            </a:extLst>
          </p:cNvPr>
          <p:cNvSpPr txBox="1"/>
          <p:nvPr/>
        </p:nvSpPr>
        <p:spPr>
          <a:xfrm>
            <a:off x="293369" y="4782068"/>
            <a:ext cx="8622031" cy="1384995"/>
          </a:xfrm>
          <a:prstGeom prst="rect">
            <a:avLst/>
          </a:prstGeom>
          <a:noFill/>
        </p:spPr>
        <p:txBody>
          <a:bodyPr wrap="square" rtlCol="0">
            <a:spAutoFit/>
          </a:bodyPr>
          <a:lstStyle/>
          <a:p>
            <a:r>
              <a:rPr lang="en-CA" sz="1200" b="1" dirty="0"/>
              <a:t>Figure S2. Relationship between reported and inferred gestational age (GA). </a:t>
            </a:r>
            <a:r>
              <a:rPr lang="en-CA" sz="1200" dirty="0"/>
              <a:t>Gestational age was inferred for all samples using the robust placental clock (Lee et al., 2019) as implemented in the R package planet. a. Association between reported and predicted GA in the training group, specifically in GSE100197 and GSE73375, which are the only 2 datasets out of 4 in the training group for which authors reported GA in weeks. b. Correlation between reported GA and inferred GA of all samples from GSE125605, GSE110829, GSE73375, and GSE75196, which are the only 4 datasets in this study that were not included as part of the training of the robust placental clock.</a:t>
            </a:r>
          </a:p>
          <a:p>
            <a:endParaRPr lang="en-CA" sz="1200" dirty="0"/>
          </a:p>
        </p:txBody>
      </p:sp>
    </p:spTree>
    <p:extLst>
      <p:ext uri="{BB962C8B-B14F-4D97-AF65-F5344CB8AC3E}">
        <p14:creationId xmlns:p14="http://schemas.microsoft.com/office/powerpoint/2010/main" val="122377309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3C551139-B7D7-4AE7-94EB-32712D29FFB0}"/>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70739" y="1678340"/>
            <a:ext cx="2436849" cy="2436849"/>
          </a:xfrm>
          <a:prstGeom prst="rect">
            <a:avLst/>
          </a:prstGeom>
        </p:spPr>
      </p:pic>
      <p:pic>
        <p:nvPicPr>
          <p:cNvPr id="7" name="Picture 6">
            <a:extLst>
              <a:ext uri="{FF2B5EF4-FFF2-40B4-BE49-F238E27FC236}">
                <a16:creationId xmlns:a16="http://schemas.microsoft.com/office/drawing/2014/main" id="{A446DD2E-18F2-471F-A797-9D9C550244B7}"/>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041779" y="1899632"/>
            <a:ext cx="5697894" cy="1994263"/>
          </a:xfrm>
          <a:prstGeom prst="rect">
            <a:avLst/>
          </a:prstGeom>
        </p:spPr>
      </p:pic>
      <p:sp>
        <p:nvSpPr>
          <p:cNvPr id="4" name="TextBox 3">
            <a:extLst>
              <a:ext uri="{FF2B5EF4-FFF2-40B4-BE49-F238E27FC236}">
                <a16:creationId xmlns:a16="http://schemas.microsoft.com/office/drawing/2014/main" id="{25F12E37-6DBC-9C5B-5033-1204219213E2}"/>
              </a:ext>
            </a:extLst>
          </p:cNvPr>
          <p:cNvSpPr txBox="1"/>
          <p:nvPr/>
        </p:nvSpPr>
        <p:spPr>
          <a:xfrm>
            <a:off x="631218" y="4115187"/>
            <a:ext cx="7842043" cy="1569660"/>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CA" sz="1200" b="1" dirty="0">
                <a:solidFill>
                  <a:srgbClr val="000000"/>
                </a:solidFill>
                <a:effectLst/>
                <a:latin typeface="Source Sans Pro" panose="020B0503030403020204" pitchFamily="34" charset="0"/>
                <a:ea typeface="Times New Roman" panose="02020603050405020304" pitchFamily="18" charset="0"/>
              </a:rPr>
              <a:t>Figure S3. Probability of EOPE using a 5 CpG model in the validation group (n=48) and in the exploratory group (n=328). </a:t>
            </a:r>
            <a:r>
              <a:rPr lang="en-CA" sz="1200" dirty="0">
                <a:solidFill>
                  <a:srgbClr val="000000"/>
                </a:solidFill>
                <a:effectLst/>
                <a:latin typeface="Source Sans Pro" panose="020B0503030403020204" pitchFamily="34" charset="0"/>
                <a:ea typeface="Times New Roman" panose="02020603050405020304" pitchFamily="18" charset="0"/>
              </a:rPr>
              <a:t>A 5 CpG model was used to predict the outcome of BMIQ normalized samples in the validation and exploratory groups (the two groups were normalized separately). There are 11 nPTB samples, and 38 EOPE samples in the validation group. </a:t>
            </a:r>
            <a:r>
              <a:rPr lang="en-CA" sz="1200" b="1" dirty="0">
                <a:solidFill>
                  <a:srgbClr val="000000"/>
                </a:solidFill>
                <a:effectLst/>
                <a:latin typeface="Source Sans Pro" panose="020B0503030403020204" pitchFamily="34" charset="0"/>
                <a:ea typeface="Times New Roman" panose="02020603050405020304" pitchFamily="18" charset="0"/>
              </a:rPr>
              <a:t>a. </a:t>
            </a:r>
            <a:r>
              <a:rPr lang="en-CA" sz="1200" dirty="0">
                <a:solidFill>
                  <a:srgbClr val="000000"/>
                </a:solidFill>
                <a:effectLst/>
                <a:latin typeface="Source Sans Pro" panose="020B0503030403020204" pitchFamily="34" charset="0"/>
                <a:ea typeface="Times New Roman" panose="02020603050405020304" pitchFamily="18" charset="0"/>
              </a:rPr>
              <a:t>Receiver operating characteristic (ROC) curve in the validation group. A classification threshold of 56% was selected to maximize Youden’s J statistic (sensitivity + specificity – 1). The diagonal line indicates the curve for a classifier that predicts the majority class in all cases. </a:t>
            </a:r>
            <a:r>
              <a:rPr lang="en-CA" sz="1200" b="1" dirty="0">
                <a:solidFill>
                  <a:srgbClr val="000000"/>
                </a:solidFill>
                <a:effectLst/>
                <a:latin typeface="Source Sans Pro" panose="020B0503030403020204" pitchFamily="34" charset="0"/>
                <a:ea typeface="Times New Roman" panose="02020603050405020304" pitchFamily="18" charset="0"/>
              </a:rPr>
              <a:t>b.</a:t>
            </a:r>
            <a:r>
              <a:rPr lang="en-CA" sz="1200" dirty="0">
                <a:solidFill>
                  <a:srgbClr val="000000"/>
                </a:solidFill>
                <a:effectLst/>
                <a:latin typeface="Source Sans Pro" panose="020B0503030403020204" pitchFamily="34" charset="0"/>
                <a:ea typeface="Times New Roman" panose="02020603050405020304" pitchFamily="18" charset="0"/>
              </a:rPr>
              <a:t> Probability of EOPE of samples in the validation and exploratory groups. EOPE and nPTB samples in the plot belong to the validation group. </a:t>
            </a:r>
            <a:endParaRPr lang="en-CA" sz="1200" dirty="0">
              <a:effectLst/>
              <a:latin typeface="Times New Roman" panose="02020603050405020304" pitchFamily="18" charset="0"/>
              <a:ea typeface="Times New Roman" panose="02020603050405020304" pitchFamily="18" charset="0"/>
            </a:endParaRPr>
          </a:p>
          <a:p>
            <a:endParaRPr lang="en-CA" sz="1200" dirty="0"/>
          </a:p>
        </p:txBody>
      </p:sp>
    </p:spTree>
    <p:extLst>
      <p:ext uri="{BB962C8B-B14F-4D97-AF65-F5344CB8AC3E}">
        <p14:creationId xmlns:p14="http://schemas.microsoft.com/office/powerpoint/2010/main" val="314424210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36D82AA1-14D9-4EA3-AD51-70195EF13A8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43250" y="677997"/>
            <a:ext cx="7731720" cy="2319517"/>
          </a:xfrm>
          <a:prstGeom prst="rect">
            <a:avLst/>
          </a:prstGeom>
        </p:spPr>
      </p:pic>
      <p:sp>
        <p:nvSpPr>
          <p:cNvPr id="6" name="TextBox 5">
            <a:extLst>
              <a:ext uri="{FF2B5EF4-FFF2-40B4-BE49-F238E27FC236}">
                <a16:creationId xmlns:a16="http://schemas.microsoft.com/office/drawing/2014/main" id="{C8E51C1A-E593-48F2-B2CE-9778D9994EC6}"/>
              </a:ext>
            </a:extLst>
          </p:cNvPr>
          <p:cNvSpPr txBox="1"/>
          <p:nvPr/>
        </p:nvSpPr>
        <p:spPr>
          <a:xfrm>
            <a:off x="878880" y="339441"/>
            <a:ext cx="4607352" cy="338554"/>
          </a:xfrm>
          <a:prstGeom prst="rect">
            <a:avLst/>
          </a:prstGeom>
          <a:noFill/>
        </p:spPr>
        <p:txBody>
          <a:bodyPr wrap="none" rtlCol="0">
            <a:spAutoFit/>
          </a:bodyPr>
          <a:lstStyle/>
          <a:p>
            <a:r>
              <a:rPr lang="en-CA" sz="1600" dirty="0">
                <a:latin typeface="Arial" panose="020B0604020202020204" pitchFamily="34" charset="0"/>
                <a:cs typeface="Arial" panose="020B0604020202020204" pitchFamily="34" charset="0"/>
              </a:rPr>
              <a:t>Cell composition of samples in the training group</a:t>
            </a:r>
          </a:p>
        </p:txBody>
      </p:sp>
      <p:sp>
        <p:nvSpPr>
          <p:cNvPr id="7" name="TextBox 6">
            <a:extLst>
              <a:ext uri="{FF2B5EF4-FFF2-40B4-BE49-F238E27FC236}">
                <a16:creationId xmlns:a16="http://schemas.microsoft.com/office/drawing/2014/main" id="{3EDFE71B-E50C-4E20-BC82-8DC6D4BD042F}"/>
              </a:ext>
            </a:extLst>
          </p:cNvPr>
          <p:cNvSpPr txBox="1"/>
          <p:nvPr/>
        </p:nvSpPr>
        <p:spPr>
          <a:xfrm>
            <a:off x="844590" y="3212509"/>
            <a:ext cx="4799712" cy="338554"/>
          </a:xfrm>
          <a:prstGeom prst="rect">
            <a:avLst/>
          </a:prstGeom>
          <a:noFill/>
        </p:spPr>
        <p:txBody>
          <a:bodyPr wrap="none" rtlCol="0">
            <a:spAutoFit/>
          </a:bodyPr>
          <a:lstStyle/>
          <a:p>
            <a:r>
              <a:rPr lang="en-CA" sz="1600" dirty="0">
                <a:latin typeface="Arial" panose="020B0604020202020204" pitchFamily="34" charset="0"/>
                <a:cs typeface="Arial" panose="020B0604020202020204" pitchFamily="34" charset="0"/>
              </a:rPr>
              <a:t>Cell composition of samples in the validation group</a:t>
            </a:r>
          </a:p>
        </p:txBody>
      </p:sp>
      <p:pic>
        <p:nvPicPr>
          <p:cNvPr id="9" name="Picture 8">
            <a:extLst>
              <a:ext uri="{FF2B5EF4-FFF2-40B4-BE49-F238E27FC236}">
                <a16:creationId xmlns:a16="http://schemas.microsoft.com/office/drawing/2014/main" id="{84C53CEF-63BB-4BC4-8432-625515787844}"/>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08960" y="3551065"/>
            <a:ext cx="8023860" cy="2407159"/>
          </a:xfrm>
          <a:prstGeom prst="rect">
            <a:avLst/>
          </a:prstGeom>
        </p:spPr>
      </p:pic>
      <p:sp>
        <p:nvSpPr>
          <p:cNvPr id="2" name="TextBox 1">
            <a:extLst>
              <a:ext uri="{FF2B5EF4-FFF2-40B4-BE49-F238E27FC236}">
                <a16:creationId xmlns:a16="http://schemas.microsoft.com/office/drawing/2014/main" id="{C307E780-A8AE-A490-E3B9-F6F954823E4C}"/>
              </a:ext>
            </a:extLst>
          </p:cNvPr>
          <p:cNvSpPr txBox="1"/>
          <p:nvPr/>
        </p:nvSpPr>
        <p:spPr>
          <a:xfrm>
            <a:off x="388088" y="6064933"/>
            <a:ext cx="7842043" cy="64633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CA" sz="1200" b="1" dirty="0">
                <a:solidFill>
                  <a:srgbClr val="000000"/>
                </a:solidFill>
                <a:effectLst/>
                <a:latin typeface="Source Sans Pro" panose="020B0503030403020204" pitchFamily="34" charset="0"/>
                <a:ea typeface="Times New Roman" panose="02020603050405020304" pitchFamily="18" charset="0"/>
              </a:rPr>
              <a:t>Figure S4. Cell composition of samples in the training (n=83) and in the validation (n=48) groups. </a:t>
            </a:r>
            <a:r>
              <a:rPr lang="en-CA" sz="1200" b="0" dirty="0">
                <a:solidFill>
                  <a:srgbClr val="000000"/>
                </a:solidFill>
                <a:effectLst/>
                <a:latin typeface="Source Sans Pro" panose="020B0503030403020204" pitchFamily="34" charset="0"/>
                <a:ea typeface="Times New Roman" panose="02020603050405020304" pitchFamily="18" charset="0"/>
              </a:rPr>
              <a:t>Placental cell composition was estimated using the R package planet (Yuan et al., 2021). </a:t>
            </a:r>
          </a:p>
          <a:p>
            <a:endParaRPr lang="en-CA" sz="1200" dirty="0"/>
          </a:p>
        </p:txBody>
      </p:sp>
    </p:spTree>
    <p:extLst>
      <p:ext uri="{BB962C8B-B14F-4D97-AF65-F5344CB8AC3E}">
        <p14:creationId xmlns:p14="http://schemas.microsoft.com/office/powerpoint/2010/main" val="54767906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1075CE53-6550-49F1-9A1A-64455447EA8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35106" y="515962"/>
            <a:ext cx="3205897" cy="3091616"/>
          </a:xfrm>
          <a:prstGeom prst="rect">
            <a:avLst/>
          </a:prstGeom>
        </p:spPr>
      </p:pic>
      <p:pic>
        <p:nvPicPr>
          <p:cNvPr id="8" name="Picture 7">
            <a:extLst>
              <a:ext uri="{FF2B5EF4-FFF2-40B4-BE49-F238E27FC236}">
                <a16:creationId xmlns:a16="http://schemas.microsoft.com/office/drawing/2014/main" id="{C8FC7CF0-4031-4110-9BD2-A2C5D1C7980A}"/>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789891" y="570422"/>
            <a:ext cx="3204303" cy="2982696"/>
          </a:xfrm>
          <a:prstGeom prst="rect">
            <a:avLst/>
          </a:prstGeom>
        </p:spPr>
      </p:pic>
      <p:pic>
        <p:nvPicPr>
          <p:cNvPr id="10" name="Picture 9">
            <a:extLst>
              <a:ext uri="{FF2B5EF4-FFF2-40B4-BE49-F238E27FC236}">
                <a16:creationId xmlns:a16="http://schemas.microsoft.com/office/drawing/2014/main" id="{19056F2C-FDD7-44D5-BA29-A152DA45FCA1}"/>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5219216" y="584841"/>
            <a:ext cx="3366271" cy="2995509"/>
          </a:xfrm>
          <a:prstGeom prst="rect">
            <a:avLst/>
          </a:prstGeom>
        </p:spPr>
      </p:pic>
      <p:pic>
        <p:nvPicPr>
          <p:cNvPr id="12" name="Picture 11">
            <a:extLst>
              <a:ext uri="{FF2B5EF4-FFF2-40B4-BE49-F238E27FC236}">
                <a16:creationId xmlns:a16="http://schemas.microsoft.com/office/drawing/2014/main" id="{8A07626F-31C8-473D-8DA2-C813417B04F0}"/>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335104" y="3616107"/>
            <a:ext cx="3204304" cy="3094652"/>
          </a:xfrm>
          <a:prstGeom prst="rect">
            <a:avLst/>
          </a:prstGeom>
        </p:spPr>
      </p:pic>
      <p:pic>
        <p:nvPicPr>
          <p:cNvPr id="14" name="Picture 13">
            <a:extLst>
              <a:ext uri="{FF2B5EF4-FFF2-40B4-BE49-F238E27FC236}">
                <a16:creationId xmlns:a16="http://schemas.microsoft.com/office/drawing/2014/main" id="{357A86EA-F105-4B44-957A-2A9118EB29B0}"/>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2748591" y="3616109"/>
            <a:ext cx="3286898" cy="3018455"/>
          </a:xfrm>
          <a:prstGeom prst="rect">
            <a:avLst/>
          </a:prstGeom>
        </p:spPr>
      </p:pic>
      <p:sp>
        <p:nvSpPr>
          <p:cNvPr id="2" name="TextBox 1">
            <a:extLst>
              <a:ext uri="{FF2B5EF4-FFF2-40B4-BE49-F238E27FC236}">
                <a16:creationId xmlns:a16="http://schemas.microsoft.com/office/drawing/2014/main" id="{E16C1D69-7CA6-2243-553D-87D89C8FE2C6}"/>
              </a:ext>
            </a:extLst>
          </p:cNvPr>
          <p:cNvSpPr txBox="1"/>
          <p:nvPr/>
        </p:nvSpPr>
        <p:spPr>
          <a:xfrm>
            <a:off x="6195178" y="3907520"/>
            <a:ext cx="2253798" cy="2123658"/>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CA" sz="1200" b="1" dirty="0">
                <a:solidFill>
                  <a:srgbClr val="000000"/>
                </a:solidFill>
                <a:effectLst/>
                <a:latin typeface="Source Sans Pro" panose="020B0503030403020204" pitchFamily="34" charset="0"/>
                <a:ea typeface="Times New Roman" panose="02020603050405020304" pitchFamily="18" charset="0"/>
              </a:rPr>
              <a:t>Figure S5. Cell-specific placental DNAme at the top 5 predictive CpGs in eoPred. </a:t>
            </a:r>
            <a:r>
              <a:rPr lang="en-CA" sz="1200" b="0" dirty="0">
                <a:solidFill>
                  <a:srgbClr val="000000"/>
                </a:solidFill>
                <a:effectLst/>
                <a:latin typeface="Source Sans Pro" panose="020B0503030403020204" pitchFamily="34" charset="0"/>
                <a:ea typeface="Times New Roman" panose="02020603050405020304" pitchFamily="18" charset="0"/>
              </a:rPr>
              <a:t>Plots were generated using the placental methylome browser described by Yuan et al., 2021 and available at https://</a:t>
            </a:r>
            <a:r>
              <a:rPr lang="en-CA" sz="1200" b="0" dirty="0" err="1">
                <a:solidFill>
                  <a:srgbClr val="000000"/>
                </a:solidFill>
                <a:effectLst/>
                <a:latin typeface="Source Sans Pro" panose="020B0503030403020204" pitchFamily="34" charset="0"/>
                <a:ea typeface="Times New Roman" panose="02020603050405020304" pitchFamily="18" charset="0"/>
              </a:rPr>
              <a:t>robinsonlab.shinyapps.io</a:t>
            </a:r>
            <a:r>
              <a:rPr lang="en-CA" sz="1200" b="0" dirty="0">
                <a:solidFill>
                  <a:srgbClr val="000000"/>
                </a:solidFill>
                <a:effectLst/>
                <a:latin typeface="Source Sans Pro" panose="020B0503030403020204" pitchFamily="34" charset="0"/>
                <a:ea typeface="Times New Roman" panose="02020603050405020304" pitchFamily="18" charset="0"/>
              </a:rPr>
              <a:t>/</a:t>
            </a:r>
            <a:r>
              <a:rPr lang="en-CA" sz="1200" b="0" dirty="0" err="1">
                <a:solidFill>
                  <a:srgbClr val="000000"/>
                </a:solidFill>
                <a:effectLst/>
                <a:latin typeface="Source Sans Pro" panose="020B0503030403020204" pitchFamily="34" charset="0"/>
                <a:ea typeface="Times New Roman" panose="02020603050405020304" pitchFamily="18" charset="0"/>
              </a:rPr>
              <a:t>Placental_Methylome_Browser</a:t>
            </a:r>
            <a:r>
              <a:rPr lang="en-CA" sz="1200" b="0" dirty="0">
                <a:solidFill>
                  <a:srgbClr val="000000"/>
                </a:solidFill>
                <a:effectLst/>
                <a:latin typeface="Source Sans Pro" panose="020B0503030403020204" pitchFamily="34" charset="0"/>
                <a:ea typeface="Times New Roman" panose="02020603050405020304" pitchFamily="18" charset="0"/>
              </a:rPr>
              <a:t>/.</a:t>
            </a:r>
          </a:p>
          <a:p>
            <a:endParaRPr lang="en-CA" sz="1200" dirty="0"/>
          </a:p>
        </p:txBody>
      </p:sp>
    </p:spTree>
    <p:extLst>
      <p:ext uri="{BB962C8B-B14F-4D97-AF65-F5344CB8AC3E}">
        <p14:creationId xmlns:p14="http://schemas.microsoft.com/office/powerpoint/2010/main" val="419576139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3F23F012-8703-4EC1-8676-E8DF507B6FA0}"/>
              </a:ext>
            </a:extLst>
          </p:cNvPr>
          <p:cNvPicPr>
            <a:picLocks noChangeAspect="1"/>
          </p:cNvPicPr>
          <p:nvPr/>
        </p:nvPicPr>
        <p:blipFill rotWithShape="1">
          <a:blip r:embed="rId3">
            <a:extLst>
              <a:ext uri="{28A0092B-C50C-407E-A947-70E740481C1C}">
                <a14:useLocalDpi xmlns:a14="http://schemas.microsoft.com/office/drawing/2010/main" val="0"/>
              </a:ext>
            </a:extLst>
          </a:blip>
          <a:srcRect l="7942" t="24235" r="32791" b="18127"/>
          <a:stretch/>
        </p:blipFill>
        <p:spPr>
          <a:xfrm>
            <a:off x="487097" y="1481699"/>
            <a:ext cx="3589020" cy="3490353"/>
          </a:xfrm>
          <a:prstGeom prst="rect">
            <a:avLst/>
          </a:prstGeom>
        </p:spPr>
      </p:pic>
      <p:sp>
        <p:nvSpPr>
          <p:cNvPr id="6" name="TextBox 5">
            <a:extLst>
              <a:ext uri="{FF2B5EF4-FFF2-40B4-BE49-F238E27FC236}">
                <a16:creationId xmlns:a16="http://schemas.microsoft.com/office/drawing/2014/main" id="{7636DA71-830C-4125-BF52-2B9289195C30}"/>
              </a:ext>
            </a:extLst>
          </p:cNvPr>
          <p:cNvSpPr txBox="1"/>
          <p:nvPr/>
        </p:nvSpPr>
        <p:spPr>
          <a:xfrm>
            <a:off x="1532653" y="1125402"/>
            <a:ext cx="1497911" cy="338554"/>
          </a:xfrm>
          <a:prstGeom prst="rect">
            <a:avLst/>
          </a:prstGeom>
          <a:noFill/>
        </p:spPr>
        <p:txBody>
          <a:bodyPr wrap="none" rtlCol="0">
            <a:spAutoFit/>
          </a:bodyPr>
          <a:lstStyle/>
          <a:p>
            <a:r>
              <a:rPr lang="en-CA" sz="1600" dirty="0">
                <a:latin typeface="Arial" panose="020B0604020202020204" pitchFamily="34" charset="0"/>
                <a:cs typeface="Arial" panose="020B0604020202020204" pitchFamily="34" charset="0"/>
              </a:rPr>
              <a:t>Training group</a:t>
            </a:r>
          </a:p>
        </p:txBody>
      </p:sp>
      <p:pic>
        <p:nvPicPr>
          <p:cNvPr id="10" name="Picture 9">
            <a:extLst>
              <a:ext uri="{FF2B5EF4-FFF2-40B4-BE49-F238E27FC236}">
                <a16:creationId xmlns:a16="http://schemas.microsoft.com/office/drawing/2014/main" id="{39D667B8-94E7-47A1-81A5-8CDEE417AC82}"/>
              </a:ext>
            </a:extLst>
          </p:cNvPr>
          <p:cNvPicPr>
            <a:picLocks noChangeAspect="1"/>
          </p:cNvPicPr>
          <p:nvPr/>
        </p:nvPicPr>
        <p:blipFill rotWithShape="1">
          <a:blip r:embed="rId4">
            <a:extLst>
              <a:ext uri="{28A0092B-C50C-407E-A947-70E740481C1C}">
                <a14:useLocalDpi xmlns:a14="http://schemas.microsoft.com/office/drawing/2010/main" val="0"/>
              </a:ext>
            </a:extLst>
          </a:blip>
          <a:srcRect t="26979" r="30178" b="16250"/>
          <a:stretch/>
        </p:blipFill>
        <p:spPr>
          <a:xfrm>
            <a:off x="3954775" y="1621103"/>
            <a:ext cx="4297687" cy="3494419"/>
          </a:xfrm>
          <a:prstGeom prst="rect">
            <a:avLst/>
          </a:prstGeom>
        </p:spPr>
      </p:pic>
      <p:pic>
        <p:nvPicPr>
          <p:cNvPr id="11" name="Picture 10">
            <a:extLst>
              <a:ext uri="{FF2B5EF4-FFF2-40B4-BE49-F238E27FC236}">
                <a16:creationId xmlns:a16="http://schemas.microsoft.com/office/drawing/2014/main" id="{2FDDA8B7-25D0-493E-826C-52B21AE23FAC}"/>
              </a:ext>
            </a:extLst>
          </p:cNvPr>
          <p:cNvPicPr>
            <a:picLocks noChangeAspect="1"/>
          </p:cNvPicPr>
          <p:nvPr/>
        </p:nvPicPr>
        <p:blipFill rotWithShape="1">
          <a:blip r:embed="rId4">
            <a:extLst>
              <a:ext uri="{28A0092B-C50C-407E-A947-70E740481C1C}">
                <a14:useLocalDpi xmlns:a14="http://schemas.microsoft.com/office/drawing/2010/main" val="0"/>
              </a:ext>
            </a:extLst>
          </a:blip>
          <a:srcRect l="74048" t="40735" b="37122"/>
          <a:stretch/>
        </p:blipFill>
        <p:spPr>
          <a:xfrm>
            <a:off x="7303770" y="5343072"/>
            <a:ext cx="1661166" cy="1417320"/>
          </a:xfrm>
          <a:prstGeom prst="rect">
            <a:avLst/>
          </a:prstGeom>
        </p:spPr>
      </p:pic>
      <p:sp>
        <p:nvSpPr>
          <p:cNvPr id="12" name="TextBox 11">
            <a:extLst>
              <a:ext uri="{FF2B5EF4-FFF2-40B4-BE49-F238E27FC236}">
                <a16:creationId xmlns:a16="http://schemas.microsoft.com/office/drawing/2014/main" id="{FA38B6F1-6662-413F-8C2D-EB3162744A46}"/>
              </a:ext>
            </a:extLst>
          </p:cNvPr>
          <p:cNvSpPr txBox="1"/>
          <p:nvPr/>
        </p:nvSpPr>
        <p:spPr>
          <a:xfrm>
            <a:off x="4938131" y="1125402"/>
            <a:ext cx="3001912" cy="338554"/>
          </a:xfrm>
          <a:prstGeom prst="rect">
            <a:avLst/>
          </a:prstGeom>
          <a:noFill/>
        </p:spPr>
        <p:txBody>
          <a:bodyPr wrap="none" rtlCol="0">
            <a:spAutoFit/>
          </a:bodyPr>
          <a:lstStyle/>
          <a:p>
            <a:r>
              <a:rPr lang="en-CA" sz="1600" dirty="0">
                <a:latin typeface="Arial" panose="020B0604020202020204" pitchFamily="34" charset="0"/>
                <a:cs typeface="Arial" panose="020B0604020202020204" pitchFamily="34" charset="0"/>
              </a:rPr>
              <a:t>Validation + exploratory groups</a:t>
            </a:r>
          </a:p>
        </p:txBody>
      </p:sp>
      <p:sp>
        <p:nvSpPr>
          <p:cNvPr id="3" name="TextBox 2">
            <a:extLst>
              <a:ext uri="{FF2B5EF4-FFF2-40B4-BE49-F238E27FC236}">
                <a16:creationId xmlns:a16="http://schemas.microsoft.com/office/drawing/2014/main" id="{36BF64BE-A0A6-D5A0-5B21-F043B8E005A4}"/>
              </a:ext>
            </a:extLst>
          </p:cNvPr>
          <p:cNvSpPr txBox="1"/>
          <p:nvPr/>
        </p:nvSpPr>
        <p:spPr>
          <a:xfrm>
            <a:off x="487097" y="5343072"/>
            <a:ext cx="4614862" cy="830997"/>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CA" sz="1200" b="1" dirty="0">
                <a:solidFill>
                  <a:srgbClr val="000000"/>
                </a:solidFill>
                <a:effectLst/>
                <a:latin typeface="Source Sans Pro" panose="020B0503030403020204" pitchFamily="34" charset="0"/>
                <a:ea typeface="Times New Roman" panose="02020603050405020304" pitchFamily="18" charset="0"/>
              </a:rPr>
              <a:t>Figure S6. Ancestry probabilities of samples in the training (n=83) and validation (n=49) and exploratory (n=328) groups. </a:t>
            </a:r>
            <a:r>
              <a:rPr lang="en-CA" sz="1200" b="0" dirty="0">
                <a:solidFill>
                  <a:srgbClr val="000000"/>
                </a:solidFill>
                <a:effectLst/>
                <a:latin typeface="Source Sans Pro" panose="020B0503030403020204" pitchFamily="34" charset="0"/>
                <a:ea typeface="Times New Roman" panose="02020603050405020304" pitchFamily="18" charset="0"/>
              </a:rPr>
              <a:t>Three ancestry probabilities (African/Asian/European) were assigned to each sample using the R package planet (Yuan et al., 2019). </a:t>
            </a:r>
          </a:p>
        </p:txBody>
      </p:sp>
    </p:spTree>
    <p:extLst>
      <p:ext uri="{BB962C8B-B14F-4D97-AF65-F5344CB8AC3E}">
        <p14:creationId xmlns:p14="http://schemas.microsoft.com/office/powerpoint/2010/main" val="350816939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picture containing screenshot, line&#10;&#10;Description automatically generated">
            <a:extLst>
              <a:ext uri="{FF2B5EF4-FFF2-40B4-BE49-F238E27FC236}">
                <a16:creationId xmlns:a16="http://schemas.microsoft.com/office/drawing/2014/main" id="{3E0993FB-7B90-B746-05CE-172640AEA11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7820" y="1559936"/>
            <a:ext cx="9126180" cy="3650472"/>
          </a:xfrm>
          <a:prstGeom prst="rect">
            <a:avLst/>
          </a:prstGeom>
        </p:spPr>
      </p:pic>
      <p:sp>
        <p:nvSpPr>
          <p:cNvPr id="2" name="TextBox 1">
            <a:extLst>
              <a:ext uri="{FF2B5EF4-FFF2-40B4-BE49-F238E27FC236}">
                <a16:creationId xmlns:a16="http://schemas.microsoft.com/office/drawing/2014/main" id="{6C6F2E60-E45F-7C98-3063-59B7653BF965}"/>
              </a:ext>
            </a:extLst>
          </p:cNvPr>
          <p:cNvSpPr txBox="1"/>
          <p:nvPr/>
        </p:nvSpPr>
        <p:spPr>
          <a:xfrm>
            <a:off x="187059" y="5298064"/>
            <a:ext cx="7971104" cy="1015663"/>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CA" sz="1200" b="1" dirty="0">
                <a:solidFill>
                  <a:srgbClr val="000000"/>
                </a:solidFill>
                <a:effectLst/>
                <a:latin typeface="Source Sans Pro" panose="020B0503030403020204" pitchFamily="34" charset="0"/>
                <a:ea typeface="Times New Roman" panose="02020603050405020304" pitchFamily="18" charset="0"/>
              </a:rPr>
              <a:t>Figure S7. Average</a:t>
            </a:r>
            <a:r>
              <a:rPr lang="en-CA" sz="1200" b="0" dirty="0">
                <a:solidFill>
                  <a:srgbClr val="000000"/>
                </a:solidFill>
                <a:effectLst/>
                <a:latin typeface="Source Sans Pro" panose="020B0503030403020204" pitchFamily="34" charset="0"/>
                <a:ea typeface="Times New Roman" panose="02020603050405020304" pitchFamily="18" charset="0"/>
              </a:rPr>
              <a:t> </a:t>
            </a:r>
            <a:r>
              <a:rPr lang="en-CA" sz="1200" b="1" dirty="0">
                <a:effectLst/>
                <a:latin typeface="Source Sans Pro" panose="020B0503030403020204" pitchFamily="34" charset="0"/>
                <a:ea typeface="Source Sans Pro" panose="020B0503030403020204" pitchFamily="34" charset="0"/>
                <a:cs typeface="Times New Roman" panose="02020603050405020304" pitchFamily="18" charset="0"/>
              </a:rPr>
              <a:t>β values at the 45 predictive CpGs used by eoPred in EOPE (n=80) and nPTB (n=52) samples in the training and validation groups</a:t>
            </a:r>
            <a:r>
              <a:rPr lang="en-CA" sz="1200" b="1" dirty="0">
                <a:solidFill>
                  <a:srgbClr val="000000"/>
                </a:solidFill>
                <a:effectLst/>
                <a:latin typeface="Source Sans Pro" panose="020B0503030403020204" pitchFamily="34" charset="0"/>
                <a:ea typeface="Times New Roman" panose="02020603050405020304" pitchFamily="18" charset="0"/>
              </a:rPr>
              <a:t>. </a:t>
            </a:r>
            <a:r>
              <a:rPr lang="en-CA" sz="1200" b="0" dirty="0">
                <a:solidFill>
                  <a:srgbClr val="000000"/>
                </a:solidFill>
                <a:effectLst/>
                <a:latin typeface="Source Sans Pro" panose="020B0503030403020204" pitchFamily="34" charset="0"/>
                <a:ea typeface="Times New Roman" panose="02020603050405020304" pitchFamily="18" charset="0"/>
              </a:rPr>
              <a:t>There are 17 samples of African ancestry, 41 samples of Asian ancestry, and 74 samples of European ancestry depicted in the plot. Ancestry was inferred using three ancestry coordinates based on DNA methylation with the R package planet. EOPE and nPTB labels are based on the labelling by the original authors of each dataset and not on eoPred-assigned probabilities.</a:t>
            </a:r>
            <a:endParaRPr lang="en-CA" sz="1000" dirty="0"/>
          </a:p>
        </p:txBody>
      </p:sp>
    </p:spTree>
    <p:extLst>
      <p:ext uri="{BB962C8B-B14F-4D97-AF65-F5344CB8AC3E}">
        <p14:creationId xmlns:p14="http://schemas.microsoft.com/office/powerpoint/2010/main" val="229965357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screenshot, line, colorfulness&#10;&#10;Description automatically generated">
            <a:extLst>
              <a:ext uri="{FF2B5EF4-FFF2-40B4-BE49-F238E27FC236}">
                <a16:creationId xmlns:a16="http://schemas.microsoft.com/office/drawing/2014/main" id="{0EEA1813-441A-2D5B-AB40-8ADC3119C37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7822" y="1631982"/>
            <a:ext cx="9106365" cy="3642546"/>
          </a:xfrm>
          <a:prstGeom prst="rect">
            <a:avLst/>
          </a:prstGeom>
        </p:spPr>
      </p:pic>
      <p:sp>
        <p:nvSpPr>
          <p:cNvPr id="2" name="TextBox 1">
            <a:extLst>
              <a:ext uri="{FF2B5EF4-FFF2-40B4-BE49-F238E27FC236}">
                <a16:creationId xmlns:a16="http://schemas.microsoft.com/office/drawing/2014/main" id="{9EB6C5AB-9E23-55F7-1C7A-087D88711514}"/>
              </a:ext>
            </a:extLst>
          </p:cNvPr>
          <p:cNvSpPr txBox="1"/>
          <p:nvPr/>
        </p:nvSpPr>
        <p:spPr>
          <a:xfrm>
            <a:off x="187059" y="5298064"/>
            <a:ext cx="7971104" cy="1015663"/>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CA" sz="1200" b="1" dirty="0">
                <a:solidFill>
                  <a:srgbClr val="000000"/>
                </a:solidFill>
                <a:effectLst/>
                <a:latin typeface="Source Sans Pro" panose="020B0503030403020204" pitchFamily="34" charset="0"/>
                <a:ea typeface="Times New Roman" panose="02020603050405020304" pitchFamily="18" charset="0"/>
              </a:rPr>
              <a:t>Figure S8. Average</a:t>
            </a:r>
            <a:r>
              <a:rPr lang="en-CA" sz="1200" b="0" dirty="0">
                <a:solidFill>
                  <a:srgbClr val="000000"/>
                </a:solidFill>
                <a:effectLst/>
                <a:latin typeface="Source Sans Pro" panose="020B0503030403020204" pitchFamily="34" charset="0"/>
                <a:ea typeface="Times New Roman" panose="02020603050405020304" pitchFamily="18" charset="0"/>
              </a:rPr>
              <a:t> </a:t>
            </a:r>
            <a:r>
              <a:rPr lang="en-CA" sz="1200" b="1" dirty="0">
                <a:effectLst/>
                <a:latin typeface="Source Sans Pro" panose="020B0503030403020204" pitchFamily="34" charset="0"/>
                <a:ea typeface="Source Sans Pro" panose="020B0503030403020204" pitchFamily="34" charset="0"/>
                <a:cs typeface="Times New Roman" panose="02020603050405020304" pitchFamily="18" charset="0"/>
              </a:rPr>
              <a:t>β values at the 45 predictive CpGs used by eoPred in EOPE (n=93) and nPTB (n=283) samples in the validation and exploratory groups</a:t>
            </a:r>
            <a:r>
              <a:rPr lang="en-CA" sz="1200" b="1" dirty="0">
                <a:solidFill>
                  <a:srgbClr val="000000"/>
                </a:solidFill>
                <a:effectLst/>
                <a:latin typeface="Source Sans Pro" panose="020B0503030403020204" pitchFamily="34" charset="0"/>
                <a:ea typeface="Times New Roman" panose="02020603050405020304" pitchFamily="18" charset="0"/>
              </a:rPr>
              <a:t>. </a:t>
            </a:r>
            <a:r>
              <a:rPr lang="en-CA" sz="1200" b="0" dirty="0">
                <a:solidFill>
                  <a:srgbClr val="000000"/>
                </a:solidFill>
                <a:effectLst/>
                <a:latin typeface="Source Sans Pro" panose="020B0503030403020204" pitchFamily="34" charset="0"/>
                <a:ea typeface="Times New Roman" panose="02020603050405020304" pitchFamily="18" charset="0"/>
              </a:rPr>
              <a:t>Sample groups (EOPE/nPTB) are defined based on eoPred-assigned probabilities. Samples with &gt;55% probability of EOPE are classified as EOPE. There are 57 samples of African ancestry, 88 samples of Asian ancestry, and 231 samples of European ancestry depicted in the plot. Ancestry was inferred using three ancestry coordinates based on DNA methylation with the R package planet. </a:t>
            </a:r>
            <a:endParaRPr lang="en-CA" sz="1000" dirty="0"/>
          </a:p>
        </p:txBody>
      </p:sp>
    </p:spTree>
    <p:extLst>
      <p:ext uri="{BB962C8B-B14F-4D97-AF65-F5344CB8AC3E}">
        <p14:creationId xmlns:p14="http://schemas.microsoft.com/office/powerpoint/2010/main" val="88562336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06441A81-AC9C-4A61-A745-7B1C0DB36D0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676402" y="300039"/>
            <a:ext cx="6257925" cy="6257925"/>
          </a:xfrm>
          <a:prstGeom prst="rect">
            <a:avLst/>
          </a:prstGeom>
        </p:spPr>
      </p:pic>
      <p:sp>
        <p:nvSpPr>
          <p:cNvPr id="3" name="TextBox 2">
            <a:extLst>
              <a:ext uri="{FF2B5EF4-FFF2-40B4-BE49-F238E27FC236}">
                <a16:creationId xmlns:a16="http://schemas.microsoft.com/office/drawing/2014/main" id="{E01F77EA-EE28-A6C9-246D-D38C7DE0D230}"/>
              </a:ext>
            </a:extLst>
          </p:cNvPr>
          <p:cNvSpPr txBox="1"/>
          <p:nvPr/>
        </p:nvSpPr>
        <p:spPr>
          <a:xfrm>
            <a:off x="129344" y="4439840"/>
            <a:ext cx="1842332" cy="2308324"/>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CA" sz="1200" b="1" dirty="0">
                <a:solidFill>
                  <a:srgbClr val="000000"/>
                </a:solidFill>
                <a:effectLst/>
                <a:latin typeface="Source Sans Pro" panose="020B0503030403020204" pitchFamily="34" charset="0"/>
                <a:ea typeface="Times New Roman" panose="02020603050405020304" pitchFamily="18" charset="0"/>
              </a:rPr>
              <a:t>Figure S9. Cell composition of EOPE and nPTB samples in the validation group. </a:t>
            </a:r>
            <a:r>
              <a:rPr lang="en-CA" sz="1200" b="0" dirty="0">
                <a:solidFill>
                  <a:srgbClr val="000000"/>
                </a:solidFill>
                <a:effectLst/>
                <a:latin typeface="Source Sans Pro" panose="020B0503030403020204" pitchFamily="34" charset="0"/>
                <a:ea typeface="Times New Roman" panose="02020603050405020304" pitchFamily="18" charset="0"/>
              </a:rPr>
              <a:t>Two datasets from the validation group are included in this plot (GSE125605 and GSE98224). Cell composition estimates were inferred using the R package planet. </a:t>
            </a:r>
            <a:endParaRPr lang="en-CA" sz="1000" dirty="0"/>
          </a:p>
        </p:txBody>
      </p:sp>
    </p:spTree>
    <p:extLst>
      <p:ext uri="{BB962C8B-B14F-4D97-AF65-F5344CB8AC3E}">
        <p14:creationId xmlns:p14="http://schemas.microsoft.com/office/powerpoint/2010/main" val="217455162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133</TotalTime>
  <Words>1616</Words>
  <Application>Microsoft Macintosh PowerPoint</Application>
  <PresentationFormat>On-screen Show (4:3)</PresentationFormat>
  <Paragraphs>82</Paragraphs>
  <Slides>9</Slides>
  <Notes>9</Notes>
  <HiddenSlides>0</HiddenSlides>
  <MMClips>0</MMClips>
  <ScaleCrop>false</ScaleCrop>
  <HeadingPairs>
    <vt:vector size="6" baseType="variant">
      <vt:variant>
        <vt:lpstr>Fonts Used</vt:lpstr>
      </vt:variant>
      <vt:variant>
        <vt:i4>8</vt:i4>
      </vt:variant>
      <vt:variant>
        <vt:lpstr>Theme</vt:lpstr>
      </vt:variant>
      <vt:variant>
        <vt:i4>1</vt:i4>
      </vt:variant>
      <vt:variant>
        <vt:lpstr>Slide Titles</vt:lpstr>
      </vt:variant>
      <vt:variant>
        <vt:i4>9</vt:i4>
      </vt:variant>
    </vt:vector>
  </HeadingPairs>
  <TitlesOfParts>
    <vt:vector size="18" baseType="lpstr">
      <vt:lpstr>Arial</vt:lpstr>
      <vt:lpstr>Calibri</vt:lpstr>
      <vt:lpstr>Calibri Light</vt:lpstr>
      <vt:lpstr>Manrope</vt:lpstr>
      <vt:lpstr>Source Sans Pro</vt:lpstr>
      <vt:lpstr>Source Sans Pro Light</vt:lpstr>
      <vt:lpstr>Source Sans Pro SemiBold</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Icíar Fernández Boyano</dc:creator>
  <cp:lastModifiedBy>Icíar Fernández Boyano</cp:lastModifiedBy>
  <cp:revision>1</cp:revision>
  <dcterms:created xsi:type="dcterms:W3CDTF">2023-05-15T19:49:36Z</dcterms:created>
  <dcterms:modified xsi:type="dcterms:W3CDTF">2023-07-26T21:22:40Z</dcterms:modified>
</cp:coreProperties>
</file>